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 id="260" r:id="rId5"/>
    <p:sldId id="261" r:id="rId6"/>
    <p:sldId id="262" r:id="rId7"/>
    <p:sldId id="265" r:id="rId8"/>
    <p:sldId id="263" r:id="rId9"/>
    <p:sldId id="264"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2AB8F2D-54A3-400B-A344-EF37852B360B}" v="349" dt="2025-05-15T03:59:42.77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00" autoAdjust="0"/>
    <p:restoredTop sz="95216" autoAdjust="0"/>
  </p:normalViewPr>
  <p:slideViewPr>
    <p:cSldViewPr snapToGrid="0">
      <p:cViewPr varScale="1">
        <p:scale>
          <a:sx n="68" d="100"/>
          <a:sy n="68" d="100"/>
        </p:scale>
        <p:origin x="2190"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 ." userId="eae2494d765c5e40" providerId="LiveId" clId="{AEB176FA-C42A-4677-87FB-B9D6DCF82C44}"/>
    <pc:docChg chg="undo custSel modSld">
      <pc:chgData name=". ." userId="eae2494d765c5e40" providerId="LiveId" clId="{AEB176FA-C42A-4677-87FB-B9D6DCF82C44}" dt="2025-03-07T05:27:09.309" v="188"/>
      <pc:docMkLst>
        <pc:docMk/>
      </pc:docMkLst>
      <pc:sldChg chg="modSp mod">
        <pc:chgData name=". ." userId="eae2494d765c5e40" providerId="LiveId" clId="{AEB176FA-C42A-4677-87FB-B9D6DCF82C44}" dt="2025-03-07T05:16:43.999" v="150"/>
        <pc:sldMkLst>
          <pc:docMk/>
          <pc:sldMk cId="2707375953" sldId="256"/>
        </pc:sldMkLst>
      </pc:sldChg>
      <pc:sldChg chg="addSp delSp modSp mod">
        <pc:chgData name=". ." userId="eae2494d765c5e40" providerId="LiveId" clId="{AEB176FA-C42A-4677-87FB-B9D6DCF82C44}" dt="2025-03-07T05:27:09.309" v="188"/>
        <pc:sldMkLst>
          <pc:docMk/>
          <pc:sldMk cId="558584970" sldId="260"/>
        </pc:sldMkLst>
      </pc:sldChg>
      <pc:sldChg chg="modSp mod">
        <pc:chgData name=". ." userId="eae2494d765c5e40" providerId="LiveId" clId="{AEB176FA-C42A-4677-87FB-B9D6DCF82C44}" dt="2025-03-07T05:04:53.703" v="0" actId="196"/>
        <pc:sldMkLst>
          <pc:docMk/>
          <pc:sldMk cId="2939614826" sldId="264"/>
        </pc:sldMkLst>
      </pc:sldChg>
      <pc:sldChg chg="addSp delSp modSp mod">
        <pc:chgData name=". ." userId="eae2494d765c5e40" providerId="LiveId" clId="{AEB176FA-C42A-4677-87FB-B9D6DCF82C44}" dt="2025-03-07T05:23:33.771" v="174" actId="21"/>
        <pc:sldMkLst>
          <pc:docMk/>
          <pc:sldMk cId="1066340976" sldId="265"/>
        </pc:sldMkLst>
      </pc:sldChg>
    </pc:docChg>
  </pc:docChgLst>
  <pc:docChgLst>
    <pc:chgData name=". ." userId="eae2494d765c5e40" providerId="LiveId" clId="{77839675-8CF5-49EC-A9CA-E39B348FCD9F}"/>
    <pc:docChg chg="undo custSel modSld">
      <pc:chgData name=". ." userId="eae2494d765c5e40" providerId="LiveId" clId="{77839675-8CF5-49EC-A9CA-E39B348FCD9F}" dt="2025-04-08T11:52:12.728" v="109" actId="554"/>
      <pc:docMkLst>
        <pc:docMk/>
      </pc:docMkLst>
      <pc:sldChg chg="addSp delSp modSp mod">
        <pc:chgData name=". ." userId="eae2494d765c5e40" providerId="LiveId" clId="{77839675-8CF5-49EC-A9CA-E39B348FCD9F}" dt="2025-04-08T11:49:19.597" v="61" actId="554"/>
        <pc:sldMkLst>
          <pc:docMk/>
          <pc:sldMk cId="558584970" sldId="260"/>
        </pc:sldMkLst>
      </pc:sldChg>
      <pc:sldChg chg="addSp delSp modSp mod">
        <pc:chgData name=". ." userId="eae2494d765c5e40" providerId="LiveId" clId="{77839675-8CF5-49EC-A9CA-E39B348FCD9F}" dt="2025-04-08T11:52:12.728" v="109" actId="554"/>
        <pc:sldMkLst>
          <pc:docMk/>
          <pc:sldMk cId="4163714797" sldId="264"/>
        </pc:sldMkLst>
      </pc:sldChg>
      <pc:sldChg chg="addSp delSp modSp mod">
        <pc:chgData name=". ." userId="eae2494d765c5e40" providerId="LiveId" clId="{77839675-8CF5-49EC-A9CA-E39B348FCD9F}" dt="2025-04-08T11:50:05.366" v="74" actId="552"/>
        <pc:sldMkLst>
          <pc:docMk/>
          <pc:sldMk cId="1066340976" sldId="265"/>
        </pc:sldMkLst>
      </pc:sldChg>
    </pc:docChg>
  </pc:docChgLst>
  <pc:docChgLst>
    <pc:chgData name=". ." userId="eae2494d765c5e40" providerId="LiveId" clId="{02AB8F2D-54A3-400B-A344-EF37852B360B}"/>
    <pc:docChg chg="undo custSel addSld modSld">
      <pc:chgData name=". ." userId="eae2494d765c5e40" providerId="LiveId" clId="{02AB8F2D-54A3-400B-A344-EF37852B360B}" dt="2025-05-15T03:59:42.772" v="2976" actId="164"/>
      <pc:docMkLst>
        <pc:docMk/>
      </pc:docMkLst>
      <pc:sldChg chg="delSp mod">
        <pc:chgData name=". ." userId="eae2494d765c5e40" providerId="LiveId" clId="{02AB8F2D-54A3-400B-A344-EF37852B360B}" dt="2025-05-13T07:47:08.548" v="893" actId="21"/>
        <pc:sldMkLst>
          <pc:docMk/>
          <pc:sldMk cId="2424892102" sldId="257"/>
        </pc:sldMkLst>
      </pc:sldChg>
      <pc:sldChg chg="addSp modSp mod">
        <pc:chgData name=". ." userId="eae2494d765c5e40" providerId="LiveId" clId="{02AB8F2D-54A3-400B-A344-EF37852B360B}" dt="2025-05-14T06:50:54.883" v="2374" actId="1076"/>
        <pc:sldMkLst>
          <pc:docMk/>
          <pc:sldMk cId="2002524046" sldId="258"/>
        </pc:sldMkLst>
        <pc:spChg chg="mod">
          <ac:chgData name=". ." userId="eae2494d765c5e40" providerId="LiveId" clId="{02AB8F2D-54A3-400B-A344-EF37852B360B}" dt="2025-05-14T06:50:54.883" v="2374" actId="1076"/>
          <ac:spMkLst>
            <pc:docMk/>
            <pc:sldMk cId="2002524046" sldId="258"/>
            <ac:spMk id="2" creationId="{D541C266-DEDD-7DA6-26A8-B792BDE3C3AF}"/>
          </ac:spMkLst>
        </pc:spChg>
        <pc:spChg chg="add mod">
          <ac:chgData name=". ." userId="eae2494d765c5e40" providerId="LiveId" clId="{02AB8F2D-54A3-400B-A344-EF37852B360B}" dt="2025-05-13T07:47:12.701" v="895" actId="1076"/>
          <ac:spMkLst>
            <pc:docMk/>
            <pc:sldMk cId="2002524046" sldId="258"/>
            <ac:spMk id="7" creationId="{00AD5367-6A93-669F-3104-E50D0590BAF8}"/>
          </ac:spMkLst>
        </pc:spChg>
        <pc:spChg chg="mod">
          <ac:chgData name=". ." userId="eae2494d765c5e40" providerId="LiveId" clId="{02AB8F2D-54A3-400B-A344-EF37852B360B}" dt="2025-05-13T07:25:33.207" v="636" actId="2711"/>
          <ac:spMkLst>
            <pc:docMk/>
            <pc:sldMk cId="2002524046" sldId="258"/>
            <ac:spMk id="73" creationId="{137A718B-51FA-A9CF-3E24-9E57F9B60866}"/>
          </ac:spMkLst>
        </pc:spChg>
      </pc:sldChg>
      <pc:sldChg chg="addSp delSp modSp add mod">
        <pc:chgData name=". ." userId="eae2494d765c5e40" providerId="LiveId" clId="{02AB8F2D-54A3-400B-A344-EF37852B360B}" dt="2025-05-14T07:23:05.901" v="2448" actId="1076"/>
        <pc:sldMkLst>
          <pc:docMk/>
          <pc:sldMk cId="1033602256" sldId="259"/>
        </pc:sldMkLst>
        <pc:spChg chg="add mod">
          <ac:chgData name=". ." userId="eae2494d765c5e40" providerId="LiveId" clId="{02AB8F2D-54A3-400B-A344-EF37852B360B}" dt="2025-05-14T06:51:37.539" v="2375" actId="255"/>
          <ac:spMkLst>
            <pc:docMk/>
            <pc:sldMk cId="1033602256" sldId="259"/>
            <ac:spMk id="4" creationId="{707EDC45-25D0-9504-BE17-0117D875FBDF}"/>
          </ac:spMkLst>
        </pc:spChg>
        <pc:spChg chg="add mod">
          <ac:chgData name=". ." userId="eae2494d765c5e40" providerId="LiveId" clId="{02AB8F2D-54A3-400B-A344-EF37852B360B}" dt="2025-05-13T07:35:02.307" v="887" actId="1076"/>
          <ac:spMkLst>
            <pc:docMk/>
            <pc:sldMk cId="1033602256" sldId="259"/>
            <ac:spMk id="5" creationId="{F86902AB-5575-0788-3112-D6BA0EF93247}"/>
          </ac:spMkLst>
        </pc:spChg>
        <pc:spChg chg="mod">
          <ac:chgData name=". ." userId="eae2494d765c5e40" providerId="LiveId" clId="{02AB8F2D-54A3-400B-A344-EF37852B360B}" dt="2025-05-13T07:34:59.268" v="886" actId="1076"/>
          <ac:spMkLst>
            <pc:docMk/>
            <pc:sldMk cId="1033602256" sldId="259"/>
            <ac:spMk id="8" creationId="{D0405A70-DBD7-4F91-447C-0A5E004CA49E}"/>
          </ac:spMkLst>
        </pc:spChg>
        <pc:spChg chg="add mod topLvl">
          <ac:chgData name=". ." userId="eae2494d765c5e40" providerId="LiveId" clId="{02AB8F2D-54A3-400B-A344-EF37852B360B}" dt="2025-05-14T07:16:20.203" v="2422" actId="164"/>
          <ac:spMkLst>
            <pc:docMk/>
            <pc:sldMk cId="1033602256" sldId="259"/>
            <ac:spMk id="70" creationId="{35743381-E4D6-FC1C-2C96-44B3FAD76E15}"/>
          </ac:spMkLst>
        </pc:spChg>
        <pc:spChg chg="add mod topLvl">
          <ac:chgData name=". ." userId="eae2494d765c5e40" providerId="LiveId" clId="{02AB8F2D-54A3-400B-A344-EF37852B360B}" dt="2025-05-14T07:16:20.203" v="2422" actId="164"/>
          <ac:spMkLst>
            <pc:docMk/>
            <pc:sldMk cId="1033602256" sldId="259"/>
            <ac:spMk id="72" creationId="{A1F9CBAA-259F-3C4C-DA36-3DDE98E5DB1F}"/>
          </ac:spMkLst>
        </pc:spChg>
        <pc:spChg chg="add mod topLvl">
          <ac:chgData name=". ." userId="eae2494d765c5e40" providerId="LiveId" clId="{02AB8F2D-54A3-400B-A344-EF37852B360B}" dt="2025-05-14T07:16:20.203" v="2422" actId="164"/>
          <ac:spMkLst>
            <pc:docMk/>
            <pc:sldMk cId="1033602256" sldId="259"/>
            <ac:spMk id="74" creationId="{61E381E7-C57A-0688-5118-EF35600D504B}"/>
          </ac:spMkLst>
        </pc:spChg>
        <pc:spChg chg="add mod topLvl">
          <ac:chgData name=". ." userId="eae2494d765c5e40" providerId="LiveId" clId="{02AB8F2D-54A3-400B-A344-EF37852B360B}" dt="2025-05-14T07:16:20.203" v="2422" actId="164"/>
          <ac:spMkLst>
            <pc:docMk/>
            <pc:sldMk cId="1033602256" sldId="259"/>
            <ac:spMk id="75" creationId="{37F42759-EE91-0630-2076-CB32003FABBA}"/>
          </ac:spMkLst>
        </pc:spChg>
        <pc:spChg chg="add mod topLvl">
          <ac:chgData name=". ." userId="eae2494d765c5e40" providerId="LiveId" clId="{02AB8F2D-54A3-400B-A344-EF37852B360B}" dt="2025-05-14T07:16:20.203" v="2422" actId="164"/>
          <ac:spMkLst>
            <pc:docMk/>
            <pc:sldMk cId="1033602256" sldId="259"/>
            <ac:spMk id="77" creationId="{BEA9ED32-A002-3A3C-CA57-4994E316191E}"/>
          </ac:spMkLst>
        </pc:spChg>
        <pc:spChg chg="add mod topLvl">
          <ac:chgData name=". ." userId="eae2494d765c5e40" providerId="LiveId" clId="{02AB8F2D-54A3-400B-A344-EF37852B360B}" dt="2025-05-14T07:16:20.203" v="2422" actId="164"/>
          <ac:spMkLst>
            <pc:docMk/>
            <pc:sldMk cId="1033602256" sldId="259"/>
            <ac:spMk id="78" creationId="{6CA5D662-C873-5625-385D-88EEF77298EF}"/>
          </ac:spMkLst>
        </pc:spChg>
        <pc:spChg chg="add mod">
          <ac:chgData name=". ." userId="eae2494d765c5e40" providerId="LiveId" clId="{02AB8F2D-54A3-400B-A344-EF37852B360B}" dt="2025-05-13T07:47:16.678" v="897" actId="20577"/>
          <ac:spMkLst>
            <pc:docMk/>
            <pc:sldMk cId="1033602256" sldId="259"/>
            <ac:spMk id="87" creationId="{3457BAFD-8EB6-F8EA-F100-E1A18F67F457}"/>
          </ac:spMkLst>
        </pc:spChg>
        <pc:spChg chg="add mod topLvl">
          <ac:chgData name=". ." userId="eae2494d765c5e40" providerId="LiveId" clId="{02AB8F2D-54A3-400B-A344-EF37852B360B}" dt="2025-05-14T07:23:02.648" v="2447" actId="164"/>
          <ac:spMkLst>
            <pc:docMk/>
            <pc:sldMk cId="1033602256" sldId="259"/>
            <ac:spMk id="89" creationId="{7626A96D-E32A-BB69-78E7-B16D28041D2D}"/>
          </ac:spMkLst>
        </pc:spChg>
        <pc:spChg chg="add mod topLvl">
          <ac:chgData name=". ." userId="eae2494d765c5e40" providerId="LiveId" clId="{02AB8F2D-54A3-400B-A344-EF37852B360B}" dt="2025-05-14T07:23:02.648" v="2447" actId="164"/>
          <ac:spMkLst>
            <pc:docMk/>
            <pc:sldMk cId="1033602256" sldId="259"/>
            <ac:spMk id="90" creationId="{0D884489-ECC5-06B2-0AB5-F69F98F560CF}"/>
          </ac:spMkLst>
        </pc:spChg>
        <pc:grpChg chg="add mod">
          <ac:chgData name=". ." userId="eae2494d765c5e40" providerId="LiveId" clId="{02AB8F2D-54A3-400B-A344-EF37852B360B}" dt="2025-05-14T07:16:21.909" v="2423" actId="1076"/>
          <ac:grpSpMkLst>
            <pc:docMk/>
            <pc:sldMk cId="1033602256" sldId="259"/>
            <ac:grpSpMk id="6" creationId="{9C53E567-4C74-0C8E-AACE-7AC126D9F7EA}"/>
          </ac:grpSpMkLst>
        </pc:grpChg>
        <pc:grpChg chg="add del mod">
          <ac:chgData name=". ." userId="eae2494d765c5e40" providerId="LiveId" clId="{02AB8F2D-54A3-400B-A344-EF37852B360B}" dt="2025-05-14T06:51:52.149" v="2379" actId="165"/>
          <ac:grpSpMkLst>
            <pc:docMk/>
            <pc:sldMk cId="1033602256" sldId="259"/>
            <ac:grpSpMk id="7" creationId="{F95DC57E-E952-61CD-006F-7F6CF09E9B22}"/>
          </ac:grpSpMkLst>
        </pc:grpChg>
        <pc:grpChg chg="add del mod">
          <ac:chgData name=". ." userId="eae2494d765c5e40" providerId="LiveId" clId="{02AB8F2D-54A3-400B-A344-EF37852B360B}" dt="2025-05-14T04:14:22.912" v="2287" actId="165"/>
          <ac:grpSpMkLst>
            <pc:docMk/>
            <pc:sldMk cId="1033602256" sldId="259"/>
            <ac:grpSpMk id="9" creationId="{C6A0BFBA-FE52-9C5E-1A12-63B47D61922E}"/>
          </ac:grpSpMkLst>
        </pc:grpChg>
        <pc:grpChg chg="add del mod">
          <ac:chgData name=". ." userId="eae2494d765c5e40" providerId="LiveId" clId="{02AB8F2D-54A3-400B-A344-EF37852B360B}" dt="2025-05-14T07:22:22.342" v="2425" actId="165"/>
          <ac:grpSpMkLst>
            <pc:docMk/>
            <pc:sldMk cId="1033602256" sldId="259"/>
            <ac:grpSpMk id="10" creationId="{91D2F005-7D26-3A3B-33BC-572D6BBE1E6D}"/>
          </ac:grpSpMkLst>
        </pc:grpChg>
        <pc:grpChg chg="add mod">
          <ac:chgData name=". ." userId="eae2494d765c5e40" providerId="LiveId" clId="{02AB8F2D-54A3-400B-A344-EF37852B360B}" dt="2025-05-14T07:23:05.901" v="2448" actId="1076"/>
          <ac:grpSpMkLst>
            <pc:docMk/>
            <pc:sldMk cId="1033602256" sldId="259"/>
            <ac:grpSpMk id="11" creationId="{AD0C4A21-C115-EAE4-76B5-4694C4D9CBAA}"/>
          </ac:grpSpMkLst>
        </pc:grpChg>
        <pc:graphicFrameChg chg="add del mod topLvl">
          <ac:chgData name=". ." userId="eae2494d765c5e40" providerId="LiveId" clId="{02AB8F2D-54A3-400B-A344-EF37852B360B}" dt="2025-05-14T07:22:44.270" v="2429" actId="478"/>
          <ac:graphicFrameMkLst>
            <pc:docMk/>
            <pc:sldMk cId="1033602256" sldId="259"/>
            <ac:graphicFrameMk id="2" creationId="{DE6D881B-9FA9-21C7-A9E9-D9B36844D98D}"/>
          </ac:graphicFrameMkLst>
        </pc:graphicFrameChg>
        <pc:graphicFrameChg chg="add mod">
          <ac:chgData name=". ." userId="eae2494d765c5e40" providerId="LiveId" clId="{02AB8F2D-54A3-400B-A344-EF37852B360B}" dt="2025-05-14T07:16:20.203" v="2422" actId="164"/>
          <ac:graphicFrameMkLst>
            <pc:docMk/>
            <pc:sldMk cId="1033602256" sldId="259"/>
            <ac:graphicFrameMk id="3" creationId="{C8800FA7-7F50-DB9A-8DF8-C5D96887A2B2}"/>
          </ac:graphicFrameMkLst>
        </pc:graphicFrameChg>
        <pc:graphicFrameChg chg="add mod">
          <ac:chgData name=". ." userId="eae2494d765c5e40" providerId="LiveId" clId="{02AB8F2D-54A3-400B-A344-EF37852B360B}" dt="2025-05-14T07:23:02.648" v="2447" actId="164"/>
          <ac:graphicFrameMkLst>
            <pc:docMk/>
            <pc:sldMk cId="1033602256" sldId="259"/>
            <ac:graphicFrameMk id="9" creationId="{61863101-F945-8383-7214-B972F55CF529}"/>
          </ac:graphicFrameMkLst>
        </pc:graphicFrameChg>
        <pc:graphicFrameChg chg="add del mod topLvl">
          <ac:chgData name=". ." userId="eae2494d765c5e40" providerId="LiveId" clId="{02AB8F2D-54A3-400B-A344-EF37852B360B}" dt="2025-05-14T07:15:49.982" v="2388" actId="478"/>
          <ac:graphicFrameMkLst>
            <pc:docMk/>
            <pc:sldMk cId="1033602256" sldId="259"/>
            <ac:graphicFrameMk id="68" creationId="{702BB2EC-973D-D91D-14D9-4E5F85E2E280}"/>
          </ac:graphicFrameMkLst>
        </pc:graphicFrameChg>
      </pc:sldChg>
      <pc:sldChg chg="addSp delSp modSp add mod">
        <pc:chgData name=". ." userId="eae2494d765c5e40" providerId="LiveId" clId="{02AB8F2D-54A3-400B-A344-EF37852B360B}" dt="2025-05-14T07:54:45.935" v="2506" actId="1076"/>
        <pc:sldMkLst>
          <pc:docMk/>
          <pc:sldMk cId="1955781093" sldId="260"/>
        </pc:sldMkLst>
        <pc:spChg chg="add mod topLvl">
          <ac:chgData name=". ." userId="eae2494d765c5e40" providerId="LiveId" clId="{02AB8F2D-54A3-400B-A344-EF37852B360B}" dt="2025-05-14T07:48:14.603" v="2485" actId="164"/>
          <ac:spMkLst>
            <pc:docMk/>
            <pc:sldMk cId="1955781093" sldId="260"/>
            <ac:spMk id="3" creationId="{5C515D99-FC8F-09DD-0872-D7ABB3E44E1A}"/>
          </ac:spMkLst>
        </pc:spChg>
        <pc:spChg chg="mod">
          <ac:chgData name=". ." userId="eae2494d765c5e40" providerId="LiveId" clId="{02AB8F2D-54A3-400B-A344-EF37852B360B}" dt="2025-05-14T07:54:43.375" v="2505" actId="1076"/>
          <ac:spMkLst>
            <pc:docMk/>
            <pc:sldMk cId="1955781093" sldId="260"/>
            <ac:spMk id="4" creationId="{81DE9F89-6884-26F1-2E9E-9D61D887BE5A}"/>
          </ac:spMkLst>
        </pc:spChg>
        <pc:spChg chg="mod">
          <ac:chgData name=". ." userId="eae2494d765c5e40" providerId="LiveId" clId="{02AB8F2D-54A3-400B-A344-EF37852B360B}" dt="2025-05-14T07:54:45.935" v="2506" actId="1076"/>
          <ac:spMkLst>
            <pc:docMk/>
            <pc:sldMk cId="1955781093" sldId="260"/>
            <ac:spMk id="5" creationId="{AB700D12-908A-0D7F-84DB-6B2E40AD1DC9}"/>
          </ac:spMkLst>
        </pc:spChg>
        <pc:spChg chg="add mod topLvl">
          <ac:chgData name=". ." userId="eae2494d765c5e40" providerId="LiveId" clId="{02AB8F2D-54A3-400B-A344-EF37852B360B}" dt="2025-05-14T07:48:14.603" v="2485" actId="164"/>
          <ac:spMkLst>
            <pc:docMk/>
            <pc:sldMk cId="1955781093" sldId="260"/>
            <ac:spMk id="6" creationId="{1CC6FD2D-3D77-DF02-A748-67C5DDCDE2D0}"/>
          </ac:spMkLst>
        </pc:spChg>
        <pc:spChg chg="add mod topLvl">
          <ac:chgData name=". ." userId="eae2494d765c5e40" providerId="LiveId" clId="{02AB8F2D-54A3-400B-A344-EF37852B360B}" dt="2025-05-14T07:48:14.603" v="2485" actId="164"/>
          <ac:spMkLst>
            <pc:docMk/>
            <pc:sldMk cId="1955781093" sldId="260"/>
            <ac:spMk id="7" creationId="{371D76CC-2463-0F90-4CF1-A185AA70102C}"/>
          </ac:spMkLst>
        </pc:spChg>
        <pc:spChg chg="mod">
          <ac:chgData name=". ." userId="eae2494d765c5e40" providerId="LiveId" clId="{02AB8F2D-54A3-400B-A344-EF37852B360B}" dt="2025-05-13T08:40:55.993" v="1062" actId="1076"/>
          <ac:spMkLst>
            <pc:docMk/>
            <pc:sldMk cId="1955781093" sldId="260"/>
            <ac:spMk id="8" creationId="{46F5EB20-C468-BA98-1032-5825999A3C7B}"/>
          </ac:spMkLst>
        </pc:spChg>
        <pc:spChg chg="add mod topLvl">
          <ac:chgData name=". ." userId="eae2494d765c5e40" providerId="LiveId" clId="{02AB8F2D-54A3-400B-A344-EF37852B360B}" dt="2025-05-14T07:48:14.603" v="2485" actId="164"/>
          <ac:spMkLst>
            <pc:docMk/>
            <pc:sldMk cId="1955781093" sldId="260"/>
            <ac:spMk id="9" creationId="{B52480A9-95D3-79E0-EDEB-0EDB4CCA32AE}"/>
          </ac:spMkLst>
        </pc:spChg>
        <pc:spChg chg="add mod topLvl">
          <ac:chgData name=". ." userId="eae2494d765c5e40" providerId="LiveId" clId="{02AB8F2D-54A3-400B-A344-EF37852B360B}" dt="2025-05-14T07:48:14.603" v="2485" actId="164"/>
          <ac:spMkLst>
            <pc:docMk/>
            <pc:sldMk cId="1955781093" sldId="260"/>
            <ac:spMk id="10" creationId="{A9D34747-3401-76D7-100E-78356CAE46F0}"/>
          </ac:spMkLst>
        </pc:spChg>
        <pc:spChg chg="add mod topLvl">
          <ac:chgData name=". ." userId="eae2494d765c5e40" providerId="LiveId" clId="{02AB8F2D-54A3-400B-A344-EF37852B360B}" dt="2025-05-14T07:48:14.603" v="2485" actId="164"/>
          <ac:spMkLst>
            <pc:docMk/>
            <pc:sldMk cId="1955781093" sldId="260"/>
            <ac:spMk id="11" creationId="{8A07C1B8-C0A4-EC38-A9B8-2FB0F5F8BE53}"/>
          </ac:spMkLst>
        </pc:spChg>
        <pc:spChg chg="add mod">
          <ac:chgData name=". ." userId="eae2494d765c5e40" providerId="LiveId" clId="{02AB8F2D-54A3-400B-A344-EF37852B360B}" dt="2025-05-13T08:40:43.513" v="1058" actId="20577"/>
          <ac:spMkLst>
            <pc:docMk/>
            <pc:sldMk cId="1955781093" sldId="260"/>
            <ac:spMk id="13" creationId="{103A575A-51DF-7122-D646-52FE53AE503F}"/>
          </ac:spMkLst>
        </pc:spChg>
        <pc:spChg chg="add mod topLvl">
          <ac:chgData name=". ." userId="eae2494d765c5e40" providerId="LiveId" clId="{02AB8F2D-54A3-400B-A344-EF37852B360B}" dt="2025-05-14T07:54:31.307" v="2503" actId="164"/>
          <ac:spMkLst>
            <pc:docMk/>
            <pc:sldMk cId="1955781093" sldId="260"/>
            <ac:spMk id="16" creationId="{6297EBCD-4E28-736E-045B-64A14887DBCB}"/>
          </ac:spMkLst>
        </pc:spChg>
        <pc:spChg chg="add mod topLvl">
          <ac:chgData name=". ." userId="eae2494d765c5e40" providerId="LiveId" clId="{02AB8F2D-54A3-400B-A344-EF37852B360B}" dt="2025-05-14T07:54:31.307" v="2503" actId="164"/>
          <ac:spMkLst>
            <pc:docMk/>
            <pc:sldMk cId="1955781093" sldId="260"/>
            <ac:spMk id="17" creationId="{1B27DFE9-E3D4-9B46-415D-6087260E0F37}"/>
          </ac:spMkLst>
        </pc:spChg>
        <pc:grpChg chg="add del mod">
          <ac:chgData name=". ." userId="eae2494d765c5e40" providerId="LiveId" clId="{02AB8F2D-54A3-400B-A344-EF37852B360B}" dt="2025-05-14T07:24:48.862" v="2449" actId="165"/>
          <ac:grpSpMkLst>
            <pc:docMk/>
            <pc:sldMk cId="1955781093" sldId="260"/>
            <ac:grpSpMk id="12" creationId="{1F9B7C1F-CAD2-97D8-825A-9442C8BC0725}"/>
          </ac:grpSpMkLst>
        </pc:grpChg>
        <pc:grpChg chg="add del mod">
          <ac:chgData name=". ." userId="eae2494d765c5e40" providerId="LiveId" clId="{02AB8F2D-54A3-400B-A344-EF37852B360B}" dt="2025-05-14T07:24:50.072" v="2450" actId="165"/>
          <ac:grpSpMkLst>
            <pc:docMk/>
            <pc:sldMk cId="1955781093" sldId="260"/>
            <ac:grpSpMk id="18" creationId="{AC43F2F1-E80B-D849-8CBB-CEB32DC08438}"/>
          </ac:grpSpMkLst>
        </pc:grpChg>
        <pc:grpChg chg="add mod">
          <ac:chgData name=". ." userId="eae2494d765c5e40" providerId="LiveId" clId="{02AB8F2D-54A3-400B-A344-EF37852B360B}" dt="2025-05-14T07:48:16.597" v="2486" actId="1076"/>
          <ac:grpSpMkLst>
            <pc:docMk/>
            <pc:sldMk cId="1955781093" sldId="260"/>
            <ac:grpSpMk id="19" creationId="{1CFED5AC-33B6-B716-5D79-92C1237DEBE0}"/>
          </ac:grpSpMkLst>
        </pc:grpChg>
        <pc:grpChg chg="add mod">
          <ac:chgData name=". ." userId="eae2494d765c5e40" providerId="LiveId" clId="{02AB8F2D-54A3-400B-A344-EF37852B360B}" dt="2025-05-14T07:54:45.935" v="2506" actId="1076"/>
          <ac:grpSpMkLst>
            <pc:docMk/>
            <pc:sldMk cId="1955781093" sldId="260"/>
            <ac:grpSpMk id="22" creationId="{CD42B17B-797F-2D4E-EEF6-7A88E2B31063}"/>
          </ac:grpSpMkLst>
        </pc:grpChg>
        <pc:graphicFrameChg chg="add del mod topLvl">
          <ac:chgData name=". ." userId="eae2494d765c5e40" providerId="LiveId" clId="{02AB8F2D-54A3-400B-A344-EF37852B360B}" dt="2025-05-14T07:47:40.555" v="2454" actId="478"/>
          <ac:graphicFrameMkLst>
            <pc:docMk/>
            <pc:sldMk cId="1955781093" sldId="260"/>
            <ac:graphicFrameMk id="2" creationId="{B8B2100C-9B17-78C8-30C3-61D006FFA193}"/>
          </ac:graphicFrameMkLst>
        </pc:graphicFrameChg>
        <pc:graphicFrameChg chg="add mod">
          <ac:chgData name=". ." userId="eae2494d765c5e40" providerId="LiveId" clId="{02AB8F2D-54A3-400B-A344-EF37852B360B}" dt="2025-05-14T07:48:14.603" v="2485" actId="164"/>
          <ac:graphicFrameMkLst>
            <pc:docMk/>
            <pc:sldMk cId="1955781093" sldId="260"/>
            <ac:graphicFrameMk id="14" creationId="{56EB6E02-DBB9-2684-28F2-6772733FD480}"/>
          </ac:graphicFrameMkLst>
        </pc:graphicFrameChg>
        <pc:graphicFrameChg chg="add del mod topLvl">
          <ac:chgData name=". ." userId="eae2494d765c5e40" providerId="LiveId" clId="{02AB8F2D-54A3-400B-A344-EF37852B360B}" dt="2025-05-14T07:54:27.259" v="2501" actId="478"/>
          <ac:graphicFrameMkLst>
            <pc:docMk/>
            <pc:sldMk cId="1955781093" sldId="260"/>
            <ac:graphicFrameMk id="15" creationId="{AED7687D-82EC-F322-11BB-48179507B1B9}"/>
          </ac:graphicFrameMkLst>
        </pc:graphicFrameChg>
        <pc:graphicFrameChg chg="add del mod">
          <ac:chgData name=". ." userId="eae2494d765c5e40" providerId="LiveId" clId="{02AB8F2D-54A3-400B-A344-EF37852B360B}" dt="2025-05-14T07:54:26.188" v="2500" actId="21"/>
          <ac:graphicFrameMkLst>
            <pc:docMk/>
            <pc:sldMk cId="1955781093" sldId="260"/>
            <ac:graphicFrameMk id="20" creationId="{D69AB416-AB1A-873C-958F-05E7EC203FF2}"/>
          </ac:graphicFrameMkLst>
        </pc:graphicFrameChg>
        <pc:graphicFrameChg chg="add mod">
          <ac:chgData name=". ." userId="eae2494d765c5e40" providerId="LiveId" clId="{02AB8F2D-54A3-400B-A344-EF37852B360B}" dt="2025-05-14T07:54:31.307" v="2503" actId="164"/>
          <ac:graphicFrameMkLst>
            <pc:docMk/>
            <pc:sldMk cId="1955781093" sldId="260"/>
            <ac:graphicFrameMk id="21" creationId="{D69AB416-AB1A-873C-958F-05E7EC203FF2}"/>
          </ac:graphicFrameMkLst>
        </pc:graphicFrameChg>
      </pc:sldChg>
      <pc:sldChg chg="addSp delSp modSp add mod">
        <pc:chgData name=". ." userId="eae2494d765c5e40" providerId="LiveId" clId="{02AB8F2D-54A3-400B-A344-EF37852B360B}" dt="2025-05-14T08:56:29.727" v="2607" actId="164"/>
        <pc:sldMkLst>
          <pc:docMk/>
          <pc:sldMk cId="2346476419" sldId="261"/>
        </pc:sldMkLst>
        <pc:spChg chg="add mod">
          <ac:chgData name=". ." userId="eae2494d765c5e40" providerId="LiveId" clId="{02AB8F2D-54A3-400B-A344-EF37852B360B}" dt="2025-05-13T08:55:09.378" v="1087" actId="20577"/>
          <ac:spMkLst>
            <pc:docMk/>
            <pc:sldMk cId="2346476419" sldId="261"/>
            <ac:spMk id="2" creationId="{3FE30272-1F47-2B84-8A33-1E036E516A26}"/>
          </ac:spMkLst>
        </pc:spChg>
        <pc:spChg chg="mod">
          <ac:chgData name=". ." userId="eae2494d765c5e40" providerId="LiveId" clId="{02AB8F2D-54A3-400B-A344-EF37852B360B}" dt="2025-05-14T07:55:11.093" v="2508" actId="1076"/>
          <ac:spMkLst>
            <pc:docMk/>
            <pc:sldMk cId="2346476419" sldId="261"/>
            <ac:spMk id="4" creationId="{BC0EEBEC-BB83-CFB3-0A0A-76180F053BA8}"/>
          </ac:spMkLst>
        </pc:spChg>
        <pc:spChg chg="mod">
          <ac:chgData name=". ." userId="eae2494d765c5e40" providerId="LiveId" clId="{02AB8F2D-54A3-400B-A344-EF37852B360B}" dt="2025-05-13T23:25:33.431" v="1252" actId="554"/>
          <ac:spMkLst>
            <pc:docMk/>
            <pc:sldMk cId="2346476419" sldId="261"/>
            <ac:spMk id="5" creationId="{7DF17BB9-CE81-76EF-A3AB-0F67EBB90FBC}"/>
          </ac:spMkLst>
        </pc:spChg>
        <pc:spChg chg="mod">
          <ac:chgData name=". ." userId="eae2494d765c5e40" providerId="LiveId" clId="{02AB8F2D-54A3-400B-A344-EF37852B360B}" dt="2025-05-13T23:25:33.431" v="1252" actId="554"/>
          <ac:spMkLst>
            <pc:docMk/>
            <pc:sldMk cId="2346476419" sldId="261"/>
            <ac:spMk id="8" creationId="{CFA4B34B-3954-0596-00A3-4D59BEFE634B}"/>
          </ac:spMkLst>
        </pc:spChg>
        <pc:spChg chg="add mod topLvl">
          <ac:chgData name=". ." userId="eae2494d765c5e40" providerId="LiveId" clId="{02AB8F2D-54A3-400B-A344-EF37852B360B}" dt="2025-05-14T08:06:14.473" v="2541" actId="164"/>
          <ac:spMkLst>
            <pc:docMk/>
            <pc:sldMk cId="2346476419" sldId="261"/>
            <ac:spMk id="9" creationId="{EAFDE9E1-5798-A94A-C6AE-A34DADE86249}"/>
          </ac:spMkLst>
        </pc:spChg>
        <pc:spChg chg="add mod topLvl">
          <ac:chgData name=". ." userId="eae2494d765c5e40" providerId="LiveId" clId="{02AB8F2D-54A3-400B-A344-EF37852B360B}" dt="2025-05-14T08:06:14.473" v="2541" actId="164"/>
          <ac:spMkLst>
            <pc:docMk/>
            <pc:sldMk cId="2346476419" sldId="261"/>
            <ac:spMk id="10" creationId="{B11CCC8B-08B5-6B86-3BE0-B9E4408BDDC6}"/>
          </ac:spMkLst>
        </pc:spChg>
        <pc:spChg chg="add mod topLvl">
          <ac:chgData name=". ." userId="eae2494d765c5e40" providerId="LiveId" clId="{02AB8F2D-54A3-400B-A344-EF37852B360B}" dt="2025-05-14T08:06:14.473" v="2541" actId="164"/>
          <ac:spMkLst>
            <pc:docMk/>
            <pc:sldMk cId="2346476419" sldId="261"/>
            <ac:spMk id="11" creationId="{7C087646-9294-DD99-F3A8-5852878911A7}"/>
          </ac:spMkLst>
        </pc:spChg>
        <pc:spChg chg="add mod topLvl">
          <ac:chgData name=". ." userId="eae2494d765c5e40" providerId="LiveId" clId="{02AB8F2D-54A3-400B-A344-EF37852B360B}" dt="2025-05-14T08:06:14.473" v="2541" actId="164"/>
          <ac:spMkLst>
            <pc:docMk/>
            <pc:sldMk cId="2346476419" sldId="261"/>
            <ac:spMk id="12" creationId="{4457C49B-6E56-01FF-D2BA-B76F3055A60A}"/>
          </ac:spMkLst>
        </pc:spChg>
        <pc:spChg chg="add mod topLvl">
          <ac:chgData name=". ." userId="eae2494d765c5e40" providerId="LiveId" clId="{02AB8F2D-54A3-400B-A344-EF37852B360B}" dt="2025-05-14T08:50:04.746" v="2569" actId="164"/>
          <ac:spMkLst>
            <pc:docMk/>
            <pc:sldMk cId="2346476419" sldId="261"/>
            <ac:spMk id="14" creationId="{613DC341-5302-FE5B-C83F-11205C9FD479}"/>
          </ac:spMkLst>
        </pc:spChg>
        <pc:spChg chg="add mod topLvl">
          <ac:chgData name=". ." userId="eae2494d765c5e40" providerId="LiveId" clId="{02AB8F2D-54A3-400B-A344-EF37852B360B}" dt="2025-05-14T08:50:04.746" v="2569" actId="164"/>
          <ac:spMkLst>
            <pc:docMk/>
            <pc:sldMk cId="2346476419" sldId="261"/>
            <ac:spMk id="15" creationId="{CEF49FB4-4398-389D-8EC7-17EA2878DD6F}"/>
          </ac:spMkLst>
        </pc:spChg>
        <pc:spChg chg="add mod topLvl">
          <ac:chgData name=". ." userId="eae2494d765c5e40" providerId="LiveId" clId="{02AB8F2D-54A3-400B-A344-EF37852B360B}" dt="2025-05-14T08:50:04.746" v="2569" actId="164"/>
          <ac:spMkLst>
            <pc:docMk/>
            <pc:sldMk cId="2346476419" sldId="261"/>
            <ac:spMk id="16" creationId="{FB90E7DD-60A5-43A4-4DD3-D0F8C40F87A3}"/>
          </ac:spMkLst>
        </pc:spChg>
        <pc:spChg chg="add mod topLvl">
          <ac:chgData name=". ." userId="eae2494d765c5e40" providerId="LiveId" clId="{02AB8F2D-54A3-400B-A344-EF37852B360B}" dt="2025-05-14T08:50:04.746" v="2569" actId="164"/>
          <ac:spMkLst>
            <pc:docMk/>
            <pc:sldMk cId="2346476419" sldId="261"/>
            <ac:spMk id="17" creationId="{C88E9B66-2CD0-4BEC-CD70-5CC0CE32869E}"/>
          </ac:spMkLst>
        </pc:spChg>
        <pc:spChg chg="add mod topLvl">
          <ac:chgData name=". ." userId="eae2494d765c5e40" providerId="LiveId" clId="{02AB8F2D-54A3-400B-A344-EF37852B360B}" dt="2025-05-14T08:53:50.423" v="2589" actId="164"/>
          <ac:spMkLst>
            <pc:docMk/>
            <pc:sldMk cId="2346476419" sldId="261"/>
            <ac:spMk id="19" creationId="{C0560855-088F-EA93-1B66-56AB5626FE4E}"/>
          </ac:spMkLst>
        </pc:spChg>
        <pc:spChg chg="add mod topLvl">
          <ac:chgData name=". ." userId="eae2494d765c5e40" providerId="LiveId" clId="{02AB8F2D-54A3-400B-A344-EF37852B360B}" dt="2025-05-14T08:53:50.423" v="2589" actId="164"/>
          <ac:spMkLst>
            <pc:docMk/>
            <pc:sldMk cId="2346476419" sldId="261"/>
            <ac:spMk id="20" creationId="{C631AE16-6715-19E1-D0DB-A5B80923DD28}"/>
          </ac:spMkLst>
        </pc:spChg>
        <pc:spChg chg="add mod topLvl">
          <ac:chgData name=". ." userId="eae2494d765c5e40" providerId="LiveId" clId="{02AB8F2D-54A3-400B-A344-EF37852B360B}" dt="2025-05-14T08:56:29.727" v="2607" actId="164"/>
          <ac:spMkLst>
            <pc:docMk/>
            <pc:sldMk cId="2346476419" sldId="261"/>
            <ac:spMk id="24" creationId="{B3C2C66B-BBDB-B5EC-3337-3F4C6EE2042C}"/>
          </ac:spMkLst>
        </pc:spChg>
        <pc:spChg chg="add mod topLvl">
          <ac:chgData name=". ." userId="eae2494d765c5e40" providerId="LiveId" clId="{02AB8F2D-54A3-400B-A344-EF37852B360B}" dt="2025-05-14T08:56:29.727" v="2607" actId="164"/>
          <ac:spMkLst>
            <pc:docMk/>
            <pc:sldMk cId="2346476419" sldId="261"/>
            <ac:spMk id="25" creationId="{5C01FB6D-0EA5-42C4-BEF2-40316DC9EB10}"/>
          </ac:spMkLst>
        </pc:spChg>
        <pc:spChg chg="add mod">
          <ac:chgData name=". ." userId="eae2494d765c5e40" providerId="LiveId" clId="{02AB8F2D-54A3-400B-A344-EF37852B360B}" dt="2025-05-13T23:25:26.421" v="1238" actId="1036"/>
          <ac:spMkLst>
            <pc:docMk/>
            <pc:sldMk cId="2346476419" sldId="261"/>
            <ac:spMk id="96" creationId="{FEA54F05-CA14-34D5-89E0-1398455F7796}"/>
          </ac:spMkLst>
        </pc:spChg>
        <pc:spChg chg="add mod">
          <ac:chgData name=". ." userId="eae2494d765c5e40" providerId="LiveId" clId="{02AB8F2D-54A3-400B-A344-EF37852B360B}" dt="2025-05-13T23:25:26.421" v="1238" actId="1036"/>
          <ac:spMkLst>
            <pc:docMk/>
            <pc:sldMk cId="2346476419" sldId="261"/>
            <ac:spMk id="97" creationId="{36A328FD-D598-6BA1-C14D-2C0F2453FE88}"/>
          </ac:spMkLst>
        </pc:spChg>
        <pc:grpChg chg="add mod">
          <ac:chgData name=". ." userId="eae2494d765c5e40" providerId="LiveId" clId="{02AB8F2D-54A3-400B-A344-EF37852B360B}" dt="2025-05-14T08:49:51.313" v="2566" actId="554"/>
          <ac:grpSpMkLst>
            <pc:docMk/>
            <pc:sldMk cId="2346476419" sldId="261"/>
            <ac:grpSpMk id="7" creationId="{3FE43BA7-3472-48E9-279B-0AAAFAA60EA6}"/>
          </ac:grpSpMkLst>
        </pc:grpChg>
        <pc:grpChg chg="add del mod">
          <ac:chgData name=". ." userId="eae2494d765c5e40" providerId="LiveId" clId="{02AB8F2D-54A3-400B-A344-EF37852B360B}" dt="2025-05-14T08:05:24.962" v="2510" actId="165"/>
          <ac:grpSpMkLst>
            <pc:docMk/>
            <pc:sldMk cId="2346476419" sldId="261"/>
            <ac:grpSpMk id="21" creationId="{FEFC54DA-2674-46C2-FEE1-1130700D2DF7}"/>
          </ac:grpSpMkLst>
        </pc:grpChg>
        <pc:grpChg chg="add del mod">
          <ac:chgData name=". ." userId="eae2494d765c5e40" providerId="LiveId" clId="{02AB8F2D-54A3-400B-A344-EF37852B360B}" dt="2025-05-14T08:05:25.843" v="2511" actId="165"/>
          <ac:grpSpMkLst>
            <pc:docMk/>
            <pc:sldMk cId="2346476419" sldId="261"/>
            <ac:grpSpMk id="22" creationId="{88AA0DA3-1AF4-A200-E255-5C9C439C34D1}"/>
          </ac:grpSpMkLst>
        </pc:grpChg>
        <pc:grpChg chg="add del mod">
          <ac:chgData name=". ." userId="eae2494d765c5e40" providerId="LiveId" clId="{02AB8F2D-54A3-400B-A344-EF37852B360B}" dt="2025-05-14T08:05:26.391" v="2512" actId="165"/>
          <ac:grpSpMkLst>
            <pc:docMk/>
            <pc:sldMk cId="2346476419" sldId="261"/>
            <ac:grpSpMk id="26" creationId="{760B1D95-6EE6-7BEE-F779-0FB57DE2B74D}"/>
          </ac:grpSpMkLst>
        </pc:grpChg>
        <pc:grpChg chg="add mod">
          <ac:chgData name=". ." userId="eae2494d765c5e40" providerId="LiveId" clId="{02AB8F2D-54A3-400B-A344-EF37852B360B}" dt="2025-05-14T08:50:04.746" v="2569" actId="164"/>
          <ac:grpSpMkLst>
            <pc:docMk/>
            <pc:sldMk cId="2346476419" sldId="261"/>
            <ac:grpSpMk id="28" creationId="{4E904107-7A75-4D95-B883-8C92453E8F69}"/>
          </ac:grpSpMkLst>
        </pc:grpChg>
        <pc:grpChg chg="add del mod">
          <ac:chgData name=". ." userId="eae2494d765c5e40" providerId="LiveId" clId="{02AB8F2D-54A3-400B-A344-EF37852B360B}" dt="2025-05-14T08:05:26.932" v="2513" actId="165"/>
          <ac:grpSpMkLst>
            <pc:docMk/>
            <pc:sldMk cId="2346476419" sldId="261"/>
            <ac:grpSpMk id="29" creationId="{933B030E-2CC4-BB64-1E15-96CF6A04C0B6}"/>
          </ac:grpSpMkLst>
        </pc:grpChg>
        <pc:grpChg chg="add mod">
          <ac:chgData name=". ." userId="eae2494d765c5e40" providerId="LiveId" clId="{02AB8F2D-54A3-400B-A344-EF37852B360B}" dt="2025-05-14T08:53:50.423" v="2589" actId="164"/>
          <ac:grpSpMkLst>
            <pc:docMk/>
            <pc:sldMk cId="2346476419" sldId="261"/>
            <ac:grpSpMk id="31" creationId="{971726B5-A7D4-EF39-BB36-06BBD8CA5EE1}"/>
          </ac:grpSpMkLst>
        </pc:grpChg>
        <pc:grpChg chg="add mod">
          <ac:chgData name=". ." userId="eae2494d765c5e40" providerId="LiveId" clId="{02AB8F2D-54A3-400B-A344-EF37852B360B}" dt="2025-05-14T08:56:29.727" v="2607" actId="164"/>
          <ac:grpSpMkLst>
            <pc:docMk/>
            <pc:sldMk cId="2346476419" sldId="261"/>
            <ac:grpSpMk id="33" creationId="{B8D74C0B-FA93-2F44-BE1E-4C59E294DD4E}"/>
          </ac:grpSpMkLst>
        </pc:grpChg>
        <pc:graphicFrameChg chg="add mod">
          <ac:chgData name=". ." userId="eae2494d765c5e40" providerId="LiveId" clId="{02AB8F2D-54A3-400B-A344-EF37852B360B}" dt="2025-05-14T08:06:14.473" v="2541" actId="164"/>
          <ac:graphicFrameMkLst>
            <pc:docMk/>
            <pc:sldMk cId="2346476419" sldId="261"/>
            <ac:graphicFrameMk id="3" creationId="{F5B6F3A7-4830-CE58-8BC2-FB980F699E47}"/>
          </ac:graphicFrameMkLst>
        </pc:graphicFrameChg>
        <pc:graphicFrameChg chg="add del mod topLvl">
          <ac:chgData name=". ." userId="eae2494d765c5e40" providerId="LiveId" clId="{02AB8F2D-54A3-400B-A344-EF37852B360B}" dt="2025-05-14T08:05:50.851" v="2516" actId="478"/>
          <ac:graphicFrameMkLst>
            <pc:docMk/>
            <pc:sldMk cId="2346476419" sldId="261"/>
            <ac:graphicFrameMk id="6" creationId="{FD6B110B-3B6A-3BBA-DC1D-7A9D210097C9}"/>
          </ac:graphicFrameMkLst>
        </pc:graphicFrameChg>
        <pc:graphicFrameChg chg="add del mod topLvl">
          <ac:chgData name=". ." userId="eae2494d765c5e40" providerId="LiveId" clId="{02AB8F2D-54A3-400B-A344-EF37852B360B}" dt="2025-05-14T08:49:23.072" v="2549" actId="478"/>
          <ac:graphicFrameMkLst>
            <pc:docMk/>
            <pc:sldMk cId="2346476419" sldId="261"/>
            <ac:graphicFrameMk id="13" creationId="{D50B037A-C305-B326-30E2-5F8BCA251CA4}"/>
          </ac:graphicFrameMkLst>
        </pc:graphicFrameChg>
        <pc:graphicFrameChg chg="add del mod topLvl">
          <ac:chgData name=". ." userId="eae2494d765c5e40" providerId="LiveId" clId="{02AB8F2D-54A3-400B-A344-EF37852B360B}" dt="2025-05-14T08:53:32.431" v="2574" actId="478"/>
          <ac:graphicFrameMkLst>
            <pc:docMk/>
            <pc:sldMk cId="2346476419" sldId="261"/>
            <ac:graphicFrameMk id="18" creationId="{C8E2E7C4-7C45-895F-43AF-D6D22E914193}"/>
          </ac:graphicFrameMkLst>
        </pc:graphicFrameChg>
        <pc:graphicFrameChg chg="add del mod topLvl">
          <ac:chgData name=". ." userId="eae2494d765c5e40" providerId="LiveId" clId="{02AB8F2D-54A3-400B-A344-EF37852B360B}" dt="2025-05-14T08:56:13.288" v="2594" actId="478"/>
          <ac:graphicFrameMkLst>
            <pc:docMk/>
            <pc:sldMk cId="2346476419" sldId="261"/>
            <ac:graphicFrameMk id="23" creationId="{9C9D6045-B490-0F89-85DD-ACF9DBA23969}"/>
          </ac:graphicFrameMkLst>
        </pc:graphicFrameChg>
        <pc:graphicFrameChg chg="add mod">
          <ac:chgData name=". ." userId="eae2494d765c5e40" providerId="LiveId" clId="{02AB8F2D-54A3-400B-A344-EF37852B360B}" dt="2025-05-14T08:50:04.746" v="2569" actId="164"/>
          <ac:graphicFrameMkLst>
            <pc:docMk/>
            <pc:sldMk cId="2346476419" sldId="261"/>
            <ac:graphicFrameMk id="27" creationId="{3375377B-C79B-F104-92C2-C2D88148C2E3}"/>
          </ac:graphicFrameMkLst>
        </pc:graphicFrameChg>
        <pc:graphicFrameChg chg="add mod">
          <ac:chgData name=". ." userId="eae2494d765c5e40" providerId="LiveId" clId="{02AB8F2D-54A3-400B-A344-EF37852B360B}" dt="2025-05-14T08:53:50.423" v="2589" actId="164"/>
          <ac:graphicFrameMkLst>
            <pc:docMk/>
            <pc:sldMk cId="2346476419" sldId="261"/>
            <ac:graphicFrameMk id="30" creationId="{680F9BE9-1458-7263-3E93-46F2E3A1D7BA}"/>
          </ac:graphicFrameMkLst>
        </pc:graphicFrameChg>
        <pc:graphicFrameChg chg="add mod">
          <ac:chgData name=". ." userId="eae2494d765c5e40" providerId="LiveId" clId="{02AB8F2D-54A3-400B-A344-EF37852B360B}" dt="2025-05-14T08:56:29.727" v="2607" actId="164"/>
          <ac:graphicFrameMkLst>
            <pc:docMk/>
            <pc:sldMk cId="2346476419" sldId="261"/>
            <ac:graphicFrameMk id="32" creationId="{3D301C41-F853-6B14-6F96-EF9F022996D2}"/>
          </ac:graphicFrameMkLst>
        </pc:graphicFrameChg>
      </pc:sldChg>
      <pc:sldChg chg="addSp delSp modSp add mod">
        <pc:chgData name=". ." userId="eae2494d765c5e40" providerId="LiveId" clId="{02AB8F2D-54A3-400B-A344-EF37852B360B}" dt="2025-05-14T09:58:00.705" v="2743" actId="164"/>
        <pc:sldMkLst>
          <pc:docMk/>
          <pc:sldMk cId="3494478633" sldId="262"/>
        </pc:sldMkLst>
        <pc:spChg chg="add mod">
          <ac:chgData name=". ." userId="eae2494d765c5e40" providerId="LiveId" clId="{02AB8F2D-54A3-400B-A344-EF37852B360B}" dt="2025-05-14T01:05:51.157" v="1834" actId="1076"/>
          <ac:spMkLst>
            <pc:docMk/>
            <pc:sldMk cId="3494478633" sldId="262"/>
            <ac:spMk id="7" creationId="{348DF616-AB59-0877-7E21-4ABE75C93CC2}"/>
          </ac:spMkLst>
        </pc:spChg>
        <pc:spChg chg="add mod topLvl">
          <ac:chgData name=". ." userId="eae2494d765c5e40" providerId="LiveId" clId="{02AB8F2D-54A3-400B-A344-EF37852B360B}" dt="2025-05-14T09:40:02.683" v="2640" actId="164"/>
          <ac:spMkLst>
            <pc:docMk/>
            <pc:sldMk cId="3494478633" sldId="262"/>
            <ac:spMk id="10" creationId="{36B3EF61-6E26-C43A-A0F7-1BB53E5D8292}"/>
          </ac:spMkLst>
        </pc:spChg>
        <pc:spChg chg="add mod topLvl">
          <ac:chgData name=". ." userId="eae2494d765c5e40" providerId="LiveId" clId="{02AB8F2D-54A3-400B-A344-EF37852B360B}" dt="2025-05-14T09:40:02.683" v="2640" actId="164"/>
          <ac:spMkLst>
            <pc:docMk/>
            <pc:sldMk cId="3494478633" sldId="262"/>
            <ac:spMk id="11" creationId="{797B5B97-0BED-B18E-B58E-20C4B7F7E024}"/>
          </ac:spMkLst>
        </pc:spChg>
        <pc:spChg chg="add mod topLvl">
          <ac:chgData name=". ." userId="eae2494d765c5e40" providerId="LiveId" clId="{02AB8F2D-54A3-400B-A344-EF37852B360B}" dt="2025-05-14T09:40:02.683" v="2640" actId="164"/>
          <ac:spMkLst>
            <pc:docMk/>
            <pc:sldMk cId="3494478633" sldId="262"/>
            <ac:spMk id="12" creationId="{E9ED943D-40DD-85C9-1776-95DA6E5C0B9D}"/>
          </ac:spMkLst>
        </pc:spChg>
        <pc:spChg chg="add mod topLvl">
          <ac:chgData name=". ." userId="eae2494d765c5e40" providerId="LiveId" clId="{02AB8F2D-54A3-400B-A344-EF37852B360B}" dt="2025-05-14T09:40:02.683" v="2640" actId="164"/>
          <ac:spMkLst>
            <pc:docMk/>
            <pc:sldMk cId="3494478633" sldId="262"/>
            <ac:spMk id="13" creationId="{F8386CBC-3D6A-1DAF-2275-20C89FBCBC1E}"/>
          </ac:spMkLst>
        </pc:spChg>
        <pc:spChg chg="add mod topLvl">
          <ac:chgData name=". ." userId="eae2494d765c5e40" providerId="LiveId" clId="{02AB8F2D-54A3-400B-A344-EF37852B360B}" dt="2025-05-14T09:40:02.683" v="2640" actId="164"/>
          <ac:spMkLst>
            <pc:docMk/>
            <pc:sldMk cId="3494478633" sldId="262"/>
            <ac:spMk id="14" creationId="{CB1F85E8-3192-7416-9F02-16DF7E2217AA}"/>
          </ac:spMkLst>
        </pc:spChg>
        <pc:spChg chg="add mod topLvl">
          <ac:chgData name=". ." userId="eae2494d765c5e40" providerId="LiveId" clId="{02AB8F2D-54A3-400B-A344-EF37852B360B}" dt="2025-05-14T09:44:46.517" v="2648" actId="164"/>
          <ac:spMkLst>
            <pc:docMk/>
            <pc:sldMk cId="3494478633" sldId="262"/>
            <ac:spMk id="17" creationId="{1E6148A3-CDB2-FE16-EAF2-A427C1DB12B9}"/>
          </ac:spMkLst>
        </pc:spChg>
        <pc:spChg chg="add mod topLvl">
          <ac:chgData name=". ." userId="eae2494d765c5e40" providerId="LiveId" clId="{02AB8F2D-54A3-400B-A344-EF37852B360B}" dt="2025-05-14T09:44:46.517" v="2648" actId="164"/>
          <ac:spMkLst>
            <pc:docMk/>
            <pc:sldMk cId="3494478633" sldId="262"/>
            <ac:spMk id="18" creationId="{27F35D5C-F2EC-306F-8F8E-B3D82735D291}"/>
          </ac:spMkLst>
        </pc:spChg>
        <pc:spChg chg="add mod topLvl">
          <ac:chgData name=". ." userId="eae2494d765c5e40" providerId="LiveId" clId="{02AB8F2D-54A3-400B-A344-EF37852B360B}" dt="2025-05-14T09:44:46.517" v="2648" actId="164"/>
          <ac:spMkLst>
            <pc:docMk/>
            <pc:sldMk cId="3494478633" sldId="262"/>
            <ac:spMk id="19" creationId="{B5AF5752-1855-DAF6-113A-38F0FCBA939D}"/>
          </ac:spMkLst>
        </pc:spChg>
        <pc:spChg chg="add mod topLvl">
          <ac:chgData name=". ." userId="eae2494d765c5e40" providerId="LiveId" clId="{02AB8F2D-54A3-400B-A344-EF37852B360B}" dt="2025-05-14T09:44:46.517" v="2648" actId="164"/>
          <ac:spMkLst>
            <pc:docMk/>
            <pc:sldMk cId="3494478633" sldId="262"/>
            <ac:spMk id="20" creationId="{D7364CD8-1F55-290E-D942-9C5FEB46B752}"/>
          </ac:spMkLst>
        </pc:spChg>
        <pc:spChg chg="add mod topLvl">
          <ac:chgData name=". ." userId="eae2494d765c5e40" providerId="LiveId" clId="{02AB8F2D-54A3-400B-A344-EF37852B360B}" dt="2025-05-14T09:44:46.517" v="2648" actId="164"/>
          <ac:spMkLst>
            <pc:docMk/>
            <pc:sldMk cId="3494478633" sldId="262"/>
            <ac:spMk id="21" creationId="{30FA4D94-8F43-83E4-2293-87F209E66A98}"/>
          </ac:spMkLst>
        </pc:spChg>
        <pc:spChg chg="add mod">
          <ac:chgData name=". ." userId="eae2494d765c5e40" providerId="LiveId" clId="{02AB8F2D-54A3-400B-A344-EF37852B360B}" dt="2025-05-14T01:12:35.610" v="1924" actId="1035"/>
          <ac:spMkLst>
            <pc:docMk/>
            <pc:sldMk cId="3494478633" sldId="262"/>
            <ac:spMk id="22" creationId="{0FA2C788-DCD9-1C81-CC1A-DEA6F9D446BB}"/>
          </ac:spMkLst>
        </pc:spChg>
        <pc:spChg chg="add mod">
          <ac:chgData name=". ." userId="eae2494d765c5e40" providerId="LiveId" clId="{02AB8F2D-54A3-400B-A344-EF37852B360B}" dt="2025-05-14T01:12:35.610" v="1924" actId="1035"/>
          <ac:spMkLst>
            <pc:docMk/>
            <pc:sldMk cId="3494478633" sldId="262"/>
            <ac:spMk id="23" creationId="{D46E3346-5C0E-D5BA-0FE0-4639FCC6731D}"/>
          </ac:spMkLst>
        </pc:spChg>
        <pc:spChg chg="add mod topLvl">
          <ac:chgData name=". ." userId="eae2494d765c5e40" providerId="LiveId" clId="{02AB8F2D-54A3-400B-A344-EF37852B360B}" dt="2025-05-14T09:49:37.209" v="2667" actId="164"/>
          <ac:spMkLst>
            <pc:docMk/>
            <pc:sldMk cId="3494478633" sldId="262"/>
            <ac:spMk id="25" creationId="{6165D999-B8C3-728E-901E-CB175312D14E}"/>
          </ac:spMkLst>
        </pc:spChg>
        <pc:spChg chg="add mod topLvl">
          <ac:chgData name=". ." userId="eae2494d765c5e40" providerId="LiveId" clId="{02AB8F2D-54A3-400B-A344-EF37852B360B}" dt="2025-05-14T09:49:37.209" v="2667" actId="164"/>
          <ac:spMkLst>
            <pc:docMk/>
            <pc:sldMk cId="3494478633" sldId="262"/>
            <ac:spMk id="26" creationId="{A7ED2507-B67D-36FC-1E2F-CD4482514A84}"/>
          </ac:spMkLst>
        </pc:spChg>
        <pc:spChg chg="add mod topLvl">
          <ac:chgData name=". ." userId="eae2494d765c5e40" providerId="LiveId" clId="{02AB8F2D-54A3-400B-A344-EF37852B360B}" dt="2025-05-14T09:49:37.209" v="2667" actId="164"/>
          <ac:spMkLst>
            <pc:docMk/>
            <pc:sldMk cId="3494478633" sldId="262"/>
            <ac:spMk id="27" creationId="{034B6B6B-693F-0D4F-FC9C-973A0615BDB9}"/>
          </ac:spMkLst>
        </pc:spChg>
        <pc:spChg chg="add mod topLvl">
          <ac:chgData name=". ." userId="eae2494d765c5e40" providerId="LiveId" clId="{02AB8F2D-54A3-400B-A344-EF37852B360B}" dt="2025-05-14T09:49:37.209" v="2667" actId="164"/>
          <ac:spMkLst>
            <pc:docMk/>
            <pc:sldMk cId="3494478633" sldId="262"/>
            <ac:spMk id="28" creationId="{52D52E85-37E5-F3F6-53AB-B981AEE9EDD2}"/>
          </ac:spMkLst>
        </pc:spChg>
        <pc:spChg chg="add mod topLvl">
          <ac:chgData name=". ." userId="eae2494d765c5e40" providerId="LiveId" clId="{02AB8F2D-54A3-400B-A344-EF37852B360B}" dt="2025-05-14T09:54:10.401" v="2709" actId="164"/>
          <ac:spMkLst>
            <pc:docMk/>
            <pc:sldMk cId="3494478633" sldId="262"/>
            <ac:spMk id="33" creationId="{9A304573-3D04-6452-C139-C76EDD9192FA}"/>
          </ac:spMkLst>
        </pc:spChg>
        <pc:spChg chg="add mod topLvl">
          <ac:chgData name=". ." userId="eae2494d765c5e40" providerId="LiveId" clId="{02AB8F2D-54A3-400B-A344-EF37852B360B}" dt="2025-05-14T09:54:10.401" v="2709" actId="164"/>
          <ac:spMkLst>
            <pc:docMk/>
            <pc:sldMk cId="3494478633" sldId="262"/>
            <ac:spMk id="34" creationId="{7AD07349-B721-43B0-019A-EB5182D70F37}"/>
          </ac:spMkLst>
        </pc:spChg>
        <pc:spChg chg="add mod topLvl">
          <ac:chgData name=". ." userId="eae2494d765c5e40" providerId="LiveId" clId="{02AB8F2D-54A3-400B-A344-EF37852B360B}" dt="2025-05-14T09:54:10.401" v="2709" actId="164"/>
          <ac:spMkLst>
            <pc:docMk/>
            <pc:sldMk cId="3494478633" sldId="262"/>
            <ac:spMk id="35" creationId="{8196B4E4-1E5F-6219-D298-A0787B659C6D}"/>
          </ac:spMkLst>
        </pc:spChg>
        <pc:spChg chg="add mod topLvl">
          <ac:chgData name=". ." userId="eae2494d765c5e40" providerId="LiveId" clId="{02AB8F2D-54A3-400B-A344-EF37852B360B}" dt="2025-05-14T09:54:10.401" v="2709" actId="164"/>
          <ac:spMkLst>
            <pc:docMk/>
            <pc:sldMk cId="3494478633" sldId="262"/>
            <ac:spMk id="36" creationId="{EFE124B2-646B-FD3C-F924-58E71880ACF9}"/>
          </ac:spMkLst>
        </pc:spChg>
        <pc:spChg chg="add mod">
          <ac:chgData name=". ." userId="eae2494d765c5e40" providerId="LiveId" clId="{02AB8F2D-54A3-400B-A344-EF37852B360B}" dt="2025-05-14T01:12:36.667" v="1928" actId="1035"/>
          <ac:spMkLst>
            <pc:docMk/>
            <pc:sldMk cId="3494478633" sldId="262"/>
            <ac:spMk id="38" creationId="{9F69B057-32E5-D2C0-5E04-0FE0790660CF}"/>
          </ac:spMkLst>
        </pc:spChg>
        <pc:spChg chg="add mod topLvl">
          <ac:chgData name=". ." userId="eae2494d765c5e40" providerId="LiveId" clId="{02AB8F2D-54A3-400B-A344-EF37852B360B}" dt="2025-05-14T09:58:00.705" v="2743" actId="164"/>
          <ac:spMkLst>
            <pc:docMk/>
            <pc:sldMk cId="3494478633" sldId="262"/>
            <ac:spMk id="40" creationId="{18FC7C45-C0AE-3C42-9F57-A203CD05C121}"/>
          </ac:spMkLst>
        </pc:spChg>
        <pc:spChg chg="add mod topLvl">
          <ac:chgData name=". ." userId="eae2494d765c5e40" providerId="LiveId" clId="{02AB8F2D-54A3-400B-A344-EF37852B360B}" dt="2025-05-14T09:58:00.705" v="2743" actId="164"/>
          <ac:spMkLst>
            <pc:docMk/>
            <pc:sldMk cId="3494478633" sldId="262"/>
            <ac:spMk id="41" creationId="{572F4FFD-9E46-9A8E-2EE0-B5A2EE88654E}"/>
          </ac:spMkLst>
        </pc:spChg>
        <pc:spChg chg="add mod topLvl">
          <ac:chgData name=". ." userId="eae2494d765c5e40" providerId="LiveId" clId="{02AB8F2D-54A3-400B-A344-EF37852B360B}" dt="2025-05-14T09:58:00.705" v="2743" actId="164"/>
          <ac:spMkLst>
            <pc:docMk/>
            <pc:sldMk cId="3494478633" sldId="262"/>
            <ac:spMk id="42" creationId="{0744EF3C-85F7-8FB6-B115-1ED5B0824AEE}"/>
          </ac:spMkLst>
        </pc:spChg>
        <pc:spChg chg="add mod topLvl">
          <ac:chgData name=". ." userId="eae2494d765c5e40" providerId="LiveId" clId="{02AB8F2D-54A3-400B-A344-EF37852B360B}" dt="2025-05-14T09:58:00.705" v="2743" actId="164"/>
          <ac:spMkLst>
            <pc:docMk/>
            <pc:sldMk cId="3494478633" sldId="262"/>
            <ac:spMk id="43" creationId="{A9413619-6318-9707-EF67-140DED582EBE}"/>
          </ac:spMkLst>
        </pc:spChg>
        <pc:spChg chg="mod">
          <ac:chgData name=". ." userId="eae2494d765c5e40" providerId="LiveId" clId="{02AB8F2D-54A3-400B-A344-EF37852B360B}" dt="2025-05-14T01:06:00.451" v="1843" actId="1037"/>
          <ac:spMkLst>
            <pc:docMk/>
            <pc:sldMk cId="3494478633" sldId="262"/>
            <ac:spMk id="96" creationId="{072696F5-41EC-5A6D-F872-82BC0807CEDC}"/>
          </ac:spMkLst>
        </pc:spChg>
        <pc:spChg chg="mod">
          <ac:chgData name=". ." userId="eae2494d765c5e40" providerId="LiveId" clId="{02AB8F2D-54A3-400B-A344-EF37852B360B}" dt="2025-05-14T01:05:53.867" v="1838" actId="1038"/>
          <ac:spMkLst>
            <pc:docMk/>
            <pc:sldMk cId="3494478633" sldId="262"/>
            <ac:spMk id="97" creationId="{86718FE6-8628-3413-6547-0CE1451C9B24}"/>
          </ac:spMkLst>
        </pc:spChg>
        <pc:grpChg chg="add mod">
          <ac:chgData name=". ." userId="eae2494d765c5e40" providerId="LiveId" clId="{02AB8F2D-54A3-400B-A344-EF37852B360B}" dt="2025-05-14T09:40:02.683" v="2640" actId="164"/>
          <ac:grpSpMkLst>
            <pc:docMk/>
            <pc:sldMk cId="3494478633" sldId="262"/>
            <ac:grpSpMk id="3" creationId="{1BF5EB74-2AAA-AC4C-2337-44392671DC3B}"/>
          </ac:grpSpMkLst>
        </pc:grpChg>
        <pc:grpChg chg="add mod">
          <ac:chgData name=". ." userId="eae2494d765c5e40" providerId="LiveId" clId="{02AB8F2D-54A3-400B-A344-EF37852B360B}" dt="2025-05-14T09:44:46.517" v="2648" actId="164"/>
          <ac:grpSpMkLst>
            <pc:docMk/>
            <pc:sldMk cId="3494478633" sldId="262"/>
            <ac:grpSpMk id="5" creationId="{EEBC7D7F-63FD-9805-3353-76E50E6CAA39}"/>
          </ac:grpSpMkLst>
        </pc:grpChg>
        <pc:grpChg chg="add mod">
          <ac:chgData name=". ." userId="eae2494d765c5e40" providerId="LiveId" clId="{02AB8F2D-54A3-400B-A344-EF37852B360B}" dt="2025-05-14T09:49:40.065" v="2669" actId="1076"/>
          <ac:grpSpMkLst>
            <pc:docMk/>
            <pc:sldMk cId="3494478633" sldId="262"/>
            <ac:grpSpMk id="8" creationId="{1964A1F5-5648-787E-60AF-7660D11CC90A}"/>
          </ac:grpSpMkLst>
        </pc:grpChg>
        <pc:grpChg chg="add del mod">
          <ac:chgData name=". ." userId="eae2494d765c5e40" providerId="LiveId" clId="{02AB8F2D-54A3-400B-A344-EF37852B360B}" dt="2025-05-14T09:39:05.311" v="2611" actId="165"/>
          <ac:grpSpMkLst>
            <pc:docMk/>
            <pc:sldMk cId="3494478633" sldId="262"/>
            <ac:grpSpMk id="29" creationId="{60E4A0C9-3ED9-0895-7621-B1C9D8294D2E}"/>
          </ac:grpSpMkLst>
        </pc:grpChg>
        <pc:grpChg chg="add del mod">
          <ac:chgData name=". ." userId="eae2494d765c5e40" providerId="LiveId" clId="{02AB8F2D-54A3-400B-A344-EF37852B360B}" dt="2025-05-14T09:39:40.020" v="2617" actId="165"/>
          <ac:grpSpMkLst>
            <pc:docMk/>
            <pc:sldMk cId="3494478633" sldId="262"/>
            <ac:grpSpMk id="30" creationId="{CC2F132B-43B6-16CD-2EF0-1A80B926B08C}"/>
          </ac:grpSpMkLst>
        </pc:grpChg>
        <pc:grpChg chg="add del mod">
          <ac:chgData name=". ." userId="eae2494d765c5e40" providerId="LiveId" clId="{02AB8F2D-54A3-400B-A344-EF37852B360B}" dt="2025-05-14T09:39:41.090" v="2619" actId="165"/>
          <ac:grpSpMkLst>
            <pc:docMk/>
            <pc:sldMk cId="3494478633" sldId="262"/>
            <ac:grpSpMk id="31" creationId="{95EB5BE8-F5DE-618F-4992-37378655FBCA}"/>
          </ac:grpSpMkLst>
        </pc:grpChg>
        <pc:grpChg chg="add del mod">
          <ac:chgData name=". ." userId="eae2494d765c5e40" providerId="LiveId" clId="{02AB8F2D-54A3-400B-A344-EF37852B360B}" dt="2025-05-14T09:39:40.635" v="2618" actId="165"/>
          <ac:grpSpMkLst>
            <pc:docMk/>
            <pc:sldMk cId="3494478633" sldId="262"/>
            <ac:grpSpMk id="37" creationId="{C094F463-05DF-ED5B-CD5F-37AD9B7AB109}"/>
          </ac:grpSpMkLst>
        </pc:grpChg>
        <pc:grpChg chg="add del mod">
          <ac:chgData name=". ." userId="eae2494d765c5e40" providerId="LiveId" clId="{02AB8F2D-54A3-400B-A344-EF37852B360B}" dt="2025-05-14T09:39:41.678" v="2620" actId="165"/>
          <ac:grpSpMkLst>
            <pc:docMk/>
            <pc:sldMk cId="3494478633" sldId="262"/>
            <ac:grpSpMk id="44" creationId="{783C40F5-DE3C-07B0-B2EB-AE5393973809}"/>
          </ac:grpSpMkLst>
        </pc:grpChg>
        <pc:grpChg chg="add mod">
          <ac:chgData name=". ." userId="eae2494d765c5e40" providerId="LiveId" clId="{02AB8F2D-54A3-400B-A344-EF37852B360B}" dt="2025-05-14T09:54:10.401" v="2709" actId="164"/>
          <ac:grpSpMkLst>
            <pc:docMk/>
            <pc:sldMk cId="3494478633" sldId="262"/>
            <ac:grpSpMk id="45" creationId="{A1B6B19B-7A02-E342-9E6F-EC85F7BFF6E4}"/>
          </ac:grpSpMkLst>
        </pc:grpChg>
        <pc:grpChg chg="add mod">
          <ac:chgData name=". ." userId="eae2494d765c5e40" providerId="LiveId" clId="{02AB8F2D-54A3-400B-A344-EF37852B360B}" dt="2025-05-14T09:58:00.705" v="2743" actId="164"/>
          <ac:grpSpMkLst>
            <pc:docMk/>
            <pc:sldMk cId="3494478633" sldId="262"/>
            <ac:grpSpMk id="47" creationId="{F38D30D9-EE5E-22DE-CED5-51CAF10F7B8B}"/>
          </ac:grpSpMkLst>
        </pc:grpChg>
        <pc:graphicFrameChg chg="add mod">
          <ac:chgData name=". ." userId="eae2494d765c5e40" providerId="LiveId" clId="{02AB8F2D-54A3-400B-A344-EF37852B360B}" dt="2025-05-14T09:40:02.683" v="2640" actId="164"/>
          <ac:graphicFrameMkLst>
            <pc:docMk/>
            <pc:sldMk cId="3494478633" sldId="262"/>
            <ac:graphicFrameMk id="2" creationId="{075F7454-85A0-7A35-E95A-B46B79DFEFE1}"/>
          </ac:graphicFrameMkLst>
        </pc:graphicFrameChg>
        <pc:graphicFrameChg chg="add mod">
          <ac:chgData name=". ." userId="eae2494d765c5e40" providerId="LiveId" clId="{02AB8F2D-54A3-400B-A344-EF37852B360B}" dt="2025-05-14T09:44:46.517" v="2648" actId="164"/>
          <ac:graphicFrameMkLst>
            <pc:docMk/>
            <pc:sldMk cId="3494478633" sldId="262"/>
            <ac:graphicFrameMk id="4" creationId="{7C166690-5438-93F8-5324-206565708AF0}"/>
          </ac:graphicFrameMkLst>
        </pc:graphicFrameChg>
        <pc:graphicFrameChg chg="add mod">
          <ac:chgData name=". ." userId="eae2494d765c5e40" providerId="LiveId" clId="{02AB8F2D-54A3-400B-A344-EF37852B360B}" dt="2025-05-14T09:49:37.209" v="2667" actId="164"/>
          <ac:graphicFrameMkLst>
            <pc:docMk/>
            <pc:sldMk cId="3494478633" sldId="262"/>
            <ac:graphicFrameMk id="6" creationId="{8206D0F2-2427-133D-BDA9-A6CFF7601ED0}"/>
          </ac:graphicFrameMkLst>
        </pc:graphicFrameChg>
        <pc:graphicFrameChg chg="add mod">
          <ac:chgData name=". ." userId="eae2494d765c5e40" providerId="LiveId" clId="{02AB8F2D-54A3-400B-A344-EF37852B360B}" dt="2025-05-14T09:54:10.401" v="2709" actId="164"/>
          <ac:graphicFrameMkLst>
            <pc:docMk/>
            <pc:sldMk cId="3494478633" sldId="262"/>
            <ac:graphicFrameMk id="9" creationId="{1D343D62-F9A9-8428-0102-5787DF3ECC46}"/>
          </ac:graphicFrameMkLst>
        </pc:graphicFrameChg>
        <pc:graphicFrameChg chg="add del mod">
          <ac:chgData name=". ." userId="eae2494d765c5e40" providerId="LiveId" clId="{02AB8F2D-54A3-400B-A344-EF37852B360B}" dt="2025-05-14T00:46:16.392" v="1765" actId="478"/>
          <ac:graphicFrameMkLst>
            <pc:docMk/>
            <pc:sldMk cId="3494478633" sldId="262"/>
            <ac:graphicFrameMk id="9" creationId="{792CEA8D-56DC-008D-7EBD-B981B135614D}"/>
          </ac:graphicFrameMkLst>
        </pc:graphicFrameChg>
        <pc:graphicFrameChg chg="add del mod topLvl">
          <ac:chgData name=". ." userId="eae2494d765c5e40" providerId="LiveId" clId="{02AB8F2D-54A3-400B-A344-EF37852B360B}" dt="2025-05-14T09:39:34.156" v="2614" actId="478"/>
          <ac:graphicFrameMkLst>
            <pc:docMk/>
            <pc:sldMk cId="3494478633" sldId="262"/>
            <ac:graphicFrameMk id="15" creationId="{B1CD9FE4-956C-2E03-1D32-E8410A0B3910}"/>
          </ac:graphicFrameMkLst>
        </pc:graphicFrameChg>
        <pc:graphicFrameChg chg="add del mod topLvl">
          <ac:chgData name=". ." userId="eae2494d765c5e40" providerId="LiveId" clId="{02AB8F2D-54A3-400B-A344-EF37852B360B}" dt="2025-05-14T09:44:34.498" v="2643" actId="478"/>
          <ac:graphicFrameMkLst>
            <pc:docMk/>
            <pc:sldMk cId="3494478633" sldId="262"/>
            <ac:graphicFrameMk id="16" creationId="{07A8B79B-B3BF-E639-8BE2-4EFB5D58895C}"/>
          </ac:graphicFrameMkLst>
        </pc:graphicFrameChg>
        <pc:graphicFrameChg chg="add del mod topLvl">
          <ac:chgData name=". ." userId="eae2494d765c5e40" providerId="LiveId" clId="{02AB8F2D-54A3-400B-A344-EF37852B360B}" dt="2025-05-14T09:49:18.849" v="2653" actId="478"/>
          <ac:graphicFrameMkLst>
            <pc:docMk/>
            <pc:sldMk cId="3494478633" sldId="262"/>
            <ac:graphicFrameMk id="24" creationId="{B6BA8CDD-8D5B-F7D4-73D5-C7603130B768}"/>
          </ac:graphicFrameMkLst>
        </pc:graphicFrameChg>
        <pc:graphicFrameChg chg="add del mod topLvl">
          <ac:chgData name=". ." userId="eae2494d765c5e40" providerId="LiveId" clId="{02AB8F2D-54A3-400B-A344-EF37852B360B}" dt="2025-05-14T09:53:46.698" v="2675" actId="478"/>
          <ac:graphicFrameMkLst>
            <pc:docMk/>
            <pc:sldMk cId="3494478633" sldId="262"/>
            <ac:graphicFrameMk id="32" creationId="{DE60EA44-FE14-41BA-2B7F-F35B73F2DA0C}"/>
          </ac:graphicFrameMkLst>
        </pc:graphicFrameChg>
        <pc:graphicFrameChg chg="add del mod topLvl">
          <ac:chgData name=". ." userId="eae2494d765c5e40" providerId="LiveId" clId="{02AB8F2D-54A3-400B-A344-EF37852B360B}" dt="2025-05-14T09:57:32.792" v="2712" actId="478"/>
          <ac:graphicFrameMkLst>
            <pc:docMk/>
            <pc:sldMk cId="3494478633" sldId="262"/>
            <ac:graphicFrameMk id="39" creationId="{21BA77E8-9A22-059F-53A6-9176ECC06BE7}"/>
          </ac:graphicFrameMkLst>
        </pc:graphicFrameChg>
        <pc:graphicFrameChg chg="add mod">
          <ac:chgData name=". ." userId="eae2494d765c5e40" providerId="LiveId" clId="{02AB8F2D-54A3-400B-A344-EF37852B360B}" dt="2025-05-14T09:58:00.705" v="2743" actId="164"/>
          <ac:graphicFrameMkLst>
            <pc:docMk/>
            <pc:sldMk cId="3494478633" sldId="262"/>
            <ac:graphicFrameMk id="46" creationId="{86361D4D-7D6C-8DD6-7441-9F8B8C916DCA}"/>
          </ac:graphicFrameMkLst>
        </pc:graphicFrameChg>
      </pc:sldChg>
      <pc:sldChg chg="addSp delSp modSp add mod">
        <pc:chgData name=". ." userId="eae2494d765c5e40" providerId="LiveId" clId="{02AB8F2D-54A3-400B-A344-EF37852B360B}" dt="2025-05-15T00:50:32.376" v="2909" actId="164"/>
        <pc:sldMkLst>
          <pc:docMk/>
          <pc:sldMk cId="285597022" sldId="263"/>
        </pc:sldMkLst>
        <pc:spChg chg="add mod">
          <ac:chgData name=". ." userId="eae2494d765c5e40" providerId="LiveId" clId="{02AB8F2D-54A3-400B-A344-EF37852B360B}" dt="2025-05-14T01:43:26.125" v="2036" actId="20577"/>
          <ac:spMkLst>
            <pc:docMk/>
            <pc:sldMk cId="285597022" sldId="263"/>
            <ac:spMk id="2" creationId="{DFC18942-6A58-244F-19DA-EE3B13EB7419}"/>
          </ac:spMkLst>
        </pc:spChg>
        <pc:spChg chg="mod">
          <ac:chgData name=". ." userId="eae2494d765c5e40" providerId="LiveId" clId="{02AB8F2D-54A3-400B-A344-EF37852B360B}" dt="2025-05-15T00:46:39.815" v="2895" actId="1076"/>
          <ac:spMkLst>
            <pc:docMk/>
            <pc:sldMk cId="285597022" sldId="263"/>
            <ac:spMk id="4" creationId="{1BE06767-31C8-0BA8-EEA0-4FE2EB057C39}"/>
          </ac:spMkLst>
        </pc:spChg>
        <pc:spChg chg="mod">
          <ac:chgData name=". ." userId="eae2494d765c5e40" providerId="LiveId" clId="{02AB8F2D-54A3-400B-A344-EF37852B360B}" dt="2025-05-14T02:14:23.326" v="2187" actId="1036"/>
          <ac:spMkLst>
            <pc:docMk/>
            <pc:sldMk cId="285597022" sldId="263"/>
            <ac:spMk id="5" creationId="{D606255E-0C41-895B-7798-EEE1D28B721F}"/>
          </ac:spMkLst>
        </pc:spChg>
        <pc:spChg chg="add mod topLvl">
          <ac:chgData name=". ." userId="eae2494d765c5e40" providerId="LiveId" clId="{02AB8F2D-54A3-400B-A344-EF37852B360B}" dt="2025-05-14T22:31:32.249" v="2861" actId="164"/>
          <ac:spMkLst>
            <pc:docMk/>
            <pc:sldMk cId="285597022" sldId="263"/>
            <ac:spMk id="6" creationId="{DD106E48-A932-769A-5199-C587849E759C}"/>
          </ac:spMkLst>
        </pc:spChg>
        <pc:spChg chg="add mod topLvl">
          <ac:chgData name=". ." userId="eae2494d765c5e40" providerId="LiveId" clId="{02AB8F2D-54A3-400B-A344-EF37852B360B}" dt="2025-05-14T22:31:32.249" v="2861" actId="164"/>
          <ac:spMkLst>
            <pc:docMk/>
            <pc:sldMk cId="285597022" sldId="263"/>
            <ac:spMk id="7" creationId="{EC7D7A26-8D78-14C6-6891-4A9FDD99E9F7}"/>
          </ac:spMkLst>
        </pc:spChg>
        <pc:spChg chg="mod">
          <ac:chgData name=". ." userId="eae2494d765c5e40" providerId="LiveId" clId="{02AB8F2D-54A3-400B-A344-EF37852B360B}" dt="2025-05-14T02:14:23.326" v="2187" actId="1036"/>
          <ac:spMkLst>
            <pc:docMk/>
            <pc:sldMk cId="285597022" sldId="263"/>
            <ac:spMk id="8" creationId="{78F822B4-A62C-F742-D4D4-89E0C69037F1}"/>
          </ac:spMkLst>
        </pc:spChg>
        <pc:spChg chg="add mod topLvl">
          <ac:chgData name=". ." userId="eae2494d765c5e40" providerId="LiveId" clId="{02AB8F2D-54A3-400B-A344-EF37852B360B}" dt="2025-05-14T22:31:32.249" v="2861" actId="164"/>
          <ac:spMkLst>
            <pc:docMk/>
            <pc:sldMk cId="285597022" sldId="263"/>
            <ac:spMk id="9" creationId="{345DA925-12C1-953B-2957-E559CC5F23C3}"/>
          </ac:spMkLst>
        </pc:spChg>
        <pc:spChg chg="add del mod">
          <ac:chgData name=". ." userId="eae2494d765c5e40" providerId="LiveId" clId="{02AB8F2D-54A3-400B-A344-EF37852B360B}" dt="2025-05-14T02:04:03.413" v="2090" actId="478"/>
          <ac:spMkLst>
            <pc:docMk/>
            <pc:sldMk cId="285597022" sldId="263"/>
            <ac:spMk id="10" creationId="{687977CE-AA38-1C7A-D768-3BC2533E81EC}"/>
          </ac:spMkLst>
        </pc:spChg>
        <pc:spChg chg="add mod topLvl">
          <ac:chgData name=". ." userId="eae2494d765c5e40" providerId="LiveId" clId="{02AB8F2D-54A3-400B-A344-EF37852B360B}" dt="2025-05-14T22:34:27.303" v="2880" actId="164"/>
          <ac:spMkLst>
            <pc:docMk/>
            <pc:sldMk cId="285597022" sldId="263"/>
            <ac:spMk id="12" creationId="{E3C031C0-EB62-6E1D-17C1-13BEAC736929}"/>
          </ac:spMkLst>
        </pc:spChg>
        <pc:spChg chg="add mod topLvl">
          <ac:chgData name=". ." userId="eae2494d765c5e40" providerId="LiveId" clId="{02AB8F2D-54A3-400B-A344-EF37852B360B}" dt="2025-05-14T22:34:27.303" v="2880" actId="164"/>
          <ac:spMkLst>
            <pc:docMk/>
            <pc:sldMk cId="285597022" sldId="263"/>
            <ac:spMk id="13" creationId="{F8DE5034-D7FB-0E12-2D68-3843419BA8BE}"/>
          </ac:spMkLst>
        </pc:spChg>
        <pc:spChg chg="add mod topLvl">
          <ac:chgData name=". ." userId="eae2494d765c5e40" providerId="LiveId" clId="{02AB8F2D-54A3-400B-A344-EF37852B360B}" dt="2025-05-14T22:34:27.303" v="2880" actId="164"/>
          <ac:spMkLst>
            <pc:docMk/>
            <pc:sldMk cId="285597022" sldId="263"/>
            <ac:spMk id="14" creationId="{8A6185B5-D82D-5F1A-C70E-28C26078D735}"/>
          </ac:spMkLst>
        </pc:spChg>
        <pc:spChg chg="add mod">
          <ac:chgData name=". ." userId="eae2494d765c5e40" providerId="LiveId" clId="{02AB8F2D-54A3-400B-A344-EF37852B360B}" dt="2025-05-14T02:14:10.923" v="2164"/>
          <ac:spMkLst>
            <pc:docMk/>
            <pc:sldMk cId="285597022" sldId="263"/>
            <ac:spMk id="18" creationId="{E900D8A8-3DA4-AF8F-E80D-73D169F230D5}"/>
          </ac:spMkLst>
        </pc:spChg>
        <pc:spChg chg="add mod">
          <ac:chgData name=". ." userId="eae2494d765c5e40" providerId="LiveId" clId="{02AB8F2D-54A3-400B-A344-EF37852B360B}" dt="2025-05-14T02:14:10.923" v="2164"/>
          <ac:spMkLst>
            <pc:docMk/>
            <pc:sldMk cId="285597022" sldId="263"/>
            <ac:spMk id="19" creationId="{11442D3A-685E-3C20-B399-D159079B759D}"/>
          </ac:spMkLst>
        </pc:spChg>
        <pc:spChg chg="add mod">
          <ac:chgData name=". ." userId="eae2494d765c5e40" providerId="LiveId" clId="{02AB8F2D-54A3-400B-A344-EF37852B360B}" dt="2025-05-14T02:14:10.923" v="2164"/>
          <ac:spMkLst>
            <pc:docMk/>
            <pc:sldMk cId="285597022" sldId="263"/>
            <ac:spMk id="20" creationId="{2C8F6FD9-DE0A-F1A7-8FCA-A8D28FCC381C}"/>
          </ac:spMkLst>
        </pc:spChg>
        <pc:spChg chg="add mod topLvl">
          <ac:chgData name=". ." userId="eae2494d765c5e40" providerId="LiveId" clId="{02AB8F2D-54A3-400B-A344-EF37852B360B}" dt="2025-05-15T00:46:30.556" v="2893" actId="164"/>
          <ac:spMkLst>
            <pc:docMk/>
            <pc:sldMk cId="285597022" sldId="263"/>
            <ac:spMk id="21" creationId="{033219CC-C81C-45DF-3778-9121ADD8303D}"/>
          </ac:spMkLst>
        </pc:spChg>
        <pc:spChg chg="add mod topLvl">
          <ac:chgData name=". ." userId="eae2494d765c5e40" providerId="LiveId" clId="{02AB8F2D-54A3-400B-A344-EF37852B360B}" dt="2025-05-15T00:46:30.556" v="2893" actId="164"/>
          <ac:spMkLst>
            <pc:docMk/>
            <pc:sldMk cId="285597022" sldId="263"/>
            <ac:spMk id="22" creationId="{775B158F-69A6-5FC3-7F40-F737B38ACB4D}"/>
          </ac:spMkLst>
        </pc:spChg>
        <pc:spChg chg="add mod topLvl">
          <ac:chgData name=". ." userId="eae2494d765c5e40" providerId="LiveId" clId="{02AB8F2D-54A3-400B-A344-EF37852B360B}" dt="2025-05-15T00:46:30.556" v="2893" actId="164"/>
          <ac:spMkLst>
            <pc:docMk/>
            <pc:sldMk cId="285597022" sldId="263"/>
            <ac:spMk id="23" creationId="{5D3E9073-B541-556C-40B1-B8D4E3BB1D42}"/>
          </ac:spMkLst>
        </pc:spChg>
        <pc:spChg chg="add mod topLvl">
          <ac:chgData name=". ." userId="eae2494d765c5e40" providerId="LiveId" clId="{02AB8F2D-54A3-400B-A344-EF37852B360B}" dt="2025-05-15T00:50:32.376" v="2909" actId="164"/>
          <ac:spMkLst>
            <pc:docMk/>
            <pc:sldMk cId="285597022" sldId="263"/>
            <ac:spMk id="26" creationId="{125C6915-48CC-23EA-B649-ED7DF1FA29C6}"/>
          </ac:spMkLst>
        </pc:spChg>
        <pc:spChg chg="add mod topLvl">
          <ac:chgData name=". ." userId="eae2494d765c5e40" providerId="LiveId" clId="{02AB8F2D-54A3-400B-A344-EF37852B360B}" dt="2025-05-15T00:50:32.376" v="2909" actId="164"/>
          <ac:spMkLst>
            <pc:docMk/>
            <pc:sldMk cId="285597022" sldId="263"/>
            <ac:spMk id="27" creationId="{69FEE923-6E70-F354-C499-241CD633AA1A}"/>
          </ac:spMkLst>
        </pc:spChg>
        <pc:spChg chg="add mod topLvl">
          <ac:chgData name=". ." userId="eae2494d765c5e40" providerId="LiveId" clId="{02AB8F2D-54A3-400B-A344-EF37852B360B}" dt="2025-05-15T00:50:32.376" v="2909" actId="164"/>
          <ac:spMkLst>
            <pc:docMk/>
            <pc:sldMk cId="285597022" sldId="263"/>
            <ac:spMk id="28" creationId="{94DAD3BE-5D55-0066-47A5-4953AE312E09}"/>
          </ac:spMkLst>
        </pc:spChg>
        <pc:spChg chg="mod">
          <ac:chgData name=". ." userId="eae2494d765c5e40" providerId="LiveId" clId="{02AB8F2D-54A3-400B-A344-EF37852B360B}" dt="2025-05-14T02:14:23.326" v="2187" actId="1036"/>
          <ac:spMkLst>
            <pc:docMk/>
            <pc:sldMk cId="285597022" sldId="263"/>
            <ac:spMk id="96" creationId="{509967B6-DE41-783E-4D7B-30F38E803053}"/>
          </ac:spMkLst>
        </pc:spChg>
        <pc:spChg chg="mod">
          <ac:chgData name=". ." userId="eae2494d765c5e40" providerId="LiveId" clId="{02AB8F2D-54A3-400B-A344-EF37852B360B}" dt="2025-05-14T02:14:23.326" v="2187" actId="1036"/>
          <ac:spMkLst>
            <pc:docMk/>
            <pc:sldMk cId="285597022" sldId="263"/>
            <ac:spMk id="97" creationId="{E9E62269-CEDC-59D6-DD2D-BAD197E6DE84}"/>
          </ac:spMkLst>
        </pc:spChg>
        <pc:grpChg chg="add mod">
          <ac:chgData name=". ." userId="eae2494d765c5e40" providerId="LiveId" clId="{02AB8F2D-54A3-400B-A344-EF37852B360B}" dt="2025-05-15T00:46:30.556" v="2893" actId="164"/>
          <ac:grpSpMkLst>
            <pc:docMk/>
            <pc:sldMk cId="285597022" sldId="263"/>
            <ac:grpSpMk id="11" creationId="{35B00BDA-1272-0604-09EB-C7780D5260AA}"/>
          </ac:grpSpMkLst>
        </pc:grpChg>
        <pc:grpChg chg="add del mod">
          <ac:chgData name=". ." userId="eae2494d765c5e40" providerId="LiveId" clId="{02AB8F2D-54A3-400B-A344-EF37852B360B}" dt="2025-05-14T22:30:36.585" v="2843" actId="165"/>
          <ac:grpSpMkLst>
            <pc:docMk/>
            <pc:sldMk cId="285597022" sldId="263"/>
            <ac:grpSpMk id="15" creationId="{35921172-019F-0851-407E-0B699B22FA71}"/>
          </ac:grpSpMkLst>
        </pc:grpChg>
        <pc:grpChg chg="add mod">
          <ac:chgData name=". ." userId="eae2494d765c5e40" providerId="LiveId" clId="{02AB8F2D-54A3-400B-A344-EF37852B360B}" dt="2025-05-15T00:50:32.376" v="2909" actId="164"/>
          <ac:grpSpMkLst>
            <pc:docMk/>
            <pc:sldMk cId="285597022" sldId="263"/>
            <ac:grpSpMk id="16" creationId="{B13D1367-72E0-18BC-16EB-978AAF2B20F2}"/>
          </ac:grpSpMkLst>
        </pc:grpChg>
        <pc:grpChg chg="add del mod">
          <ac:chgData name=". ." userId="eae2494d765c5e40" providerId="LiveId" clId="{02AB8F2D-54A3-400B-A344-EF37852B360B}" dt="2025-05-14T22:30:36.038" v="2842" actId="165"/>
          <ac:grpSpMkLst>
            <pc:docMk/>
            <pc:sldMk cId="285597022" sldId="263"/>
            <ac:grpSpMk id="16" creationId="{D774D001-7EA1-2F07-D05D-408CCCB6F491}"/>
          </ac:grpSpMkLst>
        </pc:grpChg>
        <pc:grpChg chg="add mod">
          <ac:chgData name=". ." userId="eae2494d765c5e40" providerId="LiveId" clId="{02AB8F2D-54A3-400B-A344-EF37852B360B}" dt="2025-05-14T22:31:32.249" v="2861" actId="164"/>
          <ac:grpSpMkLst>
            <pc:docMk/>
            <pc:sldMk cId="285597022" sldId="263"/>
            <ac:grpSpMk id="18" creationId="{A9791FDD-5A38-F965-25B5-CD6426B310C5}"/>
          </ac:grpSpMkLst>
        </pc:grpChg>
        <pc:grpChg chg="add mod">
          <ac:chgData name=". ." userId="eae2494d765c5e40" providerId="LiveId" clId="{02AB8F2D-54A3-400B-A344-EF37852B360B}" dt="2025-05-14T22:34:27.303" v="2880" actId="164"/>
          <ac:grpSpMkLst>
            <pc:docMk/>
            <pc:sldMk cId="285597022" sldId="263"/>
            <ac:grpSpMk id="20" creationId="{82D536DA-819E-C157-A1D9-EAB52BA68ECF}"/>
          </ac:grpSpMkLst>
        </pc:grpChg>
        <pc:grpChg chg="add del mod">
          <ac:chgData name=". ." userId="eae2494d765c5e40" providerId="LiveId" clId="{02AB8F2D-54A3-400B-A344-EF37852B360B}" dt="2025-05-14T22:30:37.672" v="2845" actId="165"/>
          <ac:grpSpMkLst>
            <pc:docMk/>
            <pc:sldMk cId="285597022" sldId="263"/>
            <ac:grpSpMk id="24" creationId="{0BC1A50C-476D-7831-9008-2615FF0D8E0B}"/>
          </ac:grpSpMkLst>
        </pc:grpChg>
        <pc:grpChg chg="add del mod">
          <ac:chgData name=". ." userId="eae2494d765c5e40" providerId="LiveId" clId="{02AB8F2D-54A3-400B-A344-EF37852B360B}" dt="2025-05-14T22:30:37.136" v="2844" actId="165"/>
          <ac:grpSpMkLst>
            <pc:docMk/>
            <pc:sldMk cId="285597022" sldId="263"/>
            <ac:grpSpMk id="29" creationId="{FF0F702A-17C4-CD38-BFB6-A1A3BB1B0B11}"/>
          </ac:grpSpMkLst>
        </pc:grpChg>
        <pc:graphicFrameChg chg="add mod">
          <ac:chgData name=". ." userId="eae2494d765c5e40" providerId="LiveId" clId="{02AB8F2D-54A3-400B-A344-EF37852B360B}" dt="2025-05-15T00:46:30.556" v="2893" actId="164"/>
          <ac:graphicFrameMkLst>
            <pc:docMk/>
            <pc:sldMk cId="285597022" sldId="263"/>
            <ac:graphicFrameMk id="3" creationId="{B049E763-CF50-434D-255C-0DE8B065CB2A}"/>
          </ac:graphicFrameMkLst>
        </pc:graphicFrameChg>
        <pc:graphicFrameChg chg="add del mod topLvl">
          <ac:chgData name=". ." userId="eae2494d765c5e40" providerId="LiveId" clId="{02AB8F2D-54A3-400B-A344-EF37852B360B}" dt="2025-05-14T22:31:02.323" v="2848" actId="478"/>
          <ac:graphicFrameMkLst>
            <pc:docMk/>
            <pc:sldMk cId="285597022" sldId="263"/>
            <ac:graphicFrameMk id="3" creationId="{B81A12A0-DCE2-D142-9D25-BFCF33F75747}"/>
          </ac:graphicFrameMkLst>
        </pc:graphicFrameChg>
        <pc:graphicFrameChg chg="add mod">
          <ac:chgData name=". ." userId="eae2494d765c5e40" providerId="LiveId" clId="{02AB8F2D-54A3-400B-A344-EF37852B360B}" dt="2025-05-14T22:31:32.249" v="2861" actId="164"/>
          <ac:graphicFrameMkLst>
            <pc:docMk/>
            <pc:sldMk cId="285597022" sldId="263"/>
            <ac:graphicFrameMk id="10" creationId="{3727924E-C036-2800-9EB3-2EF9A32E6B17}"/>
          </ac:graphicFrameMkLst>
        </pc:graphicFrameChg>
        <pc:graphicFrameChg chg="add del mod topLvl">
          <ac:chgData name=". ." userId="eae2494d765c5e40" providerId="LiveId" clId="{02AB8F2D-54A3-400B-A344-EF37852B360B}" dt="2025-05-14T22:34:09.243" v="2865" actId="478"/>
          <ac:graphicFrameMkLst>
            <pc:docMk/>
            <pc:sldMk cId="285597022" sldId="263"/>
            <ac:graphicFrameMk id="11" creationId="{74312CE9-F8D2-2770-8715-579B15A1CD60}"/>
          </ac:graphicFrameMkLst>
        </pc:graphicFrameChg>
        <pc:graphicFrameChg chg="add mod">
          <ac:chgData name=". ." userId="eae2494d765c5e40" providerId="LiveId" clId="{02AB8F2D-54A3-400B-A344-EF37852B360B}" dt="2025-05-15T00:50:32.376" v="2909" actId="164"/>
          <ac:graphicFrameMkLst>
            <pc:docMk/>
            <pc:sldMk cId="285597022" sldId="263"/>
            <ac:graphicFrameMk id="15" creationId="{A09DCA0E-163F-E9EC-EE94-66F62CEC598A}"/>
          </ac:graphicFrameMkLst>
        </pc:graphicFrameChg>
        <pc:graphicFrameChg chg="add del mod topLvl">
          <ac:chgData name=". ." userId="eae2494d765c5e40" providerId="LiveId" clId="{02AB8F2D-54A3-400B-A344-EF37852B360B}" dt="2025-05-15T00:46:14.153" v="2885" actId="478"/>
          <ac:graphicFrameMkLst>
            <pc:docMk/>
            <pc:sldMk cId="285597022" sldId="263"/>
            <ac:graphicFrameMk id="17" creationId="{DF2C88CE-27F1-D40E-49C2-31A9886E4CA0}"/>
          </ac:graphicFrameMkLst>
        </pc:graphicFrameChg>
        <pc:graphicFrameChg chg="add mod">
          <ac:chgData name=". ." userId="eae2494d765c5e40" providerId="LiveId" clId="{02AB8F2D-54A3-400B-A344-EF37852B360B}" dt="2025-05-14T22:34:27.303" v="2880" actId="164"/>
          <ac:graphicFrameMkLst>
            <pc:docMk/>
            <pc:sldMk cId="285597022" sldId="263"/>
            <ac:graphicFrameMk id="19" creationId="{7E01D9FE-B82F-BD75-B874-5C8B733D5CBB}"/>
          </ac:graphicFrameMkLst>
        </pc:graphicFrameChg>
        <pc:graphicFrameChg chg="add del mod topLvl">
          <ac:chgData name=". ." userId="eae2494d765c5e40" providerId="LiveId" clId="{02AB8F2D-54A3-400B-A344-EF37852B360B}" dt="2025-05-15T00:50:18.344" v="2900" actId="478"/>
          <ac:graphicFrameMkLst>
            <pc:docMk/>
            <pc:sldMk cId="285597022" sldId="263"/>
            <ac:graphicFrameMk id="25" creationId="{D76D7124-E7DF-402C-48AD-C45DD0669C01}"/>
          </ac:graphicFrameMkLst>
        </pc:graphicFrameChg>
      </pc:sldChg>
      <pc:sldChg chg="addSp delSp modSp add mod">
        <pc:chgData name=". ." userId="eae2494d765c5e40" providerId="LiveId" clId="{02AB8F2D-54A3-400B-A344-EF37852B360B}" dt="2025-05-15T03:59:42.772" v="2976" actId="164"/>
        <pc:sldMkLst>
          <pc:docMk/>
          <pc:sldMk cId="262983959" sldId="264"/>
        </pc:sldMkLst>
        <pc:spChg chg="add mod">
          <ac:chgData name=". ." userId="eae2494d765c5e40" providerId="LiveId" clId="{02AB8F2D-54A3-400B-A344-EF37852B360B}" dt="2025-05-14T02:27:25.346" v="2219" actId="20577"/>
          <ac:spMkLst>
            <pc:docMk/>
            <pc:sldMk cId="262983959" sldId="264"/>
            <ac:spMk id="2" creationId="{3CD758E6-CC0A-C043-A8AE-63D1AF4DF243}"/>
          </ac:spMkLst>
        </pc:spChg>
        <pc:spChg chg="mod">
          <ac:chgData name=". ." userId="eae2494d765c5e40" providerId="LiveId" clId="{02AB8F2D-54A3-400B-A344-EF37852B360B}" dt="2025-05-15T00:50:39.964" v="2911" actId="1076"/>
          <ac:spMkLst>
            <pc:docMk/>
            <pc:sldMk cId="262983959" sldId="264"/>
            <ac:spMk id="4" creationId="{1FE0FEE1-5153-F15E-5939-A3B5B9E25173}"/>
          </ac:spMkLst>
        </pc:spChg>
        <pc:spChg chg="add mod topLvl">
          <ac:chgData name=". ." userId="eae2494d765c5e40" providerId="LiveId" clId="{02AB8F2D-54A3-400B-A344-EF37852B360B}" dt="2025-05-15T03:50:20.590" v="2946" actId="164"/>
          <ac:spMkLst>
            <pc:docMk/>
            <pc:sldMk cId="262983959" sldId="264"/>
            <ac:spMk id="5" creationId="{C47F4F0E-6FD4-ADAB-2DD3-7823CDAE3B36}"/>
          </ac:spMkLst>
        </pc:spChg>
        <pc:spChg chg="add mod topLvl">
          <ac:chgData name=". ." userId="eae2494d765c5e40" providerId="LiveId" clId="{02AB8F2D-54A3-400B-A344-EF37852B360B}" dt="2025-05-15T03:50:20.590" v="2946" actId="164"/>
          <ac:spMkLst>
            <pc:docMk/>
            <pc:sldMk cId="262983959" sldId="264"/>
            <ac:spMk id="6" creationId="{4F2C1910-A51B-C5D2-E8A6-94182E402D5D}"/>
          </ac:spMkLst>
        </pc:spChg>
        <pc:spChg chg="add mod topLvl">
          <ac:chgData name=". ." userId="eae2494d765c5e40" providerId="LiveId" clId="{02AB8F2D-54A3-400B-A344-EF37852B360B}" dt="2025-05-15T03:50:20.590" v="2946" actId="164"/>
          <ac:spMkLst>
            <pc:docMk/>
            <pc:sldMk cId="262983959" sldId="264"/>
            <ac:spMk id="7" creationId="{C9312439-9121-D63B-1407-1461AC57C82A}"/>
          </ac:spMkLst>
        </pc:spChg>
        <pc:spChg chg="add mod topLvl">
          <ac:chgData name=". ." userId="eae2494d765c5e40" providerId="LiveId" clId="{02AB8F2D-54A3-400B-A344-EF37852B360B}" dt="2025-05-15T03:50:20.590" v="2946" actId="164"/>
          <ac:spMkLst>
            <pc:docMk/>
            <pc:sldMk cId="262983959" sldId="264"/>
            <ac:spMk id="8" creationId="{CC1E794B-A2BA-7FEA-4602-A9CAC233CAC1}"/>
          </ac:spMkLst>
        </pc:spChg>
        <pc:spChg chg="add mod topLvl">
          <ac:chgData name=". ." userId="eae2494d765c5e40" providerId="LiveId" clId="{02AB8F2D-54A3-400B-A344-EF37852B360B}" dt="2025-05-15T03:50:20.590" v="2946" actId="164"/>
          <ac:spMkLst>
            <pc:docMk/>
            <pc:sldMk cId="262983959" sldId="264"/>
            <ac:spMk id="9" creationId="{C499039F-C4D9-A7E1-C3B7-B372135C69D3}"/>
          </ac:spMkLst>
        </pc:spChg>
        <pc:spChg chg="add mod topLvl">
          <ac:chgData name=". ." userId="eae2494d765c5e40" providerId="LiveId" clId="{02AB8F2D-54A3-400B-A344-EF37852B360B}" dt="2025-05-15T03:50:20.590" v="2946" actId="164"/>
          <ac:spMkLst>
            <pc:docMk/>
            <pc:sldMk cId="262983959" sldId="264"/>
            <ac:spMk id="10" creationId="{14D0A1CD-B61A-B4CF-3EF8-4756F80EE5F9}"/>
          </ac:spMkLst>
        </pc:spChg>
        <pc:spChg chg="add mod topLvl">
          <ac:chgData name=". ." userId="eae2494d765c5e40" providerId="LiveId" clId="{02AB8F2D-54A3-400B-A344-EF37852B360B}" dt="2025-05-15T03:59:42.772" v="2976" actId="164"/>
          <ac:spMkLst>
            <pc:docMk/>
            <pc:sldMk cId="262983959" sldId="264"/>
            <ac:spMk id="12" creationId="{EEB7DFA8-2E33-D6F3-56A9-DE54A0BD6100}"/>
          </ac:spMkLst>
        </pc:spChg>
        <pc:spChg chg="add mod topLvl">
          <ac:chgData name=". ." userId="eae2494d765c5e40" providerId="LiveId" clId="{02AB8F2D-54A3-400B-A344-EF37852B360B}" dt="2025-05-15T03:59:42.772" v="2976" actId="164"/>
          <ac:spMkLst>
            <pc:docMk/>
            <pc:sldMk cId="262983959" sldId="264"/>
            <ac:spMk id="13" creationId="{8FF2FC70-5236-23C1-C2CC-95076F579D47}"/>
          </ac:spMkLst>
        </pc:spChg>
        <pc:spChg chg="mod">
          <ac:chgData name=". ." userId="eae2494d765c5e40" providerId="LiveId" clId="{02AB8F2D-54A3-400B-A344-EF37852B360B}" dt="2025-05-14T04:21:12.191" v="2372" actId="1036"/>
          <ac:spMkLst>
            <pc:docMk/>
            <pc:sldMk cId="262983959" sldId="264"/>
            <ac:spMk id="96" creationId="{C1390B71-A785-7A72-9DE3-C7D08C9FC27F}"/>
          </ac:spMkLst>
        </pc:spChg>
        <pc:spChg chg="mod">
          <ac:chgData name=". ." userId="eae2494d765c5e40" providerId="LiveId" clId="{02AB8F2D-54A3-400B-A344-EF37852B360B}" dt="2025-05-15T03:50:00.161" v="2938" actId="1036"/>
          <ac:spMkLst>
            <pc:docMk/>
            <pc:sldMk cId="262983959" sldId="264"/>
            <ac:spMk id="97" creationId="{B466D09C-8CA7-DD7D-9211-F19AC799F550}"/>
          </ac:spMkLst>
        </pc:spChg>
        <pc:grpChg chg="add del mod">
          <ac:chgData name=". ." userId="eae2494d765c5e40" providerId="LiveId" clId="{02AB8F2D-54A3-400B-A344-EF37852B360B}" dt="2025-05-15T01:32:10.342" v="2915" actId="165"/>
          <ac:grpSpMkLst>
            <pc:docMk/>
            <pc:sldMk cId="262983959" sldId="264"/>
            <ac:grpSpMk id="11" creationId="{ECAE4B83-89DB-0BAC-985D-9767779D22C9}"/>
          </ac:grpSpMkLst>
        </pc:grpChg>
        <pc:grpChg chg="add del mod">
          <ac:chgData name=". ." userId="eae2494d765c5e40" providerId="LiveId" clId="{02AB8F2D-54A3-400B-A344-EF37852B360B}" dt="2025-05-15T01:32:10.983" v="2916" actId="165"/>
          <ac:grpSpMkLst>
            <pc:docMk/>
            <pc:sldMk cId="262983959" sldId="264"/>
            <ac:grpSpMk id="15" creationId="{BCB6C874-0BC9-099F-7AFF-97450146216F}"/>
          </ac:grpSpMkLst>
        </pc:grpChg>
        <pc:grpChg chg="add mod">
          <ac:chgData name=". ." userId="eae2494d765c5e40" providerId="LiveId" clId="{02AB8F2D-54A3-400B-A344-EF37852B360B}" dt="2025-05-15T03:50:20.590" v="2946" actId="164"/>
          <ac:grpSpMkLst>
            <pc:docMk/>
            <pc:sldMk cId="262983959" sldId="264"/>
            <ac:grpSpMk id="17" creationId="{510FBAD1-DD92-8C66-D9FC-287227762D40}"/>
          </ac:grpSpMkLst>
        </pc:grpChg>
        <pc:grpChg chg="add mod">
          <ac:chgData name=". ." userId="eae2494d765c5e40" providerId="LiveId" clId="{02AB8F2D-54A3-400B-A344-EF37852B360B}" dt="2025-05-15T03:59:42.772" v="2976" actId="164"/>
          <ac:grpSpMkLst>
            <pc:docMk/>
            <pc:sldMk cId="262983959" sldId="264"/>
            <ac:grpSpMk id="19" creationId="{1404D1DC-07BF-76CA-765C-05D53F505B65}"/>
          </ac:grpSpMkLst>
        </pc:grpChg>
        <pc:graphicFrameChg chg="add del mod topLvl">
          <ac:chgData name=". ." userId="eae2494d765c5e40" providerId="LiveId" clId="{02AB8F2D-54A3-400B-A344-EF37852B360B}" dt="2025-05-15T03:49:46.609" v="2920" actId="478"/>
          <ac:graphicFrameMkLst>
            <pc:docMk/>
            <pc:sldMk cId="262983959" sldId="264"/>
            <ac:graphicFrameMk id="3" creationId="{718C7F53-0876-8EFA-E617-1FBC1B6E7BE6}"/>
          </ac:graphicFrameMkLst>
        </pc:graphicFrameChg>
        <pc:graphicFrameChg chg="add del mod topLvl">
          <ac:chgData name=". ." userId="eae2494d765c5e40" providerId="LiveId" clId="{02AB8F2D-54A3-400B-A344-EF37852B360B}" dt="2025-05-15T03:59:15.814" v="2951" actId="478"/>
          <ac:graphicFrameMkLst>
            <pc:docMk/>
            <pc:sldMk cId="262983959" sldId="264"/>
            <ac:graphicFrameMk id="14" creationId="{EADD029D-53DC-BF08-E95A-AC37F40F168E}"/>
          </ac:graphicFrameMkLst>
        </pc:graphicFrameChg>
        <pc:graphicFrameChg chg="add mod">
          <ac:chgData name=". ." userId="eae2494d765c5e40" providerId="LiveId" clId="{02AB8F2D-54A3-400B-A344-EF37852B360B}" dt="2025-05-15T03:50:20.590" v="2946" actId="164"/>
          <ac:graphicFrameMkLst>
            <pc:docMk/>
            <pc:sldMk cId="262983959" sldId="264"/>
            <ac:graphicFrameMk id="16" creationId="{2FE7AE23-8559-2EA0-2DD3-3D57A4D9E88B}"/>
          </ac:graphicFrameMkLst>
        </pc:graphicFrameChg>
        <pc:graphicFrameChg chg="add mod">
          <ac:chgData name=". ." userId="eae2494d765c5e40" providerId="LiveId" clId="{02AB8F2D-54A3-400B-A344-EF37852B360B}" dt="2025-05-15T03:59:42.772" v="2976" actId="164"/>
          <ac:graphicFrameMkLst>
            <pc:docMk/>
            <pc:sldMk cId="262983959" sldId="264"/>
            <ac:graphicFrameMk id="18" creationId="{BC02A363-2A0B-9DB5-DBE0-3A2D37AA403E}"/>
          </ac:graphicFrameMkLst>
        </pc:graphicFrameChg>
      </pc:sldChg>
      <pc:sldChg chg="addSp delSp modSp add mod">
        <pc:chgData name=". ." userId="eae2494d765c5e40" providerId="LiveId" clId="{02AB8F2D-54A3-400B-A344-EF37852B360B}" dt="2025-05-14T10:06:51.024" v="2840" actId="164"/>
        <pc:sldMkLst>
          <pc:docMk/>
          <pc:sldMk cId="368040849" sldId="265"/>
        </pc:sldMkLst>
        <pc:spChg chg="mod">
          <ac:chgData name=". ." userId="eae2494d765c5e40" providerId="LiveId" clId="{02AB8F2D-54A3-400B-A344-EF37852B360B}" dt="2025-05-14T08:56:42.123" v="2609" actId="1076"/>
          <ac:spMkLst>
            <pc:docMk/>
            <pc:sldMk cId="368040849" sldId="265"/>
            <ac:spMk id="4" creationId="{3D81B343-E128-D6D6-BFEE-8264910A12D1}"/>
          </ac:spMkLst>
        </pc:spChg>
        <pc:spChg chg="mod">
          <ac:chgData name=". ." userId="eae2494d765c5e40" providerId="LiveId" clId="{02AB8F2D-54A3-400B-A344-EF37852B360B}" dt="2025-05-14T01:43:17.145" v="2033" actId="1076"/>
          <ac:spMkLst>
            <pc:docMk/>
            <pc:sldMk cId="368040849" sldId="265"/>
            <ac:spMk id="7" creationId="{EAA613FC-1795-5636-5F80-8C6A67E85A9F}"/>
          </ac:spMkLst>
        </pc:spChg>
        <pc:spChg chg="add mod">
          <ac:chgData name=". ." userId="eae2494d765c5e40" providerId="LiveId" clId="{02AB8F2D-54A3-400B-A344-EF37852B360B}" dt="2025-05-14T09:58:10.606" v="2746" actId="1076"/>
          <ac:spMkLst>
            <pc:docMk/>
            <pc:sldMk cId="368040849" sldId="265"/>
            <ac:spMk id="9" creationId="{577C761E-E8C4-16B9-AF79-68A5B9B1274D}"/>
          </ac:spMkLst>
        </pc:spChg>
        <pc:spChg chg="add mod">
          <ac:chgData name=". ." userId="eae2494d765c5e40" providerId="LiveId" clId="{02AB8F2D-54A3-400B-A344-EF37852B360B}" dt="2025-05-14T09:58:14.018" v="2747" actId="1076"/>
          <ac:spMkLst>
            <pc:docMk/>
            <pc:sldMk cId="368040849" sldId="265"/>
            <ac:spMk id="10" creationId="{482A1E52-1B8C-238F-26B4-D3CD0694491D}"/>
          </ac:spMkLst>
        </pc:spChg>
        <pc:spChg chg="add mod topLvl">
          <ac:chgData name=". ." userId="eae2494d765c5e40" providerId="LiveId" clId="{02AB8F2D-54A3-400B-A344-EF37852B360B}" dt="2025-05-14T10:02:40.931" v="2793" actId="164"/>
          <ac:spMkLst>
            <pc:docMk/>
            <pc:sldMk cId="368040849" sldId="265"/>
            <ac:spMk id="12" creationId="{461D390B-FEBF-B4FA-7D0C-84041FDCC3B0}"/>
          </ac:spMkLst>
        </pc:spChg>
        <pc:spChg chg="add mod topLvl">
          <ac:chgData name=". ." userId="eae2494d765c5e40" providerId="LiveId" clId="{02AB8F2D-54A3-400B-A344-EF37852B360B}" dt="2025-05-14T10:02:40.931" v="2793" actId="164"/>
          <ac:spMkLst>
            <pc:docMk/>
            <pc:sldMk cId="368040849" sldId="265"/>
            <ac:spMk id="13" creationId="{5D1FBC11-5D24-A1F8-7A42-9DA739A3231C}"/>
          </ac:spMkLst>
        </pc:spChg>
        <pc:spChg chg="add mod topLvl">
          <ac:chgData name=". ." userId="eae2494d765c5e40" providerId="LiveId" clId="{02AB8F2D-54A3-400B-A344-EF37852B360B}" dt="2025-05-14T10:02:40.931" v="2793" actId="164"/>
          <ac:spMkLst>
            <pc:docMk/>
            <pc:sldMk cId="368040849" sldId="265"/>
            <ac:spMk id="14" creationId="{AA621BA4-097B-6FBB-F404-D1DF83B0E826}"/>
          </ac:spMkLst>
        </pc:spChg>
        <pc:spChg chg="add mod topLvl">
          <ac:chgData name=". ." userId="eae2494d765c5e40" providerId="LiveId" clId="{02AB8F2D-54A3-400B-A344-EF37852B360B}" dt="2025-05-14T10:02:40.931" v="2793" actId="164"/>
          <ac:spMkLst>
            <pc:docMk/>
            <pc:sldMk cId="368040849" sldId="265"/>
            <ac:spMk id="15" creationId="{2EA4317B-7FB2-DFBA-32D3-97719C99874F}"/>
          </ac:spMkLst>
        </pc:spChg>
        <pc:spChg chg="add mod topLvl">
          <ac:chgData name=". ." userId="eae2494d765c5e40" providerId="LiveId" clId="{02AB8F2D-54A3-400B-A344-EF37852B360B}" dt="2025-05-14T10:02:40.931" v="2793" actId="164"/>
          <ac:spMkLst>
            <pc:docMk/>
            <pc:sldMk cId="368040849" sldId="265"/>
            <ac:spMk id="16" creationId="{2C75C8E5-06F4-83BF-D396-490FDDB539F6}"/>
          </ac:spMkLst>
        </pc:spChg>
        <pc:spChg chg="add mod topLvl">
          <ac:chgData name=". ." userId="eae2494d765c5e40" providerId="LiveId" clId="{02AB8F2D-54A3-400B-A344-EF37852B360B}" dt="2025-05-14T10:06:51.024" v="2840" actId="164"/>
          <ac:spMkLst>
            <pc:docMk/>
            <pc:sldMk cId="368040849" sldId="265"/>
            <ac:spMk id="19" creationId="{1AB28654-99F6-8C4F-6CE3-53696D0497A9}"/>
          </ac:spMkLst>
        </pc:spChg>
        <pc:spChg chg="add mod topLvl">
          <ac:chgData name=". ." userId="eae2494d765c5e40" providerId="LiveId" clId="{02AB8F2D-54A3-400B-A344-EF37852B360B}" dt="2025-05-14T10:06:51.024" v="2840" actId="164"/>
          <ac:spMkLst>
            <pc:docMk/>
            <pc:sldMk cId="368040849" sldId="265"/>
            <ac:spMk id="20" creationId="{0A79FC7D-180C-1A85-E23F-921B8D66533E}"/>
          </ac:spMkLst>
        </pc:spChg>
        <pc:spChg chg="add mod topLvl">
          <ac:chgData name=". ." userId="eae2494d765c5e40" providerId="LiveId" clId="{02AB8F2D-54A3-400B-A344-EF37852B360B}" dt="2025-05-14T10:06:51.024" v="2840" actId="164"/>
          <ac:spMkLst>
            <pc:docMk/>
            <pc:sldMk cId="368040849" sldId="265"/>
            <ac:spMk id="21" creationId="{87EF596E-D282-FCF5-BFE1-011FF2B7FE7E}"/>
          </ac:spMkLst>
        </pc:spChg>
        <pc:spChg chg="add mod topLvl">
          <ac:chgData name=". ." userId="eae2494d765c5e40" providerId="LiveId" clId="{02AB8F2D-54A3-400B-A344-EF37852B360B}" dt="2025-05-14T10:06:51.024" v="2840" actId="164"/>
          <ac:spMkLst>
            <pc:docMk/>
            <pc:sldMk cId="368040849" sldId="265"/>
            <ac:spMk id="22" creationId="{C0FD8BBC-A1F0-21FB-9928-8980951DACB5}"/>
          </ac:spMkLst>
        </pc:spChg>
        <pc:grpChg chg="add mod">
          <ac:chgData name=". ." userId="eae2494d765c5e40" providerId="LiveId" clId="{02AB8F2D-54A3-400B-A344-EF37852B360B}" dt="2025-05-14T10:02:42.257" v="2794" actId="1076"/>
          <ac:grpSpMkLst>
            <pc:docMk/>
            <pc:sldMk cId="368040849" sldId="265"/>
            <ac:grpSpMk id="3" creationId="{4BB8E74E-5028-A0C9-9D87-F4885F729786}"/>
          </ac:grpSpMkLst>
        </pc:grpChg>
        <pc:grpChg chg="add mod">
          <ac:chgData name=". ." userId="eae2494d765c5e40" providerId="LiveId" clId="{02AB8F2D-54A3-400B-A344-EF37852B360B}" dt="2025-05-14T10:06:51.024" v="2840" actId="164"/>
          <ac:grpSpMkLst>
            <pc:docMk/>
            <pc:sldMk cId="368040849" sldId="265"/>
            <ac:grpSpMk id="6" creationId="{EA334968-5323-1EFE-A2C0-62279F6B0A6D}"/>
          </ac:grpSpMkLst>
        </pc:grpChg>
        <pc:grpChg chg="add del mod">
          <ac:chgData name=". ." userId="eae2494d765c5e40" providerId="LiveId" clId="{02AB8F2D-54A3-400B-A344-EF37852B360B}" dt="2025-05-14T09:58:03.025" v="2744" actId="165"/>
          <ac:grpSpMkLst>
            <pc:docMk/>
            <pc:sldMk cId="368040849" sldId="265"/>
            <ac:grpSpMk id="17" creationId="{25E2135A-F5BA-538C-EDC3-79D8A302D424}"/>
          </ac:grpSpMkLst>
        </pc:grpChg>
        <pc:grpChg chg="add del mod">
          <ac:chgData name=". ." userId="eae2494d765c5e40" providerId="LiveId" clId="{02AB8F2D-54A3-400B-A344-EF37852B360B}" dt="2025-05-14T09:58:03.739" v="2745" actId="165"/>
          <ac:grpSpMkLst>
            <pc:docMk/>
            <pc:sldMk cId="368040849" sldId="265"/>
            <ac:grpSpMk id="23" creationId="{43D8B9AF-4E66-165D-DEE2-B0A5A3F2A87B}"/>
          </ac:grpSpMkLst>
        </pc:grpChg>
        <pc:graphicFrameChg chg="add mod">
          <ac:chgData name=". ." userId="eae2494d765c5e40" providerId="LiveId" clId="{02AB8F2D-54A3-400B-A344-EF37852B360B}" dt="2025-05-14T10:02:40.931" v="2793" actId="164"/>
          <ac:graphicFrameMkLst>
            <pc:docMk/>
            <pc:sldMk cId="368040849" sldId="265"/>
            <ac:graphicFrameMk id="2" creationId="{6E92B3DA-2B10-21A1-89CE-3571D1B480AE}"/>
          </ac:graphicFrameMkLst>
        </pc:graphicFrameChg>
        <pc:graphicFrameChg chg="add mod">
          <ac:chgData name=". ." userId="eae2494d765c5e40" providerId="LiveId" clId="{02AB8F2D-54A3-400B-A344-EF37852B360B}" dt="2025-05-14T10:06:51.024" v="2840" actId="164"/>
          <ac:graphicFrameMkLst>
            <pc:docMk/>
            <pc:sldMk cId="368040849" sldId="265"/>
            <ac:graphicFrameMk id="5" creationId="{74F1F477-3E8F-BA44-D04B-631B9E221459}"/>
          </ac:graphicFrameMkLst>
        </pc:graphicFrameChg>
        <pc:graphicFrameChg chg="add del mod topLvl">
          <ac:chgData name=". ." userId="eae2494d765c5e40" providerId="LiveId" clId="{02AB8F2D-54A3-400B-A344-EF37852B360B}" dt="2025-05-14T10:02:15.257" v="2750" actId="478"/>
          <ac:graphicFrameMkLst>
            <pc:docMk/>
            <pc:sldMk cId="368040849" sldId="265"/>
            <ac:graphicFrameMk id="11" creationId="{1EF56E57-7B36-30A5-B723-A28981FFA3CF}"/>
          </ac:graphicFrameMkLst>
        </pc:graphicFrameChg>
        <pc:graphicFrameChg chg="add del mod topLvl">
          <ac:chgData name=". ." userId="eae2494d765c5e40" providerId="LiveId" clId="{02AB8F2D-54A3-400B-A344-EF37852B360B}" dt="2025-05-14T10:06:28.656" v="2801" actId="478"/>
          <ac:graphicFrameMkLst>
            <pc:docMk/>
            <pc:sldMk cId="368040849" sldId="265"/>
            <ac:graphicFrameMk id="18" creationId="{722A10C8-FE8B-CA83-FB46-306F1042E1D3}"/>
          </ac:graphicFrameMkLst>
        </pc:graphicFrameChg>
      </pc:sldChg>
    </pc:docChg>
  </pc:docChgLst>
  <pc:docChgLst>
    <pc:chgData name=". ." userId="eae2494d765c5e40" providerId="LiveId" clId="{002A6AFC-E162-495B-A568-E8A8E2C5D5EA}"/>
    <pc:docChg chg="undo custSel addSld delSld modSld">
      <pc:chgData name=". ." userId="eae2494d765c5e40" providerId="LiveId" clId="{002A6AFC-E162-495B-A568-E8A8E2C5D5EA}" dt="2025-04-09T00:45:08.252" v="192" actId="1076"/>
      <pc:docMkLst>
        <pc:docMk/>
      </pc:docMkLst>
      <pc:sldChg chg="addSp delSp modSp mod">
        <pc:chgData name=". ." userId="eae2494d765c5e40" providerId="LiveId" clId="{002A6AFC-E162-495B-A568-E8A8E2C5D5EA}" dt="2025-04-09T00:42:09.171" v="137" actId="1036"/>
        <pc:sldMkLst>
          <pc:docMk/>
          <pc:sldMk cId="1076809069" sldId="258"/>
        </pc:sldMkLst>
      </pc:sldChg>
      <pc:sldChg chg="modSp mod">
        <pc:chgData name=". ." userId="eae2494d765c5e40" providerId="LiveId" clId="{002A6AFC-E162-495B-A568-E8A8E2C5D5EA}" dt="2025-04-09T00:45:08.252" v="192" actId="1076"/>
        <pc:sldMkLst>
          <pc:docMk/>
          <pc:sldMk cId="2189183528" sldId="259"/>
        </pc:sldMkLst>
      </pc:sldChg>
      <pc:sldChg chg="modSp mod">
        <pc:chgData name=". ." userId="eae2494d765c5e40" providerId="LiveId" clId="{002A6AFC-E162-495B-A568-E8A8E2C5D5EA}" dt="2025-04-09T00:44:59.349" v="189" actId="1076"/>
        <pc:sldMkLst>
          <pc:docMk/>
          <pc:sldMk cId="558584970" sldId="260"/>
        </pc:sldMkLst>
      </pc:sldChg>
      <pc:sldChg chg="addSp delSp modSp mod">
        <pc:chgData name=". ." userId="eae2494d765c5e40" providerId="LiveId" clId="{002A6AFC-E162-495B-A568-E8A8E2C5D5EA}" dt="2025-04-09T00:42:18.607" v="138" actId="1076"/>
        <pc:sldMkLst>
          <pc:docMk/>
          <pc:sldMk cId="1986655416" sldId="262"/>
        </pc:sldMkLst>
      </pc:sldChg>
      <pc:sldChg chg="modSp mod">
        <pc:chgData name=". ." userId="eae2494d765c5e40" providerId="LiveId" clId="{002A6AFC-E162-495B-A568-E8A8E2C5D5EA}" dt="2025-04-09T00:44:55.769" v="188" actId="1076"/>
        <pc:sldMkLst>
          <pc:docMk/>
          <pc:sldMk cId="1467653079" sldId="263"/>
        </pc:sldMkLst>
      </pc:sldChg>
      <pc:sldChg chg="del">
        <pc:chgData name=". ." userId="eae2494d765c5e40" providerId="LiveId" clId="{002A6AFC-E162-495B-A568-E8A8E2C5D5EA}" dt="2025-04-07T00:11:15.425" v="4" actId="2696"/>
        <pc:sldMkLst>
          <pc:docMk/>
          <pc:sldMk cId="2939614826" sldId="264"/>
        </pc:sldMkLst>
      </pc:sldChg>
      <pc:sldChg chg="modSp add mod">
        <pc:chgData name=". ." userId="eae2494d765c5e40" providerId="LiveId" clId="{002A6AFC-E162-495B-A568-E8A8E2C5D5EA}" dt="2025-04-09T00:45:05.626" v="191" actId="1076"/>
        <pc:sldMkLst>
          <pc:docMk/>
          <pc:sldMk cId="4163714797" sldId="264"/>
        </pc:sldMkLst>
      </pc:sldChg>
      <pc:sldChg chg="modSp mod">
        <pc:chgData name=". ." userId="eae2494d765c5e40" providerId="LiveId" clId="{002A6AFC-E162-495B-A568-E8A8E2C5D5EA}" dt="2025-04-09T00:45:03.191" v="190" actId="1076"/>
        <pc:sldMkLst>
          <pc:docMk/>
          <pc:sldMk cId="1066340976" sldId="265"/>
        </pc:sldMkLst>
      </pc:sldChg>
    </pc:docChg>
  </pc:docChgLst>
  <pc:docChgLst>
    <pc:chgData name=". ." userId="eae2494d765c5e40" providerId="LiveId" clId="{1129CCB6-27C9-4390-95D2-3DB14E9B4683}"/>
    <pc:docChg chg="undo custSel addSld delSld modSld sldOrd">
      <pc:chgData name=". ." userId="eae2494d765c5e40" providerId="LiveId" clId="{1129CCB6-27C9-4390-95D2-3DB14E9B4683}" dt="2025-03-06T09:47:48.863" v="423"/>
      <pc:docMkLst>
        <pc:docMk/>
      </pc:docMkLst>
      <pc:sldChg chg="addSp delSp modSp mod ord">
        <pc:chgData name=". ." userId="eae2494d765c5e40" providerId="LiveId" clId="{1129CCB6-27C9-4390-95D2-3DB14E9B4683}" dt="2025-03-06T09:47:48.863" v="423"/>
        <pc:sldMkLst>
          <pc:docMk/>
          <pc:sldMk cId="2424892102" sldId="257"/>
        </pc:sldMkLst>
      </pc:sldChg>
      <pc:sldChg chg="addSp delSp modSp mod">
        <pc:chgData name=". ." userId="eae2494d765c5e40" providerId="LiveId" clId="{1129CCB6-27C9-4390-95D2-3DB14E9B4683}" dt="2025-03-06T04:29:16.524" v="104" actId="20577"/>
        <pc:sldMkLst>
          <pc:docMk/>
          <pc:sldMk cId="1076809069" sldId="258"/>
        </pc:sldMkLst>
      </pc:sldChg>
      <pc:sldChg chg="addSp delSp modSp mod">
        <pc:chgData name=". ." userId="eae2494d765c5e40" providerId="LiveId" clId="{1129CCB6-27C9-4390-95D2-3DB14E9B4683}" dt="2025-03-06T09:47:23.238" v="409"/>
        <pc:sldMkLst>
          <pc:docMk/>
          <pc:sldMk cId="2189183528" sldId="259"/>
        </pc:sldMkLst>
      </pc:sldChg>
      <pc:sldChg chg="addSp delSp modSp mod">
        <pc:chgData name=". ." userId="eae2494d765c5e40" providerId="LiveId" clId="{1129CCB6-27C9-4390-95D2-3DB14E9B4683}" dt="2025-03-06T05:01:02.913" v="378"/>
        <pc:sldMkLst>
          <pc:docMk/>
          <pc:sldMk cId="558584970" sldId="260"/>
        </pc:sldMkLst>
      </pc:sldChg>
      <pc:sldChg chg="delSp del mod">
        <pc:chgData name=". ." userId="eae2494d765c5e40" providerId="LiveId" clId="{1129CCB6-27C9-4390-95D2-3DB14E9B4683}" dt="2025-03-05T22:03:31.575" v="38" actId="47"/>
        <pc:sldMkLst>
          <pc:docMk/>
          <pc:sldMk cId="342413545" sldId="261"/>
        </pc:sldMkLst>
      </pc:sldChg>
      <pc:sldChg chg="addSp delSp modSp mod">
        <pc:chgData name=". ." userId="eae2494d765c5e40" providerId="LiveId" clId="{1129CCB6-27C9-4390-95D2-3DB14E9B4683}" dt="2025-03-06T04:29:50.040" v="107" actId="1076"/>
        <pc:sldMkLst>
          <pc:docMk/>
          <pc:sldMk cId="1986655416" sldId="262"/>
        </pc:sldMkLst>
      </pc:sldChg>
      <pc:sldChg chg="addSp delSp modSp mod">
        <pc:chgData name=". ." userId="eae2494d765c5e40" providerId="LiveId" clId="{1129CCB6-27C9-4390-95D2-3DB14E9B4683}" dt="2025-03-06T04:32:09.461" v="108" actId="20577"/>
        <pc:sldMkLst>
          <pc:docMk/>
          <pc:sldMk cId="1467653079" sldId="263"/>
        </pc:sldMkLst>
      </pc:sldChg>
      <pc:sldChg chg="addSp delSp modSp mod ord">
        <pc:chgData name=". ." userId="eae2494d765c5e40" providerId="LiveId" clId="{1129CCB6-27C9-4390-95D2-3DB14E9B4683}" dt="2025-03-06T04:32:18.669" v="110" actId="20577"/>
        <pc:sldMkLst>
          <pc:docMk/>
          <pc:sldMk cId="2939614826" sldId="264"/>
        </pc:sldMkLst>
      </pc:sldChg>
      <pc:sldChg chg="addSp delSp modSp add mod">
        <pc:chgData name=". ." userId="eae2494d765c5e40" providerId="LiveId" clId="{1129CCB6-27C9-4390-95D2-3DB14E9B4683}" dt="2025-03-06T05:02:58.640" v="388" actId="478"/>
        <pc:sldMkLst>
          <pc:docMk/>
          <pc:sldMk cId="1066340976" sldId="265"/>
        </pc:sldMkLst>
      </pc:sldChg>
      <pc:sldChg chg="delSp del mod">
        <pc:chgData name=". ." userId="eae2494d765c5e40" providerId="LiveId" clId="{1129CCB6-27C9-4390-95D2-3DB14E9B4683}" dt="2025-03-05T22:03:31.054" v="37" actId="47"/>
        <pc:sldMkLst>
          <pc:docMk/>
          <pc:sldMk cId="3738287662" sldId="268"/>
        </pc:sldMkLst>
      </pc:sldChg>
    </pc:docChg>
  </pc:docChgLst>
  <pc:docChgLst>
    <pc:chgData name=". ." userId="eae2494d765c5e40" providerId="LiveId" clId="{009F47A8-FDB4-43FC-BDB0-6762BA4A8810}"/>
    <pc:docChg chg="undo redo custSel addSld delSld modSld">
      <pc:chgData name=". ." userId="eae2494d765c5e40" providerId="LiveId" clId="{009F47A8-FDB4-43FC-BDB0-6762BA4A8810}" dt="2025-04-10T02:23:52.640" v="82" actId="1076"/>
      <pc:docMkLst>
        <pc:docMk/>
      </pc:docMkLst>
      <pc:sldChg chg="addSp delSp modSp mod">
        <pc:chgData name=". ." userId="eae2494d765c5e40" providerId="LiveId" clId="{009F47A8-FDB4-43FC-BDB0-6762BA4A8810}" dt="2025-04-10T02:22:37.357" v="68" actId="1076"/>
        <pc:sldMkLst>
          <pc:docMk/>
          <pc:sldMk cId="2424892102" sldId="257"/>
        </pc:sldMkLst>
        <pc:spChg chg="mod">
          <ac:chgData name=". ." userId="eae2494d765c5e40" providerId="LiveId" clId="{009F47A8-FDB4-43FC-BDB0-6762BA4A8810}" dt="2025-04-10T02:20:26.873" v="21" actId="2711"/>
          <ac:spMkLst>
            <pc:docMk/>
            <pc:sldMk cId="2424892102" sldId="257"/>
            <ac:spMk id="2" creationId="{977208FA-24B5-E68F-0680-C6A191A435D2}"/>
          </ac:spMkLst>
        </pc:spChg>
        <pc:spChg chg="add mod">
          <ac:chgData name=". ." userId="eae2494d765c5e40" providerId="LiveId" clId="{009F47A8-FDB4-43FC-BDB0-6762BA4A8810}" dt="2025-04-10T02:22:15.565" v="46" actId="404"/>
          <ac:spMkLst>
            <pc:docMk/>
            <pc:sldMk cId="2424892102" sldId="257"/>
            <ac:spMk id="3" creationId="{69A5C612-5A0E-84F4-7077-D824808AC052}"/>
          </ac:spMkLst>
        </pc:spChg>
        <pc:spChg chg="add mod">
          <ac:chgData name=". ." userId="eae2494d765c5e40" providerId="LiveId" clId="{009F47A8-FDB4-43FC-BDB0-6762BA4A8810}" dt="2025-04-10T02:21:51.036" v="43" actId="1076"/>
          <ac:spMkLst>
            <pc:docMk/>
            <pc:sldMk cId="2424892102" sldId="257"/>
            <ac:spMk id="6" creationId="{FBFE506E-264E-3441-A6EF-C92760ACC3C5}"/>
          </ac:spMkLst>
        </pc:spChg>
      </pc:sldChg>
      <pc:sldChg chg="del">
        <pc:chgData name=". ." userId="eae2494d765c5e40" providerId="LiveId" clId="{009F47A8-FDB4-43FC-BDB0-6762BA4A8810}" dt="2025-04-10T01:51:01.440" v="0" actId="47"/>
        <pc:sldMkLst>
          <pc:docMk/>
          <pc:sldMk cId="1076809069" sldId="258"/>
        </pc:sldMkLst>
      </pc:sldChg>
      <pc:sldChg chg="modSp add mod">
        <pc:chgData name=". ." userId="eae2494d765c5e40" providerId="LiveId" clId="{009F47A8-FDB4-43FC-BDB0-6762BA4A8810}" dt="2025-04-10T02:23:52.640" v="82" actId="1076"/>
        <pc:sldMkLst>
          <pc:docMk/>
          <pc:sldMk cId="2002524046" sldId="258"/>
        </pc:sldMkLst>
        <pc:spChg chg="mod">
          <ac:chgData name=". ." userId="eae2494d765c5e40" providerId="LiveId" clId="{009F47A8-FDB4-43FC-BDB0-6762BA4A8810}" dt="2025-04-10T02:23:52.640" v="82" actId="1076"/>
          <ac:spMkLst>
            <pc:docMk/>
            <pc:sldMk cId="2002524046" sldId="258"/>
            <ac:spMk id="2" creationId="{D541C266-DEDD-7DA6-26A8-B792BDE3C3AF}"/>
          </ac:spMkLst>
        </pc:spChg>
        <pc:spChg chg="mod">
          <ac:chgData name=". ." userId="eae2494d765c5e40" providerId="LiveId" clId="{009F47A8-FDB4-43FC-BDB0-6762BA4A8810}" dt="2025-04-10T02:22:53.902" v="70" actId="1076"/>
          <ac:spMkLst>
            <pc:docMk/>
            <pc:sldMk cId="2002524046" sldId="258"/>
            <ac:spMk id="8" creationId="{277FC240-E73D-6C46-D751-02A2A753CD63}"/>
          </ac:spMkLst>
        </pc:spChg>
        <pc:spChg chg="mod">
          <ac:chgData name=". ." userId="eae2494d765c5e40" providerId="LiveId" clId="{009F47A8-FDB4-43FC-BDB0-6762BA4A8810}" dt="2025-04-10T02:22:53.902" v="70" actId="1076"/>
          <ac:spMkLst>
            <pc:docMk/>
            <pc:sldMk cId="2002524046" sldId="258"/>
            <ac:spMk id="32" creationId="{77288E05-D15B-6173-B89D-8E40C6658879}"/>
          </ac:spMkLst>
        </pc:spChg>
        <pc:spChg chg="mod">
          <ac:chgData name=". ." userId="eae2494d765c5e40" providerId="LiveId" clId="{009F47A8-FDB4-43FC-BDB0-6762BA4A8810}" dt="2025-04-10T02:22:53.902" v="70" actId="1076"/>
          <ac:spMkLst>
            <pc:docMk/>
            <pc:sldMk cId="2002524046" sldId="258"/>
            <ac:spMk id="42" creationId="{692AC6E4-E3EC-542A-CB77-51AB5ACF1DDB}"/>
          </ac:spMkLst>
        </pc:spChg>
        <pc:spChg chg="mod">
          <ac:chgData name=". ." userId="eae2494d765c5e40" providerId="LiveId" clId="{009F47A8-FDB4-43FC-BDB0-6762BA4A8810}" dt="2025-04-10T02:22:53.902" v="70" actId="1076"/>
          <ac:spMkLst>
            <pc:docMk/>
            <pc:sldMk cId="2002524046" sldId="258"/>
            <ac:spMk id="50" creationId="{EB79B53A-94F5-ED36-3410-3A5F5ABE45C6}"/>
          </ac:spMkLst>
        </pc:spChg>
        <pc:spChg chg="mod">
          <ac:chgData name=". ." userId="eae2494d765c5e40" providerId="LiveId" clId="{009F47A8-FDB4-43FC-BDB0-6762BA4A8810}" dt="2025-04-10T02:22:53.902" v="70" actId="1076"/>
          <ac:spMkLst>
            <pc:docMk/>
            <pc:sldMk cId="2002524046" sldId="258"/>
            <ac:spMk id="57" creationId="{22CA3F4F-44B2-C6D1-F108-F8A566B8014E}"/>
          </ac:spMkLst>
        </pc:spChg>
        <pc:spChg chg="mod">
          <ac:chgData name=". ." userId="eae2494d765c5e40" providerId="LiveId" clId="{009F47A8-FDB4-43FC-BDB0-6762BA4A8810}" dt="2025-04-10T02:22:53.902" v="70" actId="1076"/>
          <ac:spMkLst>
            <pc:docMk/>
            <pc:sldMk cId="2002524046" sldId="258"/>
            <ac:spMk id="80" creationId="{40EDB98F-335E-CB4E-4ABB-4E86C7E18FC7}"/>
          </ac:spMkLst>
        </pc:spChg>
        <pc:spChg chg="mod">
          <ac:chgData name=". ." userId="eae2494d765c5e40" providerId="LiveId" clId="{009F47A8-FDB4-43FC-BDB0-6762BA4A8810}" dt="2025-04-10T02:22:53.902" v="70" actId="1076"/>
          <ac:spMkLst>
            <pc:docMk/>
            <pc:sldMk cId="2002524046" sldId="258"/>
            <ac:spMk id="101" creationId="{CF52D1C4-CA08-4AF3-6BBD-9024748DD5CE}"/>
          </ac:spMkLst>
        </pc:spChg>
        <pc:spChg chg="mod">
          <ac:chgData name=". ." userId="eae2494d765c5e40" providerId="LiveId" clId="{009F47A8-FDB4-43FC-BDB0-6762BA4A8810}" dt="2025-04-10T02:22:53.902" v="70" actId="1076"/>
          <ac:spMkLst>
            <pc:docMk/>
            <pc:sldMk cId="2002524046" sldId="258"/>
            <ac:spMk id="103" creationId="{7080DC1F-B3FC-B6B4-167D-ABA801F6EBA2}"/>
          </ac:spMkLst>
        </pc:spChg>
        <pc:spChg chg="mod">
          <ac:chgData name=". ." userId="eae2494d765c5e40" providerId="LiveId" clId="{009F47A8-FDB4-43FC-BDB0-6762BA4A8810}" dt="2025-04-10T02:22:53.902" v="70" actId="1076"/>
          <ac:spMkLst>
            <pc:docMk/>
            <pc:sldMk cId="2002524046" sldId="258"/>
            <ac:spMk id="104" creationId="{EACA5A7A-F401-FD1E-5A94-89DFB080B20C}"/>
          </ac:spMkLst>
        </pc:spChg>
        <pc:spChg chg="mod">
          <ac:chgData name=". ." userId="eae2494d765c5e40" providerId="LiveId" clId="{009F47A8-FDB4-43FC-BDB0-6762BA4A8810}" dt="2025-04-10T02:22:53.902" v="70" actId="1076"/>
          <ac:spMkLst>
            <pc:docMk/>
            <pc:sldMk cId="2002524046" sldId="258"/>
            <ac:spMk id="109" creationId="{AC2DB5F6-4FAE-C8F6-E9E7-822FE11ED7BD}"/>
          </ac:spMkLst>
        </pc:spChg>
      </pc:sldChg>
      <pc:sldChg chg="del">
        <pc:chgData name=". ." userId="eae2494d765c5e40" providerId="LiveId" clId="{009F47A8-FDB4-43FC-BDB0-6762BA4A8810}" dt="2025-04-10T01:51:01.440" v="0" actId="47"/>
        <pc:sldMkLst>
          <pc:docMk/>
          <pc:sldMk cId="2189183528" sldId="259"/>
        </pc:sldMkLst>
      </pc:sldChg>
      <pc:sldChg chg="del">
        <pc:chgData name=". ." userId="eae2494d765c5e40" providerId="LiveId" clId="{009F47A8-FDB4-43FC-BDB0-6762BA4A8810}" dt="2025-04-10T01:51:01.440" v="0" actId="47"/>
        <pc:sldMkLst>
          <pc:docMk/>
          <pc:sldMk cId="558584970" sldId="260"/>
        </pc:sldMkLst>
      </pc:sldChg>
      <pc:sldChg chg="del">
        <pc:chgData name=". ." userId="eae2494d765c5e40" providerId="LiveId" clId="{009F47A8-FDB4-43FC-BDB0-6762BA4A8810}" dt="2025-04-10T01:51:01.440" v="0" actId="47"/>
        <pc:sldMkLst>
          <pc:docMk/>
          <pc:sldMk cId="1986655416" sldId="262"/>
        </pc:sldMkLst>
      </pc:sldChg>
      <pc:sldChg chg="del">
        <pc:chgData name=". ." userId="eae2494d765c5e40" providerId="LiveId" clId="{009F47A8-FDB4-43FC-BDB0-6762BA4A8810}" dt="2025-04-10T01:51:01.440" v="0" actId="47"/>
        <pc:sldMkLst>
          <pc:docMk/>
          <pc:sldMk cId="1467653079" sldId="263"/>
        </pc:sldMkLst>
      </pc:sldChg>
      <pc:sldChg chg="del">
        <pc:chgData name=". ." userId="eae2494d765c5e40" providerId="LiveId" clId="{009F47A8-FDB4-43FC-BDB0-6762BA4A8810}" dt="2025-04-10T01:51:01.440" v="0" actId="47"/>
        <pc:sldMkLst>
          <pc:docMk/>
          <pc:sldMk cId="4163714797" sldId="264"/>
        </pc:sldMkLst>
      </pc:sldChg>
      <pc:sldChg chg="del">
        <pc:chgData name=". ." userId="eae2494d765c5e40" providerId="LiveId" clId="{009F47A8-FDB4-43FC-BDB0-6762BA4A8810}" dt="2025-04-10T01:51:01.440" v="0" actId="47"/>
        <pc:sldMkLst>
          <pc:docMk/>
          <pc:sldMk cId="1066340976" sldId="265"/>
        </pc:sldMkLst>
      </pc:sldChg>
    </pc:docChg>
  </pc:docChgLst>
  <pc:docChgLst>
    <pc:chgData name=". ." userId="eae2494d765c5e40" providerId="LiveId" clId="{07C60700-8F4F-439D-A6F9-A8D575668D61}"/>
    <pc:docChg chg="undo custSel delSld modSld">
      <pc:chgData name=". ." userId="eae2494d765c5e40" providerId="LiveId" clId="{07C60700-8F4F-439D-A6F9-A8D575668D61}" dt="2025-03-26T00:54:50.531" v="520" actId="1036"/>
      <pc:docMkLst>
        <pc:docMk/>
      </pc:docMkLst>
      <pc:sldChg chg="del">
        <pc:chgData name=". ." userId="eae2494d765c5e40" providerId="LiveId" clId="{07C60700-8F4F-439D-A6F9-A8D575668D61}" dt="2025-03-26T00:21:49.717" v="0" actId="47"/>
        <pc:sldMkLst>
          <pc:docMk/>
          <pc:sldMk cId="2424892102" sldId="257"/>
        </pc:sldMkLst>
      </pc:sldChg>
      <pc:sldChg chg="modSp mod">
        <pc:chgData name=". ." userId="eae2494d765c5e40" providerId="LiveId" clId="{07C60700-8F4F-439D-A6F9-A8D575668D61}" dt="2025-03-26T00:35:18.714" v="182" actId="1037"/>
        <pc:sldMkLst>
          <pc:docMk/>
          <pc:sldMk cId="1076809069" sldId="258"/>
        </pc:sldMkLst>
      </pc:sldChg>
      <pc:sldChg chg="modSp mod">
        <pc:chgData name=". ." userId="eae2494d765c5e40" providerId="LiveId" clId="{07C60700-8F4F-439D-A6F9-A8D575668D61}" dt="2025-03-26T00:54:50.531" v="520" actId="1036"/>
        <pc:sldMkLst>
          <pc:docMk/>
          <pc:sldMk cId="2189183528" sldId="259"/>
        </pc:sldMkLst>
      </pc:sldChg>
      <pc:sldChg chg="addSp delSp modSp mod">
        <pc:chgData name=". ." userId="eae2494d765c5e40" providerId="LiveId" clId="{07C60700-8F4F-439D-A6F9-A8D575668D61}" dt="2025-03-26T00:50:20.863" v="433" actId="1076"/>
        <pc:sldMkLst>
          <pc:docMk/>
          <pc:sldMk cId="558584970" sldId="260"/>
        </pc:sldMkLst>
      </pc:sldChg>
      <pc:sldChg chg="modSp mod">
        <pc:chgData name=". ." userId="eae2494d765c5e40" providerId="LiveId" clId="{07C60700-8F4F-439D-A6F9-A8D575668D61}" dt="2025-03-26T00:37:11.066" v="232" actId="1037"/>
        <pc:sldMkLst>
          <pc:docMk/>
          <pc:sldMk cId="1986655416" sldId="262"/>
        </pc:sldMkLst>
      </pc:sldChg>
      <pc:sldChg chg="modSp mod">
        <pc:chgData name=". ." userId="eae2494d765c5e40" providerId="LiveId" clId="{07C60700-8F4F-439D-A6F9-A8D575668D61}" dt="2025-03-26T00:39:47.002" v="276" actId="554"/>
        <pc:sldMkLst>
          <pc:docMk/>
          <pc:sldMk cId="1467653079" sldId="263"/>
        </pc:sldMkLst>
      </pc:sldChg>
      <pc:sldChg chg="modSp mod">
        <pc:chgData name=". ." userId="eae2494d765c5e40" providerId="LiveId" clId="{07C60700-8F4F-439D-A6F9-A8D575668D61}" dt="2025-03-26T00:43:45.962" v="349" actId="1037"/>
        <pc:sldMkLst>
          <pc:docMk/>
          <pc:sldMk cId="2939614826" sldId="264"/>
        </pc:sldMkLst>
      </pc:sldChg>
      <pc:sldChg chg="addSp modSp mod">
        <pc:chgData name=". ." userId="eae2494d765c5e40" providerId="LiveId" clId="{07C60700-8F4F-439D-A6F9-A8D575668D61}" dt="2025-03-26T00:51:48.888" v="456" actId="554"/>
        <pc:sldMkLst>
          <pc:docMk/>
          <pc:sldMk cId="1066340976" sldId="265"/>
        </pc:sldMkLst>
      </pc:sldChg>
    </pc:docChg>
  </pc:docChgLst>
  <pc:docChgLst>
    <pc:chgData name=". ." userId="eae2494d765c5e40" providerId="LiveId" clId="{D231ABB4-F41F-4297-8484-BF2EF4CBA00A}"/>
    <pc:docChg chg="custSel addSld modSld">
      <pc:chgData name=". ." userId="eae2494d765c5e40" providerId="LiveId" clId="{D231ABB4-F41F-4297-8484-BF2EF4CBA00A}" dt="2025-04-09T01:03:55.282" v="2" actId="1076"/>
      <pc:docMkLst>
        <pc:docMk/>
      </pc:docMkLst>
      <pc:sldChg chg="delSp modSp add mod">
        <pc:chgData name=". ." userId="eae2494d765c5e40" providerId="LiveId" clId="{D231ABB4-F41F-4297-8484-BF2EF4CBA00A}" dt="2025-04-09T01:03:55.282" v="2" actId="1076"/>
        <pc:sldMkLst>
          <pc:docMk/>
          <pc:sldMk cId="2424892102" sldId="257"/>
        </pc:sldMkLst>
        <pc:spChg chg="mod">
          <ac:chgData name=". ." userId="eae2494d765c5e40" providerId="LiveId" clId="{D231ABB4-F41F-4297-8484-BF2EF4CBA00A}" dt="2025-04-09T01:03:55.282" v="2" actId="1076"/>
          <ac:spMkLst>
            <pc:docMk/>
            <pc:sldMk cId="2424892102" sldId="257"/>
            <ac:spMk id="2" creationId="{977208FA-24B5-E68F-0680-C6A191A435D2}"/>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625918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9840247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30830458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34969567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31954668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40387143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40869156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22374948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33427718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36151055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B639F49C-181A-4196-AC44-48591B935981}" type="datetimeFigureOut">
              <a:rPr lang="ko-KR" altLang="en-US" smtClean="0"/>
              <a:t>2025-05-1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90575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B639F49C-181A-4196-AC44-48591B935981}" type="datetimeFigureOut">
              <a:rPr lang="ko-KR" altLang="en-US" smtClean="0"/>
              <a:t>2025-05-15</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7028D48E-5C02-4E98-B961-AC30C00ADFDE}" type="slidenum">
              <a:rPr lang="ko-KR" altLang="en-US" smtClean="0"/>
              <a:t>‹#›</a:t>
            </a:fld>
            <a:endParaRPr lang="ko-KR" altLang="en-US"/>
          </a:p>
        </p:txBody>
      </p:sp>
    </p:spTree>
    <p:extLst>
      <p:ext uri="{BB962C8B-B14F-4D97-AF65-F5344CB8AC3E}">
        <p14:creationId xmlns:p14="http://schemas.microsoft.com/office/powerpoint/2010/main" val="23751467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hgjeong@cnu.ac.kr"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4.wmf"/><Relationship Id="rId3" Type="http://schemas.openxmlformats.org/officeDocument/2006/relationships/image" Target="../media/image1.wmf"/><Relationship Id="rId7" Type="http://schemas.openxmlformats.org/officeDocument/2006/relationships/oleObject" Target="../embeddings/oleObject3.bin"/><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image" Target="../media/image3.jpeg"/><Relationship Id="rId5" Type="http://schemas.openxmlformats.org/officeDocument/2006/relationships/image" Target="../media/image2.wmf"/><Relationship Id="rId10" Type="http://schemas.openxmlformats.org/officeDocument/2006/relationships/image" Target="../media/image5.wmf"/><Relationship Id="rId4" Type="http://schemas.openxmlformats.org/officeDocument/2006/relationships/oleObject" Target="../embeddings/oleObject2.bin"/><Relationship Id="rId9" Type="http://schemas.openxmlformats.org/officeDocument/2006/relationships/oleObject" Target="../embeddings/oleObject4.bin"/></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5.bin"/><Relationship Id="rId1" Type="http://schemas.openxmlformats.org/officeDocument/2006/relationships/slideLayout" Target="../slideLayouts/slideLayout7.xml"/><Relationship Id="rId5" Type="http://schemas.openxmlformats.org/officeDocument/2006/relationships/image" Target="../media/image7.emf"/><Relationship Id="rId4" Type="http://schemas.openxmlformats.org/officeDocument/2006/relationships/oleObject" Target="../embeddings/oleObject6.bin"/></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oleObject" Target="../embeddings/oleObject7.bin"/><Relationship Id="rId1" Type="http://schemas.openxmlformats.org/officeDocument/2006/relationships/slideLayout" Target="../slideLayouts/slideLayout7.xml"/><Relationship Id="rId5" Type="http://schemas.openxmlformats.org/officeDocument/2006/relationships/image" Target="../media/image9.emf"/><Relationship Id="rId4" Type="http://schemas.openxmlformats.org/officeDocument/2006/relationships/oleObject" Target="../embeddings/oleObject8.bin"/></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2.bin"/><Relationship Id="rId3" Type="http://schemas.openxmlformats.org/officeDocument/2006/relationships/image" Target="../media/image10.emf"/><Relationship Id="rId7" Type="http://schemas.openxmlformats.org/officeDocument/2006/relationships/image" Target="../media/image12.emf"/><Relationship Id="rId2" Type="http://schemas.openxmlformats.org/officeDocument/2006/relationships/oleObject" Target="../embeddings/oleObject9.bin"/><Relationship Id="rId1" Type="http://schemas.openxmlformats.org/officeDocument/2006/relationships/slideLayout" Target="../slideLayouts/slideLayout7.xml"/><Relationship Id="rId6" Type="http://schemas.openxmlformats.org/officeDocument/2006/relationships/oleObject" Target="../embeddings/oleObject11.bin"/><Relationship Id="rId5" Type="http://schemas.openxmlformats.org/officeDocument/2006/relationships/image" Target="../media/image11.emf"/><Relationship Id="rId4" Type="http://schemas.openxmlformats.org/officeDocument/2006/relationships/oleObject" Target="../embeddings/oleObject10.bin"/><Relationship Id="rId9" Type="http://schemas.openxmlformats.org/officeDocument/2006/relationships/image" Target="../media/image13.emf"/></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6.bin"/><Relationship Id="rId3" Type="http://schemas.openxmlformats.org/officeDocument/2006/relationships/image" Target="../media/image14.emf"/><Relationship Id="rId7" Type="http://schemas.openxmlformats.org/officeDocument/2006/relationships/image" Target="../media/image16.emf"/><Relationship Id="rId2" Type="http://schemas.openxmlformats.org/officeDocument/2006/relationships/oleObject" Target="../embeddings/oleObject13.bin"/><Relationship Id="rId1" Type="http://schemas.openxmlformats.org/officeDocument/2006/relationships/slideLayout" Target="../slideLayouts/slideLayout7.xml"/><Relationship Id="rId6" Type="http://schemas.openxmlformats.org/officeDocument/2006/relationships/oleObject" Target="../embeddings/oleObject15.bin"/><Relationship Id="rId11" Type="http://schemas.openxmlformats.org/officeDocument/2006/relationships/image" Target="../media/image18.emf"/><Relationship Id="rId5" Type="http://schemas.openxmlformats.org/officeDocument/2006/relationships/image" Target="../media/image15.emf"/><Relationship Id="rId10" Type="http://schemas.openxmlformats.org/officeDocument/2006/relationships/oleObject" Target="../embeddings/oleObject17.bin"/><Relationship Id="rId4" Type="http://schemas.openxmlformats.org/officeDocument/2006/relationships/oleObject" Target="../embeddings/oleObject14.bin"/><Relationship Id="rId9" Type="http://schemas.openxmlformats.org/officeDocument/2006/relationships/image" Target="../media/image17.emf"/></Relationships>
</file>

<file path=ppt/slides/_rels/slide7.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oleObject" Target="../embeddings/oleObject18.bin"/><Relationship Id="rId1" Type="http://schemas.openxmlformats.org/officeDocument/2006/relationships/slideLayout" Target="../slideLayouts/slideLayout7.xml"/><Relationship Id="rId5" Type="http://schemas.openxmlformats.org/officeDocument/2006/relationships/image" Target="../media/image20.emf"/><Relationship Id="rId4" Type="http://schemas.openxmlformats.org/officeDocument/2006/relationships/oleObject" Target="../embeddings/oleObject19.bin"/></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23.bin"/><Relationship Id="rId3" Type="http://schemas.openxmlformats.org/officeDocument/2006/relationships/image" Target="../media/image21.emf"/><Relationship Id="rId7" Type="http://schemas.openxmlformats.org/officeDocument/2006/relationships/image" Target="../media/image23.emf"/><Relationship Id="rId2" Type="http://schemas.openxmlformats.org/officeDocument/2006/relationships/oleObject" Target="../embeddings/oleObject20.bin"/><Relationship Id="rId1" Type="http://schemas.openxmlformats.org/officeDocument/2006/relationships/slideLayout" Target="../slideLayouts/slideLayout7.xml"/><Relationship Id="rId6" Type="http://schemas.openxmlformats.org/officeDocument/2006/relationships/oleObject" Target="../embeddings/oleObject22.bin"/><Relationship Id="rId5" Type="http://schemas.openxmlformats.org/officeDocument/2006/relationships/image" Target="../media/image22.emf"/><Relationship Id="rId4" Type="http://schemas.openxmlformats.org/officeDocument/2006/relationships/oleObject" Target="../embeddings/oleObject21.bin"/><Relationship Id="rId9" Type="http://schemas.openxmlformats.org/officeDocument/2006/relationships/image" Target="../media/image24.emf"/></Relationships>
</file>

<file path=ppt/slides/_rels/slide9.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oleObject" Target="../embeddings/oleObject24.bin"/><Relationship Id="rId1" Type="http://schemas.openxmlformats.org/officeDocument/2006/relationships/slideLayout" Target="../slideLayouts/slideLayout7.xml"/><Relationship Id="rId5" Type="http://schemas.openxmlformats.org/officeDocument/2006/relationships/image" Target="../media/image26.emf"/><Relationship Id="rId4" Type="http://schemas.openxmlformats.org/officeDocument/2006/relationships/oleObject" Target="../embeddings/oleObject2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77208FA-24B5-E68F-0680-C6A191A435D2}"/>
              </a:ext>
            </a:extLst>
          </p:cNvPr>
          <p:cNvSpPr txBox="1"/>
          <p:nvPr/>
        </p:nvSpPr>
        <p:spPr>
          <a:xfrm>
            <a:off x="508034" y="865720"/>
            <a:ext cx="5841932" cy="923330"/>
          </a:xfrm>
          <a:prstGeom prst="rect">
            <a:avLst/>
          </a:prstGeom>
          <a:noFill/>
        </p:spPr>
        <p:txBody>
          <a:bodyPr wrap="square" rtlCol="0" anchor="ctr">
            <a:spAutoFit/>
          </a:bodyPr>
          <a:lstStyle/>
          <a:p>
            <a:pPr>
              <a:spcAft>
                <a:spcPts val="1200"/>
              </a:spcAft>
            </a:pPr>
            <a:r>
              <a:rPr lang="en-US" altLang="ko-KR" sz="1800" b="1" dirty="0">
                <a:solidFill>
                  <a:srgbClr val="000000"/>
                </a:solidFill>
                <a:effectLst/>
                <a:latin typeface="Times New Roman" panose="02020603050405020304" pitchFamily="18" charset="0"/>
                <a:ea typeface="Arial Unicode MS" panose="020B0604020202020204" pitchFamily="50" charset="-127"/>
                <a:cs typeface="Times New Roman" panose="02020603050405020304" pitchFamily="18" charset="0"/>
              </a:rPr>
              <a:t>Protective effect of </a:t>
            </a:r>
            <a:r>
              <a:rPr lang="en-US" altLang="ko-KR" sz="1800" b="1" dirty="0" err="1">
                <a:solidFill>
                  <a:srgbClr val="000000"/>
                </a:solidFill>
                <a:effectLst/>
                <a:latin typeface="Times New Roman" panose="02020603050405020304" pitchFamily="18" charset="0"/>
                <a:ea typeface="Arial Unicode MS" panose="020B0604020202020204" pitchFamily="50" charset="-127"/>
                <a:cs typeface="Times New Roman" panose="02020603050405020304" pitchFamily="18" charset="0"/>
              </a:rPr>
              <a:t>Impressic</a:t>
            </a:r>
            <a:r>
              <a:rPr lang="en-US" altLang="ko-KR" sz="1800" b="1" dirty="0">
                <a:solidFill>
                  <a:srgbClr val="000000"/>
                </a:solidFill>
                <a:effectLst/>
                <a:latin typeface="Times New Roman" panose="02020603050405020304" pitchFamily="18" charset="0"/>
                <a:ea typeface="Arial Unicode MS" panose="020B0604020202020204" pitchFamily="50" charset="-127"/>
                <a:cs typeface="Times New Roman" panose="02020603050405020304" pitchFamily="18" charset="0"/>
              </a:rPr>
              <a:t> acid on diesel exhaust particulate matter-induced NLRP1 inflammasome via Keap1/p62/Nrf2 signaling pathway in keratinocytes</a:t>
            </a:r>
            <a:endParaRPr lang="ko-KR" altLang="ko-KR" sz="1800" b="1" dirty="0">
              <a:solidFill>
                <a:srgbClr val="000000"/>
              </a:solidFill>
              <a:effectLst/>
              <a:latin typeface="Times New Roman" panose="02020603050405020304" pitchFamily="18" charset="0"/>
              <a:ea typeface="Arial Unicode MS" panose="020B0604020202020204" pitchFamily="50" charset="-127"/>
              <a:cs typeface="Times New Roman" panose="02020603050405020304" pitchFamily="18" charset="0"/>
            </a:endParaRPr>
          </a:p>
        </p:txBody>
      </p:sp>
      <p:sp>
        <p:nvSpPr>
          <p:cNvPr id="3" name="TextBox 2">
            <a:extLst>
              <a:ext uri="{FF2B5EF4-FFF2-40B4-BE49-F238E27FC236}">
                <a16:creationId xmlns:a16="http://schemas.microsoft.com/office/drawing/2014/main" id="{69A5C612-5A0E-84F4-7077-D824808AC052}"/>
              </a:ext>
            </a:extLst>
          </p:cNvPr>
          <p:cNvSpPr txBox="1"/>
          <p:nvPr/>
        </p:nvSpPr>
        <p:spPr>
          <a:xfrm>
            <a:off x="508034" y="2083490"/>
            <a:ext cx="5841932" cy="430887"/>
          </a:xfrm>
          <a:prstGeom prst="rect">
            <a:avLst/>
          </a:prstGeom>
          <a:noFill/>
        </p:spPr>
        <p:txBody>
          <a:bodyPr wrap="square" rtlCol="0" anchor="ctr">
            <a:spAutoFit/>
          </a:bodyPr>
          <a:lstStyle/>
          <a:p>
            <a:pPr>
              <a:spcAft>
                <a:spcPts val="1200"/>
              </a:spcAft>
            </a:pP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Seung Yeon Lee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Gi Ho Lee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r>
              <a:rPr lang="en-US" altLang="ko-KR" sz="1100" b="1" dirty="0" err="1">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Jeonghwan</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Maeng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Su Yeon Kim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Hwi-Yeol Yun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Gil-Saeng Jeong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nd Hye Gwang Jeong </a:t>
            </a:r>
            <a:r>
              <a:rPr lang="en-US" altLang="ko-KR" sz="1100" b="1" baseline="30000"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r>
              <a:rPr lang="en-US"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t>
            </a:r>
            <a:endParaRPr lang="ko-KR" altLang="ko-KR" sz="11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 name="TextBox 5">
            <a:extLst>
              <a:ext uri="{FF2B5EF4-FFF2-40B4-BE49-F238E27FC236}">
                <a16:creationId xmlns:a16="http://schemas.microsoft.com/office/drawing/2014/main" id="{FBFE506E-264E-3441-A6EF-C92760ACC3C5}"/>
              </a:ext>
            </a:extLst>
          </p:cNvPr>
          <p:cNvSpPr txBox="1"/>
          <p:nvPr/>
        </p:nvSpPr>
        <p:spPr>
          <a:xfrm>
            <a:off x="-1328738" y="2808817"/>
            <a:ext cx="7907304" cy="485967"/>
          </a:xfrm>
          <a:prstGeom prst="rect">
            <a:avLst/>
          </a:prstGeom>
          <a:noFill/>
        </p:spPr>
        <p:txBody>
          <a:bodyPr wrap="square" rtlCol="0" anchor="ctr">
            <a:spAutoFit/>
          </a:bodyPr>
          <a:lstStyle/>
          <a:p>
            <a:pPr marL="1781810" indent="-125730">
              <a:lnSpc>
                <a:spcPts val="1000"/>
              </a:lnSpc>
              <a:buNone/>
            </a:pPr>
            <a:r>
              <a:rPr lang="en-US" altLang="ko-KR" sz="1200" baseline="300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1</a:t>
            </a:r>
            <a:r>
              <a:rPr lang="en-US"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ollege of Pharmacy, </a:t>
            </a:r>
            <a:r>
              <a:rPr lang="en-US" altLang="ko-KR" sz="12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hungnam</a:t>
            </a:r>
            <a:r>
              <a:rPr lang="en-US"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National University, Daejeon 34134, Republic of Korea</a:t>
            </a:r>
            <a:endParaRPr lang="ko-KR"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indent="-125730">
              <a:lnSpc>
                <a:spcPts val="1000"/>
              </a:lnSpc>
              <a:buNone/>
            </a:pPr>
            <a:r>
              <a:rPr lang="en-US" altLang="ko-KR" sz="12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t>
            </a:r>
            <a:r>
              <a:rPr lang="en-US"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orrespondence: </a:t>
            </a:r>
            <a:r>
              <a:rPr lang="en-US" altLang="ko-KR" sz="1200" u="sng"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hlinkClick r:id="rId2"/>
              </a:rPr>
              <a:t>hgjeong@cnu.ac.kr</a:t>
            </a:r>
            <a:r>
              <a:rPr lang="en-US"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Tel.: +82-42-821-5936; Fax: +82-42-823-6566</a:t>
            </a:r>
            <a:r>
              <a:rPr lang="en-US" altLang="ko-KR" sz="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t>
            </a:r>
            <a:endParaRPr lang="ko-KR"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indent="-125730">
              <a:lnSpc>
                <a:spcPts val="1000"/>
              </a:lnSpc>
            </a:pPr>
            <a:r>
              <a:rPr lang="ko-KR" altLang="ko-KR" sz="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t>
            </a:r>
            <a:r>
              <a:rPr lang="en-US" altLang="ko-KR" sz="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These authors contributed equally to this work.</a:t>
            </a:r>
            <a:endParaRPr lang="ko-KR" altLang="ko-KR"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248921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BB1AE9-587A-5943-ACBF-FFE6D266D6CB}"/>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277FC240-E73D-6C46-D751-02A2A753CD63}"/>
              </a:ext>
            </a:extLst>
          </p:cNvPr>
          <p:cNvSpPr txBox="1"/>
          <p:nvPr/>
        </p:nvSpPr>
        <p:spPr>
          <a:xfrm>
            <a:off x="303775" y="588644"/>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grpSp>
        <p:nvGrpSpPr>
          <p:cNvPr id="29" name="그룹 28">
            <a:extLst>
              <a:ext uri="{FF2B5EF4-FFF2-40B4-BE49-F238E27FC236}">
                <a16:creationId xmlns:a16="http://schemas.microsoft.com/office/drawing/2014/main" id="{3C269A6F-B9CB-C701-7F3F-313DE480728E}"/>
              </a:ext>
            </a:extLst>
          </p:cNvPr>
          <p:cNvGrpSpPr/>
          <p:nvPr/>
        </p:nvGrpSpPr>
        <p:grpSpPr>
          <a:xfrm>
            <a:off x="576404" y="2530989"/>
            <a:ext cx="2690671" cy="1986127"/>
            <a:chOff x="576404" y="2868613"/>
            <a:chExt cx="2690671" cy="1986127"/>
          </a:xfrm>
        </p:grpSpPr>
        <p:sp>
          <p:nvSpPr>
            <p:cNvPr id="32" name="TextBox 31">
              <a:extLst>
                <a:ext uri="{FF2B5EF4-FFF2-40B4-BE49-F238E27FC236}">
                  <a16:creationId xmlns:a16="http://schemas.microsoft.com/office/drawing/2014/main" id="{77288E05-D15B-6173-B89D-8E40C6658879}"/>
                </a:ext>
              </a:extLst>
            </p:cNvPr>
            <p:cNvSpPr txBox="1"/>
            <p:nvPr/>
          </p:nvSpPr>
          <p:spPr>
            <a:xfrm>
              <a:off x="576404" y="4577741"/>
              <a:ext cx="775533" cy="276999"/>
            </a:xfrm>
            <a:prstGeom prst="rect">
              <a:avLst/>
            </a:prstGeom>
            <a:noFill/>
          </p:spPr>
          <p:txBody>
            <a:bodyPr wrap="none" rtlCol="0" anchor="ctr">
              <a:spAutoFit/>
            </a:bodyPr>
            <a:lstStyle/>
            <a:p>
              <a:pPr algn="r"/>
              <a:r>
                <a:rPr lang="en-US" altLang="ko-KR" sz="1200" dirty="0">
                  <a:latin typeface="Arial" panose="020B0604020202020204" pitchFamily="34" charset="0"/>
                  <a:cs typeface="Arial" panose="020B0604020202020204" pitchFamily="34" charset="0"/>
                </a:rPr>
                <a:t>IPA (</a:t>
              </a:r>
              <a:r>
                <a:rPr lang="el-GR" altLang="ko-KR" sz="1200" dirty="0">
                  <a:latin typeface="Arial" panose="020B0604020202020204" pitchFamily="34" charset="0"/>
                  <a:cs typeface="Arial" panose="020B0604020202020204" pitchFamily="34" charset="0"/>
                </a:rPr>
                <a:t>μ</a:t>
              </a:r>
              <a:r>
                <a:rPr lang="en-US" altLang="ko-KR" sz="1200" dirty="0">
                  <a:latin typeface="Arial" panose="020B0604020202020204" pitchFamily="34" charset="0"/>
                  <a:cs typeface="Arial" panose="020B0604020202020204" pitchFamily="34" charset="0"/>
                </a:rPr>
                <a:t>M)</a:t>
              </a:r>
              <a:endParaRPr lang="ko-KR" altLang="en-US" sz="1200"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B7523805-B83C-CE1B-8D27-1E47B38CA936}"/>
                </a:ext>
              </a:extLst>
            </p:cNvPr>
            <p:cNvSpPr txBox="1"/>
            <p:nvPr/>
          </p:nvSpPr>
          <p:spPr>
            <a:xfrm>
              <a:off x="1308533" y="4577741"/>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F2719140-0E1B-D037-3CFB-3E56B411D11D}"/>
                </a:ext>
              </a:extLst>
            </p:cNvPr>
            <p:cNvSpPr txBox="1"/>
            <p:nvPr/>
          </p:nvSpPr>
          <p:spPr>
            <a:xfrm>
              <a:off x="1658008" y="4577741"/>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a:t>
              </a:r>
              <a:endParaRPr lang="ko-KR" altLang="en-US" sz="12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74178F91-7869-52A0-8B39-A3C957FB5D7E}"/>
                </a:ext>
              </a:extLst>
            </p:cNvPr>
            <p:cNvSpPr txBox="1"/>
            <p:nvPr/>
          </p:nvSpPr>
          <p:spPr>
            <a:xfrm>
              <a:off x="2022536" y="4577741"/>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5</a:t>
              </a:r>
              <a:endParaRPr lang="ko-KR" altLang="en-US" sz="12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79A20DFD-7ECC-6087-A9DD-362D49D408FB}"/>
                </a:ext>
              </a:extLst>
            </p:cNvPr>
            <p:cNvSpPr txBox="1"/>
            <p:nvPr/>
          </p:nvSpPr>
          <p:spPr>
            <a:xfrm>
              <a:off x="2338251" y="4577741"/>
              <a:ext cx="35458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0</a:t>
              </a:r>
              <a:endParaRPr lang="ko-KR" altLang="en-US" sz="1200"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228F6D10-13F1-069E-8A3A-F678C3D6F987}"/>
                </a:ext>
              </a:extLst>
            </p:cNvPr>
            <p:cNvSpPr txBox="1"/>
            <p:nvPr/>
          </p:nvSpPr>
          <p:spPr>
            <a:xfrm>
              <a:off x="2700821" y="4577741"/>
              <a:ext cx="35458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20</a:t>
              </a:r>
              <a:endParaRPr lang="ko-KR" altLang="en-US" sz="1200" dirty="0">
                <a:latin typeface="Arial" panose="020B0604020202020204" pitchFamily="34" charset="0"/>
                <a:cs typeface="Arial" panose="020B0604020202020204" pitchFamily="34" charset="0"/>
              </a:endParaRPr>
            </a:p>
          </p:txBody>
        </p:sp>
        <p:graphicFrame>
          <p:nvGraphicFramePr>
            <p:cNvPr id="38" name="개체 37">
              <a:extLst>
                <a:ext uri="{FF2B5EF4-FFF2-40B4-BE49-F238E27FC236}">
                  <a16:creationId xmlns:a16="http://schemas.microsoft.com/office/drawing/2014/main" id="{64ED0E8F-3DDF-C904-8E78-6B310C89F2EE}"/>
                </a:ext>
              </a:extLst>
            </p:cNvPr>
            <p:cNvGraphicFramePr>
              <a:graphicFrameLocks/>
            </p:cNvGraphicFramePr>
            <p:nvPr/>
          </p:nvGraphicFramePr>
          <p:xfrm>
            <a:off x="606425" y="2868613"/>
            <a:ext cx="2660650" cy="1927225"/>
          </p:xfrm>
          <a:graphic>
            <a:graphicData uri="http://schemas.openxmlformats.org/presentationml/2006/ole">
              <mc:AlternateContent xmlns:mc="http://schemas.openxmlformats.org/markup-compatibility/2006">
                <mc:Choice xmlns:v="urn:schemas-microsoft-com:vml" Requires="v">
                  <p:oleObj name="Graph" r:id="rId2" imgW="4153680" imgH="2901600" progId="Origin50.Graph">
                    <p:embed/>
                  </p:oleObj>
                </mc:Choice>
                <mc:Fallback>
                  <p:oleObj name="Graph" r:id="rId2" imgW="4153680" imgH="2901600" progId="Origin50.Graph">
                    <p:embed/>
                    <p:pic>
                      <p:nvPicPr>
                        <p:cNvPr id="38" name="개체 37">
                          <a:extLst>
                            <a:ext uri="{FF2B5EF4-FFF2-40B4-BE49-F238E27FC236}">
                              <a16:creationId xmlns:a16="http://schemas.microsoft.com/office/drawing/2014/main" id="{64ED0E8F-3DDF-C904-8E78-6B310C89F2EE}"/>
                            </a:ext>
                          </a:extLst>
                        </p:cNvPr>
                        <p:cNvPicPr preferRelativeResize="0"/>
                        <p:nvPr/>
                      </p:nvPicPr>
                      <p:blipFill>
                        <a:blip r:embed="rId3"/>
                        <a:stretch>
                          <a:fillRect/>
                        </a:stretch>
                      </p:blipFill>
                      <p:spPr>
                        <a:xfrm>
                          <a:off x="606425" y="2868613"/>
                          <a:ext cx="2660650" cy="1927225"/>
                        </a:xfrm>
                        <a:prstGeom prst="rect">
                          <a:avLst/>
                        </a:prstGeom>
                      </p:spPr>
                    </p:pic>
                  </p:oleObj>
                </mc:Fallback>
              </mc:AlternateContent>
            </a:graphicData>
          </a:graphic>
        </p:graphicFrame>
      </p:grpSp>
      <p:grpSp>
        <p:nvGrpSpPr>
          <p:cNvPr id="39" name="그룹 38">
            <a:extLst>
              <a:ext uri="{FF2B5EF4-FFF2-40B4-BE49-F238E27FC236}">
                <a16:creationId xmlns:a16="http://schemas.microsoft.com/office/drawing/2014/main" id="{252C08B1-F6AD-43A8-0B40-4CF02E013990}"/>
              </a:ext>
            </a:extLst>
          </p:cNvPr>
          <p:cNvGrpSpPr/>
          <p:nvPr/>
        </p:nvGrpSpPr>
        <p:grpSpPr>
          <a:xfrm>
            <a:off x="3696937" y="2531744"/>
            <a:ext cx="2665232" cy="1947272"/>
            <a:chOff x="3696937" y="2869368"/>
            <a:chExt cx="2665232" cy="1947272"/>
          </a:xfrm>
        </p:grpSpPr>
        <p:sp>
          <p:nvSpPr>
            <p:cNvPr id="40" name="TextBox 39">
              <a:extLst>
                <a:ext uri="{FF2B5EF4-FFF2-40B4-BE49-F238E27FC236}">
                  <a16:creationId xmlns:a16="http://schemas.microsoft.com/office/drawing/2014/main" id="{27EC03DC-72E7-E97F-D64F-2D1F49CA0702}"/>
                </a:ext>
              </a:extLst>
            </p:cNvPr>
            <p:cNvSpPr txBox="1"/>
            <p:nvPr/>
          </p:nvSpPr>
          <p:spPr>
            <a:xfrm>
              <a:off x="3696937" y="4539641"/>
              <a:ext cx="775533" cy="276999"/>
            </a:xfrm>
            <a:prstGeom prst="rect">
              <a:avLst/>
            </a:prstGeom>
            <a:noFill/>
          </p:spPr>
          <p:txBody>
            <a:bodyPr wrap="none" rtlCol="0" anchor="ctr">
              <a:spAutoFit/>
            </a:bodyPr>
            <a:lstStyle/>
            <a:p>
              <a:pPr algn="r"/>
              <a:r>
                <a:rPr lang="en-US" altLang="ko-KR" sz="1200" dirty="0">
                  <a:latin typeface="Arial" panose="020B0604020202020204" pitchFamily="34" charset="0"/>
                  <a:cs typeface="Arial" panose="020B0604020202020204" pitchFamily="34" charset="0"/>
                </a:rPr>
                <a:t>IPA (</a:t>
              </a:r>
              <a:r>
                <a:rPr lang="el-GR" altLang="ko-KR" sz="1200" dirty="0">
                  <a:latin typeface="Arial" panose="020B0604020202020204" pitchFamily="34" charset="0"/>
                  <a:cs typeface="Arial" panose="020B0604020202020204" pitchFamily="34" charset="0"/>
                </a:rPr>
                <a:t>μ</a:t>
              </a:r>
              <a:r>
                <a:rPr lang="en-US" altLang="ko-KR" sz="1200" dirty="0">
                  <a:latin typeface="Arial" panose="020B0604020202020204" pitchFamily="34" charset="0"/>
                  <a:cs typeface="Arial" panose="020B0604020202020204" pitchFamily="34" charset="0"/>
                </a:rPr>
                <a:t>M)</a:t>
              </a:r>
              <a:endParaRPr lang="ko-KR" altLang="en-US" sz="12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692AC6E4-E3EC-542A-CB77-51AB5ACF1DDB}"/>
                </a:ext>
              </a:extLst>
            </p:cNvPr>
            <p:cNvSpPr txBox="1"/>
            <p:nvPr/>
          </p:nvSpPr>
          <p:spPr>
            <a:xfrm>
              <a:off x="4398700" y="4539641"/>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38BC3CD4-DCC1-277F-7917-EAC1AD4B28A3}"/>
                </a:ext>
              </a:extLst>
            </p:cNvPr>
            <p:cNvSpPr txBox="1"/>
            <p:nvPr/>
          </p:nvSpPr>
          <p:spPr>
            <a:xfrm>
              <a:off x="4749445" y="4539641"/>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a:t>
              </a:r>
              <a:endParaRPr lang="ko-KR" altLang="en-US" sz="1200"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3065521C-6B01-5C5E-4619-9F53EFC3D040}"/>
                </a:ext>
              </a:extLst>
            </p:cNvPr>
            <p:cNvSpPr txBox="1"/>
            <p:nvPr/>
          </p:nvSpPr>
          <p:spPr>
            <a:xfrm>
              <a:off x="5113857" y="4539641"/>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5</a:t>
              </a:r>
              <a:endParaRPr lang="ko-KR" altLang="en-US" sz="1200"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B38EE5F8-2104-53DF-126B-2832DF27D773}"/>
                </a:ext>
              </a:extLst>
            </p:cNvPr>
            <p:cNvSpPr txBox="1"/>
            <p:nvPr/>
          </p:nvSpPr>
          <p:spPr>
            <a:xfrm>
              <a:off x="5436038" y="4539641"/>
              <a:ext cx="35458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0</a:t>
              </a:r>
              <a:endParaRPr lang="ko-KR" altLang="en-US" sz="1200" dirty="0">
                <a:latin typeface="Arial" panose="020B0604020202020204" pitchFamily="34" charset="0"/>
                <a:cs typeface="Arial" panose="020B0604020202020204" pitchFamily="34" charset="0"/>
              </a:endParaRPr>
            </a:p>
          </p:txBody>
        </p:sp>
        <p:sp>
          <p:nvSpPr>
            <p:cNvPr id="50" name="TextBox 49">
              <a:extLst>
                <a:ext uri="{FF2B5EF4-FFF2-40B4-BE49-F238E27FC236}">
                  <a16:creationId xmlns:a16="http://schemas.microsoft.com/office/drawing/2014/main" id="{EB79B53A-94F5-ED36-3410-3A5F5ABE45C6}"/>
                </a:ext>
              </a:extLst>
            </p:cNvPr>
            <p:cNvSpPr txBox="1"/>
            <p:nvPr/>
          </p:nvSpPr>
          <p:spPr>
            <a:xfrm>
              <a:off x="5797338" y="4539641"/>
              <a:ext cx="35458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20</a:t>
              </a:r>
              <a:endParaRPr lang="ko-KR" altLang="en-US" sz="1200" dirty="0">
                <a:latin typeface="Arial" panose="020B0604020202020204" pitchFamily="34" charset="0"/>
                <a:cs typeface="Arial" panose="020B0604020202020204" pitchFamily="34" charset="0"/>
              </a:endParaRPr>
            </a:p>
          </p:txBody>
        </p:sp>
        <p:graphicFrame>
          <p:nvGraphicFramePr>
            <p:cNvPr id="52" name="개체 51">
              <a:extLst>
                <a:ext uri="{FF2B5EF4-FFF2-40B4-BE49-F238E27FC236}">
                  <a16:creationId xmlns:a16="http://schemas.microsoft.com/office/drawing/2014/main" id="{E6B6F881-24BE-FEAE-C69B-6425D2D6FBEC}"/>
                </a:ext>
              </a:extLst>
            </p:cNvPr>
            <p:cNvGraphicFramePr>
              <a:graphicFrameLocks/>
            </p:cNvGraphicFramePr>
            <p:nvPr/>
          </p:nvGraphicFramePr>
          <p:xfrm>
            <a:off x="3701769" y="2869368"/>
            <a:ext cx="2660400" cy="1926586"/>
          </p:xfrm>
          <a:graphic>
            <a:graphicData uri="http://schemas.openxmlformats.org/presentationml/2006/ole">
              <mc:AlternateContent xmlns:mc="http://schemas.openxmlformats.org/markup-compatibility/2006">
                <mc:Choice xmlns:v="urn:schemas-microsoft-com:vml" Requires="v">
                  <p:oleObj name="Graph" r:id="rId4" imgW="4153680" imgH="2901600" progId="Origin50.Graph">
                    <p:embed/>
                  </p:oleObj>
                </mc:Choice>
                <mc:Fallback>
                  <p:oleObj name="Graph" r:id="rId4" imgW="4153680" imgH="2901600" progId="Origin50.Graph">
                    <p:embed/>
                    <p:pic>
                      <p:nvPicPr>
                        <p:cNvPr id="52" name="개체 51">
                          <a:extLst>
                            <a:ext uri="{FF2B5EF4-FFF2-40B4-BE49-F238E27FC236}">
                              <a16:creationId xmlns:a16="http://schemas.microsoft.com/office/drawing/2014/main" id="{E6B6F881-24BE-FEAE-C69B-6425D2D6FBEC}"/>
                            </a:ext>
                          </a:extLst>
                        </p:cNvPr>
                        <p:cNvPicPr preferRelativeResize="0"/>
                        <p:nvPr/>
                      </p:nvPicPr>
                      <p:blipFill>
                        <a:blip r:embed="rId5"/>
                        <a:stretch>
                          <a:fillRect/>
                        </a:stretch>
                      </p:blipFill>
                      <p:spPr>
                        <a:xfrm>
                          <a:off x="3701769" y="2869368"/>
                          <a:ext cx="2660400" cy="1926586"/>
                        </a:xfrm>
                        <a:prstGeom prst="rect">
                          <a:avLst/>
                        </a:prstGeom>
                      </p:spPr>
                    </p:pic>
                  </p:oleObj>
                </mc:Fallback>
              </mc:AlternateContent>
            </a:graphicData>
          </a:graphic>
        </p:graphicFrame>
      </p:grpSp>
      <p:sp>
        <p:nvSpPr>
          <p:cNvPr id="53" name="TextBox 52">
            <a:extLst>
              <a:ext uri="{FF2B5EF4-FFF2-40B4-BE49-F238E27FC236}">
                <a16:creationId xmlns:a16="http://schemas.microsoft.com/office/drawing/2014/main" id="{6B9498E9-1BB3-2208-E2B0-D95F2C8FE974}"/>
              </a:ext>
            </a:extLst>
          </p:cNvPr>
          <p:cNvSpPr txBox="1"/>
          <p:nvPr/>
        </p:nvSpPr>
        <p:spPr>
          <a:xfrm>
            <a:off x="303775" y="2560558"/>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pic>
        <p:nvPicPr>
          <p:cNvPr id="54" name="그림 53">
            <a:extLst>
              <a:ext uri="{FF2B5EF4-FFF2-40B4-BE49-F238E27FC236}">
                <a16:creationId xmlns:a16="http://schemas.microsoft.com/office/drawing/2014/main" id="{43698CD3-7E26-2F91-9CA9-072F266ED12D}"/>
              </a:ext>
            </a:extLst>
          </p:cNvPr>
          <p:cNvPicPr preferRelativeResize="0">
            <a:picLocks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06425" y="582629"/>
            <a:ext cx="2339388" cy="18339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55" name="그룹 54">
            <a:extLst>
              <a:ext uri="{FF2B5EF4-FFF2-40B4-BE49-F238E27FC236}">
                <a16:creationId xmlns:a16="http://schemas.microsoft.com/office/drawing/2014/main" id="{0D102E8F-DD17-F3DB-5E28-A1C0939F6237}"/>
              </a:ext>
            </a:extLst>
          </p:cNvPr>
          <p:cNvGrpSpPr/>
          <p:nvPr/>
        </p:nvGrpSpPr>
        <p:grpSpPr>
          <a:xfrm>
            <a:off x="37521" y="4677275"/>
            <a:ext cx="3229554" cy="2285237"/>
            <a:chOff x="37521" y="5014899"/>
            <a:chExt cx="3229554" cy="2285237"/>
          </a:xfrm>
        </p:grpSpPr>
        <p:sp>
          <p:nvSpPr>
            <p:cNvPr id="56" name="TextBox 55">
              <a:extLst>
                <a:ext uri="{FF2B5EF4-FFF2-40B4-BE49-F238E27FC236}">
                  <a16:creationId xmlns:a16="http://schemas.microsoft.com/office/drawing/2014/main" id="{3AE5747A-334A-6399-5CF5-E8C50BD70127}"/>
                </a:ext>
              </a:extLst>
            </p:cNvPr>
            <p:cNvSpPr txBox="1"/>
            <p:nvPr/>
          </p:nvSpPr>
          <p:spPr>
            <a:xfrm>
              <a:off x="582029" y="7023137"/>
              <a:ext cx="775533" cy="276999"/>
            </a:xfrm>
            <a:prstGeom prst="rect">
              <a:avLst/>
            </a:prstGeom>
            <a:noFill/>
          </p:spPr>
          <p:txBody>
            <a:bodyPr wrap="none" rtlCol="0" anchor="ctr">
              <a:spAutoFit/>
            </a:bodyPr>
            <a:lstStyle/>
            <a:p>
              <a:pPr algn="r"/>
              <a:r>
                <a:rPr lang="en-US" altLang="ko-KR" sz="1200" dirty="0">
                  <a:latin typeface="Arial" panose="020B0604020202020204" pitchFamily="34" charset="0"/>
                  <a:cs typeface="Arial" panose="020B0604020202020204" pitchFamily="34" charset="0"/>
                </a:rPr>
                <a:t>IPA (</a:t>
              </a:r>
              <a:r>
                <a:rPr lang="el-GR" altLang="ko-KR" sz="1200" dirty="0">
                  <a:latin typeface="Arial" panose="020B0604020202020204" pitchFamily="34" charset="0"/>
                  <a:cs typeface="Arial" panose="020B0604020202020204" pitchFamily="34" charset="0"/>
                </a:rPr>
                <a:t>μ</a:t>
              </a:r>
              <a:r>
                <a:rPr lang="en-US" altLang="ko-KR" sz="1200" dirty="0">
                  <a:latin typeface="Arial" panose="020B0604020202020204" pitchFamily="34" charset="0"/>
                  <a:cs typeface="Arial" panose="020B0604020202020204" pitchFamily="34" charset="0"/>
                </a:rPr>
                <a:t>M)</a:t>
              </a:r>
              <a:endParaRPr lang="ko-KR" altLang="en-US" sz="1200" dirty="0">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22CA3F4F-44B2-C6D1-F108-F8A566B8014E}"/>
                </a:ext>
              </a:extLst>
            </p:cNvPr>
            <p:cNvSpPr txBox="1"/>
            <p:nvPr/>
          </p:nvSpPr>
          <p:spPr>
            <a:xfrm>
              <a:off x="1311931" y="7023137"/>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EF125A2D-6357-36C1-029A-02D171B57FF3}"/>
                </a:ext>
              </a:extLst>
            </p:cNvPr>
            <p:cNvSpPr txBox="1"/>
            <p:nvPr/>
          </p:nvSpPr>
          <p:spPr>
            <a:xfrm>
              <a:off x="2027188" y="7023137"/>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a:t>
              </a:r>
              <a:endParaRPr lang="ko-KR" altLang="en-US" sz="1200"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ACECD335-C490-9ED9-1D26-154A2886E065}"/>
                </a:ext>
              </a:extLst>
            </p:cNvPr>
            <p:cNvSpPr txBox="1"/>
            <p:nvPr/>
          </p:nvSpPr>
          <p:spPr>
            <a:xfrm>
              <a:off x="2372150" y="7023137"/>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5</a:t>
              </a:r>
              <a:endParaRPr lang="ko-KR" altLang="en-US" sz="1200"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06758DE9-EBEA-29DD-6B2A-D9A75268BF1C}"/>
                </a:ext>
              </a:extLst>
            </p:cNvPr>
            <p:cNvSpPr txBox="1"/>
            <p:nvPr/>
          </p:nvSpPr>
          <p:spPr>
            <a:xfrm>
              <a:off x="2697663" y="7023137"/>
              <a:ext cx="35458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0</a:t>
              </a:r>
              <a:endParaRPr lang="ko-KR" altLang="en-US" sz="1200" dirty="0">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137A718B-51FA-A9CF-3E24-9E57F9B60866}"/>
                </a:ext>
              </a:extLst>
            </p:cNvPr>
            <p:cNvSpPr txBox="1"/>
            <p:nvPr/>
          </p:nvSpPr>
          <p:spPr>
            <a:xfrm>
              <a:off x="37521" y="6710453"/>
              <a:ext cx="1320041" cy="276999"/>
            </a:xfrm>
            <a:prstGeom prst="rect">
              <a:avLst/>
            </a:prstGeom>
            <a:noFill/>
          </p:spPr>
          <p:txBody>
            <a:bodyPr wrap="none" rtlCol="0" anchor="ctr">
              <a:spAutoFit/>
            </a:bodyPr>
            <a:lstStyle/>
            <a:p>
              <a:pPr algn="r"/>
              <a:r>
                <a:rPr lang="en-US" altLang="ko-KR" sz="1200" dirty="0">
                  <a:latin typeface="Arial" panose="020B0604020202020204" pitchFamily="34" charset="0"/>
                  <a:cs typeface="Arial" panose="020B0604020202020204" pitchFamily="34" charset="0"/>
                </a:rPr>
                <a:t>DEP (</a:t>
              </a:r>
              <a:r>
                <a:rPr lang="en-US" altLang="ko-KR" sz="1200" dirty="0">
                  <a:latin typeface="Arial" panose="020B0604020202020204" pitchFamily="34" charset="0"/>
                  <a:cs typeface="Arial" panose="020B0604020202020204" pitchFamily="34" charset="0"/>
                  <a:sym typeface="Symbol" panose="05050102010706020507" pitchFamily="18" charset="2"/>
                </a:rPr>
                <a:t>100 </a:t>
              </a:r>
              <a:r>
                <a:rPr lang="el-GR" altLang="ko-KR" sz="1200" dirty="0">
                  <a:latin typeface="Arial" panose="020B0604020202020204" pitchFamily="34" charset="0"/>
                  <a:cs typeface="Arial" panose="020B0604020202020204" pitchFamily="34" charset="0"/>
                </a:rPr>
                <a:t>μ</a:t>
              </a:r>
              <a:r>
                <a:rPr lang="en-US" altLang="ko-KR" sz="1200" dirty="0">
                  <a:latin typeface="Arial" panose="020B0604020202020204" pitchFamily="34" charset="0"/>
                  <a:cs typeface="Arial" panose="020B0604020202020204" pitchFamily="34" charset="0"/>
                </a:rPr>
                <a:t>g/ml)</a:t>
              </a:r>
              <a:endParaRPr lang="ko-KR" altLang="en-US" sz="1200" dirty="0">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D0F8D212-921B-2598-A957-82E90328BE18}"/>
                </a:ext>
              </a:extLst>
            </p:cNvPr>
            <p:cNvSpPr txBox="1"/>
            <p:nvPr/>
          </p:nvSpPr>
          <p:spPr>
            <a:xfrm>
              <a:off x="1311931" y="6710453"/>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D59774A0-9BE8-5320-421C-35B9EB02A653}"/>
                </a:ext>
              </a:extLst>
            </p:cNvPr>
            <p:cNvSpPr txBox="1"/>
            <p:nvPr/>
          </p:nvSpPr>
          <p:spPr>
            <a:xfrm>
              <a:off x="2369746" y="6706555"/>
              <a:ext cx="274434"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40EDB98F-335E-CB4E-4ABB-4E86C7E18FC7}"/>
                </a:ext>
              </a:extLst>
            </p:cNvPr>
            <p:cNvSpPr txBox="1"/>
            <p:nvPr/>
          </p:nvSpPr>
          <p:spPr>
            <a:xfrm>
              <a:off x="2024784" y="6710453"/>
              <a:ext cx="274434"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7DECB001-150D-E295-F648-E3B72E4CBF1B}"/>
                </a:ext>
              </a:extLst>
            </p:cNvPr>
            <p:cNvSpPr txBox="1"/>
            <p:nvPr/>
          </p:nvSpPr>
          <p:spPr>
            <a:xfrm>
              <a:off x="2737738" y="6706555"/>
              <a:ext cx="274434"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graphicFrame>
          <p:nvGraphicFramePr>
            <p:cNvPr id="82" name="개체 81">
              <a:extLst>
                <a:ext uri="{FF2B5EF4-FFF2-40B4-BE49-F238E27FC236}">
                  <a16:creationId xmlns:a16="http://schemas.microsoft.com/office/drawing/2014/main" id="{65C9F527-70C0-3670-FEFD-8C5A34C67427}"/>
                </a:ext>
              </a:extLst>
            </p:cNvPr>
            <p:cNvGraphicFramePr>
              <a:graphicFrameLocks/>
            </p:cNvGraphicFramePr>
            <p:nvPr/>
          </p:nvGraphicFramePr>
          <p:xfrm>
            <a:off x="606425" y="5014899"/>
            <a:ext cx="2660650" cy="1927225"/>
          </p:xfrm>
          <a:graphic>
            <a:graphicData uri="http://schemas.openxmlformats.org/presentationml/2006/ole">
              <mc:AlternateContent xmlns:mc="http://schemas.openxmlformats.org/markup-compatibility/2006">
                <mc:Choice xmlns:v="urn:schemas-microsoft-com:vml" Requires="v">
                  <p:oleObj name="Graph" r:id="rId7" imgW="4153680" imgH="2901600" progId="Origin50.Graph">
                    <p:embed/>
                  </p:oleObj>
                </mc:Choice>
                <mc:Fallback>
                  <p:oleObj name="Graph" r:id="rId7" imgW="4153680" imgH="2901600" progId="Origin50.Graph">
                    <p:embed/>
                    <p:pic>
                      <p:nvPicPr>
                        <p:cNvPr id="82" name="개체 81">
                          <a:extLst>
                            <a:ext uri="{FF2B5EF4-FFF2-40B4-BE49-F238E27FC236}">
                              <a16:creationId xmlns:a16="http://schemas.microsoft.com/office/drawing/2014/main" id="{65C9F527-70C0-3670-FEFD-8C5A34C67427}"/>
                            </a:ext>
                          </a:extLst>
                        </p:cNvPr>
                        <p:cNvPicPr preferRelativeResize="0"/>
                        <p:nvPr/>
                      </p:nvPicPr>
                      <p:blipFill>
                        <a:blip r:embed="rId8"/>
                        <a:stretch>
                          <a:fillRect/>
                        </a:stretch>
                      </p:blipFill>
                      <p:spPr>
                        <a:xfrm>
                          <a:off x="606425" y="5014899"/>
                          <a:ext cx="2660650" cy="1927225"/>
                        </a:xfrm>
                        <a:prstGeom prst="rect">
                          <a:avLst/>
                        </a:prstGeom>
                      </p:spPr>
                    </p:pic>
                  </p:oleObj>
                </mc:Fallback>
              </mc:AlternateContent>
            </a:graphicData>
          </a:graphic>
        </p:graphicFrame>
        <p:sp>
          <p:nvSpPr>
            <p:cNvPr id="83" name="TextBox 82">
              <a:extLst>
                <a:ext uri="{FF2B5EF4-FFF2-40B4-BE49-F238E27FC236}">
                  <a16:creationId xmlns:a16="http://schemas.microsoft.com/office/drawing/2014/main" id="{C408DC34-3682-D603-7AA8-B44E38B45BFF}"/>
                </a:ext>
              </a:extLst>
            </p:cNvPr>
            <p:cNvSpPr txBox="1"/>
            <p:nvPr/>
          </p:nvSpPr>
          <p:spPr>
            <a:xfrm>
              <a:off x="1677452" y="7023137"/>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F4812B6C-F35C-4385-F7F4-7C1A0BD2DDE3}"/>
                </a:ext>
              </a:extLst>
            </p:cNvPr>
            <p:cNvSpPr txBox="1"/>
            <p:nvPr/>
          </p:nvSpPr>
          <p:spPr>
            <a:xfrm>
              <a:off x="1658216" y="6710453"/>
              <a:ext cx="27443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grpSp>
      <p:grpSp>
        <p:nvGrpSpPr>
          <p:cNvPr id="85" name="그룹 84">
            <a:extLst>
              <a:ext uri="{FF2B5EF4-FFF2-40B4-BE49-F238E27FC236}">
                <a16:creationId xmlns:a16="http://schemas.microsoft.com/office/drawing/2014/main" id="{5CF50C28-22CE-31A0-D282-0C1FE5870229}"/>
              </a:ext>
            </a:extLst>
          </p:cNvPr>
          <p:cNvGrpSpPr/>
          <p:nvPr/>
        </p:nvGrpSpPr>
        <p:grpSpPr>
          <a:xfrm>
            <a:off x="3147405" y="4579438"/>
            <a:ext cx="3214764" cy="2383074"/>
            <a:chOff x="3147405" y="4917062"/>
            <a:chExt cx="3214764" cy="2383074"/>
          </a:xfrm>
        </p:grpSpPr>
        <p:graphicFrame>
          <p:nvGraphicFramePr>
            <p:cNvPr id="91" name="개체 90">
              <a:extLst>
                <a:ext uri="{FF2B5EF4-FFF2-40B4-BE49-F238E27FC236}">
                  <a16:creationId xmlns:a16="http://schemas.microsoft.com/office/drawing/2014/main" id="{C91E99D5-FCE0-4D68-0707-63F7391DCDAF}"/>
                </a:ext>
              </a:extLst>
            </p:cNvPr>
            <p:cNvGraphicFramePr>
              <a:graphicFrameLocks/>
            </p:cNvGraphicFramePr>
            <p:nvPr/>
          </p:nvGraphicFramePr>
          <p:xfrm>
            <a:off x="3701769" y="4917062"/>
            <a:ext cx="2660400" cy="1926586"/>
          </p:xfrm>
          <a:graphic>
            <a:graphicData uri="http://schemas.openxmlformats.org/presentationml/2006/ole">
              <mc:AlternateContent xmlns:mc="http://schemas.openxmlformats.org/markup-compatibility/2006">
                <mc:Choice xmlns:v="urn:schemas-microsoft-com:vml" Requires="v">
                  <p:oleObj name="Graph" r:id="rId9" imgW="4153680" imgH="2901600" progId="Origin50.Graph">
                    <p:embed/>
                  </p:oleObj>
                </mc:Choice>
                <mc:Fallback>
                  <p:oleObj name="Graph" r:id="rId9" imgW="4153680" imgH="2901600" progId="Origin50.Graph">
                    <p:embed/>
                    <p:pic>
                      <p:nvPicPr>
                        <p:cNvPr id="91" name="개체 90">
                          <a:extLst>
                            <a:ext uri="{FF2B5EF4-FFF2-40B4-BE49-F238E27FC236}">
                              <a16:creationId xmlns:a16="http://schemas.microsoft.com/office/drawing/2014/main" id="{C91E99D5-FCE0-4D68-0707-63F7391DCDAF}"/>
                            </a:ext>
                          </a:extLst>
                        </p:cNvPr>
                        <p:cNvPicPr preferRelativeResize="0"/>
                        <p:nvPr/>
                      </p:nvPicPr>
                      <p:blipFill>
                        <a:blip r:embed="rId10"/>
                        <a:stretch>
                          <a:fillRect/>
                        </a:stretch>
                      </p:blipFill>
                      <p:spPr>
                        <a:xfrm>
                          <a:off x="3701769" y="4917062"/>
                          <a:ext cx="2660400" cy="1926586"/>
                        </a:xfrm>
                        <a:prstGeom prst="rect">
                          <a:avLst/>
                        </a:prstGeom>
                      </p:spPr>
                    </p:pic>
                  </p:oleObj>
                </mc:Fallback>
              </mc:AlternateContent>
            </a:graphicData>
          </a:graphic>
        </p:graphicFrame>
        <p:sp>
          <p:nvSpPr>
            <p:cNvPr id="97" name="TextBox 96">
              <a:extLst>
                <a:ext uri="{FF2B5EF4-FFF2-40B4-BE49-F238E27FC236}">
                  <a16:creationId xmlns:a16="http://schemas.microsoft.com/office/drawing/2014/main" id="{FA9B33C2-D6F5-387D-6657-94DE083AEEC9}"/>
                </a:ext>
              </a:extLst>
            </p:cNvPr>
            <p:cNvSpPr txBox="1"/>
            <p:nvPr/>
          </p:nvSpPr>
          <p:spPr>
            <a:xfrm>
              <a:off x="3691913" y="7023137"/>
              <a:ext cx="775533" cy="276999"/>
            </a:xfrm>
            <a:prstGeom prst="rect">
              <a:avLst/>
            </a:prstGeom>
            <a:noFill/>
          </p:spPr>
          <p:txBody>
            <a:bodyPr wrap="none" rtlCol="0" anchor="ctr">
              <a:spAutoFit/>
            </a:bodyPr>
            <a:lstStyle/>
            <a:p>
              <a:pPr algn="r"/>
              <a:r>
                <a:rPr lang="en-US" altLang="ko-KR" sz="1200" dirty="0">
                  <a:latin typeface="Arial" panose="020B0604020202020204" pitchFamily="34" charset="0"/>
                  <a:cs typeface="Arial" panose="020B0604020202020204" pitchFamily="34" charset="0"/>
                </a:rPr>
                <a:t>IPA (</a:t>
              </a:r>
              <a:r>
                <a:rPr lang="el-GR" altLang="ko-KR" sz="1200" dirty="0">
                  <a:latin typeface="Arial" panose="020B0604020202020204" pitchFamily="34" charset="0"/>
                  <a:cs typeface="Arial" panose="020B0604020202020204" pitchFamily="34" charset="0"/>
                </a:rPr>
                <a:t>μ</a:t>
              </a:r>
              <a:r>
                <a:rPr lang="en-US" altLang="ko-KR" sz="1200" dirty="0">
                  <a:latin typeface="Arial" panose="020B0604020202020204" pitchFamily="34" charset="0"/>
                  <a:cs typeface="Arial" panose="020B0604020202020204" pitchFamily="34" charset="0"/>
                </a:rPr>
                <a:t>M)</a:t>
              </a:r>
              <a:endParaRPr lang="ko-KR" altLang="en-US" sz="1200" dirty="0">
                <a:latin typeface="Arial" panose="020B0604020202020204" pitchFamily="34" charset="0"/>
                <a:cs typeface="Arial" panose="020B0604020202020204" pitchFamily="34" charset="0"/>
              </a:endParaRPr>
            </a:p>
          </p:txBody>
        </p:sp>
        <p:sp>
          <p:nvSpPr>
            <p:cNvPr id="98" name="TextBox 97">
              <a:extLst>
                <a:ext uri="{FF2B5EF4-FFF2-40B4-BE49-F238E27FC236}">
                  <a16:creationId xmlns:a16="http://schemas.microsoft.com/office/drawing/2014/main" id="{E7E508C4-0949-FC1A-41BE-18E4717CC0A5}"/>
                </a:ext>
              </a:extLst>
            </p:cNvPr>
            <p:cNvSpPr txBox="1"/>
            <p:nvPr/>
          </p:nvSpPr>
          <p:spPr>
            <a:xfrm>
              <a:off x="4401920" y="7023137"/>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99" name="TextBox 98">
              <a:extLst>
                <a:ext uri="{FF2B5EF4-FFF2-40B4-BE49-F238E27FC236}">
                  <a16:creationId xmlns:a16="http://schemas.microsoft.com/office/drawing/2014/main" id="{4CC859B7-202E-6ECA-B327-41D6A9C60A54}"/>
                </a:ext>
              </a:extLst>
            </p:cNvPr>
            <p:cNvSpPr txBox="1"/>
            <p:nvPr/>
          </p:nvSpPr>
          <p:spPr>
            <a:xfrm>
              <a:off x="5123216" y="7023137"/>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a:t>
              </a:r>
              <a:endParaRPr lang="ko-KR" altLang="en-US" sz="1200" dirty="0">
                <a:latin typeface="Arial" panose="020B0604020202020204" pitchFamily="34" charset="0"/>
                <a:cs typeface="Arial" panose="020B0604020202020204" pitchFamily="34" charset="0"/>
              </a:endParaRPr>
            </a:p>
          </p:txBody>
        </p:sp>
        <p:sp>
          <p:nvSpPr>
            <p:cNvPr id="100" name="TextBox 99">
              <a:extLst>
                <a:ext uri="{FF2B5EF4-FFF2-40B4-BE49-F238E27FC236}">
                  <a16:creationId xmlns:a16="http://schemas.microsoft.com/office/drawing/2014/main" id="{BCAD2BB2-0695-2766-E80E-1EAD2DBFC4F9}"/>
                </a:ext>
              </a:extLst>
            </p:cNvPr>
            <p:cNvSpPr txBox="1"/>
            <p:nvPr/>
          </p:nvSpPr>
          <p:spPr>
            <a:xfrm>
              <a:off x="5476207" y="7023137"/>
              <a:ext cx="269626"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5</a:t>
              </a:r>
              <a:endParaRPr lang="ko-KR" altLang="en-US" sz="1200" dirty="0">
                <a:latin typeface="Arial" panose="020B0604020202020204" pitchFamily="34" charset="0"/>
                <a:cs typeface="Arial" panose="020B0604020202020204" pitchFamily="34" charset="0"/>
              </a:endParaRPr>
            </a:p>
          </p:txBody>
        </p:sp>
        <p:sp>
          <p:nvSpPr>
            <p:cNvPr id="101" name="TextBox 100">
              <a:extLst>
                <a:ext uri="{FF2B5EF4-FFF2-40B4-BE49-F238E27FC236}">
                  <a16:creationId xmlns:a16="http://schemas.microsoft.com/office/drawing/2014/main" id="{CF52D1C4-CA08-4AF3-6BBD-9024748DD5CE}"/>
                </a:ext>
              </a:extLst>
            </p:cNvPr>
            <p:cNvSpPr txBox="1"/>
            <p:nvPr/>
          </p:nvSpPr>
          <p:spPr>
            <a:xfrm>
              <a:off x="5793692" y="7023137"/>
              <a:ext cx="35458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10</a:t>
              </a:r>
              <a:endParaRPr lang="ko-KR" altLang="en-US" sz="1200" dirty="0">
                <a:latin typeface="Arial" panose="020B0604020202020204" pitchFamily="34" charset="0"/>
                <a:cs typeface="Arial" panose="020B0604020202020204" pitchFamily="34" charset="0"/>
              </a:endParaRPr>
            </a:p>
          </p:txBody>
        </p:sp>
        <p:sp>
          <p:nvSpPr>
            <p:cNvPr id="102" name="TextBox 101">
              <a:extLst>
                <a:ext uri="{FF2B5EF4-FFF2-40B4-BE49-F238E27FC236}">
                  <a16:creationId xmlns:a16="http://schemas.microsoft.com/office/drawing/2014/main" id="{0FE70544-897C-8D9B-F3BE-67127558DEC4}"/>
                </a:ext>
              </a:extLst>
            </p:cNvPr>
            <p:cNvSpPr txBox="1"/>
            <p:nvPr/>
          </p:nvSpPr>
          <p:spPr>
            <a:xfrm>
              <a:off x="3147405" y="6710453"/>
              <a:ext cx="1320041" cy="276999"/>
            </a:xfrm>
            <a:prstGeom prst="rect">
              <a:avLst/>
            </a:prstGeom>
            <a:noFill/>
          </p:spPr>
          <p:txBody>
            <a:bodyPr wrap="none" rtlCol="0" anchor="ctr">
              <a:spAutoFit/>
            </a:bodyPr>
            <a:lstStyle/>
            <a:p>
              <a:pPr algn="r"/>
              <a:r>
                <a:rPr lang="en-US" altLang="ko-KR" sz="1200" dirty="0">
                  <a:latin typeface="Arial" panose="020B0604020202020204" pitchFamily="34" charset="0"/>
                  <a:cs typeface="Arial" panose="020B0604020202020204" pitchFamily="34" charset="0"/>
                </a:rPr>
                <a:t>DEP (</a:t>
              </a:r>
              <a:r>
                <a:rPr lang="en-US" altLang="ko-KR" sz="1200" dirty="0">
                  <a:latin typeface="Arial" panose="020B0604020202020204" pitchFamily="34" charset="0"/>
                  <a:cs typeface="Arial" panose="020B0604020202020204" pitchFamily="34" charset="0"/>
                  <a:sym typeface="Symbol" panose="05050102010706020507" pitchFamily="18" charset="2"/>
                </a:rPr>
                <a:t>100 </a:t>
              </a:r>
              <a:r>
                <a:rPr lang="el-GR" altLang="ko-KR" sz="1200" dirty="0">
                  <a:latin typeface="Arial" panose="020B0604020202020204" pitchFamily="34" charset="0"/>
                  <a:cs typeface="Arial" panose="020B0604020202020204" pitchFamily="34" charset="0"/>
                </a:rPr>
                <a:t>μ</a:t>
              </a:r>
              <a:r>
                <a:rPr lang="en-US" altLang="ko-KR" sz="1200" dirty="0">
                  <a:latin typeface="Arial" panose="020B0604020202020204" pitchFamily="34" charset="0"/>
                  <a:cs typeface="Arial" panose="020B0604020202020204" pitchFamily="34" charset="0"/>
                </a:rPr>
                <a:t>g/ml)</a:t>
              </a:r>
              <a:endParaRPr lang="ko-KR" altLang="en-US" sz="1200" dirty="0">
                <a:latin typeface="Arial" panose="020B0604020202020204" pitchFamily="34" charset="0"/>
                <a:cs typeface="Arial" panose="020B0604020202020204" pitchFamily="34" charset="0"/>
              </a:endParaRPr>
            </a:p>
          </p:txBody>
        </p:sp>
        <p:sp>
          <p:nvSpPr>
            <p:cNvPr id="103" name="TextBox 102">
              <a:extLst>
                <a:ext uri="{FF2B5EF4-FFF2-40B4-BE49-F238E27FC236}">
                  <a16:creationId xmlns:a16="http://schemas.microsoft.com/office/drawing/2014/main" id="{7080DC1F-B3FC-B6B4-167D-ABA801F6EBA2}"/>
                </a:ext>
              </a:extLst>
            </p:cNvPr>
            <p:cNvSpPr txBox="1"/>
            <p:nvPr/>
          </p:nvSpPr>
          <p:spPr>
            <a:xfrm>
              <a:off x="4401920" y="6710453"/>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104" name="TextBox 103">
              <a:extLst>
                <a:ext uri="{FF2B5EF4-FFF2-40B4-BE49-F238E27FC236}">
                  <a16:creationId xmlns:a16="http://schemas.microsoft.com/office/drawing/2014/main" id="{EACA5A7A-F401-FD1E-5A94-89DFB080B20C}"/>
                </a:ext>
              </a:extLst>
            </p:cNvPr>
            <p:cNvSpPr txBox="1"/>
            <p:nvPr/>
          </p:nvSpPr>
          <p:spPr>
            <a:xfrm>
              <a:off x="5473803" y="6706555"/>
              <a:ext cx="274434"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105" name="TextBox 104">
              <a:extLst>
                <a:ext uri="{FF2B5EF4-FFF2-40B4-BE49-F238E27FC236}">
                  <a16:creationId xmlns:a16="http://schemas.microsoft.com/office/drawing/2014/main" id="{37FB4D99-5B41-C7CE-30DA-36AEC101A7B8}"/>
                </a:ext>
              </a:extLst>
            </p:cNvPr>
            <p:cNvSpPr txBox="1"/>
            <p:nvPr/>
          </p:nvSpPr>
          <p:spPr>
            <a:xfrm>
              <a:off x="5120812" y="6710453"/>
              <a:ext cx="274434"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106" name="TextBox 105">
              <a:extLst>
                <a:ext uri="{FF2B5EF4-FFF2-40B4-BE49-F238E27FC236}">
                  <a16:creationId xmlns:a16="http://schemas.microsoft.com/office/drawing/2014/main" id="{CE509DB5-E8A8-D449-C45C-5996A5B9B957}"/>
                </a:ext>
              </a:extLst>
            </p:cNvPr>
            <p:cNvSpPr txBox="1"/>
            <p:nvPr/>
          </p:nvSpPr>
          <p:spPr>
            <a:xfrm>
              <a:off x="5833767" y="6706555"/>
              <a:ext cx="274434"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108" name="TextBox 107">
              <a:extLst>
                <a:ext uri="{FF2B5EF4-FFF2-40B4-BE49-F238E27FC236}">
                  <a16:creationId xmlns:a16="http://schemas.microsoft.com/office/drawing/2014/main" id="{DC2727C0-49C2-8A50-1811-C6FA389112E0}"/>
                </a:ext>
              </a:extLst>
            </p:cNvPr>
            <p:cNvSpPr txBox="1"/>
            <p:nvPr/>
          </p:nvSpPr>
          <p:spPr>
            <a:xfrm>
              <a:off x="4771852" y="7023137"/>
              <a:ext cx="235962"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sp>
          <p:nvSpPr>
            <p:cNvPr id="109" name="TextBox 108">
              <a:extLst>
                <a:ext uri="{FF2B5EF4-FFF2-40B4-BE49-F238E27FC236}">
                  <a16:creationId xmlns:a16="http://schemas.microsoft.com/office/drawing/2014/main" id="{AC2DB5F6-4FAE-C8F6-E9E7-822FE11ED7BD}"/>
                </a:ext>
              </a:extLst>
            </p:cNvPr>
            <p:cNvSpPr txBox="1"/>
            <p:nvPr/>
          </p:nvSpPr>
          <p:spPr>
            <a:xfrm>
              <a:off x="4752616" y="6710453"/>
              <a:ext cx="274435" cy="276999"/>
            </a:xfrm>
            <a:prstGeom prst="rect">
              <a:avLst/>
            </a:prstGeom>
            <a:noFill/>
          </p:spPr>
          <p:txBody>
            <a:bodyPr wrap="none" rtlCol="0" anchor="ctr">
              <a:spAutoFit/>
            </a:bodyPr>
            <a:lstStyle/>
            <a:p>
              <a:pPr algn="ctr"/>
              <a:r>
                <a:rPr lang="en-US" altLang="ko-KR" sz="1200" dirty="0">
                  <a:latin typeface="Arial" panose="020B0604020202020204" pitchFamily="34" charset="0"/>
                  <a:cs typeface="Arial" panose="020B0604020202020204" pitchFamily="34" charset="0"/>
                </a:rPr>
                <a:t>+</a:t>
              </a:r>
              <a:endParaRPr lang="ko-KR" altLang="en-US" sz="1200" dirty="0">
                <a:latin typeface="Arial" panose="020B0604020202020204" pitchFamily="34" charset="0"/>
                <a:cs typeface="Arial" panose="020B0604020202020204" pitchFamily="34" charset="0"/>
              </a:endParaRPr>
            </a:p>
          </p:txBody>
        </p:sp>
      </p:grpSp>
      <p:sp>
        <p:nvSpPr>
          <p:cNvPr id="110" name="TextBox 109">
            <a:extLst>
              <a:ext uri="{FF2B5EF4-FFF2-40B4-BE49-F238E27FC236}">
                <a16:creationId xmlns:a16="http://schemas.microsoft.com/office/drawing/2014/main" id="{C31C0A2F-3197-FA7B-33E7-03D7C3C1A707}"/>
              </a:ext>
            </a:extLst>
          </p:cNvPr>
          <p:cNvSpPr txBox="1"/>
          <p:nvPr/>
        </p:nvSpPr>
        <p:spPr>
          <a:xfrm>
            <a:off x="303775" y="4713637"/>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D541C266-DEDD-7DA6-26A8-B792BDE3C3AF}"/>
              </a:ext>
            </a:extLst>
          </p:cNvPr>
          <p:cNvSpPr txBox="1"/>
          <p:nvPr/>
        </p:nvSpPr>
        <p:spPr>
          <a:xfrm>
            <a:off x="243715" y="7652245"/>
            <a:ext cx="6370570" cy="1384995"/>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1. </a:t>
            </a:r>
            <a:r>
              <a:rPr lang="en-US" altLang="ko-KR" sz="1200" dirty="0">
                <a:latin typeface="Times New Roman" panose="02020603050405020304" pitchFamily="18" charset="0"/>
                <a:cs typeface="Times New Roman" panose="02020603050405020304" pitchFamily="18" charset="0"/>
              </a:rPr>
              <a:t>Effect of IPA on DEP-induced cytotoxicity in </a:t>
            </a:r>
            <a:r>
              <a:rPr lang="en-US" altLang="ko-KR" sz="1200" dirty="0" err="1">
                <a:latin typeface="Times New Roman" panose="02020603050405020304" pitchFamily="18" charset="0"/>
                <a:cs typeface="Times New Roman" panose="02020603050405020304" pitchFamily="18" charset="0"/>
              </a:rPr>
              <a:t>HaCaT</a:t>
            </a:r>
            <a:r>
              <a:rPr lang="en-US" altLang="ko-KR" sz="1200" dirty="0">
                <a:latin typeface="Times New Roman" panose="02020603050405020304" pitchFamily="18" charset="0"/>
                <a:cs typeface="Times New Roman" panose="02020603050405020304" pitchFamily="18" charset="0"/>
              </a:rPr>
              <a:t> cells</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A) IPA structure is presented.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HaCaT</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cells were challenged with varying levels of IPA (1-20 </a:t>
            </a:r>
            <a:r>
              <a:rPr lang="en-US" altLang="ko-KR" sz="1200" kern="100" dirty="0" err="1">
                <a:effectLst/>
                <a:latin typeface="Times New Roman" panose="02020603050405020304" pitchFamily="18" charset="0"/>
                <a:ea typeface="Times New Roman" panose="02020603050405020304" pitchFamily="18" charset="0"/>
                <a:cs typeface="Arial" panose="020B0604020202020204" pitchFamily="34" charset="0"/>
              </a:rPr>
              <a:t>μ</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for 24 h. (B) Cell viability and cytotoxicity were measured by MTT and LDH assays, respectively. Cells were pretreated with 1-10 </a:t>
            </a:r>
            <a:r>
              <a:rPr lang="en-US" altLang="ko-KR" sz="1200" kern="100" dirty="0" err="1">
                <a:effectLst/>
                <a:latin typeface="Times New Roman" panose="02020603050405020304" pitchFamily="18" charset="0"/>
                <a:ea typeface="Times New Roman" panose="02020603050405020304" pitchFamily="18" charset="0"/>
                <a:cs typeface="Arial" panose="020B0604020202020204" pitchFamily="34" charset="0"/>
              </a:rPr>
              <a:t>μ</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followed by treatment with DEP 100 </a:t>
            </a:r>
            <a:r>
              <a:rPr lang="en-US" altLang="ko-KR" sz="1200" kern="100" dirty="0" err="1">
                <a:effectLst/>
                <a:latin typeface="Times New Roman" panose="02020603050405020304" pitchFamily="18" charset="0"/>
                <a:ea typeface="Times New Roman" panose="02020603050405020304" pitchFamily="18" charset="0"/>
                <a:cs typeface="Arial" panose="020B0604020202020204" pitchFamily="34" charset="0"/>
              </a:rPr>
              <a:t>μ</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g</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ml for 24 h. (C) The cell viability and cytotoxicity were assessed using MTT and LDH assay. All experiments were performed thrice. Data are expressed as the mean ± SD. *p&lt; 0.01 compared to the control group. </a:t>
            </a:r>
            <a:r>
              <a:rPr lang="en-US" altLang="ko-KR" sz="1200" kern="100" baseline="30000" dirty="0">
                <a:effectLst/>
                <a:latin typeface="Times New Roman" panose="02020603050405020304" pitchFamily="18" charset="0"/>
                <a:ea typeface="맑은 고딕" panose="020B0503020000020004" pitchFamily="50" charset="-127"/>
                <a:cs typeface="Arial" panose="020B0604020202020204" pitchFamily="34" charset="0"/>
              </a:rPr>
              <a:t>#</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p&lt; 0.01 compared to the control group.</a:t>
            </a:r>
            <a:endParaRPr lang="ko-KR" altLang="ko-KR" sz="1200" kern="100" dirty="0">
              <a:effectLst/>
              <a:latin typeface="Aptos" panose="020B0004020202020204" pitchFamily="34" charset="0"/>
              <a:ea typeface="맑은 고딕" panose="020B0503020000020004" pitchFamily="50" charset="-127"/>
              <a:cs typeface="Arial" panose="020B0604020202020204" pitchFamily="34" charset="0"/>
            </a:endParaRPr>
          </a:p>
        </p:txBody>
      </p:sp>
      <p:sp>
        <p:nvSpPr>
          <p:cNvPr id="7" name="TextBox 6">
            <a:extLst>
              <a:ext uri="{FF2B5EF4-FFF2-40B4-BE49-F238E27FC236}">
                <a16:creationId xmlns:a16="http://schemas.microsoft.com/office/drawing/2014/main" id="{00AD5367-6A93-669F-3104-E50D0590BAF8}"/>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1.</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Tree>
    <p:extLst>
      <p:ext uri="{BB962C8B-B14F-4D97-AF65-F5344CB8AC3E}">
        <p14:creationId xmlns:p14="http://schemas.microsoft.com/office/powerpoint/2010/main" val="20025240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78848C-9159-4A78-635D-BFFB1065598E}"/>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D0405A70-DBD7-4F91-447C-0A5E004CA49E}"/>
              </a:ext>
            </a:extLst>
          </p:cNvPr>
          <p:cNvSpPr txBox="1"/>
          <p:nvPr/>
        </p:nvSpPr>
        <p:spPr>
          <a:xfrm>
            <a:off x="303776" y="727143"/>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707EDC45-25D0-9504-BE17-0117D875FBDF}"/>
              </a:ext>
            </a:extLst>
          </p:cNvPr>
          <p:cNvSpPr txBox="1"/>
          <p:nvPr/>
        </p:nvSpPr>
        <p:spPr>
          <a:xfrm>
            <a:off x="243715" y="8001616"/>
            <a:ext cx="6370570" cy="1200329"/>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2. </a:t>
            </a:r>
            <a:r>
              <a:rPr lang="en-US" altLang="ko-KR" sz="1200" dirty="0">
                <a:latin typeface="Times New Roman" panose="02020603050405020304" pitchFamily="18" charset="0"/>
                <a:cs typeface="Times New Roman" panose="02020603050405020304" pitchFamily="18" charset="0"/>
              </a:rPr>
              <a:t>Effect of DEP on NLRP1 inflammasome complex in </a:t>
            </a:r>
            <a:r>
              <a:rPr lang="en-US" altLang="ko-KR" sz="1200" dirty="0" err="1">
                <a:latin typeface="Times New Roman" panose="02020603050405020304" pitchFamily="18" charset="0"/>
                <a:cs typeface="Times New Roman" panose="02020603050405020304" pitchFamily="18" charset="0"/>
              </a:rPr>
              <a:t>HaCaT</a:t>
            </a:r>
            <a:r>
              <a:rPr lang="en-US" altLang="ko-KR" sz="1200" dirty="0">
                <a:latin typeface="Times New Roman" panose="02020603050405020304" pitchFamily="18" charset="0"/>
                <a:cs typeface="Times New Roman" panose="02020603050405020304" pitchFamily="18" charset="0"/>
              </a:rPr>
              <a:t> cells</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Cells were treated with 10–10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g</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ml DEP for 24 h or 30 min. (A) Quantification of band intensity from Figure 1A, normalized to the corresponding loading control. (B) Quantification of band intensity from Figure 1C, normalized to the corresponding loading control. The band intensity was analyzed using the ImageJ program. All experiments were performed thrice (n=3). Data are expressed as the mean ± SD. *p&lt; 0.01 compared to the control group.</a:t>
            </a:r>
          </a:p>
        </p:txBody>
      </p:sp>
      <p:sp>
        <p:nvSpPr>
          <p:cNvPr id="5" name="TextBox 4">
            <a:extLst>
              <a:ext uri="{FF2B5EF4-FFF2-40B4-BE49-F238E27FC236}">
                <a16:creationId xmlns:a16="http://schemas.microsoft.com/office/drawing/2014/main" id="{F86902AB-5575-0788-3112-D6BA0EF93247}"/>
              </a:ext>
            </a:extLst>
          </p:cNvPr>
          <p:cNvSpPr txBox="1"/>
          <p:nvPr/>
        </p:nvSpPr>
        <p:spPr>
          <a:xfrm>
            <a:off x="354186" y="4420604"/>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87" name="TextBox 86">
            <a:extLst>
              <a:ext uri="{FF2B5EF4-FFF2-40B4-BE49-F238E27FC236}">
                <a16:creationId xmlns:a16="http://schemas.microsoft.com/office/drawing/2014/main" id="{3457BAFD-8EB6-F8EA-F100-E1A18F67F457}"/>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2.</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nvGrpSpPr>
          <p:cNvPr id="6" name="그룹 5">
            <a:extLst>
              <a:ext uri="{FF2B5EF4-FFF2-40B4-BE49-F238E27FC236}">
                <a16:creationId xmlns:a16="http://schemas.microsoft.com/office/drawing/2014/main" id="{9C53E567-4C74-0C8E-AACE-7AC126D9F7EA}"/>
              </a:ext>
            </a:extLst>
          </p:cNvPr>
          <p:cNvGrpSpPr/>
          <p:nvPr/>
        </p:nvGrpSpPr>
        <p:grpSpPr>
          <a:xfrm>
            <a:off x="649460" y="661333"/>
            <a:ext cx="4310063" cy="3144296"/>
            <a:chOff x="704324" y="626560"/>
            <a:chExt cx="4310063" cy="3144296"/>
          </a:xfrm>
        </p:grpSpPr>
        <p:sp>
          <p:nvSpPr>
            <p:cNvPr id="70" name="TextBox 69">
              <a:extLst>
                <a:ext uri="{FF2B5EF4-FFF2-40B4-BE49-F238E27FC236}">
                  <a16:creationId xmlns:a16="http://schemas.microsoft.com/office/drawing/2014/main" id="{35743381-E4D6-FC1C-2C96-44B3FAD76E15}"/>
                </a:ext>
              </a:extLst>
            </p:cNvPr>
            <p:cNvSpPr txBox="1"/>
            <p:nvPr/>
          </p:nvSpPr>
          <p:spPr>
            <a:xfrm>
              <a:off x="1470637" y="3386135"/>
              <a:ext cx="59663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NLRP1</a:t>
              </a:r>
              <a:endParaRPr lang="ko-KR" altLang="en-US" sz="1000" dirty="0">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A1F9CBAA-259F-3C4C-DA36-3DDE98E5DB1F}"/>
                </a:ext>
              </a:extLst>
            </p:cNvPr>
            <p:cNvSpPr txBox="1"/>
            <p:nvPr/>
          </p:nvSpPr>
          <p:spPr>
            <a:xfrm>
              <a:off x="1870621" y="3386135"/>
              <a:ext cx="744114"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N-terminal</a:t>
              </a:r>
            </a:p>
            <a:p>
              <a:pPr algn="ctr"/>
              <a:r>
                <a:rPr lang="en-US" altLang="ko-KR" sz="950" dirty="0">
                  <a:latin typeface="Arial" panose="020B0604020202020204" pitchFamily="34" charset="0"/>
                  <a:cs typeface="Arial" panose="020B0604020202020204" pitchFamily="34" charset="0"/>
                </a:rPr>
                <a:t>GSDMD</a:t>
              </a:r>
              <a:endParaRPr lang="ko-KR" altLang="en-US" sz="950"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61E381E7-C57A-0688-5118-EF35600D504B}"/>
                </a:ext>
              </a:extLst>
            </p:cNvPr>
            <p:cNvSpPr txBox="1"/>
            <p:nvPr/>
          </p:nvSpPr>
          <p:spPr>
            <a:xfrm>
              <a:off x="2512636" y="3386135"/>
              <a:ext cx="44755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ASC</a:t>
              </a:r>
              <a:endParaRPr lang="ko-KR" altLang="en-US" sz="1000" dirty="0">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37F42759-EE91-0630-2076-CB32003FABBA}"/>
                </a:ext>
              </a:extLst>
            </p:cNvPr>
            <p:cNvSpPr txBox="1"/>
            <p:nvPr/>
          </p:nvSpPr>
          <p:spPr>
            <a:xfrm>
              <a:off x="2973825" y="3386135"/>
              <a:ext cx="518091"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NEK7</a:t>
              </a:r>
              <a:endParaRPr lang="ko-KR" altLang="en-US" sz="1000" dirty="0">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BEA9ED32-A002-3A3C-CA57-4994E316191E}"/>
                </a:ext>
              </a:extLst>
            </p:cNvPr>
            <p:cNvSpPr txBox="1"/>
            <p:nvPr/>
          </p:nvSpPr>
          <p:spPr>
            <a:xfrm>
              <a:off x="3316303" y="3386135"/>
              <a:ext cx="771365"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Cleaved</a:t>
              </a:r>
            </a:p>
            <a:p>
              <a:pPr algn="ctr"/>
              <a:r>
                <a:rPr lang="en-US" altLang="ko-KR" sz="950" dirty="0">
                  <a:latin typeface="Arial" panose="020B0604020202020204" pitchFamily="34" charset="0"/>
                  <a:cs typeface="Arial" panose="020B0604020202020204" pitchFamily="34" charset="0"/>
                </a:rPr>
                <a:t>Caspase-1</a:t>
              </a:r>
              <a:endParaRPr lang="ko-KR" altLang="en-US" sz="950" dirty="0">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6CA5D662-C873-5625-385D-88EEF77298EF}"/>
                </a:ext>
              </a:extLst>
            </p:cNvPr>
            <p:cNvSpPr txBox="1"/>
            <p:nvPr/>
          </p:nvSpPr>
          <p:spPr>
            <a:xfrm>
              <a:off x="3886101" y="3386135"/>
              <a:ext cx="630301"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Cleaved</a:t>
              </a:r>
            </a:p>
            <a:p>
              <a:pPr algn="ctr"/>
              <a:r>
                <a:rPr lang="en-US" altLang="ko-KR" sz="950" dirty="0">
                  <a:latin typeface="Arial" panose="020B0604020202020204" pitchFamily="34" charset="0"/>
                  <a:cs typeface="Arial" panose="020B0604020202020204" pitchFamily="34" charset="0"/>
                </a:rPr>
                <a:t>IL-1</a:t>
              </a:r>
              <a:r>
                <a:rPr lang="en-US" altLang="ko-KR" sz="950" dirty="0">
                  <a:latin typeface="Arial" panose="020B0604020202020204" pitchFamily="34" charset="0"/>
                  <a:cs typeface="Arial" panose="020B0604020202020204" pitchFamily="34" charset="0"/>
                  <a:sym typeface="Symbol" panose="05050102010706020507" pitchFamily="18" charset="2"/>
                </a:rPr>
                <a:t></a:t>
              </a:r>
              <a:endParaRPr lang="ko-KR" altLang="en-US" sz="950"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C8800FA7-7F50-DB9A-8DF8-C5D96887A2B2}"/>
                </a:ext>
              </a:extLst>
            </p:cNvPr>
            <p:cNvGraphicFramePr>
              <a:graphicFrameLocks noChangeAspect="1"/>
            </p:cNvGraphicFramePr>
            <p:nvPr>
              <p:extLst>
                <p:ext uri="{D42A27DB-BD31-4B8C-83A1-F6EECF244321}">
                  <p14:modId xmlns:p14="http://schemas.microsoft.com/office/powerpoint/2010/main" val="1729801400"/>
                </p:ext>
              </p:extLst>
            </p:nvPr>
          </p:nvGraphicFramePr>
          <p:xfrm>
            <a:off x="704324" y="626560"/>
            <a:ext cx="4310063" cy="3048000"/>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3" name="개체 2">
                          <a:extLst>
                            <a:ext uri="{FF2B5EF4-FFF2-40B4-BE49-F238E27FC236}">
                              <a16:creationId xmlns:a16="http://schemas.microsoft.com/office/drawing/2014/main" id="{C8800FA7-7F50-DB9A-8DF8-C5D96887A2B2}"/>
                            </a:ext>
                          </a:extLst>
                        </p:cNvPr>
                        <p:cNvPicPr/>
                        <p:nvPr/>
                      </p:nvPicPr>
                      <p:blipFill>
                        <a:blip r:embed="rId3"/>
                        <a:stretch>
                          <a:fillRect/>
                        </a:stretch>
                      </p:blipFill>
                      <p:spPr>
                        <a:xfrm>
                          <a:off x="704324" y="626560"/>
                          <a:ext cx="4310063" cy="3048000"/>
                        </a:xfrm>
                        <a:prstGeom prst="rect">
                          <a:avLst/>
                        </a:prstGeom>
                      </p:spPr>
                    </p:pic>
                  </p:oleObj>
                </mc:Fallback>
              </mc:AlternateContent>
            </a:graphicData>
          </a:graphic>
        </p:graphicFrame>
      </p:grpSp>
      <p:grpSp>
        <p:nvGrpSpPr>
          <p:cNvPr id="11" name="그룹 10">
            <a:extLst>
              <a:ext uri="{FF2B5EF4-FFF2-40B4-BE49-F238E27FC236}">
                <a16:creationId xmlns:a16="http://schemas.microsoft.com/office/drawing/2014/main" id="{AD0C4A21-C115-EAE4-76B5-4694C4D9CBAA}"/>
              </a:ext>
            </a:extLst>
          </p:cNvPr>
          <p:cNvGrpSpPr/>
          <p:nvPr/>
        </p:nvGrpSpPr>
        <p:grpSpPr>
          <a:xfrm>
            <a:off x="599050" y="4331474"/>
            <a:ext cx="4310063" cy="3048000"/>
            <a:chOff x="599050" y="4188206"/>
            <a:chExt cx="4310063" cy="3048000"/>
          </a:xfrm>
        </p:grpSpPr>
        <p:sp>
          <p:nvSpPr>
            <p:cNvPr id="89" name="TextBox 88">
              <a:extLst>
                <a:ext uri="{FF2B5EF4-FFF2-40B4-BE49-F238E27FC236}">
                  <a16:creationId xmlns:a16="http://schemas.microsoft.com/office/drawing/2014/main" id="{7626A96D-E32A-BB69-78E7-B16D28041D2D}"/>
                </a:ext>
              </a:extLst>
            </p:cNvPr>
            <p:cNvSpPr txBox="1"/>
            <p:nvPr/>
          </p:nvSpPr>
          <p:spPr>
            <a:xfrm>
              <a:off x="1595048" y="6915998"/>
              <a:ext cx="123623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NF-</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NF-</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a:t>
              </a:r>
            </a:p>
          </p:txBody>
        </p:sp>
        <p:sp>
          <p:nvSpPr>
            <p:cNvPr id="90" name="TextBox 89">
              <a:extLst>
                <a:ext uri="{FF2B5EF4-FFF2-40B4-BE49-F238E27FC236}">
                  <a16:creationId xmlns:a16="http://schemas.microsoft.com/office/drawing/2014/main" id="{0D884489-ECC5-06B2-0AB5-F69F98F560CF}"/>
                </a:ext>
              </a:extLst>
            </p:cNvPr>
            <p:cNvSpPr txBox="1"/>
            <p:nvPr/>
          </p:nvSpPr>
          <p:spPr>
            <a:xfrm>
              <a:off x="3250013" y="6915998"/>
              <a:ext cx="86113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I</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I-</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a:t>
              </a:r>
            </a:p>
          </p:txBody>
        </p:sp>
        <p:graphicFrame>
          <p:nvGraphicFramePr>
            <p:cNvPr id="9" name="개체 8">
              <a:extLst>
                <a:ext uri="{FF2B5EF4-FFF2-40B4-BE49-F238E27FC236}">
                  <a16:creationId xmlns:a16="http://schemas.microsoft.com/office/drawing/2014/main" id="{61863101-F945-8383-7214-B972F55CF529}"/>
                </a:ext>
              </a:extLst>
            </p:cNvPr>
            <p:cNvGraphicFramePr>
              <a:graphicFrameLocks noChangeAspect="1"/>
            </p:cNvGraphicFramePr>
            <p:nvPr>
              <p:extLst>
                <p:ext uri="{D42A27DB-BD31-4B8C-83A1-F6EECF244321}">
                  <p14:modId xmlns:p14="http://schemas.microsoft.com/office/powerpoint/2010/main" val="429381180"/>
                </p:ext>
              </p:extLst>
            </p:nvPr>
          </p:nvGraphicFramePr>
          <p:xfrm>
            <a:off x="599050" y="4188206"/>
            <a:ext cx="4310063" cy="3048000"/>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9" name="개체 8">
                          <a:extLst>
                            <a:ext uri="{FF2B5EF4-FFF2-40B4-BE49-F238E27FC236}">
                              <a16:creationId xmlns:a16="http://schemas.microsoft.com/office/drawing/2014/main" id="{61863101-F945-8383-7214-B972F55CF529}"/>
                            </a:ext>
                          </a:extLst>
                        </p:cNvPr>
                        <p:cNvPicPr/>
                        <p:nvPr/>
                      </p:nvPicPr>
                      <p:blipFill>
                        <a:blip r:embed="rId5"/>
                        <a:stretch>
                          <a:fillRect/>
                        </a:stretch>
                      </p:blipFill>
                      <p:spPr>
                        <a:xfrm>
                          <a:off x="599050" y="4188206"/>
                          <a:ext cx="4310063" cy="3048000"/>
                        </a:xfrm>
                        <a:prstGeom prst="rect">
                          <a:avLst/>
                        </a:prstGeom>
                      </p:spPr>
                    </p:pic>
                  </p:oleObj>
                </mc:Fallback>
              </mc:AlternateContent>
            </a:graphicData>
          </a:graphic>
        </p:graphicFrame>
      </p:grpSp>
    </p:spTree>
    <p:extLst>
      <p:ext uri="{BB962C8B-B14F-4D97-AF65-F5344CB8AC3E}">
        <p14:creationId xmlns:p14="http://schemas.microsoft.com/office/powerpoint/2010/main" val="10336022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D9959A-9835-D2CB-8575-A3DF7CD3EFDF}"/>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46F5EB20-C468-BA98-1032-5825999A3C7B}"/>
              </a:ext>
            </a:extLst>
          </p:cNvPr>
          <p:cNvSpPr txBox="1"/>
          <p:nvPr/>
        </p:nvSpPr>
        <p:spPr>
          <a:xfrm>
            <a:off x="303776" y="751755"/>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81DE9F89-6884-26F1-2E9E-9D61D887BE5A}"/>
              </a:ext>
            </a:extLst>
          </p:cNvPr>
          <p:cNvSpPr txBox="1"/>
          <p:nvPr/>
        </p:nvSpPr>
        <p:spPr>
          <a:xfrm>
            <a:off x="149297" y="8019389"/>
            <a:ext cx="6370570" cy="1384995"/>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3. </a:t>
            </a:r>
            <a:r>
              <a:rPr lang="en-US" altLang="ko-KR" sz="1200" dirty="0">
                <a:latin typeface="Times New Roman" panose="02020603050405020304" pitchFamily="18" charset="0"/>
                <a:cs typeface="Times New Roman" panose="02020603050405020304" pitchFamily="18" charset="0"/>
              </a:rPr>
              <a:t>Effect of IPA on the DEP-induced NLRP1 inflammasome complex in </a:t>
            </a:r>
            <a:r>
              <a:rPr lang="en-US" altLang="ko-KR" sz="1200" dirty="0" err="1">
                <a:latin typeface="Times New Roman" panose="02020603050405020304" pitchFamily="18" charset="0"/>
                <a:cs typeface="Times New Roman" panose="02020603050405020304" pitchFamily="18" charset="0"/>
              </a:rPr>
              <a:t>HaCaT</a:t>
            </a:r>
            <a:r>
              <a:rPr lang="en-US" altLang="ko-KR" sz="1200" dirty="0">
                <a:latin typeface="Times New Roman" panose="02020603050405020304" pitchFamily="18" charset="0"/>
                <a:cs typeface="Times New Roman" panose="02020603050405020304" pitchFamily="18" charset="0"/>
              </a:rPr>
              <a:t> cells</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Cells were treated with 1–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before being treated with 10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g</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ml DEP for 24 h. (A) Quantification of band intensity from Figure 2A, normalized to the corresponding loading control. (B) Quantification of band intensity from Figure 2C, normalized to the corresponding loading control. The band intensity was analyzed using the ImageJ program. All experiments were performed thrice (n=3). Data are expressed as the mean ± SD. *p&lt; 0.01 compared to the control group. #p&lt; 0.01 compared with the DEP treatment group.</a:t>
            </a:r>
          </a:p>
        </p:txBody>
      </p:sp>
      <p:sp>
        <p:nvSpPr>
          <p:cNvPr id="5" name="TextBox 4">
            <a:extLst>
              <a:ext uri="{FF2B5EF4-FFF2-40B4-BE49-F238E27FC236}">
                <a16:creationId xmlns:a16="http://schemas.microsoft.com/office/drawing/2014/main" id="{AB700D12-908A-0D7F-84DB-6B2E40AD1DC9}"/>
              </a:ext>
            </a:extLst>
          </p:cNvPr>
          <p:cNvSpPr txBox="1"/>
          <p:nvPr/>
        </p:nvSpPr>
        <p:spPr>
          <a:xfrm>
            <a:off x="303776" y="4266838"/>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103A575A-51DF-7122-D646-52FE53AE503F}"/>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3.</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nvGrpSpPr>
          <p:cNvPr id="19" name="그룹 18">
            <a:extLst>
              <a:ext uri="{FF2B5EF4-FFF2-40B4-BE49-F238E27FC236}">
                <a16:creationId xmlns:a16="http://schemas.microsoft.com/office/drawing/2014/main" id="{1CFED5AC-33B6-B716-5D79-92C1237DEBE0}"/>
              </a:ext>
            </a:extLst>
          </p:cNvPr>
          <p:cNvGrpSpPr/>
          <p:nvPr/>
        </p:nvGrpSpPr>
        <p:grpSpPr>
          <a:xfrm>
            <a:off x="512137" y="501616"/>
            <a:ext cx="4469477" cy="3432722"/>
            <a:chOff x="594892" y="477396"/>
            <a:chExt cx="4469477" cy="3432722"/>
          </a:xfrm>
        </p:grpSpPr>
        <p:sp>
          <p:nvSpPr>
            <p:cNvPr id="3" name="TextBox 2">
              <a:extLst>
                <a:ext uri="{FF2B5EF4-FFF2-40B4-BE49-F238E27FC236}">
                  <a16:creationId xmlns:a16="http://schemas.microsoft.com/office/drawing/2014/main" id="{5C515D99-FC8F-09DD-0872-D7ABB3E44E1A}"/>
                </a:ext>
              </a:extLst>
            </p:cNvPr>
            <p:cNvSpPr txBox="1"/>
            <p:nvPr/>
          </p:nvSpPr>
          <p:spPr>
            <a:xfrm>
              <a:off x="1441941" y="3525397"/>
              <a:ext cx="59663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NLRP1</a:t>
              </a:r>
              <a:endParaRPr lang="ko-KR" altLang="en-US" sz="10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1CC6FD2D-3D77-DF02-A748-67C5DDCDE2D0}"/>
                </a:ext>
              </a:extLst>
            </p:cNvPr>
            <p:cNvSpPr txBox="1"/>
            <p:nvPr/>
          </p:nvSpPr>
          <p:spPr>
            <a:xfrm>
              <a:off x="1870062" y="3525397"/>
              <a:ext cx="744114"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N-terminal</a:t>
              </a:r>
            </a:p>
            <a:p>
              <a:pPr algn="ctr"/>
              <a:r>
                <a:rPr lang="en-US" altLang="ko-KR" sz="950" dirty="0">
                  <a:latin typeface="Arial" panose="020B0604020202020204" pitchFamily="34" charset="0"/>
                  <a:cs typeface="Arial" panose="020B0604020202020204" pitchFamily="34" charset="0"/>
                </a:rPr>
                <a:t>GSDMD</a:t>
              </a:r>
              <a:endParaRPr lang="ko-KR" altLang="en-US" sz="95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371D76CC-2463-0F90-4CF1-A185AA70102C}"/>
                </a:ext>
              </a:extLst>
            </p:cNvPr>
            <p:cNvSpPr txBox="1"/>
            <p:nvPr/>
          </p:nvSpPr>
          <p:spPr>
            <a:xfrm>
              <a:off x="2526145" y="3525397"/>
              <a:ext cx="447558"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ASC</a:t>
              </a:r>
              <a:endParaRPr lang="ko-KR" altLang="en-US" sz="10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B52480A9-95D3-79E0-EDEB-0EDB4CCA32AE}"/>
                </a:ext>
              </a:extLst>
            </p:cNvPr>
            <p:cNvSpPr txBox="1"/>
            <p:nvPr/>
          </p:nvSpPr>
          <p:spPr>
            <a:xfrm>
              <a:off x="3015470" y="3525397"/>
              <a:ext cx="518091"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NEK7</a:t>
              </a:r>
              <a:endParaRPr lang="ko-KR" altLang="en-US" sz="10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A9D34747-3401-76D7-100E-78356CAE46F0}"/>
                </a:ext>
              </a:extLst>
            </p:cNvPr>
            <p:cNvSpPr txBox="1"/>
            <p:nvPr/>
          </p:nvSpPr>
          <p:spPr>
            <a:xfrm>
              <a:off x="3386084" y="3525397"/>
              <a:ext cx="771365"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Cleaved</a:t>
              </a:r>
            </a:p>
            <a:p>
              <a:pPr algn="ctr"/>
              <a:r>
                <a:rPr lang="en-US" altLang="ko-KR" sz="950" dirty="0">
                  <a:latin typeface="Arial" panose="020B0604020202020204" pitchFamily="34" charset="0"/>
                  <a:cs typeface="Arial" panose="020B0604020202020204" pitchFamily="34" charset="0"/>
                </a:rPr>
                <a:t>Caspase-1</a:t>
              </a:r>
              <a:endParaRPr lang="ko-KR" altLang="en-US" sz="95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8A07C1B8-C0A4-EC38-A9B8-2FB0F5F8BE53}"/>
                </a:ext>
              </a:extLst>
            </p:cNvPr>
            <p:cNvSpPr txBox="1"/>
            <p:nvPr/>
          </p:nvSpPr>
          <p:spPr>
            <a:xfrm>
              <a:off x="3969949" y="3525397"/>
              <a:ext cx="630301"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Cleaved</a:t>
              </a:r>
            </a:p>
            <a:p>
              <a:pPr algn="ctr"/>
              <a:r>
                <a:rPr lang="en-US" altLang="ko-KR" sz="950" dirty="0">
                  <a:latin typeface="Arial" panose="020B0604020202020204" pitchFamily="34" charset="0"/>
                  <a:cs typeface="Arial" panose="020B0604020202020204" pitchFamily="34" charset="0"/>
                </a:rPr>
                <a:t>IL-1</a:t>
              </a:r>
              <a:r>
                <a:rPr lang="en-US" altLang="ko-KR" sz="950" dirty="0">
                  <a:latin typeface="Arial" panose="020B0604020202020204" pitchFamily="34" charset="0"/>
                  <a:cs typeface="Arial" panose="020B0604020202020204" pitchFamily="34" charset="0"/>
                  <a:sym typeface="Symbol" panose="05050102010706020507" pitchFamily="18" charset="2"/>
                </a:rPr>
                <a:t></a:t>
              </a:r>
              <a:endParaRPr lang="ko-KR" altLang="en-US" sz="950" dirty="0">
                <a:latin typeface="Arial" panose="020B0604020202020204" pitchFamily="34" charset="0"/>
                <a:cs typeface="Arial" panose="020B0604020202020204" pitchFamily="34" charset="0"/>
              </a:endParaRPr>
            </a:p>
          </p:txBody>
        </p:sp>
        <p:graphicFrame>
          <p:nvGraphicFramePr>
            <p:cNvPr id="14" name="개체 13">
              <a:extLst>
                <a:ext uri="{FF2B5EF4-FFF2-40B4-BE49-F238E27FC236}">
                  <a16:creationId xmlns:a16="http://schemas.microsoft.com/office/drawing/2014/main" id="{56EB6E02-DBB9-2684-28F2-6772733FD480}"/>
                </a:ext>
              </a:extLst>
            </p:cNvPr>
            <p:cNvGraphicFramePr>
              <a:graphicFrameLocks noChangeAspect="1"/>
            </p:cNvGraphicFramePr>
            <p:nvPr>
              <p:extLst>
                <p:ext uri="{D42A27DB-BD31-4B8C-83A1-F6EECF244321}">
                  <p14:modId xmlns:p14="http://schemas.microsoft.com/office/powerpoint/2010/main" val="510061210"/>
                </p:ext>
              </p:extLst>
            </p:nvPr>
          </p:nvGraphicFramePr>
          <p:xfrm>
            <a:off x="594892" y="477396"/>
            <a:ext cx="4469477" cy="3160735"/>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14" name="개체 13">
                          <a:extLst>
                            <a:ext uri="{FF2B5EF4-FFF2-40B4-BE49-F238E27FC236}">
                              <a16:creationId xmlns:a16="http://schemas.microsoft.com/office/drawing/2014/main" id="{56EB6E02-DBB9-2684-28F2-6772733FD480}"/>
                            </a:ext>
                          </a:extLst>
                        </p:cNvPr>
                        <p:cNvPicPr/>
                        <p:nvPr/>
                      </p:nvPicPr>
                      <p:blipFill>
                        <a:blip r:embed="rId3"/>
                        <a:stretch>
                          <a:fillRect/>
                        </a:stretch>
                      </p:blipFill>
                      <p:spPr>
                        <a:xfrm>
                          <a:off x="594892" y="477396"/>
                          <a:ext cx="4469477" cy="3160735"/>
                        </a:xfrm>
                        <a:prstGeom prst="rect">
                          <a:avLst/>
                        </a:prstGeom>
                      </p:spPr>
                    </p:pic>
                  </p:oleObj>
                </mc:Fallback>
              </mc:AlternateContent>
            </a:graphicData>
          </a:graphic>
        </p:graphicFrame>
      </p:grpSp>
      <p:grpSp>
        <p:nvGrpSpPr>
          <p:cNvPr id="22" name="그룹 21">
            <a:extLst>
              <a:ext uri="{FF2B5EF4-FFF2-40B4-BE49-F238E27FC236}">
                <a16:creationId xmlns:a16="http://schemas.microsoft.com/office/drawing/2014/main" id="{CD42B17B-797F-2D4E-EEF6-7A88E2B31063}"/>
              </a:ext>
            </a:extLst>
          </p:cNvPr>
          <p:cNvGrpSpPr/>
          <p:nvPr/>
        </p:nvGrpSpPr>
        <p:grpSpPr>
          <a:xfrm>
            <a:off x="604488" y="4157835"/>
            <a:ext cx="4310063" cy="3094082"/>
            <a:chOff x="604488" y="4106862"/>
            <a:chExt cx="4310063" cy="3094082"/>
          </a:xfrm>
        </p:grpSpPr>
        <p:sp>
          <p:nvSpPr>
            <p:cNvPr id="16" name="TextBox 15">
              <a:extLst>
                <a:ext uri="{FF2B5EF4-FFF2-40B4-BE49-F238E27FC236}">
                  <a16:creationId xmlns:a16="http://schemas.microsoft.com/office/drawing/2014/main" id="{6297EBCD-4E28-736E-045B-64A14887DBCB}"/>
                </a:ext>
              </a:extLst>
            </p:cNvPr>
            <p:cNvSpPr txBox="1"/>
            <p:nvPr/>
          </p:nvSpPr>
          <p:spPr>
            <a:xfrm>
              <a:off x="1538776" y="6923945"/>
              <a:ext cx="123623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NF-</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NF-</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1B27DFE9-E3D4-9B46-415D-6087260E0F37}"/>
                </a:ext>
              </a:extLst>
            </p:cNvPr>
            <p:cNvSpPr txBox="1"/>
            <p:nvPr/>
          </p:nvSpPr>
          <p:spPr>
            <a:xfrm>
              <a:off x="3193743" y="6923945"/>
              <a:ext cx="86113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I</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I-</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a:t>
              </a:r>
            </a:p>
          </p:txBody>
        </p:sp>
        <p:graphicFrame>
          <p:nvGraphicFramePr>
            <p:cNvPr id="21" name="개체 20">
              <a:extLst>
                <a:ext uri="{FF2B5EF4-FFF2-40B4-BE49-F238E27FC236}">
                  <a16:creationId xmlns:a16="http://schemas.microsoft.com/office/drawing/2014/main" id="{D69AB416-AB1A-873C-958F-05E7EC203FF2}"/>
                </a:ext>
              </a:extLst>
            </p:cNvPr>
            <p:cNvGraphicFramePr>
              <a:graphicFrameLocks noChangeAspect="1"/>
            </p:cNvGraphicFramePr>
            <p:nvPr>
              <p:extLst>
                <p:ext uri="{D42A27DB-BD31-4B8C-83A1-F6EECF244321}">
                  <p14:modId xmlns:p14="http://schemas.microsoft.com/office/powerpoint/2010/main" val="995658662"/>
                </p:ext>
              </p:extLst>
            </p:nvPr>
          </p:nvGraphicFramePr>
          <p:xfrm>
            <a:off x="604488" y="4106862"/>
            <a:ext cx="4310063" cy="3048000"/>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21" name="개체 20">
                          <a:extLst>
                            <a:ext uri="{FF2B5EF4-FFF2-40B4-BE49-F238E27FC236}">
                              <a16:creationId xmlns:a16="http://schemas.microsoft.com/office/drawing/2014/main" id="{D69AB416-AB1A-873C-958F-05E7EC203FF2}"/>
                            </a:ext>
                          </a:extLst>
                        </p:cNvPr>
                        <p:cNvPicPr/>
                        <p:nvPr/>
                      </p:nvPicPr>
                      <p:blipFill>
                        <a:blip r:embed="rId5"/>
                        <a:stretch>
                          <a:fillRect/>
                        </a:stretch>
                      </p:blipFill>
                      <p:spPr>
                        <a:xfrm>
                          <a:off x="604488" y="4106862"/>
                          <a:ext cx="4310063" cy="3048000"/>
                        </a:xfrm>
                        <a:prstGeom prst="rect">
                          <a:avLst/>
                        </a:prstGeom>
                      </p:spPr>
                    </p:pic>
                  </p:oleObj>
                </mc:Fallback>
              </mc:AlternateContent>
            </a:graphicData>
          </a:graphic>
        </p:graphicFrame>
      </p:grpSp>
    </p:spTree>
    <p:extLst>
      <p:ext uri="{BB962C8B-B14F-4D97-AF65-F5344CB8AC3E}">
        <p14:creationId xmlns:p14="http://schemas.microsoft.com/office/powerpoint/2010/main" val="19557810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4309B13-3259-2B2B-B867-239FE6ABD07F}"/>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CFA4B34B-3954-0596-00A3-4D59BEFE634B}"/>
              </a:ext>
            </a:extLst>
          </p:cNvPr>
          <p:cNvSpPr txBox="1"/>
          <p:nvPr/>
        </p:nvSpPr>
        <p:spPr>
          <a:xfrm>
            <a:off x="149297" y="3916153"/>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BC0EEBEC-BB83-CFB3-0A0A-76180F053BA8}"/>
              </a:ext>
            </a:extLst>
          </p:cNvPr>
          <p:cNvSpPr txBox="1"/>
          <p:nvPr/>
        </p:nvSpPr>
        <p:spPr>
          <a:xfrm>
            <a:off x="243715" y="7650934"/>
            <a:ext cx="6370570" cy="1754326"/>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4. </a:t>
            </a:r>
            <a:r>
              <a:rPr lang="en-US" altLang="ko-KR" sz="1200" dirty="0">
                <a:latin typeface="Times New Roman" panose="02020603050405020304" pitchFamily="18" charset="0"/>
                <a:cs typeface="Times New Roman" panose="02020603050405020304" pitchFamily="18" charset="0"/>
              </a:rPr>
              <a:t>Effect of IPA on antioxidant enzyme by activating Nrf2 signaling pathway</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The cells were treated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3–12 h and 1–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A and B) Quantification of band intensity from Figures 3A</a:t>
            </a:r>
            <a:r>
              <a:rPr lang="en-US" altLang="ko-KR" sz="1200" kern="100" dirty="0">
                <a:latin typeface="Times New Roman" panose="02020603050405020304" pitchFamily="18" charset="0"/>
                <a:ea typeface="맑은 고딕" panose="020B0503020000020004" pitchFamily="50" charset="-127"/>
                <a:cs typeface="Arial" panose="020B0604020202020204" pitchFamily="34" charset="0"/>
              </a:rPr>
              <a:t> and 3B</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normalized to the corresponding loading control. Additionally, the nuclear translocation of the Nrf2 was evaluated following treatment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3–12 h and 1–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with both nuclear and cytosol protein fractions analyzed by western blot. (C and D) Quantification of band intensity from Figures 3C and 3D, normalized to the corresponding loading control. The band intensity was analyzed using the ImageJ program. All experiments were performed thrice (n=3). Data are expressed as the mean ± SD. *p&lt; 0.01 compared to the control group.</a:t>
            </a:r>
          </a:p>
        </p:txBody>
      </p:sp>
      <p:sp>
        <p:nvSpPr>
          <p:cNvPr id="5" name="TextBox 4">
            <a:extLst>
              <a:ext uri="{FF2B5EF4-FFF2-40B4-BE49-F238E27FC236}">
                <a16:creationId xmlns:a16="http://schemas.microsoft.com/office/drawing/2014/main" id="{7DF17BB9-CE81-76EF-A3AB-0F67EBB90FBC}"/>
              </a:ext>
            </a:extLst>
          </p:cNvPr>
          <p:cNvSpPr txBox="1"/>
          <p:nvPr/>
        </p:nvSpPr>
        <p:spPr>
          <a:xfrm>
            <a:off x="3419692" y="3916153"/>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D</a:t>
            </a:r>
            <a:endParaRPr lang="ko-KR" altLang="en-US" sz="1200" b="1" dirty="0">
              <a:latin typeface="Arial" panose="020B0604020202020204" pitchFamily="34" charset="0"/>
              <a:cs typeface="Arial" panose="020B0604020202020204" pitchFamily="34" charset="0"/>
            </a:endParaRPr>
          </a:p>
        </p:txBody>
      </p:sp>
      <p:sp>
        <p:nvSpPr>
          <p:cNvPr id="96" name="TextBox 95">
            <a:extLst>
              <a:ext uri="{FF2B5EF4-FFF2-40B4-BE49-F238E27FC236}">
                <a16:creationId xmlns:a16="http://schemas.microsoft.com/office/drawing/2014/main" id="{FEA54F05-CA14-34D5-89E0-1398455F7796}"/>
              </a:ext>
            </a:extLst>
          </p:cNvPr>
          <p:cNvSpPr txBox="1"/>
          <p:nvPr/>
        </p:nvSpPr>
        <p:spPr>
          <a:xfrm>
            <a:off x="149297" y="727218"/>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36A328FD-D598-6BA1-C14D-2C0F2453FE88}"/>
              </a:ext>
            </a:extLst>
          </p:cNvPr>
          <p:cNvSpPr txBox="1"/>
          <p:nvPr/>
        </p:nvSpPr>
        <p:spPr>
          <a:xfrm>
            <a:off x="3419692" y="727218"/>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3FE30272-1F47-2B84-8A33-1E036E516A26}"/>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4.</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nvGrpSpPr>
          <p:cNvPr id="7" name="그룹 6">
            <a:extLst>
              <a:ext uri="{FF2B5EF4-FFF2-40B4-BE49-F238E27FC236}">
                <a16:creationId xmlns:a16="http://schemas.microsoft.com/office/drawing/2014/main" id="{3FE43BA7-3472-48E9-279B-0AAAFAA60EA6}"/>
              </a:ext>
            </a:extLst>
          </p:cNvPr>
          <p:cNvGrpSpPr/>
          <p:nvPr/>
        </p:nvGrpSpPr>
        <p:grpSpPr>
          <a:xfrm>
            <a:off x="149297" y="777810"/>
            <a:ext cx="3507064" cy="2551909"/>
            <a:chOff x="149297" y="777810"/>
            <a:chExt cx="3507064" cy="2551909"/>
          </a:xfrm>
        </p:grpSpPr>
        <p:sp>
          <p:nvSpPr>
            <p:cNvPr id="9" name="TextBox 8">
              <a:extLst>
                <a:ext uri="{FF2B5EF4-FFF2-40B4-BE49-F238E27FC236}">
                  <a16:creationId xmlns:a16="http://schemas.microsoft.com/office/drawing/2014/main" id="{EAFDE9E1-5798-A94A-C6AE-A34DADE86249}"/>
                </a:ext>
              </a:extLst>
            </p:cNvPr>
            <p:cNvSpPr txBox="1"/>
            <p:nvPr/>
          </p:nvSpPr>
          <p:spPr>
            <a:xfrm>
              <a:off x="837027" y="3052720"/>
              <a:ext cx="62709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Keap1</a:t>
              </a:r>
              <a:endParaRPr lang="ko-KR" altLang="en-US" sz="12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B11CCC8B-08B5-6B86-3BE0-B9E4408BDDC6}"/>
                </a:ext>
              </a:extLst>
            </p:cNvPr>
            <p:cNvSpPr txBox="1"/>
            <p:nvPr/>
          </p:nvSpPr>
          <p:spPr>
            <a:xfrm>
              <a:off x="1459121" y="3052720"/>
              <a:ext cx="55175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HO-1</a:t>
              </a:r>
              <a:endParaRPr lang="ko-KR" altLang="en-US" sz="12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7C087646-9294-DD99-F3A8-5852878911A7}"/>
                </a:ext>
              </a:extLst>
            </p:cNvPr>
            <p:cNvSpPr txBox="1"/>
            <p:nvPr/>
          </p:nvSpPr>
          <p:spPr>
            <a:xfrm>
              <a:off x="2038367" y="3052720"/>
              <a:ext cx="62068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QO1</a:t>
              </a:r>
              <a:endParaRPr lang="ko-KR" altLang="en-US" sz="12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4457C49B-6E56-01FF-D2BA-B76F3055A60A}"/>
                </a:ext>
              </a:extLst>
            </p:cNvPr>
            <p:cNvSpPr txBox="1"/>
            <p:nvPr/>
          </p:nvSpPr>
          <p:spPr>
            <a:xfrm>
              <a:off x="2632074" y="3052720"/>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GCLC</a:t>
              </a:r>
              <a:endParaRPr lang="ko-KR" altLang="en-US" sz="1200"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F5B6F3A7-4830-CE58-8BC2-FB980F699E47}"/>
                </a:ext>
              </a:extLst>
            </p:cNvPr>
            <p:cNvGraphicFramePr>
              <a:graphicFrameLocks noChangeAspect="1"/>
            </p:cNvGraphicFramePr>
            <p:nvPr>
              <p:extLst>
                <p:ext uri="{D42A27DB-BD31-4B8C-83A1-F6EECF244321}">
                  <p14:modId xmlns:p14="http://schemas.microsoft.com/office/powerpoint/2010/main" val="3160290081"/>
                </p:ext>
              </p:extLst>
            </p:nvPr>
          </p:nvGraphicFramePr>
          <p:xfrm>
            <a:off x="149297" y="777810"/>
            <a:ext cx="3507064" cy="2480133"/>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3" name="개체 2">
                          <a:extLst>
                            <a:ext uri="{FF2B5EF4-FFF2-40B4-BE49-F238E27FC236}">
                              <a16:creationId xmlns:a16="http://schemas.microsoft.com/office/drawing/2014/main" id="{F5B6F3A7-4830-CE58-8BC2-FB980F699E47}"/>
                            </a:ext>
                          </a:extLst>
                        </p:cNvPr>
                        <p:cNvPicPr/>
                        <p:nvPr/>
                      </p:nvPicPr>
                      <p:blipFill>
                        <a:blip r:embed="rId3"/>
                        <a:stretch>
                          <a:fillRect/>
                        </a:stretch>
                      </p:blipFill>
                      <p:spPr>
                        <a:xfrm>
                          <a:off x="149297" y="777810"/>
                          <a:ext cx="3507064" cy="2480133"/>
                        </a:xfrm>
                        <a:prstGeom prst="rect">
                          <a:avLst/>
                        </a:prstGeom>
                      </p:spPr>
                    </p:pic>
                  </p:oleObj>
                </mc:Fallback>
              </mc:AlternateContent>
            </a:graphicData>
          </a:graphic>
        </p:graphicFrame>
      </p:grpSp>
      <p:grpSp>
        <p:nvGrpSpPr>
          <p:cNvPr id="28" name="그룹 27">
            <a:extLst>
              <a:ext uri="{FF2B5EF4-FFF2-40B4-BE49-F238E27FC236}">
                <a16:creationId xmlns:a16="http://schemas.microsoft.com/office/drawing/2014/main" id="{4E904107-7A75-4D95-B883-8C92453E8F69}"/>
              </a:ext>
            </a:extLst>
          </p:cNvPr>
          <p:cNvGrpSpPr/>
          <p:nvPr/>
        </p:nvGrpSpPr>
        <p:grpSpPr>
          <a:xfrm>
            <a:off x="3419692" y="891014"/>
            <a:ext cx="3507064" cy="2530651"/>
            <a:chOff x="3419692" y="891014"/>
            <a:chExt cx="3507064" cy="2530651"/>
          </a:xfrm>
        </p:grpSpPr>
        <p:sp>
          <p:nvSpPr>
            <p:cNvPr id="14" name="TextBox 13">
              <a:extLst>
                <a:ext uri="{FF2B5EF4-FFF2-40B4-BE49-F238E27FC236}">
                  <a16:creationId xmlns:a16="http://schemas.microsoft.com/office/drawing/2014/main" id="{613DC341-5302-FE5B-C83F-11205C9FD479}"/>
                </a:ext>
              </a:extLst>
            </p:cNvPr>
            <p:cNvSpPr txBox="1"/>
            <p:nvPr/>
          </p:nvSpPr>
          <p:spPr>
            <a:xfrm>
              <a:off x="4106801" y="3052720"/>
              <a:ext cx="62709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Keap1</a:t>
              </a:r>
              <a:endParaRPr lang="ko-KR" altLang="en-US" sz="12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CEF49FB4-4398-389D-8EC7-17EA2878DD6F}"/>
                </a:ext>
              </a:extLst>
            </p:cNvPr>
            <p:cNvSpPr txBox="1"/>
            <p:nvPr/>
          </p:nvSpPr>
          <p:spPr>
            <a:xfrm>
              <a:off x="4742963" y="3052720"/>
              <a:ext cx="55175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HO-1</a:t>
              </a:r>
              <a:endParaRPr lang="ko-KR" altLang="en-US" sz="12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FB90E7DD-60A5-43A4-4DD3-D0F8C40F87A3}"/>
                </a:ext>
              </a:extLst>
            </p:cNvPr>
            <p:cNvSpPr txBox="1"/>
            <p:nvPr/>
          </p:nvSpPr>
          <p:spPr>
            <a:xfrm>
              <a:off x="5308141" y="3052720"/>
              <a:ext cx="62068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QO1</a:t>
              </a:r>
              <a:endParaRPr lang="ko-KR" altLang="en-US" sz="12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C88E9B66-2CD0-4BEC-CD70-5CC0CE32869E}"/>
                </a:ext>
              </a:extLst>
            </p:cNvPr>
            <p:cNvSpPr txBox="1"/>
            <p:nvPr/>
          </p:nvSpPr>
          <p:spPr>
            <a:xfrm>
              <a:off x="5901848" y="3052720"/>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GCLC</a:t>
              </a:r>
              <a:endParaRPr lang="ko-KR" altLang="en-US" sz="1200" dirty="0">
                <a:latin typeface="Arial" panose="020B0604020202020204" pitchFamily="34" charset="0"/>
                <a:cs typeface="Arial" panose="020B0604020202020204" pitchFamily="34" charset="0"/>
              </a:endParaRPr>
            </a:p>
          </p:txBody>
        </p:sp>
        <p:graphicFrame>
          <p:nvGraphicFramePr>
            <p:cNvPr id="27" name="개체 26">
              <a:extLst>
                <a:ext uri="{FF2B5EF4-FFF2-40B4-BE49-F238E27FC236}">
                  <a16:creationId xmlns:a16="http://schemas.microsoft.com/office/drawing/2014/main" id="{3375377B-C79B-F104-92C2-C2D88148C2E3}"/>
                </a:ext>
              </a:extLst>
            </p:cNvPr>
            <p:cNvGraphicFramePr>
              <a:graphicFrameLocks noChangeAspect="1"/>
            </p:cNvGraphicFramePr>
            <p:nvPr>
              <p:extLst>
                <p:ext uri="{D42A27DB-BD31-4B8C-83A1-F6EECF244321}">
                  <p14:modId xmlns:p14="http://schemas.microsoft.com/office/powerpoint/2010/main" val="3427599333"/>
                </p:ext>
              </p:extLst>
            </p:nvPr>
          </p:nvGraphicFramePr>
          <p:xfrm>
            <a:off x="3419692" y="891014"/>
            <a:ext cx="3507064" cy="2530651"/>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27" name="개체 26">
                          <a:extLst>
                            <a:ext uri="{FF2B5EF4-FFF2-40B4-BE49-F238E27FC236}">
                              <a16:creationId xmlns:a16="http://schemas.microsoft.com/office/drawing/2014/main" id="{3375377B-C79B-F104-92C2-C2D88148C2E3}"/>
                            </a:ext>
                          </a:extLst>
                        </p:cNvPr>
                        <p:cNvPicPr/>
                        <p:nvPr/>
                      </p:nvPicPr>
                      <p:blipFill>
                        <a:blip r:embed="rId5"/>
                        <a:stretch>
                          <a:fillRect/>
                        </a:stretch>
                      </p:blipFill>
                      <p:spPr>
                        <a:xfrm>
                          <a:off x="3419692" y="891014"/>
                          <a:ext cx="3507064" cy="2530651"/>
                        </a:xfrm>
                        <a:prstGeom prst="rect">
                          <a:avLst/>
                        </a:prstGeom>
                      </p:spPr>
                    </p:pic>
                  </p:oleObj>
                </mc:Fallback>
              </mc:AlternateContent>
            </a:graphicData>
          </a:graphic>
        </p:graphicFrame>
      </p:grpSp>
      <p:grpSp>
        <p:nvGrpSpPr>
          <p:cNvPr id="31" name="그룹 30">
            <a:extLst>
              <a:ext uri="{FF2B5EF4-FFF2-40B4-BE49-F238E27FC236}">
                <a16:creationId xmlns:a16="http://schemas.microsoft.com/office/drawing/2014/main" id="{971726B5-A7D4-EF39-BB36-06BBD8CA5EE1}"/>
              </a:ext>
            </a:extLst>
          </p:cNvPr>
          <p:cNvGrpSpPr/>
          <p:nvPr/>
        </p:nvGrpSpPr>
        <p:grpSpPr>
          <a:xfrm>
            <a:off x="103189" y="3993419"/>
            <a:ext cx="3507065" cy="2645944"/>
            <a:chOff x="103189" y="3993419"/>
            <a:chExt cx="3507065" cy="2645944"/>
          </a:xfrm>
        </p:grpSpPr>
        <p:sp>
          <p:nvSpPr>
            <p:cNvPr id="19" name="TextBox 18">
              <a:extLst>
                <a:ext uri="{FF2B5EF4-FFF2-40B4-BE49-F238E27FC236}">
                  <a16:creationId xmlns:a16="http://schemas.microsoft.com/office/drawing/2014/main" id="{C0560855-088F-EA93-1B66-56AB5626FE4E}"/>
                </a:ext>
              </a:extLst>
            </p:cNvPr>
            <p:cNvSpPr txBox="1"/>
            <p:nvPr/>
          </p:nvSpPr>
          <p:spPr>
            <a:xfrm>
              <a:off x="1082382" y="6177698"/>
              <a:ext cx="756938" cy="461665"/>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Cyt-Nrf2</a:t>
              </a:r>
            </a:p>
            <a:p>
              <a:r>
                <a:rPr lang="en-US" altLang="ko-KR" sz="1200" dirty="0">
                  <a:latin typeface="Arial" panose="020B0604020202020204" pitchFamily="34" charset="0"/>
                  <a:cs typeface="Arial" panose="020B0604020202020204" pitchFamily="34" charset="0"/>
                </a:rPr>
                <a:t>/</a:t>
              </a:r>
              <a:r>
                <a:rPr lang="en-US" altLang="ko-KR" sz="1200" dirty="0">
                  <a:latin typeface="Arial" panose="020B0604020202020204" pitchFamily="34" charset="0"/>
                  <a:cs typeface="Arial" panose="020B0604020202020204" pitchFamily="34" charset="0"/>
                  <a:sym typeface="Symbol" panose="05050102010706020507" pitchFamily="18" charset="2"/>
                </a:rPr>
                <a:t>-actin</a:t>
              </a:r>
              <a:endParaRPr lang="en-US" altLang="ko-KR" sz="12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C631AE16-6715-19E1-D0DB-A5B80923DD28}"/>
                </a:ext>
              </a:extLst>
            </p:cNvPr>
            <p:cNvSpPr txBox="1"/>
            <p:nvPr/>
          </p:nvSpPr>
          <p:spPr>
            <a:xfrm>
              <a:off x="2216837" y="6177698"/>
              <a:ext cx="875561" cy="461665"/>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uc-Nrf2</a:t>
              </a:r>
            </a:p>
            <a:p>
              <a:r>
                <a:rPr lang="en-US" altLang="ko-KR" sz="1200" dirty="0">
                  <a:latin typeface="Arial" panose="020B0604020202020204" pitchFamily="34" charset="0"/>
                  <a:cs typeface="Arial" panose="020B0604020202020204" pitchFamily="34" charset="0"/>
                </a:rPr>
                <a:t>/Lamin B1</a:t>
              </a:r>
            </a:p>
          </p:txBody>
        </p:sp>
        <p:graphicFrame>
          <p:nvGraphicFramePr>
            <p:cNvPr id="30" name="개체 29">
              <a:extLst>
                <a:ext uri="{FF2B5EF4-FFF2-40B4-BE49-F238E27FC236}">
                  <a16:creationId xmlns:a16="http://schemas.microsoft.com/office/drawing/2014/main" id="{680F9BE9-1458-7263-3E93-46F2E3A1D7BA}"/>
                </a:ext>
              </a:extLst>
            </p:cNvPr>
            <p:cNvGraphicFramePr>
              <a:graphicFrameLocks noChangeAspect="1"/>
            </p:cNvGraphicFramePr>
            <p:nvPr>
              <p:extLst>
                <p:ext uri="{D42A27DB-BD31-4B8C-83A1-F6EECF244321}">
                  <p14:modId xmlns:p14="http://schemas.microsoft.com/office/powerpoint/2010/main" val="3104186564"/>
                </p:ext>
              </p:extLst>
            </p:nvPr>
          </p:nvGraphicFramePr>
          <p:xfrm>
            <a:off x="103189" y="3993419"/>
            <a:ext cx="3507065" cy="2480134"/>
          </p:xfrm>
          <a:graphic>
            <a:graphicData uri="http://schemas.openxmlformats.org/presentationml/2006/ole">
              <mc:AlternateContent xmlns:mc="http://schemas.openxmlformats.org/markup-compatibility/2006">
                <mc:Choice xmlns:v="urn:schemas-microsoft-com:vml" Requires="v">
                  <p:oleObj name="Graph" r:id="rId6" imgW="33403857" imgH="23621831" progId="Origin50.Graph">
                    <p:embed/>
                  </p:oleObj>
                </mc:Choice>
                <mc:Fallback>
                  <p:oleObj name="Graph" r:id="rId6" imgW="33403857" imgH="23621831" progId="Origin50.Graph">
                    <p:embed/>
                    <p:pic>
                      <p:nvPicPr>
                        <p:cNvPr id="30" name="개체 29">
                          <a:extLst>
                            <a:ext uri="{FF2B5EF4-FFF2-40B4-BE49-F238E27FC236}">
                              <a16:creationId xmlns:a16="http://schemas.microsoft.com/office/drawing/2014/main" id="{680F9BE9-1458-7263-3E93-46F2E3A1D7BA}"/>
                            </a:ext>
                          </a:extLst>
                        </p:cNvPr>
                        <p:cNvPicPr/>
                        <p:nvPr/>
                      </p:nvPicPr>
                      <p:blipFill>
                        <a:blip r:embed="rId7"/>
                        <a:stretch>
                          <a:fillRect/>
                        </a:stretch>
                      </p:blipFill>
                      <p:spPr>
                        <a:xfrm>
                          <a:off x="103189" y="3993419"/>
                          <a:ext cx="3507065" cy="2480134"/>
                        </a:xfrm>
                        <a:prstGeom prst="rect">
                          <a:avLst/>
                        </a:prstGeom>
                      </p:spPr>
                    </p:pic>
                  </p:oleObj>
                </mc:Fallback>
              </mc:AlternateContent>
            </a:graphicData>
          </a:graphic>
        </p:graphicFrame>
      </p:grpSp>
      <p:grpSp>
        <p:nvGrpSpPr>
          <p:cNvPr id="33" name="그룹 32">
            <a:extLst>
              <a:ext uri="{FF2B5EF4-FFF2-40B4-BE49-F238E27FC236}">
                <a16:creationId xmlns:a16="http://schemas.microsoft.com/office/drawing/2014/main" id="{B8D74C0B-FA93-2F44-BE1E-4C59E294DD4E}"/>
              </a:ext>
            </a:extLst>
          </p:cNvPr>
          <p:cNvGrpSpPr/>
          <p:nvPr/>
        </p:nvGrpSpPr>
        <p:grpSpPr>
          <a:xfrm>
            <a:off x="3434265" y="3993419"/>
            <a:ext cx="3507064" cy="2645944"/>
            <a:chOff x="3434265" y="3993419"/>
            <a:chExt cx="3507064" cy="2645944"/>
          </a:xfrm>
        </p:grpSpPr>
        <p:sp>
          <p:nvSpPr>
            <p:cNvPr id="24" name="TextBox 23">
              <a:extLst>
                <a:ext uri="{FF2B5EF4-FFF2-40B4-BE49-F238E27FC236}">
                  <a16:creationId xmlns:a16="http://schemas.microsoft.com/office/drawing/2014/main" id="{B3C2C66B-BBDB-B5EC-3337-3F4C6EE2042C}"/>
                </a:ext>
              </a:extLst>
            </p:cNvPr>
            <p:cNvSpPr txBox="1"/>
            <p:nvPr/>
          </p:nvSpPr>
          <p:spPr>
            <a:xfrm>
              <a:off x="4396458" y="6177698"/>
              <a:ext cx="756938" cy="461665"/>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Cyt-Nrf2</a:t>
              </a:r>
            </a:p>
            <a:p>
              <a:r>
                <a:rPr lang="en-US" altLang="ko-KR" sz="1200" dirty="0">
                  <a:latin typeface="Arial" panose="020B0604020202020204" pitchFamily="34" charset="0"/>
                  <a:cs typeface="Arial" panose="020B0604020202020204" pitchFamily="34" charset="0"/>
                </a:rPr>
                <a:t>/</a:t>
              </a:r>
              <a:r>
                <a:rPr lang="en-US" altLang="ko-KR" sz="1200" dirty="0">
                  <a:latin typeface="Arial" panose="020B0604020202020204" pitchFamily="34" charset="0"/>
                  <a:cs typeface="Arial" panose="020B0604020202020204" pitchFamily="34" charset="0"/>
                  <a:sym typeface="Symbol" panose="05050102010706020507" pitchFamily="18" charset="2"/>
                </a:rPr>
                <a:t>-actin</a:t>
              </a:r>
              <a:endParaRPr lang="en-US" altLang="ko-KR" sz="12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5C01FB6D-0EA5-42C4-BEF2-40316DC9EB10}"/>
                </a:ext>
              </a:extLst>
            </p:cNvPr>
            <p:cNvSpPr txBox="1"/>
            <p:nvPr/>
          </p:nvSpPr>
          <p:spPr>
            <a:xfrm>
              <a:off x="5516844" y="6177698"/>
              <a:ext cx="875561" cy="461665"/>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uc-Nrf2</a:t>
              </a:r>
            </a:p>
            <a:p>
              <a:r>
                <a:rPr lang="en-US" altLang="ko-KR" sz="1200" dirty="0">
                  <a:latin typeface="Arial" panose="020B0604020202020204" pitchFamily="34" charset="0"/>
                  <a:cs typeface="Arial" panose="020B0604020202020204" pitchFamily="34" charset="0"/>
                </a:rPr>
                <a:t>/Lamin B1</a:t>
              </a:r>
            </a:p>
          </p:txBody>
        </p:sp>
        <p:graphicFrame>
          <p:nvGraphicFramePr>
            <p:cNvPr id="32" name="개체 31">
              <a:extLst>
                <a:ext uri="{FF2B5EF4-FFF2-40B4-BE49-F238E27FC236}">
                  <a16:creationId xmlns:a16="http://schemas.microsoft.com/office/drawing/2014/main" id="{3D301C41-F853-6B14-6F96-EF9F022996D2}"/>
                </a:ext>
              </a:extLst>
            </p:cNvPr>
            <p:cNvGraphicFramePr>
              <a:graphicFrameLocks noChangeAspect="1"/>
            </p:cNvGraphicFramePr>
            <p:nvPr>
              <p:extLst>
                <p:ext uri="{D42A27DB-BD31-4B8C-83A1-F6EECF244321}">
                  <p14:modId xmlns:p14="http://schemas.microsoft.com/office/powerpoint/2010/main" val="3185084131"/>
                </p:ext>
              </p:extLst>
            </p:nvPr>
          </p:nvGraphicFramePr>
          <p:xfrm>
            <a:off x="3434265" y="3993419"/>
            <a:ext cx="3507064" cy="2480133"/>
          </p:xfrm>
          <a:graphic>
            <a:graphicData uri="http://schemas.openxmlformats.org/presentationml/2006/ole">
              <mc:AlternateContent xmlns:mc="http://schemas.openxmlformats.org/markup-compatibility/2006">
                <mc:Choice xmlns:v="urn:schemas-microsoft-com:vml" Requires="v">
                  <p:oleObj name="Graph" r:id="rId8" imgW="33403857" imgH="23621831" progId="Origin50.Graph">
                    <p:embed/>
                  </p:oleObj>
                </mc:Choice>
                <mc:Fallback>
                  <p:oleObj name="Graph" r:id="rId8" imgW="33403857" imgH="23621831" progId="Origin50.Graph">
                    <p:embed/>
                    <p:pic>
                      <p:nvPicPr>
                        <p:cNvPr id="32" name="개체 31">
                          <a:extLst>
                            <a:ext uri="{FF2B5EF4-FFF2-40B4-BE49-F238E27FC236}">
                              <a16:creationId xmlns:a16="http://schemas.microsoft.com/office/drawing/2014/main" id="{3D301C41-F853-6B14-6F96-EF9F022996D2}"/>
                            </a:ext>
                          </a:extLst>
                        </p:cNvPr>
                        <p:cNvPicPr/>
                        <p:nvPr/>
                      </p:nvPicPr>
                      <p:blipFill>
                        <a:blip r:embed="rId9"/>
                        <a:stretch>
                          <a:fillRect/>
                        </a:stretch>
                      </p:blipFill>
                      <p:spPr>
                        <a:xfrm>
                          <a:off x="3434265" y="3993419"/>
                          <a:ext cx="3507064" cy="2480133"/>
                        </a:xfrm>
                        <a:prstGeom prst="rect">
                          <a:avLst/>
                        </a:prstGeom>
                      </p:spPr>
                    </p:pic>
                  </p:oleObj>
                </mc:Fallback>
              </mc:AlternateContent>
            </a:graphicData>
          </a:graphic>
        </p:graphicFrame>
      </p:grpSp>
    </p:spTree>
    <p:extLst>
      <p:ext uri="{BB962C8B-B14F-4D97-AF65-F5344CB8AC3E}">
        <p14:creationId xmlns:p14="http://schemas.microsoft.com/office/powerpoint/2010/main" val="23464764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FE99A44-B423-AECA-B003-FE05ACCFA350}"/>
            </a:ext>
          </a:extLst>
        </p:cNvPr>
        <p:cNvGrpSpPr/>
        <p:nvPr/>
      </p:nvGrpSpPr>
      <p:grpSpPr>
        <a:xfrm>
          <a:off x="0" y="0"/>
          <a:ext cx="0" cy="0"/>
          <a:chOff x="0" y="0"/>
          <a:chExt cx="0" cy="0"/>
        </a:xfrm>
      </p:grpSpPr>
      <p:sp>
        <p:nvSpPr>
          <p:cNvPr id="96" name="TextBox 95">
            <a:extLst>
              <a:ext uri="{FF2B5EF4-FFF2-40B4-BE49-F238E27FC236}">
                <a16:creationId xmlns:a16="http://schemas.microsoft.com/office/drawing/2014/main" id="{072696F5-41EC-5A6D-F872-82BC0807CEDC}"/>
              </a:ext>
            </a:extLst>
          </p:cNvPr>
          <p:cNvSpPr txBox="1"/>
          <p:nvPr/>
        </p:nvSpPr>
        <p:spPr>
          <a:xfrm>
            <a:off x="233436" y="679555"/>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86718FE6-8628-3413-6547-0CE1451C9B24}"/>
              </a:ext>
            </a:extLst>
          </p:cNvPr>
          <p:cNvSpPr txBox="1"/>
          <p:nvPr/>
        </p:nvSpPr>
        <p:spPr>
          <a:xfrm>
            <a:off x="3595299" y="679555"/>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348DF616-AB59-0877-7E21-4ABE75C93CC2}"/>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5.</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2" name="TextBox 21">
            <a:extLst>
              <a:ext uri="{FF2B5EF4-FFF2-40B4-BE49-F238E27FC236}">
                <a16:creationId xmlns:a16="http://schemas.microsoft.com/office/drawing/2014/main" id="{0FA2C788-DCD9-1C81-CC1A-DEA6F9D446BB}"/>
              </a:ext>
            </a:extLst>
          </p:cNvPr>
          <p:cNvSpPr txBox="1"/>
          <p:nvPr/>
        </p:nvSpPr>
        <p:spPr>
          <a:xfrm>
            <a:off x="233436" y="3695500"/>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D46E3346-5C0E-D5BA-0FE0-4639FCC6731D}"/>
              </a:ext>
            </a:extLst>
          </p:cNvPr>
          <p:cNvSpPr txBox="1"/>
          <p:nvPr/>
        </p:nvSpPr>
        <p:spPr>
          <a:xfrm>
            <a:off x="3595299" y="3695500"/>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D</a:t>
            </a:r>
            <a:endParaRPr lang="ko-KR" altLang="en-US" sz="1200" b="1"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9F69B057-32E5-D2C0-5E04-0FE0790660CF}"/>
              </a:ext>
            </a:extLst>
          </p:cNvPr>
          <p:cNvSpPr txBox="1"/>
          <p:nvPr/>
        </p:nvSpPr>
        <p:spPr>
          <a:xfrm>
            <a:off x="233436" y="6724736"/>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E</a:t>
            </a:r>
            <a:endParaRPr lang="ko-KR" altLang="en-US" sz="1200" b="1" dirty="0">
              <a:latin typeface="Arial" panose="020B0604020202020204" pitchFamily="34" charset="0"/>
              <a:cs typeface="Arial" panose="020B0604020202020204" pitchFamily="34" charset="0"/>
            </a:endParaRPr>
          </a:p>
        </p:txBody>
      </p:sp>
      <p:grpSp>
        <p:nvGrpSpPr>
          <p:cNvPr id="3" name="그룹 2">
            <a:extLst>
              <a:ext uri="{FF2B5EF4-FFF2-40B4-BE49-F238E27FC236}">
                <a16:creationId xmlns:a16="http://schemas.microsoft.com/office/drawing/2014/main" id="{1BF5EB74-2AAA-AC4C-2337-44392671DC3B}"/>
              </a:ext>
            </a:extLst>
          </p:cNvPr>
          <p:cNvGrpSpPr/>
          <p:nvPr/>
        </p:nvGrpSpPr>
        <p:grpSpPr>
          <a:xfrm>
            <a:off x="151901" y="775850"/>
            <a:ext cx="3465738" cy="2547086"/>
            <a:chOff x="151901" y="775850"/>
            <a:chExt cx="3465738" cy="2547086"/>
          </a:xfrm>
        </p:grpSpPr>
        <p:sp>
          <p:nvSpPr>
            <p:cNvPr id="10" name="TextBox 9">
              <a:extLst>
                <a:ext uri="{FF2B5EF4-FFF2-40B4-BE49-F238E27FC236}">
                  <a16:creationId xmlns:a16="http://schemas.microsoft.com/office/drawing/2014/main" id="{36B3EF61-6E26-C43A-A0F7-1BB53E5D8292}"/>
                </a:ext>
              </a:extLst>
            </p:cNvPr>
            <p:cNvSpPr txBox="1"/>
            <p:nvPr/>
          </p:nvSpPr>
          <p:spPr>
            <a:xfrm rot="19560000">
              <a:off x="724507" y="2956282"/>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Nrf2</a:t>
              </a:r>
              <a:endParaRPr lang="ko-KR" altLang="en-US" sz="12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797B5B97-0BED-B18E-B58E-20C4B7F7E024}"/>
                </a:ext>
              </a:extLst>
            </p:cNvPr>
            <p:cNvSpPr txBox="1"/>
            <p:nvPr/>
          </p:nvSpPr>
          <p:spPr>
            <a:xfrm rot="19569742">
              <a:off x="896235" y="3045937"/>
              <a:ext cx="934871"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a:t>
              </a:r>
              <a:r>
                <a:rPr lang="en-US" altLang="ko-KR" sz="1200" dirty="0" err="1">
                  <a:latin typeface="Arial" panose="020B0604020202020204" pitchFamily="34" charset="0"/>
                  <a:cs typeface="Arial" panose="020B0604020202020204" pitchFamily="34" charset="0"/>
                </a:rPr>
                <a:t>CaMKK</a:t>
              </a:r>
              <a:r>
                <a:rPr lang="en-US" altLang="ko-KR" sz="1200" dirty="0">
                  <a:latin typeface="Arial" panose="020B0604020202020204" pitchFamily="34" charset="0"/>
                  <a:cs typeface="Arial" panose="020B0604020202020204" pitchFamily="34" charset="0"/>
                  <a:sym typeface="Symbol" panose="05050102010706020507" pitchFamily="18" charset="2"/>
                </a:rPr>
                <a:t></a:t>
              </a:r>
              <a:endParaRPr lang="ko-KR" altLang="en-US" sz="12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E9ED943D-40DD-85C9-1776-95DA6E5C0B9D}"/>
                </a:ext>
              </a:extLst>
            </p:cNvPr>
            <p:cNvSpPr txBox="1"/>
            <p:nvPr/>
          </p:nvSpPr>
          <p:spPr>
            <a:xfrm rot="19560000">
              <a:off x="1540101" y="2997067"/>
              <a:ext cx="756938"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AMPK</a:t>
              </a:r>
              <a:endParaRPr lang="ko-KR" altLang="en-US" sz="12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F8386CBC-3D6A-1DAF-2275-20C89FBCBC1E}"/>
                </a:ext>
              </a:extLst>
            </p:cNvPr>
            <p:cNvSpPr txBox="1"/>
            <p:nvPr/>
          </p:nvSpPr>
          <p:spPr>
            <a:xfrm rot="19560000">
              <a:off x="2136403" y="2956282"/>
              <a:ext cx="611065" cy="276999"/>
            </a:xfrm>
            <a:prstGeom prst="rect">
              <a:avLst/>
            </a:prstGeom>
            <a:noFill/>
          </p:spPr>
          <p:txBody>
            <a:bodyPr wrap="square" rtlCol="0">
              <a:spAutoFit/>
            </a:bodyPr>
            <a:lstStyle/>
            <a:p>
              <a:r>
                <a:rPr lang="en-US" altLang="ko-KR" sz="1200" dirty="0">
                  <a:latin typeface="Arial" panose="020B0604020202020204" pitchFamily="34" charset="0"/>
                  <a:cs typeface="Arial" panose="020B0604020202020204" pitchFamily="34" charset="0"/>
                </a:rPr>
                <a:t>p-Akt</a:t>
              </a:r>
              <a:endParaRPr lang="ko-KR" altLang="en-US" sz="12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CB1F85E8-3192-7416-9F02-16DF7E2217AA}"/>
                </a:ext>
              </a:extLst>
            </p:cNvPr>
            <p:cNvSpPr txBox="1"/>
            <p:nvPr/>
          </p:nvSpPr>
          <p:spPr>
            <a:xfrm rot="19560000">
              <a:off x="2421626" y="3013651"/>
              <a:ext cx="816249"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GSK3</a:t>
              </a:r>
              <a:r>
                <a:rPr lang="en-US" altLang="ko-KR" sz="1200" dirty="0">
                  <a:latin typeface="Arial" panose="020B0604020202020204" pitchFamily="34" charset="0"/>
                  <a:cs typeface="Arial" panose="020B0604020202020204" pitchFamily="34" charset="0"/>
                  <a:sym typeface="Symbol" panose="05050102010706020507" pitchFamily="18" charset="2"/>
                </a:rPr>
                <a:t></a:t>
              </a:r>
              <a:endParaRPr lang="ko-KR" altLang="en-US" sz="1200" dirty="0">
                <a:latin typeface="Arial" panose="020B0604020202020204" pitchFamily="34" charset="0"/>
                <a:cs typeface="Arial" panose="020B0604020202020204" pitchFamily="34" charset="0"/>
              </a:endParaRPr>
            </a:p>
          </p:txBody>
        </p:sp>
        <p:graphicFrame>
          <p:nvGraphicFramePr>
            <p:cNvPr id="2" name="개체 1">
              <a:extLst>
                <a:ext uri="{FF2B5EF4-FFF2-40B4-BE49-F238E27FC236}">
                  <a16:creationId xmlns:a16="http://schemas.microsoft.com/office/drawing/2014/main" id="{075F7454-85A0-7A35-E95A-B46B79DFEFE1}"/>
                </a:ext>
              </a:extLst>
            </p:cNvPr>
            <p:cNvGraphicFramePr>
              <a:graphicFrameLocks noChangeAspect="1"/>
            </p:cNvGraphicFramePr>
            <p:nvPr>
              <p:extLst>
                <p:ext uri="{D42A27DB-BD31-4B8C-83A1-F6EECF244321}">
                  <p14:modId xmlns:p14="http://schemas.microsoft.com/office/powerpoint/2010/main" val="1795497718"/>
                </p:ext>
              </p:extLst>
            </p:nvPr>
          </p:nvGraphicFramePr>
          <p:xfrm>
            <a:off x="151901" y="775850"/>
            <a:ext cx="3465738" cy="2450908"/>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2" name="개체 1">
                          <a:extLst>
                            <a:ext uri="{FF2B5EF4-FFF2-40B4-BE49-F238E27FC236}">
                              <a16:creationId xmlns:a16="http://schemas.microsoft.com/office/drawing/2014/main" id="{075F7454-85A0-7A35-E95A-B46B79DFEFE1}"/>
                            </a:ext>
                          </a:extLst>
                        </p:cNvPr>
                        <p:cNvPicPr/>
                        <p:nvPr/>
                      </p:nvPicPr>
                      <p:blipFill>
                        <a:blip r:embed="rId3"/>
                        <a:stretch>
                          <a:fillRect/>
                        </a:stretch>
                      </p:blipFill>
                      <p:spPr>
                        <a:xfrm>
                          <a:off x="151901" y="775850"/>
                          <a:ext cx="3465738" cy="2450908"/>
                        </a:xfrm>
                        <a:prstGeom prst="rect">
                          <a:avLst/>
                        </a:prstGeom>
                      </p:spPr>
                    </p:pic>
                  </p:oleObj>
                </mc:Fallback>
              </mc:AlternateContent>
            </a:graphicData>
          </a:graphic>
        </p:graphicFrame>
      </p:grpSp>
      <p:grpSp>
        <p:nvGrpSpPr>
          <p:cNvPr id="5" name="그룹 4">
            <a:extLst>
              <a:ext uri="{FF2B5EF4-FFF2-40B4-BE49-F238E27FC236}">
                <a16:creationId xmlns:a16="http://schemas.microsoft.com/office/drawing/2014/main" id="{EEBC7D7F-63FD-9805-3353-76E50E6CAA39}"/>
              </a:ext>
            </a:extLst>
          </p:cNvPr>
          <p:cNvGrpSpPr/>
          <p:nvPr/>
        </p:nvGrpSpPr>
        <p:grpSpPr>
          <a:xfrm>
            <a:off x="3617639" y="775850"/>
            <a:ext cx="3465737" cy="2547087"/>
            <a:chOff x="3617639" y="775850"/>
            <a:chExt cx="3465737" cy="2547087"/>
          </a:xfrm>
        </p:grpSpPr>
        <p:sp>
          <p:nvSpPr>
            <p:cNvPr id="17" name="TextBox 16">
              <a:extLst>
                <a:ext uri="{FF2B5EF4-FFF2-40B4-BE49-F238E27FC236}">
                  <a16:creationId xmlns:a16="http://schemas.microsoft.com/office/drawing/2014/main" id="{1E6148A3-CDB2-FE16-EAF2-A427C1DB12B9}"/>
                </a:ext>
              </a:extLst>
            </p:cNvPr>
            <p:cNvSpPr txBox="1"/>
            <p:nvPr/>
          </p:nvSpPr>
          <p:spPr>
            <a:xfrm rot="19560000">
              <a:off x="4154053" y="2956283"/>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Nrf2</a:t>
              </a:r>
              <a:endParaRPr lang="ko-KR" altLang="en-US" sz="12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27F35D5C-F2EC-306F-8F8E-B3D82735D291}"/>
                </a:ext>
              </a:extLst>
            </p:cNvPr>
            <p:cNvSpPr txBox="1"/>
            <p:nvPr/>
          </p:nvSpPr>
          <p:spPr>
            <a:xfrm rot="19569742">
              <a:off x="4325781" y="3045938"/>
              <a:ext cx="934871"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a:t>
              </a:r>
              <a:r>
                <a:rPr lang="en-US" altLang="ko-KR" sz="1200" dirty="0" err="1">
                  <a:latin typeface="Arial" panose="020B0604020202020204" pitchFamily="34" charset="0"/>
                  <a:cs typeface="Arial" panose="020B0604020202020204" pitchFamily="34" charset="0"/>
                </a:rPr>
                <a:t>CaMKK</a:t>
              </a:r>
              <a:r>
                <a:rPr lang="en-US" altLang="ko-KR" sz="1200" dirty="0">
                  <a:latin typeface="Arial" panose="020B0604020202020204" pitchFamily="34" charset="0"/>
                  <a:cs typeface="Arial" panose="020B0604020202020204" pitchFamily="34" charset="0"/>
                  <a:sym typeface="Symbol" panose="05050102010706020507" pitchFamily="18" charset="2"/>
                </a:rPr>
                <a:t></a:t>
              </a:r>
              <a:endParaRPr lang="ko-KR" altLang="en-US" sz="12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B5AF5752-1855-DAF6-113A-38F0FCBA939D}"/>
                </a:ext>
              </a:extLst>
            </p:cNvPr>
            <p:cNvSpPr txBox="1"/>
            <p:nvPr/>
          </p:nvSpPr>
          <p:spPr>
            <a:xfrm rot="19560000">
              <a:off x="4955579" y="2997068"/>
              <a:ext cx="756938"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AMPK</a:t>
              </a:r>
              <a:endParaRPr lang="ko-KR" altLang="en-US" sz="12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D7364CD8-1F55-290E-D942-9C5FEB46B752}"/>
                </a:ext>
              </a:extLst>
            </p:cNvPr>
            <p:cNvSpPr txBox="1"/>
            <p:nvPr/>
          </p:nvSpPr>
          <p:spPr>
            <a:xfrm rot="19560000">
              <a:off x="5537813" y="2956283"/>
              <a:ext cx="611065" cy="276999"/>
            </a:xfrm>
            <a:prstGeom prst="rect">
              <a:avLst/>
            </a:prstGeom>
            <a:noFill/>
          </p:spPr>
          <p:txBody>
            <a:bodyPr wrap="square" rtlCol="0">
              <a:spAutoFit/>
            </a:bodyPr>
            <a:lstStyle/>
            <a:p>
              <a:r>
                <a:rPr lang="en-US" altLang="ko-KR" sz="1200" dirty="0">
                  <a:latin typeface="Arial" panose="020B0604020202020204" pitchFamily="34" charset="0"/>
                  <a:cs typeface="Arial" panose="020B0604020202020204" pitchFamily="34" charset="0"/>
                </a:rPr>
                <a:t>p-Akt</a:t>
              </a:r>
              <a:endParaRPr lang="ko-KR" altLang="en-US" sz="12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30FA4D94-8F43-83E4-2293-87F209E66A98}"/>
                </a:ext>
              </a:extLst>
            </p:cNvPr>
            <p:cNvSpPr txBox="1"/>
            <p:nvPr/>
          </p:nvSpPr>
          <p:spPr>
            <a:xfrm rot="19560000">
              <a:off x="5823036" y="3013652"/>
              <a:ext cx="816249"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GSK3</a:t>
              </a:r>
              <a:r>
                <a:rPr lang="en-US" altLang="ko-KR" sz="1200" dirty="0">
                  <a:latin typeface="Arial" panose="020B0604020202020204" pitchFamily="34" charset="0"/>
                  <a:cs typeface="Arial" panose="020B0604020202020204" pitchFamily="34" charset="0"/>
                  <a:sym typeface="Symbol" panose="05050102010706020507" pitchFamily="18" charset="2"/>
                </a:rPr>
                <a:t></a:t>
              </a:r>
              <a:endParaRPr lang="ko-KR" altLang="en-US" sz="1200" dirty="0">
                <a:latin typeface="Arial" panose="020B0604020202020204" pitchFamily="34" charset="0"/>
                <a:cs typeface="Arial" panose="020B0604020202020204" pitchFamily="34" charset="0"/>
              </a:endParaRPr>
            </a:p>
          </p:txBody>
        </p:sp>
        <p:graphicFrame>
          <p:nvGraphicFramePr>
            <p:cNvPr id="4" name="개체 3">
              <a:extLst>
                <a:ext uri="{FF2B5EF4-FFF2-40B4-BE49-F238E27FC236}">
                  <a16:creationId xmlns:a16="http://schemas.microsoft.com/office/drawing/2014/main" id="{7C166690-5438-93F8-5324-206565708AF0}"/>
                </a:ext>
              </a:extLst>
            </p:cNvPr>
            <p:cNvGraphicFramePr>
              <a:graphicFrameLocks noChangeAspect="1"/>
            </p:cNvGraphicFramePr>
            <p:nvPr>
              <p:extLst>
                <p:ext uri="{D42A27DB-BD31-4B8C-83A1-F6EECF244321}">
                  <p14:modId xmlns:p14="http://schemas.microsoft.com/office/powerpoint/2010/main" val="3559707370"/>
                </p:ext>
              </p:extLst>
            </p:nvPr>
          </p:nvGraphicFramePr>
          <p:xfrm>
            <a:off x="3617639" y="775850"/>
            <a:ext cx="3465737" cy="2450908"/>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4" name="개체 3">
                          <a:extLst>
                            <a:ext uri="{FF2B5EF4-FFF2-40B4-BE49-F238E27FC236}">
                              <a16:creationId xmlns:a16="http://schemas.microsoft.com/office/drawing/2014/main" id="{7C166690-5438-93F8-5324-206565708AF0}"/>
                            </a:ext>
                          </a:extLst>
                        </p:cNvPr>
                        <p:cNvPicPr/>
                        <p:nvPr/>
                      </p:nvPicPr>
                      <p:blipFill>
                        <a:blip r:embed="rId5"/>
                        <a:stretch>
                          <a:fillRect/>
                        </a:stretch>
                      </p:blipFill>
                      <p:spPr>
                        <a:xfrm>
                          <a:off x="3617639" y="775850"/>
                          <a:ext cx="3465737" cy="2450908"/>
                        </a:xfrm>
                        <a:prstGeom prst="rect">
                          <a:avLst/>
                        </a:prstGeom>
                      </p:spPr>
                    </p:pic>
                  </p:oleObj>
                </mc:Fallback>
              </mc:AlternateContent>
            </a:graphicData>
          </a:graphic>
        </p:graphicFrame>
      </p:grpSp>
      <p:grpSp>
        <p:nvGrpSpPr>
          <p:cNvPr id="8" name="그룹 7">
            <a:extLst>
              <a:ext uri="{FF2B5EF4-FFF2-40B4-BE49-F238E27FC236}">
                <a16:creationId xmlns:a16="http://schemas.microsoft.com/office/drawing/2014/main" id="{1964A1F5-5648-787E-60AF-7660D11CC90A}"/>
              </a:ext>
            </a:extLst>
          </p:cNvPr>
          <p:cNvGrpSpPr/>
          <p:nvPr/>
        </p:nvGrpSpPr>
        <p:grpSpPr>
          <a:xfrm>
            <a:off x="95149" y="3836014"/>
            <a:ext cx="3669180" cy="2594779"/>
            <a:chOff x="95149" y="3836014"/>
            <a:chExt cx="3669180" cy="2594779"/>
          </a:xfrm>
        </p:grpSpPr>
        <p:sp>
          <p:nvSpPr>
            <p:cNvPr id="25" name="TextBox 24">
              <a:extLst>
                <a:ext uri="{FF2B5EF4-FFF2-40B4-BE49-F238E27FC236}">
                  <a16:creationId xmlns:a16="http://schemas.microsoft.com/office/drawing/2014/main" id="{6165D999-B8C3-728E-901E-CB175312D14E}"/>
                </a:ext>
              </a:extLst>
            </p:cNvPr>
            <p:cNvSpPr txBox="1"/>
            <p:nvPr/>
          </p:nvSpPr>
          <p:spPr>
            <a:xfrm>
              <a:off x="871648" y="6112363"/>
              <a:ext cx="47481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rf2</a:t>
              </a:r>
              <a:endParaRPr lang="ko-KR" altLang="en-US" sz="12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A7ED2507-B67D-36FC-1E2F-CD4482514A84}"/>
                </a:ext>
              </a:extLst>
            </p:cNvPr>
            <p:cNvSpPr txBox="1"/>
            <p:nvPr/>
          </p:nvSpPr>
          <p:spPr>
            <a:xfrm>
              <a:off x="1451538" y="6112363"/>
              <a:ext cx="55175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HO-1</a:t>
              </a:r>
              <a:endParaRPr lang="ko-KR" altLang="en-US" sz="12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034B6B6B-693F-0D4F-FC9C-973A0615BDB9}"/>
                </a:ext>
              </a:extLst>
            </p:cNvPr>
            <p:cNvSpPr txBox="1"/>
            <p:nvPr/>
          </p:nvSpPr>
          <p:spPr>
            <a:xfrm>
              <a:off x="2044852" y="6112363"/>
              <a:ext cx="62068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QO1</a:t>
              </a:r>
              <a:endParaRPr lang="ko-KR" altLang="en-US" sz="12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52D52E85-37E5-F3F6-53AB-B981AEE9EDD2}"/>
                </a:ext>
              </a:extLst>
            </p:cNvPr>
            <p:cNvSpPr txBox="1"/>
            <p:nvPr/>
          </p:nvSpPr>
          <p:spPr>
            <a:xfrm>
              <a:off x="2666695" y="6112363"/>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GCLC</a:t>
              </a:r>
              <a:endParaRPr lang="ko-KR" altLang="en-US" sz="1200" dirty="0">
                <a:latin typeface="Arial" panose="020B0604020202020204" pitchFamily="34" charset="0"/>
                <a:cs typeface="Arial" panose="020B0604020202020204" pitchFamily="34" charset="0"/>
              </a:endParaRPr>
            </a:p>
          </p:txBody>
        </p:sp>
        <p:graphicFrame>
          <p:nvGraphicFramePr>
            <p:cNvPr id="6" name="개체 5">
              <a:extLst>
                <a:ext uri="{FF2B5EF4-FFF2-40B4-BE49-F238E27FC236}">
                  <a16:creationId xmlns:a16="http://schemas.microsoft.com/office/drawing/2014/main" id="{8206D0F2-2427-133D-BDA9-A6CFF7601ED0}"/>
                </a:ext>
              </a:extLst>
            </p:cNvPr>
            <p:cNvGraphicFramePr>
              <a:graphicFrameLocks noChangeAspect="1"/>
            </p:cNvGraphicFramePr>
            <p:nvPr>
              <p:extLst>
                <p:ext uri="{D42A27DB-BD31-4B8C-83A1-F6EECF244321}">
                  <p14:modId xmlns:p14="http://schemas.microsoft.com/office/powerpoint/2010/main" val="2927615984"/>
                </p:ext>
              </p:extLst>
            </p:nvPr>
          </p:nvGraphicFramePr>
          <p:xfrm>
            <a:off x="95149" y="3836014"/>
            <a:ext cx="3669180" cy="2594779"/>
          </p:xfrm>
          <a:graphic>
            <a:graphicData uri="http://schemas.openxmlformats.org/presentationml/2006/ole">
              <mc:AlternateContent xmlns:mc="http://schemas.openxmlformats.org/markup-compatibility/2006">
                <mc:Choice xmlns:v="urn:schemas-microsoft-com:vml" Requires="v">
                  <p:oleObj name="Graph" r:id="rId6" imgW="33403857" imgH="23621831" progId="Origin50.Graph">
                    <p:embed/>
                  </p:oleObj>
                </mc:Choice>
                <mc:Fallback>
                  <p:oleObj name="Graph" r:id="rId6" imgW="33403857" imgH="23621831" progId="Origin50.Graph">
                    <p:embed/>
                    <p:pic>
                      <p:nvPicPr>
                        <p:cNvPr id="6" name="개체 5">
                          <a:extLst>
                            <a:ext uri="{FF2B5EF4-FFF2-40B4-BE49-F238E27FC236}">
                              <a16:creationId xmlns:a16="http://schemas.microsoft.com/office/drawing/2014/main" id="{8206D0F2-2427-133D-BDA9-A6CFF7601ED0}"/>
                            </a:ext>
                          </a:extLst>
                        </p:cNvPr>
                        <p:cNvPicPr/>
                        <p:nvPr/>
                      </p:nvPicPr>
                      <p:blipFill>
                        <a:blip r:embed="rId7"/>
                        <a:stretch>
                          <a:fillRect/>
                        </a:stretch>
                      </p:blipFill>
                      <p:spPr>
                        <a:xfrm>
                          <a:off x="95149" y="3836014"/>
                          <a:ext cx="3669180" cy="2594779"/>
                        </a:xfrm>
                        <a:prstGeom prst="rect">
                          <a:avLst/>
                        </a:prstGeom>
                      </p:spPr>
                    </p:pic>
                  </p:oleObj>
                </mc:Fallback>
              </mc:AlternateContent>
            </a:graphicData>
          </a:graphic>
        </p:graphicFrame>
      </p:grpSp>
      <p:grpSp>
        <p:nvGrpSpPr>
          <p:cNvPr id="45" name="그룹 44">
            <a:extLst>
              <a:ext uri="{FF2B5EF4-FFF2-40B4-BE49-F238E27FC236}">
                <a16:creationId xmlns:a16="http://schemas.microsoft.com/office/drawing/2014/main" id="{A1B6B19B-7A02-E342-9E6F-EC85F7BFF6E4}"/>
              </a:ext>
            </a:extLst>
          </p:cNvPr>
          <p:cNvGrpSpPr/>
          <p:nvPr/>
        </p:nvGrpSpPr>
        <p:grpSpPr>
          <a:xfrm>
            <a:off x="3525731" y="4008020"/>
            <a:ext cx="3465737" cy="2450908"/>
            <a:chOff x="3525731" y="4008020"/>
            <a:chExt cx="3465737" cy="2450908"/>
          </a:xfrm>
        </p:grpSpPr>
        <p:sp>
          <p:nvSpPr>
            <p:cNvPr id="33" name="TextBox 32">
              <a:extLst>
                <a:ext uri="{FF2B5EF4-FFF2-40B4-BE49-F238E27FC236}">
                  <a16:creationId xmlns:a16="http://schemas.microsoft.com/office/drawing/2014/main" id="{9A304573-3D04-6452-C139-C76EDD9192FA}"/>
                </a:ext>
              </a:extLst>
            </p:cNvPr>
            <p:cNvSpPr txBox="1"/>
            <p:nvPr/>
          </p:nvSpPr>
          <p:spPr>
            <a:xfrm>
              <a:off x="4362440" y="6112363"/>
              <a:ext cx="47481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rf2</a:t>
              </a:r>
              <a:endParaRPr lang="ko-KR" altLang="en-US" sz="1200"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7AD07349-B721-43B0-019A-EB5182D70F37}"/>
                </a:ext>
              </a:extLst>
            </p:cNvPr>
            <p:cNvSpPr txBox="1"/>
            <p:nvPr/>
          </p:nvSpPr>
          <p:spPr>
            <a:xfrm>
              <a:off x="4914194" y="6112363"/>
              <a:ext cx="55175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HO-1</a:t>
              </a:r>
              <a:endParaRPr lang="ko-KR" altLang="en-US" sz="12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8196B4E4-1E5F-6219-D298-A0787B659C6D}"/>
                </a:ext>
              </a:extLst>
            </p:cNvPr>
            <p:cNvSpPr txBox="1"/>
            <p:nvPr/>
          </p:nvSpPr>
          <p:spPr>
            <a:xfrm>
              <a:off x="5451237" y="6112363"/>
              <a:ext cx="62068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QO1</a:t>
              </a:r>
              <a:endParaRPr lang="ko-KR" altLang="en-US" sz="12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EFE124B2-646B-FD3C-F924-58E71880ACF9}"/>
                </a:ext>
              </a:extLst>
            </p:cNvPr>
            <p:cNvSpPr txBox="1"/>
            <p:nvPr/>
          </p:nvSpPr>
          <p:spPr>
            <a:xfrm>
              <a:off x="6044943" y="6112363"/>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GCLC</a:t>
              </a:r>
              <a:endParaRPr lang="ko-KR" altLang="en-US" sz="1200" dirty="0">
                <a:latin typeface="Arial" panose="020B0604020202020204" pitchFamily="34" charset="0"/>
                <a:cs typeface="Arial" panose="020B0604020202020204" pitchFamily="34" charset="0"/>
              </a:endParaRPr>
            </a:p>
          </p:txBody>
        </p:sp>
        <p:graphicFrame>
          <p:nvGraphicFramePr>
            <p:cNvPr id="9" name="개체 8">
              <a:extLst>
                <a:ext uri="{FF2B5EF4-FFF2-40B4-BE49-F238E27FC236}">
                  <a16:creationId xmlns:a16="http://schemas.microsoft.com/office/drawing/2014/main" id="{1D343D62-F9A9-8428-0102-5787DF3ECC46}"/>
                </a:ext>
              </a:extLst>
            </p:cNvPr>
            <p:cNvGraphicFramePr>
              <a:graphicFrameLocks noChangeAspect="1"/>
            </p:cNvGraphicFramePr>
            <p:nvPr>
              <p:extLst>
                <p:ext uri="{D42A27DB-BD31-4B8C-83A1-F6EECF244321}">
                  <p14:modId xmlns:p14="http://schemas.microsoft.com/office/powerpoint/2010/main" val="527361286"/>
                </p:ext>
              </p:extLst>
            </p:nvPr>
          </p:nvGraphicFramePr>
          <p:xfrm>
            <a:off x="3525731" y="4008020"/>
            <a:ext cx="3465737" cy="2450908"/>
          </p:xfrm>
          <a:graphic>
            <a:graphicData uri="http://schemas.openxmlformats.org/presentationml/2006/ole">
              <mc:AlternateContent xmlns:mc="http://schemas.openxmlformats.org/markup-compatibility/2006">
                <mc:Choice xmlns:v="urn:schemas-microsoft-com:vml" Requires="v">
                  <p:oleObj name="Graph" r:id="rId8" imgW="33403857" imgH="23621831" progId="Origin50.Graph">
                    <p:embed/>
                  </p:oleObj>
                </mc:Choice>
                <mc:Fallback>
                  <p:oleObj name="Graph" r:id="rId8" imgW="33403857" imgH="23621831" progId="Origin50.Graph">
                    <p:embed/>
                    <p:pic>
                      <p:nvPicPr>
                        <p:cNvPr id="9" name="개체 8">
                          <a:extLst>
                            <a:ext uri="{FF2B5EF4-FFF2-40B4-BE49-F238E27FC236}">
                              <a16:creationId xmlns:a16="http://schemas.microsoft.com/office/drawing/2014/main" id="{1D343D62-F9A9-8428-0102-5787DF3ECC46}"/>
                            </a:ext>
                          </a:extLst>
                        </p:cNvPr>
                        <p:cNvPicPr/>
                        <p:nvPr/>
                      </p:nvPicPr>
                      <p:blipFill>
                        <a:blip r:embed="rId9"/>
                        <a:stretch>
                          <a:fillRect/>
                        </a:stretch>
                      </p:blipFill>
                      <p:spPr>
                        <a:xfrm>
                          <a:off x="3525731" y="4008020"/>
                          <a:ext cx="3465737" cy="2450908"/>
                        </a:xfrm>
                        <a:prstGeom prst="rect">
                          <a:avLst/>
                        </a:prstGeom>
                      </p:spPr>
                    </p:pic>
                  </p:oleObj>
                </mc:Fallback>
              </mc:AlternateContent>
            </a:graphicData>
          </a:graphic>
        </p:graphicFrame>
      </p:grpSp>
      <p:grpSp>
        <p:nvGrpSpPr>
          <p:cNvPr id="47" name="그룹 46">
            <a:extLst>
              <a:ext uri="{FF2B5EF4-FFF2-40B4-BE49-F238E27FC236}">
                <a16:creationId xmlns:a16="http://schemas.microsoft.com/office/drawing/2014/main" id="{F38D30D9-EE5E-22DE-CED5-51CAF10F7B8B}"/>
              </a:ext>
            </a:extLst>
          </p:cNvPr>
          <p:cNvGrpSpPr/>
          <p:nvPr/>
        </p:nvGrpSpPr>
        <p:grpSpPr>
          <a:xfrm>
            <a:off x="91862" y="6739177"/>
            <a:ext cx="3465737" cy="2547576"/>
            <a:chOff x="91862" y="6739177"/>
            <a:chExt cx="3465737" cy="2547576"/>
          </a:xfrm>
        </p:grpSpPr>
        <p:sp>
          <p:nvSpPr>
            <p:cNvPr id="40" name="TextBox 39">
              <a:extLst>
                <a:ext uri="{FF2B5EF4-FFF2-40B4-BE49-F238E27FC236}">
                  <a16:creationId xmlns:a16="http://schemas.microsoft.com/office/drawing/2014/main" id="{18FC7C45-C0AE-3C42-9F57-A203CD05C121}"/>
                </a:ext>
              </a:extLst>
            </p:cNvPr>
            <p:cNvSpPr txBox="1"/>
            <p:nvPr/>
          </p:nvSpPr>
          <p:spPr>
            <a:xfrm>
              <a:off x="910062" y="9009754"/>
              <a:ext cx="47481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rf2</a:t>
              </a:r>
              <a:endParaRPr lang="ko-KR" altLang="en-US" sz="12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572F4FFD-9E46-9A8E-2EE0-B5A2EE88654E}"/>
                </a:ext>
              </a:extLst>
            </p:cNvPr>
            <p:cNvSpPr txBox="1"/>
            <p:nvPr/>
          </p:nvSpPr>
          <p:spPr>
            <a:xfrm>
              <a:off x="1447748" y="9009754"/>
              <a:ext cx="55175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HO-1</a:t>
              </a:r>
              <a:endParaRPr lang="ko-KR" altLang="en-US" sz="12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0744EF3C-85F7-8FB6-B115-1ED5B0824AEE}"/>
                </a:ext>
              </a:extLst>
            </p:cNvPr>
            <p:cNvSpPr txBox="1"/>
            <p:nvPr/>
          </p:nvSpPr>
          <p:spPr>
            <a:xfrm>
              <a:off x="1998859" y="9009754"/>
              <a:ext cx="62068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QO1</a:t>
              </a:r>
              <a:endParaRPr lang="ko-KR" altLang="en-US" sz="1200"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A9413619-6318-9707-EF67-140DED582EBE}"/>
                </a:ext>
              </a:extLst>
            </p:cNvPr>
            <p:cNvSpPr txBox="1"/>
            <p:nvPr/>
          </p:nvSpPr>
          <p:spPr>
            <a:xfrm>
              <a:off x="2592568" y="9009754"/>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GCLC</a:t>
              </a:r>
              <a:endParaRPr lang="ko-KR" altLang="en-US" sz="1200" dirty="0">
                <a:latin typeface="Arial" panose="020B0604020202020204" pitchFamily="34" charset="0"/>
                <a:cs typeface="Arial" panose="020B0604020202020204" pitchFamily="34" charset="0"/>
              </a:endParaRPr>
            </a:p>
          </p:txBody>
        </p:sp>
        <p:graphicFrame>
          <p:nvGraphicFramePr>
            <p:cNvPr id="46" name="개체 45">
              <a:extLst>
                <a:ext uri="{FF2B5EF4-FFF2-40B4-BE49-F238E27FC236}">
                  <a16:creationId xmlns:a16="http://schemas.microsoft.com/office/drawing/2014/main" id="{86361D4D-7D6C-8DD6-7441-9F8B8C916DCA}"/>
                </a:ext>
              </a:extLst>
            </p:cNvPr>
            <p:cNvGraphicFramePr>
              <a:graphicFrameLocks noChangeAspect="1"/>
            </p:cNvGraphicFramePr>
            <p:nvPr>
              <p:extLst>
                <p:ext uri="{D42A27DB-BD31-4B8C-83A1-F6EECF244321}">
                  <p14:modId xmlns:p14="http://schemas.microsoft.com/office/powerpoint/2010/main" val="877977344"/>
                </p:ext>
              </p:extLst>
            </p:nvPr>
          </p:nvGraphicFramePr>
          <p:xfrm>
            <a:off x="91862" y="6739177"/>
            <a:ext cx="3465737" cy="2450908"/>
          </p:xfrm>
          <a:graphic>
            <a:graphicData uri="http://schemas.openxmlformats.org/presentationml/2006/ole">
              <mc:AlternateContent xmlns:mc="http://schemas.openxmlformats.org/markup-compatibility/2006">
                <mc:Choice xmlns:v="urn:schemas-microsoft-com:vml" Requires="v">
                  <p:oleObj name="Graph" r:id="rId10" imgW="33403857" imgH="23621831" progId="Origin50.Graph">
                    <p:embed/>
                  </p:oleObj>
                </mc:Choice>
                <mc:Fallback>
                  <p:oleObj name="Graph" r:id="rId10" imgW="33403857" imgH="23621831" progId="Origin50.Graph">
                    <p:embed/>
                    <p:pic>
                      <p:nvPicPr>
                        <p:cNvPr id="46" name="개체 45">
                          <a:extLst>
                            <a:ext uri="{FF2B5EF4-FFF2-40B4-BE49-F238E27FC236}">
                              <a16:creationId xmlns:a16="http://schemas.microsoft.com/office/drawing/2014/main" id="{86361D4D-7D6C-8DD6-7441-9F8B8C916DCA}"/>
                            </a:ext>
                          </a:extLst>
                        </p:cNvPr>
                        <p:cNvPicPr/>
                        <p:nvPr/>
                      </p:nvPicPr>
                      <p:blipFill>
                        <a:blip r:embed="rId11"/>
                        <a:stretch>
                          <a:fillRect/>
                        </a:stretch>
                      </p:blipFill>
                      <p:spPr>
                        <a:xfrm>
                          <a:off x="91862" y="6739177"/>
                          <a:ext cx="3465737" cy="2450908"/>
                        </a:xfrm>
                        <a:prstGeom prst="rect">
                          <a:avLst/>
                        </a:prstGeom>
                      </p:spPr>
                    </p:pic>
                  </p:oleObj>
                </mc:Fallback>
              </mc:AlternateContent>
            </a:graphicData>
          </a:graphic>
        </p:graphicFrame>
      </p:grpSp>
    </p:spTree>
    <p:extLst>
      <p:ext uri="{BB962C8B-B14F-4D97-AF65-F5344CB8AC3E}">
        <p14:creationId xmlns:p14="http://schemas.microsoft.com/office/powerpoint/2010/main" val="34944786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AB33D9-C1C8-85BC-A6C4-057AC65C6A62}"/>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3D81B343-E128-D6D6-BFEE-8264910A12D1}"/>
              </a:ext>
            </a:extLst>
          </p:cNvPr>
          <p:cNvSpPr txBox="1"/>
          <p:nvPr/>
        </p:nvSpPr>
        <p:spPr>
          <a:xfrm>
            <a:off x="243715" y="7037719"/>
            <a:ext cx="6370570" cy="2308324"/>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5. </a:t>
            </a:r>
            <a:r>
              <a:rPr lang="en-US" altLang="ko-KR" sz="1200" dirty="0">
                <a:latin typeface="Times New Roman" panose="02020603050405020304" pitchFamily="18" charset="0"/>
                <a:cs typeface="Times New Roman" panose="02020603050405020304" pitchFamily="18" charset="0"/>
              </a:rPr>
              <a:t>Effect of Ca</a:t>
            </a:r>
            <a:r>
              <a:rPr lang="en-US" altLang="ko-KR" sz="1200" baseline="30000" dirty="0">
                <a:latin typeface="Times New Roman" panose="02020603050405020304" pitchFamily="18" charset="0"/>
                <a:cs typeface="Times New Roman" panose="02020603050405020304" pitchFamily="18" charset="0"/>
              </a:rPr>
              <a:t>2+</a:t>
            </a:r>
            <a:r>
              <a:rPr lang="en-US" altLang="ko-KR" sz="1200" dirty="0">
                <a:latin typeface="Times New Roman" panose="02020603050405020304" pitchFamily="18" charset="0"/>
                <a:cs typeface="Times New Roman" panose="02020603050405020304" pitchFamily="18" charset="0"/>
              </a:rPr>
              <a:t> on IPA-induced Nrf2 expression via the Akt/AMPK/GSK3β signaling pathway</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The cells were treated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5–60 min and 1–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30 min. (A and B) Quantification of band intensity from Figures 4A and 4B, normalized to the corresponding loading control. In addition, the cells were pretreated with the inhibitor for 1 h, respectively, before treatment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C-E) Quantification of band intensity from Figures 4C-4E, normalized to the corresponding loading control. The cells were subjected to pretreatment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W7 and EDTA for 1 h and treated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30 min or 12 h. (F and G) Quantification of band intensity from Figures 4F and 4G, normalized to the corresponding loading control. The band intensity was analyzed using the ImageJ program. All experiments were performed thrice (n=3). Data are expressed as the mean ± SD. *p&lt; 0.01 compared to the control group. #p&lt; 0.01 compared with the IPA treatment group.</a:t>
            </a:r>
          </a:p>
        </p:txBody>
      </p:sp>
      <p:sp>
        <p:nvSpPr>
          <p:cNvPr id="7" name="TextBox 6">
            <a:extLst>
              <a:ext uri="{FF2B5EF4-FFF2-40B4-BE49-F238E27FC236}">
                <a16:creationId xmlns:a16="http://schemas.microsoft.com/office/drawing/2014/main" id="{EAA613FC-1795-5636-5F80-8C6A67E85A9F}"/>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5.</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 name="TextBox 8">
            <a:extLst>
              <a:ext uri="{FF2B5EF4-FFF2-40B4-BE49-F238E27FC236}">
                <a16:creationId xmlns:a16="http://schemas.microsoft.com/office/drawing/2014/main" id="{577C761E-E8C4-16B9-AF79-68A5B9B1274D}"/>
              </a:ext>
            </a:extLst>
          </p:cNvPr>
          <p:cNvSpPr txBox="1"/>
          <p:nvPr/>
        </p:nvSpPr>
        <p:spPr>
          <a:xfrm>
            <a:off x="390748" y="603889"/>
            <a:ext cx="279243"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F</a:t>
            </a:r>
            <a:endParaRPr lang="ko-KR" altLang="en-US" sz="12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482A1E52-1B8C-238F-26B4-D3CD0694491D}"/>
              </a:ext>
            </a:extLst>
          </p:cNvPr>
          <p:cNvSpPr txBox="1"/>
          <p:nvPr/>
        </p:nvSpPr>
        <p:spPr>
          <a:xfrm>
            <a:off x="238302" y="3847993"/>
            <a:ext cx="304892"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G</a:t>
            </a:r>
            <a:endParaRPr lang="ko-KR" altLang="en-US" sz="1200" b="1" dirty="0">
              <a:latin typeface="Arial" panose="020B0604020202020204" pitchFamily="34" charset="0"/>
              <a:cs typeface="Arial" panose="020B0604020202020204" pitchFamily="34" charset="0"/>
            </a:endParaRPr>
          </a:p>
        </p:txBody>
      </p:sp>
      <p:grpSp>
        <p:nvGrpSpPr>
          <p:cNvPr id="3" name="그룹 2">
            <a:extLst>
              <a:ext uri="{FF2B5EF4-FFF2-40B4-BE49-F238E27FC236}">
                <a16:creationId xmlns:a16="http://schemas.microsoft.com/office/drawing/2014/main" id="{4BB8E74E-5028-A0C9-9D87-F4885F729786}"/>
              </a:ext>
            </a:extLst>
          </p:cNvPr>
          <p:cNvGrpSpPr/>
          <p:nvPr/>
        </p:nvGrpSpPr>
        <p:grpSpPr>
          <a:xfrm>
            <a:off x="232844" y="630339"/>
            <a:ext cx="4036280" cy="2854386"/>
            <a:chOff x="149297" y="559957"/>
            <a:chExt cx="4036280" cy="2854386"/>
          </a:xfrm>
        </p:grpSpPr>
        <p:sp>
          <p:nvSpPr>
            <p:cNvPr id="12" name="TextBox 11">
              <a:extLst>
                <a:ext uri="{FF2B5EF4-FFF2-40B4-BE49-F238E27FC236}">
                  <a16:creationId xmlns:a16="http://schemas.microsoft.com/office/drawing/2014/main" id="{461D390B-FEBF-B4FA-7D0C-84041FDCC3B0}"/>
                </a:ext>
              </a:extLst>
            </p:cNvPr>
            <p:cNvSpPr txBox="1"/>
            <p:nvPr/>
          </p:nvSpPr>
          <p:spPr>
            <a:xfrm rot="19560000">
              <a:off x="859737" y="3042392"/>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Nrf2</a:t>
              </a:r>
              <a:endParaRPr lang="ko-KR" altLang="en-US" sz="12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5D1FBC11-5D24-A1F8-7A42-9DA739A3231C}"/>
                </a:ext>
              </a:extLst>
            </p:cNvPr>
            <p:cNvSpPr txBox="1"/>
            <p:nvPr/>
          </p:nvSpPr>
          <p:spPr>
            <a:xfrm rot="19569742">
              <a:off x="1115870" y="3132047"/>
              <a:ext cx="934871"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a:t>
              </a:r>
              <a:r>
                <a:rPr lang="en-US" altLang="ko-KR" sz="1200" dirty="0" err="1">
                  <a:latin typeface="Arial" panose="020B0604020202020204" pitchFamily="34" charset="0"/>
                  <a:cs typeface="Arial" panose="020B0604020202020204" pitchFamily="34" charset="0"/>
                </a:rPr>
                <a:t>CaMKK</a:t>
              </a:r>
              <a:r>
                <a:rPr lang="en-US" altLang="ko-KR" sz="1200" dirty="0">
                  <a:latin typeface="Arial" panose="020B0604020202020204" pitchFamily="34" charset="0"/>
                  <a:cs typeface="Arial" panose="020B0604020202020204" pitchFamily="34" charset="0"/>
                  <a:sym typeface="Symbol" panose="05050102010706020507" pitchFamily="18" charset="2"/>
                </a:rPr>
                <a:t></a:t>
              </a:r>
              <a:endParaRPr lang="ko-KR" altLang="en-US" sz="12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AA621BA4-097B-6FBB-F404-D1DF83B0E826}"/>
                </a:ext>
              </a:extLst>
            </p:cNvPr>
            <p:cNvSpPr txBox="1"/>
            <p:nvPr/>
          </p:nvSpPr>
          <p:spPr>
            <a:xfrm rot="19560000">
              <a:off x="1816008" y="3083177"/>
              <a:ext cx="756938"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AMPK</a:t>
              </a:r>
              <a:endParaRPr lang="ko-KR" altLang="en-US" sz="12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2EA4317B-7FB2-DFBA-32D3-97719C99874F}"/>
                </a:ext>
              </a:extLst>
            </p:cNvPr>
            <p:cNvSpPr txBox="1"/>
            <p:nvPr/>
          </p:nvSpPr>
          <p:spPr>
            <a:xfrm rot="19560000">
              <a:off x="2482650" y="3042392"/>
              <a:ext cx="611065" cy="276999"/>
            </a:xfrm>
            <a:prstGeom prst="rect">
              <a:avLst/>
            </a:prstGeom>
            <a:noFill/>
          </p:spPr>
          <p:txBody>
            <a:bodyPr wrap="square" rtlCol="0">
              <a:spAutoFit/>
            </a:bodyPr>
            <a:lstStyle/>
            <a:p>
              <a:r>
                <a:rPr lang="en-US" altLang="ko-KR" sz="1200" dirty="0">
                  <a:latin typeface="Arial" panose="020B0604020202020204" pitchFamily="34" charset="0"/>
                  <a:cs typeface="Arial" panose="020B0604020202020204" pitchFamily="34" charset="0"/>
                </a:rPr>
                <a:t>p-Akt</a:t>
              </a:r>
              <a:endParaRPr lang="ko-KR" altLang="en-US" sz="12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2C75C8E5-06F4-83BF-D396-490FDDB539F6}"/>
                </a:ext>
              </a:extLst>
            </p:cNvPr>
            <p:cNvSpPr txBox="1"/>
            <p:nvPr/>
          </p:nvSpPr>
          <p:spPr>
            <a:xfrm rot="19560000">
              <a:off x="2838213" y="3099761"/>
              <a:ext cx="816249"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GSK3</a:t>
              </a:r>
              <a:r>
                <a:rPr lang="en-US" altLang="ko-KR" sz="1200" dirty="0">
                  <a:latin typeface="Arial" panose="020B0604020202020204" pitchFamily="34" charset="0"/>
                  <a:cs typeface="Arial" panose="020B0604020202020204" pitchFamily="34" charset="0"/>
                  <a:sym typeface="Symbol" panose="05050102010706020507" pitchFamily="18" charset="2"/>
                </a:rPr>
                <a:t></a:t>
              </a:r>
              <a:endParaRPr lang="ko-KR" altLang="en-US" sz="1200" dirty="0">
                <a:latin typeface="Arial" panose="020B0604020202020204" pitchFamily="34" charset="0"/>
                <a:cs typeface="Arial" panose="020B0604020202020204" pitchFamily="34" charset="0"/>
              </a:endParaRPr>
            </a:p>
          </p:txBody>
        </p:sp>
        <p:graphicFrame>
          <p:nvGraphicFramePr>
            <p:cNvPr id="2" name="개체 1">
              <a:extLst>
                <a:ext uri="{FF2B5EF4-FFF2-40B4-BE49-F238E27FC236}">
                  <a16:creationId xmlns:a16="http://schemas.microsoft.com/office/drawing/2014/main" id="{6E92B3DA-2B10-21A1-89CE-3571D1B480AE}"/>
                </a:ext>
              </a:extLst>
            </p:cNvPr>
            <p:cNvGraphicFramePr>
              <a:graphicFrameLocks noChangeAspect="1"/>
            </p:cNvGraphicFramePr>
            <p:nvPr>
              <p:extLst>
                <p:ext uri="{D42A27DB-BD31-4B8C-83A1-F6EECF244321}">
                  <p14:modId xmlns:p14="http://schemas.microsoft.com/office/powerpoint/2010/main" val="2211221936"/>
                </p:ext>
              </p:extLst>
            </p:nvPr>
          </p:nvGraphicFramePr>
          <p:xfrm>
            <a:off x="149297" y="559957"/>
            <a:ext cx="4036280" cy="2854386"/>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2" name="개체 1">
                          <a:extLst>
                            <a:ext uri="{FF2B5EF4-FFF2-40B4-BE49-F238E27FC236}">
                              <a16:creationId xmlns:a16="http://schemas.microsoft.com/office/drawing/2014/main" id="{6E92B3DA-2B10-21A1-89CE-3571D1B480AE}"/>
                            </a:ext>
                          </a:extLst>
                        </p:cNvPr>
                        <p:cNvPicPr/>
                        <p:nvPr/>
                      </p:nvPicPr>
                      <p:blipFill>
                        <a:blip r:embed="rId3"/>
                        <a:stretch>
                          <a:fillRect/>
                        </a:stretch>
                      </p:blipFill>
                      <p:spPr>
                        <a:xfrm>
                          <a:off x="149297" y="559957"/>
                          <a:ext cx="4036280" cy="2854386"/>
                        </a:xfrm>
                        <a:prstGeom prst="rect">
                          <a:avLst/>
                        </a:prstGeom>
                      </p:spPr>
                    </p:pic>
                  </p:oleObj>
                </mc:Fallback>
              </mc:AlternateContent>
            </a:graphicData>
          </a:graphic>
        </p:graphicFrame>
      </p:grpSp>
      <p:grpSp>
        <p:nvGrpSpPr>
          <p:cNvPr id="6" name="그룹 5">
            <a:extLst>
              <a:ext uri="{FF2B5EF4-FFF2-40B4-BE49-F238E27FC236}">
                <a16:creationId xmlns:a16="http://schemas.microsoft.com/office/drawing/2014/main" id="{EA334968-5323-1EFE-A2C0-62279F6B0A6D}"/>
              </a:ext>
            </a:extLst>
          </p:cNvPr>
          <p:cNvGrpSpPr/>
          <p:nvPr/>
        </p:nvGrpSpPr>
        <p:grpSpPr>
          <a:xfrm>
            <a:off x="390748" y="3847993"/>
            <a:ext cx="4036281" cy="2854386"/>
            <a:chOff x="390748" y="3847993"/>
            <a:chExt cx="4036281" cy="2854386"/>
          </a:xfrm>
        </p:grpSpPr>
        <p:sp>
          <p:nvSpPr>
            <p:cNvPr id="19" name="TextBox 18">
              <a:extLst>
                <a:ext uri="{FF2B5EF4-FFF2-40B4-BE49-F238E27FC236}">
                  <a16:creationId xmlns:a16="http://schemas.microsoft.com/office/drawing/2014/main" id="{1AB28654-99F6-8C4F-6CE3-53696D0497A9}"/>
                </a:ext>
              </a:extLst>
            </p:cNvPr>
            <p:cNvSpPr txBox="1"/>
            <p:nvPr/>
          </p:nvSpPr>
          <p:spPr>
            <a:xfrm>
              <a:off x="1260098" y="6350913"/>
              <a:ext cx="47481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rf2</a:t>
              </a:r>
              <a:endParaRPr lang="ko-KR" altLang="en-US" sz="12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0A79FC7D-180C-1A85-E23F-921B8D66533E}"/>
                </a:ext>
              </a:extLst>
            </p:cNvPr>
            <p:cNvSpPr txBox="1"/>
            <p:nvPr/>
          </p:nvSpPr>
          <p:spPr>
            <a:xfrm>
              <a:off x="1910328" y="6350913"/>
              <a:ext cx="55175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HO-1</a:t>
              </a:r>
              <a:endParaRPr lang="ko-KR" altLang="en-US" sz="12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87EF596E-D282-FCF5-BFE1-011FF2B7FE7E}"/>
                </a:ext>
              </a:extLst>
            </p:cNvPr>
            <p:cNvSpPr txBox="1"/>
            <p:nvPr/>
          </p:nvSpPr>
          <p:spPr>
            <a:xfrm>
              <a:off x="2559914" y="6350913"/>
              <a:ext cx="620683"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NQO1</a:t>
              </a:r>
              <a:endParaRPr lang="ko-KR" altLang="en-US" sz="12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C0FD8BBC-A1F0-21FB-9928-8980951DACB5}"/>
                </a:ext>
              </a:extLst>
            </p:cNvPr>
            <p:cNvSpPr txBox="1"/>
            <p:nvPr/>
          </p:nvSpPr>
          <p:spPr>
            <a:xfrm>
              <a:off x="3252097" y="6350913"/>
              <a:ext cx="61106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GCLC</a:t>
              </a:r>
              <a:endParaRPr lang="ko-KR" altLang="en-US" sz="1200" dirty="0">
                <a:latin typeface="Arial" panose="020B0604020202020204" pitchFamily="34" charset="0"/>
                <a:cs typeface="Arial" panose="020B0604020202020204" pitchFamily="34" charset="0"/>
              </a:endParaRPr>
            </a:p>
          </p:txBody>
        </p:sp>
        <p:graphicFrame>
          <p:nvGraphicFramePr>
            <p:cNvPr id="5" name="개체 4">
              <a:extLst>
                <a:ext uri="{FF2B5EF4-FFF2-40B4-BE49-F238E27FC236}">
                  <a16:creationId xmlns:a16="http://schemas.microsoft.com/office/drawing/2014/main" id="{74F1F477-3E8F-BA44-D04B-631B9E221459}"/>
                </a:ext>
              </a:extLst>
            </p:cNvPr>
            <p:cNvGraphicFramePr>
              <a:graphicFrameLocks noChangeAspect="1"/>
            </p:cNvGraphicFramePr>
            <p:nvPr>
              <p:extLst>
                <p:ext uri="{D42A27DB-BD31-4B8C-83A1-F6EECF244321}">
                  <p14:modId xmlns:p14="http://schemas.microsoft.com/office/powerpoint/2010/main" val="3058421810"/>
                </p:ext>
              </p:extLst>
            </p:nvPr>
          </p:nvGraphicFramePr>
          <p:xfrm>
            <a:off x="390748" y="3847993"/>
            <a:ext cx="4036281" cy="2854386"/>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5" name="개체 4">
                          <a:extLst>
                            <a:ext uri="{FF2B5EF4-FFF2-40B4-BE49-F238E27FC236}">
                              <a16:creationId xmlns:a16="http://schemas.microsoft.com/office/drawing/2014/main" id="{74F1F477-3E8F-BA44-D04B-631B9E221459}"/>
                            </a:ext>
                          </a:extLst>
                        </p:cNvPr>
                        <p:cNvPicPr/>
                        <p:nvPr/>
                      </p:nvPicPr>
                      <p:blipFill>
                        <a:blip r:embed="rId5"/>
                        <a:stretch>
                          <a:fillRect/>
                        </a:stretch>
                      </p:blipFill>
                      <p:spPr>
                        <a:xfrm>
                          <a:off x="390748" y="3847993"/>
                          <a:ext cx="4036281" cy="2854386"/>
                        </a:xfrm>
                        <a:prstGeom prst="rect">
                          <a:avLst/>
                        </a:prstGeom>
                      </p:spPr>
                    </p:pic>
                  </p:oleObj>
                </mc:Fallback>
              </mc:AlternateContent>
            </a:graphicData>
          </a:graphic>
        </p:graphicFrame>
      </p:grpSp>
    </p:spTree>
    <p:extLst>
      <p:ext uri="{BB962C8B-B14F-4D97-AF65-F5344CB8AC3E}">
        <p14:creationId xmlns:p14="http://schemas.microsoft.com/office/powerpoint/2010/main" val="3680408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5EA1620-3A4F-53F6-E09A-CB987F827B83}"/>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78F822B4-A62C-F742-D4D4-89E0C69037F1}"/>
              </a:ext>
            </a:extLst>
          </p:cNvPr>
          <p:cNvSpPr txBox="1"/>
          <p:nvPr/>
        </p:nvSpPr>
        <p:spPr>
          <a:xfrm>
            <a:off x="303776" y="3696110"/>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1BE06767-31C8-0BA8-EEA0-4FE2EB057C39}"/>
              </a:ext>
            </a:extLst>
          </p:cNvPr>
          <p:cNvSpPr txBox="1"/>
          <p:nvPr/>
        </p:nvSpPr>
        <p:spPr>
          <a:xfrm>
            <a:off x="243715" y="7707594"/>
            <a:ext cx="6370570" cy="1569660"/>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6. </a:t>
            </a:r>
            <a:r>
              <a:rPr lang="en-US" altLang="ko-KR" sz="1200" dirty="0">
                <a:latin typeface="Times New Roman" panose="02020603050405020304" pitchFamily="18" charset="0"/>
                <a:cs typeface="Times New Roman" panose="02020603050405020304" pitchFamily="18" charset="0"/>
              </a:rPr>
              <a:t>Effect of IPA on Nrf2 activation via the Keap1/p62 signaling pathway</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The cells were exposed to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3–12 h and 1–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for 12 h. (A and B) Quantification of band intensity from Figure 5A and 5B, normalized to the corresponding loading control. After pretreatment of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Compound C or Chloroquine for 1 h, the cells were treated with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C and D) Quantification of band intensity from Figure 5</a:t>
            </a:r>
            <a:r>
              <a:rPr lang="en-US" altLang="ko-KR" sz="1200" kern="100" dirty="0">
                <a:latin typeface="Times New Roman" panose="02020603050405020304" pitchFamily="18" charset="0"/>
                <a:ea typeface="맑은 고딕" panose="020B0503020000020004" pitchFamily="50" charset="-127"/>
                <a:cs typeface="Arial" panose="020B0604020202020204" pitchFamily="34" charset="0"/>
              </a:rPr>
              <a:t>D and 5E</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normalized to the corresponding loading control. The band intensity was analyzed using the ImageJ program. All experiments were performed thrice (n=3). Data are expressed as the mean ± SD. *p&lt; 0.01 compared to the control group. #p&lt; 0.01 compared with the IPA treatment group.</a:t>
            </a:r>
          </a:p>
        </p:txBody>
      </p:sp>
      <p:sp>
        <p:nvSpPr>
          <p:cNvPr id="5" name="TextBox 4">
            <a:extLst>
              <a:ext uri="{FF2B5EF4-FFF2-40B4-BE49-F238E27FC236}">
                <a16:creationId xmlns:a16="http://schemas.microsoft.com/office/drawing/2014/main" id="{D606255E-0C41-895B-7798-EEE1D28B721F}"/>
              </a:ext>
            </a:extLst>
          </p:cNvPr>
          <p:cNvSpPr txBox="1"/>
          <p:nvPr/>
        </p:nvSpPr>
        <p:spPr>
          <a:xfrm>
            <a:off x="3467714" y="3696110"/>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D</a:t>
            </a:r>
            <a:endParaRPr lang="ko-KR" altLang="en-US" sz="1200" b="1" dirty="0">
              <a:latin typeface="Arial" panose="020B0604020202020204" pitchFamily="34" charset="0"/>
              <a:cs typeface="Arial" panose="020B0604020202020204" pitchFamily="34" charset="0"/>
            </a:endParaRPr>
          </a:p>
        </p:txBody>
      </p:sp>
      <p:sp>
        <p:nvSpPr>
          <p:cNvPr id="96" name="TextBox 95">
            <a:extLst>
              <a:ext uri="{FF2B5EF4-FFF2-40B4-BE49-F238E27FC236}">
                <a16:creationId xmlns:a16="http://schemas.microsoft.com/office/drawing/2014/main" id="{509967B6-DE41-783E-4D7B-30F38E803053}"/>
              </a:ext>
            </a:extLst>
          </p:cNvPr>
          <p:cNvSpPr txBox="1"/>
          <p:nvPr/>
        </p:nvSpPr>
        <p:spPr>
          <a:xfrm>
            <a:off x="303776" y="628746"/>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E9E62269-CEDC-59D6-DD2D-BAD197E6DE84}"/>
              </a:ext>
            </a:extLst>
          </p:cNvPr>
          <p:cNvSpPr txBox="1"/>
          <p:nvPr/>
        </p:nvSpPr>
        <p:spPr>
          <a:xfrm>
            <a:off x="3467714" y="628746"/>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DFC18942-6A58-244F-19DA-EE3B13EB7419}"/>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6.</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nvGrpSpPr>
          <p:cNvPr id="18" name="그룹 17">
            <a:extLst>
              <a:ext uri="{FF2B5EF4-FFF2-40B4-BE49-F238E27FC236}">
                <a16:creationId xmlns:a16="http://schemas.microsoft.com/office/drawing/2014/main" id="{A9791FDD-5A38-F965-25B5-CD6426B310C5}"/>
              </a:ext>
            </a:extLst>
          </p:cNvPr>
          <p:cNvGrpSpPr/>
          <p:nvPr/>
        </p:nvGrpSpPr>
        <p:grpSpPr>
          <a:xfrm>
            <a:off x="55475" y="806153"/>
            <a:ext cx="3478184" cy="2459710"/>
            <a:chOff x="55475" y="806153"/>
            <a:chExt cx="3478184" cy="2459710"/>
          </a:xfrm>
        </p:grpSpPr>
        <p:sp>
          <p:nvSpPr>
            <p:cNvPr id="6" name="TextBox 5">
              <a:extLst>
                <a:ext uri="{FF2B5EF4-FFF2-40B4-BE49-F238E27FC236}">
                  <a16:creationId xmlns:a16="http://schemas.microsoft.com/office/drawing/2014/main" id="{DD106E48-A932-769A-5199-C587849E759C}"/>
                </a:ext>
              </a:extLst>
            </p:cNvPr>
            <p:cNvSpPr txBox="1"/>
            <p:nvPr/>
          </p:nvSpPr>
          <p:spPr>
            <a:xfrm>
              <a:off x="899786" y="2974796"/>
              <a:ext cx="62709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Keap1</a:t>
              </a:r>
              <a:endParaRPr lang="ko-KR" altLang="en-US" sz="12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EC7D7A26-8D78-14C6-6891-4A9FDD99E9F7}"/>
                </a:ext>
              </a:extLst>
            </p:cNvPr>
            <p:cNvSpPr txBox="1"/>
            <p:nvPr/>
          </p:nvSpPr>
          <p:spPr>
            <a:xfrm>
              <a:off x="1775096" y="2974796"/>
              <a:ext cx="45717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62</a:t>
              </a:r>
              <a:endParaRPr lang="ko-KR" altLang="en-US" sz="12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345DA925-12C1-953B-2957-E559CC5F23C3}"/>
                </a:ext>
              </a:extLst>
            </p:cNvPr>
            <p:cNvSpPr txBox="1"/>
            <p:nvPr/>
          </p:nvSpPr>
          <p:spPr>
            <a:xfrm>
              <a:off x="2509090" y="2974796"/>
              <a:ext cx="56778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LC3B</a:t>
              </a:r>
              <a:endParaRPr lang="ko-KR" altLang="en-US" sz="1200" dirty="0">
                <a:latin typeface="Arial" panose="020B0604020202020204" pitchFamily="34" charset="0"/>
                <a:cs typeface="Arial" panose="020B0604020202020204" pitchFamily="34" charset="0"/>
              </a:endParaRPr>
            </a:p>
          </p:txBody>
        </p:sp>
        <p:graphicFrame>
          <p:nvGraphicFramePr>
            <p:cNvPr id="10" name="개체 9">
              <a:extLst>
                <a:ext uri="{FF2B5EF4-FFF2-40B4-BE49-F238E27FC236}">
                  <a16:creationId xmlns:a16="http://schemas.microsoft.com/office/drawing/2014/main" id="{3727924E-C036-2800-9EB3-2EF9A32E6B17}"/>
                </a:ext>
              </a:extLst>
            </p:cNvPr>
            <p:cNvGraphicFramePr>
              <a:graphicFrameLocks noChangeAspect="1"/>
            </p:cNvGraphicFramePr>
            <p:nvPr>
              <p:extLst>
                <p:ext uri="{D42A27DB-BD31-4B8C-83A1-F6EECF244321}">
                  <p14:modId xmlns:p14="http://schemas.microsoft.com/office/powerpoint/2010/main" val="836868561"/>
                </p:ext>
              </p:extLst>
            </p:nvPr>
          </p:nvGraphicFramePr>
          <p:xfrm>
            <a:off x="55475" y="806153"/>
            <a:ext cx="3478184" cy="2459710"/>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10" name="개체 9">
                          <a:extLst>
                            <a:ext uri="{FF2B5EF4-FFF2-40B4-BE49-F238E27FC236}">
                              <a16:creationId xmlns:a16="http://schemas.microsoft.com/office/drawing/2014/main" id="{3727924E-C036-2800-9EB3-2EF9A32E6B17}"/>
                            </a:ext>
                          </a:extLst>
                        </p:cNvPr>
                        <p:cNvPicPr/>
                        <p:nvPr/>
                      </p:nvPicPr>
                      <p:blipFill>
                        <a:blip r:embed="rId3"/>
                        <a:stretch>
                          <a:fillRect/>
                        </a:stretch>
                      </p:blipFill>
                      <p:spPr>
                        <a:xfrm>
                          <a:off x="55475" y="806153"/>
                          <a:ext cx="3478184" cy="2459710"/>
                        </a:xfrm>
                        <a:prstGeom prst="rect">
                          <a:avLst/>
                        </a:prstGeom>
                      </p:spPr>
                    </p:pic>
                  </p:oleObj>
                </mc:Fallback>
              </mc:AlternateContent>
            </a:graphicData>
          </a:graphic>
        </p:graphicFrame>
      </p:grpSp>
      <p:grpSp>
        <p:nvGrpSpPr>
          <p:cNvPr id="20" name="그룹 19">
            <a:extLst>
              <a:ext uri="{FF2B5EF4-FFF2-40B4-BE49-F238E27FC236}">
                <a16:creationId xmlns:a16="http://schemas.microsoft.com/office/drawing/2014/main" id="{82D536DA-819E-C157-A1D9-EAB52BA68ECF}"/>
              </a:ext>
            </a:extLst>
          </p:cNvPr>
          <p:cNvGrpSpPr/>
          <p:nvPr/>
        </p:nvGrpSpPr>
        <p:grpSpPr>
          <a:xfrm>
            <a:off x="3449696" y="779160"/>
            <a:ext cx="3525244" cy="2492990"/>
            <a:chOff x="3449696" y="779160"/>
            <a:chExt cx="3525244" cy="2492990"/>
          </a:xfrm>
        </p:grpSpPr>
        <p:sp>
          <p:nvSpPr>
            <p:cNvPr id="12" name="TextBox 11">
              <a:extLst>
                <a:ext uri="{FF2B5EF4-FFF2-40B4-BE49-F238E27FC236}">
                  <a16:creationId xmlns:a16="http://schemas.microsoft.com/office/drawing/2014/main" id="{E3C031C0-EB62-6E1D-17C1-13BEAC736929}"/>
                </a:ext>
              </a:extLst>
            </p:cNvPr>
            <p:cNvSpPr txBox="1"/>
            <p:nvPr/>
          </p:nvSpPr>
          <p:spPr>
            <a:xfrm>
              <a:off x="4300650" y="2974796"/>
              <a:ext cx="62709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Keap1</a:t>
              </a:r>
              <a:endParaRPr lang="ko-KR" altLang="en-US" sz="12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F8DE5034-D7FB-0E12-2D68-3843419BA8BE}"/>
                </a:ext>
              </a:extLst>
            </p:cNvPr>
            <p:cNvSpPr txBox="1"/>
            <p:nvPr/>
          </p:nvSpPr>
          <p:spPr>
            <a:xfrm>
              <a:off x="5190028" y="2974796"/>
              <a:ext cx="45717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62</a:t>
              </a:r>
              <a:endParaRPr lang="ko-KR" altLang="en-US" sz="12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A6185B5-D82D-5F1A-C70E-28C26078D735}"/>
                </a:ext>
              </a:extLst>
            </p:cNvPr>
            <p:cNvSpPr txBox="1"/>
            <p:nvPr/>
          </p:nvSpPr>
          <p:spPr>
            <a:xfrm>
              <a:off x="5924022" y="2974796"/>
              <a:ext cx="56778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LC3B</a:t>
              </a:r>
              <a:endParaRPr lang="ko-KR" altLang="en-US" sz="1200" dirty="0">
                <a:latin typeface="Arial" panose="020B0604020202020204" pitchFamily="34" charset="0"/>
                <a:cs typeface="Arial" panose="020B0604020202020204" pitchFamily="34" charset="0"/>
              </a:endParaRPr>
            </a:p>
          </p:txBody>
        </p:sp>
        <p:graphicFrame>
          <p:nvGraphicFramePr>
            <p:cNvPr id="19" name="개체 18">
              <a:extLst>
                <a:ext uri="{FF2B5EF4-FFF2-40B4-BE49-F238E27FC236}">
                  <a16:creationId xmlns:a16="http://schemas.microsoft.com/office/drawing/2014/main" id="{7E01D9FE-B82F-BD75-B874-5C8B733D5CBB}"/>
                </a:ext>
              </a:extLst>
            </p:cNvPr>
            <p:cNvGraphicFramePr>
              <a:graphicFrameLocks noChangeAspect="1"/>
            </p:cNvGraphicFramePr>
            <p:nvPr>
              <p:extLst>
                <p:ext uri="{D42A27DB-BD31-4B8C-83A1-F6EECF244321}">
                  <p14:modId xmlns:p14="http://schemas.microsoft.com/office/powerpoint/2010/main" val="2034177870"/>
                </p:ext>
              </p:extLst>
            </p:nvPr>
          </p:nvGraphicFramePr>
          <p:xfrm>
            <a:off x="3449696" y="779160"/>
            <a:ext cx="3525244" cy="2492990"/>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19" name="개체 18">
                          <a:extLst>
                            <a:ext uri="{FF2B5EF4-FFF2-40B4-BE49-F238E27FC236}">
                              <a16:creationId xmlns:a16="http://schemas.microsoft.com/office/drawing/2014/main" id="{7E01D9FE-B82F-BD75-B874-5C8B733D5CBB}"/>
                            </a:ext>
                          </a:extLst>
                        </p:cNvPr>
                        <p:cNvPicPr/>
                        <p:nvPr/>
                      </p:nvPicPr>
                      <p:blipFill>
                        <a:blip r:embed="rId5"/>
                        <a:stretch>
                          <a:fillRect/>
                        </a:stretch>
                      </p:blipFill>
                      <p:spPr>
                        <a:xfrm>
                          <a:off x="3449696" y="779160"/>
                          <a:ext cx="3525244" cy="2492990"/>
                        </a:xfrm>
                        <a:prstGeom prst="rect">
                          <a:avLst/>
                        </a:prstGeom>
                      </p:spPr>
                    </p:pic>
                  </p:oleObj>
                </mc:Fallback>
              </mc:AlternateContent>
            </a:graphicData>
          </a:graphic>
        </p:graphicFrame>
      </p:grpSp>
      <p:grpSp>
        <p:nvGrpSpPr>
          <p:cNvPr id="11" name="그룹 10">
            <a:extLst>
              <a:ext uri="{FF2B5EF4-FFF2-40B4-BE49-F238E27FC236}">
                <a16:creationId xmlns:a16="http://schemas.microsoft.com/office/drawing/2014/main" id="{35B00BDA-1272-0604-09EB-C7780D5260AA}"/>
              </a:ext>
            </a:extLst>
          </p:cNvPr>
          <p:cNvGrpSpPr/>
          <p:nvPr/>
        </p:nvGrpSpPr>
        <p:grpSpPr>
          <a:xfrm>
            <a:off x="42155" y="3873197"/>
            <a:ext cx="3573196" cy="2671687"/>
            <a:chOff x="42155" y="3873197"/>
            <a:chExt cx="3573196" cy="2671687"/>
          </a:xfrm>
        </p:grpSpPr>
        <p:sp>
          <p:nvSpPr>
            <p:cNvPr id="21" name="TextBox 20">
              <a:extLst>
                <a:ext uri="{FF2B5EF4-FFF2-40B4-BE49-F238E27FC236}">
                  <a16:creationId xmlns:a16="http://schemas.microsoft.com/office/drawing/2014/main" id="{033219CC-C81C-45DF-3778-9121ADD8303D}"/>
                </a:ext>
              </a:extLst>
            </p:cNvPr>
            <p:cNvSpPr txBox="1"/>
            <p:nvPr/>
          </p:nvSpPr>
          <p:spPr>
            <a:xfrm>
              <a:off x="883374" y="6267885"/>
              <a:ext cx="62709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Keap1</a:t>
              </a:r>
              <a:endParaRPr lang="ko-KR" altLang="en-US" sz="12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775B158F-69A6-5FC3-7F40-F737B38ACB4D}"/>
                </a:ext>
              </a:extLst>
            </p:cNvPr>
            <p:cNvSpPr txBox="1"/>
            <p:nvPr/>
          </p:nvSpPr>
          <p:spPr>
            <a:xfrm>
              <a:off x="1786820" y="6267885"/>
              <a:ext cx="45717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62</a:t>
              </a:r>
              <a:endParaRPr lang="ko-KR" altLang="en-US" sz="12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5D3E9073-B541-556C-40B1-B8D4E3BB1D42}"/>
                </a:ext>
              </a:extLst>
            </p:cNvPr>
            <p:cNvSpPr txBox="1"/>
            <p:nvPr/>
          </p:nvSpPr>
          <p:spPr>
            <a:xfrm>
              <a:off x="2534882" y="6267885"/>
              <a:ext cx="56778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LC3B</a:t>
              </a:r>
              <a:endParaRPr lang="ko-KR" altLang="en-US" sz="1200"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B049E763-CF50-434D-255C-0DE8B065CB2A}"/>
                </a:ext>
              </a:extLst>
            </p:cNvPr>
            <p:cNvGraphicFramePr>
              <a:graphicFrameLocks noChangeAspect="1"/>
            </p:cNvGraphicFramePr>
            <p:nvPr>
              <p:extLst>
                <p:ext uri="{D42A27DB-BD31-4B8C-83A1-F6EECF244321}">
                  <p14:modId xmlns:p14="http://schemas.microsoft.com/office/powerpoint/2010/main" val="3731943867"/>
                </p:ext>
              </p:extLst>
            </p:nvPr>
          </p:nvGraphicFramePr>
          <p:xfrm>
            <a:off x="42155" y="3873197"/>
            <a:ext cx="3573196" cy="2526901"/>
          </p:xfrm>
          <a:graphic>
            <a:graphicData uri="http://schemas.openxmlformats.org/presentationml/2006/ole">
              <mc:AlternateContent xmlns:mc="http://schemas.openxmlformats.org/markup-compatibility/2006">
                <mc:Choice xmlns:v="urn:schemas-microsoft-com:vml" Requires="v">
                  <p:oleObj name="Graph" r:id="rId6" imgW="33403857" imgH="23621831" progId="Origin50.Graph">
                    <p:embed/>
                  </p:oleObj>
                </mc:Choice>
                <mc:Fallback>
                  <p:oleObj name="Graph" r:id="rId6" imgW="33403857" imgH="23621831" progId="Origin50.Graph">
                    <p:embed/>
                    <p:pic>
                      <p:nvPicPr>
                        <p:cNvPr id="3" name="개체 2">
                          <a:extLst>
                            <a:ext uri="{FF2B5EF4-FFF2-40B4-BE49-F238E27FC236}">
                              <a16:creationId xmlns:a16="http://schemas.microsoft.com/office/drawing/2014/main" id="{B049E763-CF50-434D-255C-0DE8B065CB2A}"/>
                            </a:ext>
                          </a:extLst>
                        </p:cNvPr>
                        <p:cNvPicPr/>
                        <p:nvPr/>
                      </p:nvPicPr>
                      <p:blipFill>
                        <a:blip r:embed="rId7"/>
                        <a:stretch>
                          <a:fillRect/>
                        </a:stretch>
                      </p:blipFill>
                      <p:spPr>
                        <a:xfrm>
                          <a:off x="42155" y="3873197"/>
                          <a:ext cx="3573196" cy="2526901"/>
                        </a:xfrm>
                        <a:prstGeom prst="rect">
                          <a:avLst/>
                        </a:prstGeom>
                      </p:spPr>
                    </p:pic>
                  </p:oleObj>
                </mc:Fallback>
              </mc:AlternateContent>
            </a:graphicData>
          </a:graphic>
        </p:graphicFrame>
      </p:grpSp>
      <p:grpSp>
        <p:nvGrpSpPr>
          <p:cNvPr id="16" name="그룹 15">
            <a:extLst>
              <a:ext uri="{FF2B5EF4-FFF2-40B4-BE49-F238E27FC236}">
                <a16:creationId xmlns:a16="http://schemas.microsoft.com/office/drawing/2014/main" id="{B13D1367-72E0-18BC-16EB-978AAF2B20F2}"/>
              </a:ext>
            </a:extLst>
          </p:cNvPr>
          <p:cNvGrpSpPr/>
          <p:nvPr/>
        </p:nvGrpSpPr>
        <p:grpSpPr>
          <a:xfrm>
            <a:off x="3449696" y="3893552"/>
            <a:ext cx="3525244" cy="2651331"/>
            <a:chOff x="3449696" y="3893552"/>
            <a:chExt cx="3525244" cy="2651331"/>
          </a:xfrm>
        </p:grpSpPr>
        <p:sp>
          <p:nvSpPr>
            <p:cNvPr id="26" name="TextBox 25">
              <a:extLst>
                <a:ext uri="{FF2B5EF4-FFF2-40B4-BE49-F238E27FC236}">
                  <a16:creationId xmlns:a16="http://schemas.microsoft.com/office/drawing/2014/main" id="{125C6915-48CC-23EA-B649-ED7DF1FA29C6}"/>
                </a:ext>
              </a:extLst>
            </p:cNvPr>
            <p:cNvSpPr txBox="1"/>
            <p:nvPr/>
          </p:nvSpPr>
          <p:spPr>
            <a:xfrm>
              <a:off x="4269009" y="6267884"/>
              <a:ext cx="627095"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Keap1</a:t>
              </a:r>
              <a:endParaRPr lang="ko-KR" altLang="en-US" sz="12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69FEE923-6E70-F354-C499-241CD633AA1A}"/>
                </a:ext>
              </a:extLst>
            </p:cNvPr>
            <p:cNvSpPr txBox="1"/>
            <p:nvPr/>
          </p:nvSpPr>
          <p:spPr>
            <a:xfrm>
              <a:off x="5158387" y="6267884"/>
              <a:ext cx="457176"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62</a:t>
              </a:r>
              <a:endParaRPr lang="ko-KR" altLang="en-US" sz="12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94DAD3BE-5D55-0066-47A5-4953AE312E09}"/>
                </a:ext>
              </a:extLst>
            </p:cNvPr>
            <p:cNvSpPr txBox="1"/>
            <p:nvPr/>
          </p:nvSpPr>
          <p:spPr>
            <a:xfrm>
              <a:off x="5892381" y="6267884"/>
              <a:ext cx="567784"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LC3B</a:t>
              </a:r>
              <a:endParaRPr lang="ko-KR" altLang="en-US" sz="1200" dirty="0">
                <a:latin typeface="Arial" panose="020B0604020202020204" pitchFamily="34" charset="0"/>
                <a:cs typeface="Arial" panose="020B0604020202020204" pitchFamily="34" charset="0"/>
              </a:endParaRPr>
            </a:p>
          </p:txBody>
        </p:sp>
        <p:graphicFrame>
          <p:nvGraphicFramePr>
            <p:cNvPr id="15" name="개체 14">
              <a:extLst>
                <a:ext uri="{FF2B5EF4-FFF2-40B4-BE49-F238E27FC236}">
                  <a16:creationId xmlns:a16="http://schemas.microsoft.com/office/drawing/2014/main" id="{A09DCA0E-163F-E9EC-EE94-66F62CEC598A}"/>
                </a:ext>
              </a:extLst>
            </p:cNvPr>
            <p:cNvGraphicFramePr>
              <a:graphicFrameLocks noChangeAspect="1"/>
            </p:cNvGraphicFramePr>
            <p:nvPr>
              <p:extLst>
                <p:ext uri="{D42A27DB-BD31-4B8C-83A1-F6EECF244321}">
                  <p14:modId xmlns:p14="http://schemas.microsoft.com/office/powerpoint/2010/main" val="1673617710"/>
                </p:ext>
              </p:extLst>
            </p:nvPr>
          </p:nvGraphicFramePr>
          <p:xfrm>
            <a:off x="3449696" y="3893552"/>
            <a:ext cx="3525244" cy="2492990"/>
          </p:xfrm>
          <a:graphic>
            <a:graphicData uri="http://schemas.openxmlformats.org/presentationml/2006/ole">
              <mc:AlternateContent xmlns:mc="http://schemas.openxmlformats.org/markup-compatibility/2006">
                <mc:Choice xmlns:v="urn:schemas-microsoft-com:vml" Requires="v">
                  <p:oleObj name="Graph" r:id="rId8" imgW="33403857" imgH="23621831" progId="Origin50.Graph">
                    <p:embed/>
                  </p:oleObj>
                </mc:Choice>
                <mc:Fallback>
                  <p:oleObj name="Graph" r:id="rId8" imgW="33403857" imgH="23621831" progId="Origin50.Graph">
                    <p:embed/>
                    <p:pic>
                      <p:nvPicPr>
                        <p:cNvPr id="15" name="개체 14">
                          <a:extLst>
                            <a:ext uri="{FF2B5EF4-FFF2-40B4-BE49-F238E27FC236}">
                              <a16:creationId xmlns:a16="http://schemas.microsoft.com/office/drawing/2014/main" id="{A09DCA0E-163F-E9EC-EE94-66F62CEC598A}"/>
                            </a:ext>
                          </a:extLst>
                        </p:cNvPr>
                        <p:cNvPicPr/>
                        <p:nvPr/>
                      </p:nvPicPr>
                      <p:blipFill>
                        <a:blip r:embed="rId9"/>
                        <a:stretch>
                          <a:fillRect/>
                        </a:stretch>
                      </p:blipFill>
                      <p:spPr>
                        <a:xfrm>
                          <a:off x="3449696" y="3893552"/>
                          <a:ext cx="3525244" cy="2492990"/>
                        </a:xfrm>
                        <a:prstGeom prst="rect">
                          <a:avLst/>
                        </a:prstGeom>
                      </p:spPr>
                    </p:pic>
                  </p:oleObj>
                </mc:Fallback>
              </mc:AlternateContent>
            </a:graphicData>
          </a:graphic>
        </p:graphicFrame>
      </p:grpSp>
    </p:spTree>
    <p:extLst>
      <p:ext uri="{BB962C8B-B14F-4D97-AF65-F5344CB8AC3E}">
        <p14:creationId xmlns:p14="http://schemas.microsoft.com/office/powerpoint/2010/main" val="2855970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49477FD-F7EB-8E0D-0298-0D7AE3744382}"/>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1FE0FEE1-5153-F15E-5939-A3B5B9E25173}"/>
              </a:ext>
            </a:extLst>
          </p:cNvPr>
          <p:cNvSpPr txBox="1"/>
          <p:nvPr/>
        </p:nvSpPr>
        <p:spPr>
          <a:xfrm>
            <a:off x="259036" y="7551582"/>
            <a:ext cx="6370570" cy="1754326"/>
          </a:xfrm>
          <a:prstGeom prst="rect">
            <a:avLst/>
          </a:prstGeom>
          <a:noFill/>
        </p:spPr>
        <p:txBody>
          <a:bodyPr wrap="square" rtlCol="0" anchor="ctr">
            <a:spAutoFit/>
          </a:bodyPr>
          <a:lstStyle/>
          <a:p>
            <a:r>
              <a:rPr lang="en-US" altLang="ko-KR" sz="1200" b="1" dirty="0">
                <a:latin typeface="Times New Roman" panose="02020603050405020304" pitchFamily="18" charset="0"/>
                <a:cs typeface="Times New Roman" panose="02020603050405020304" pitchFamily="18" charset="0"/>
              </a:rPr>
              <a:t>Figure S7. </a:t>
            </a:r>
            <a:r>
              <a:rPr lang="en-US" altLang="ko-KR" sz="1200" dirty="0">
                <a:latin typeface="Times New Roman" panose="02020603050405020304" pitchFamily="18" charset="0"/>
                <a:cs typeface="Times New Roman" panose="02020603050405020304" pitchFamily="18" charset="0"/>
              </a:rPr>
              <a:t>Effect of ROS generation on DEP-induced NLRP1 inflammasome through the Nrf2 signaling pathway</a:t>
            </a:r>
          </a:p>
          <a:p>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The cells were cultured with 0.5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NAC for 1 h before adding 5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ML385 for 1 h before the addition of 1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M</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 IPA for 12 h, followed by 100 </a:t>
            </a:r>
            <a:r>
              <a:rPr lang="en-US" altLang="ko-KR" sz="1200" kern="100" dirty="0" err="1">
                <a:effectLst/>
                <a:latin typeface="Times New Roman" panose="02020603050405020304" pitchFamily="18" charset="0"/>
                <a:ea typeface="맑은 고딕" panose="020B0503020000020004" pitchFamily="50" charset="-127"/>
                <a:cs typeface="Arial" panose="020B0604020202020204" pitchFamily="34" charset="0"/>
              </a:rPr>
              <a:t>μg</a:t>
            </a:r>
            <a:r>
              <a:rPr lang="en-US" altLang="ko-KR" sz="1200" kern="100" dirty="0">
                <a:effectLst/>
                <a:latin typeface="Times New Roman" panose="02020603050405020304" pitchFamily="18" charset="0"/>
                <a:ea typeface="맑은 고딕" panose="020B0503020000020004" pitchFamily="50" charset="-127"/>
                <a:cs typeface="Arial" panose="020B0604020202020204" pitchFamily="34" charset="0"/>
              </a:rPr>
              <a:t>/ml DEP for 24 h or 30 min. (A and B) Quantification of band intensity from Figure 6A and 6C, normalized to the corresponding loading control. The band intensity was analyzed using the ImageJ program. All experiments were performed thrice (n=3). Data are expressed as the mean ± SD. *p&lt; 0.01 compared to the control group. #p&lt; 0.01 compared with DEP treatment group. $p&lt; 0.01 compared with the DEP and IPA treatment groups. &amp;p&lt; 0.01 compared with the DEP, IPA, and ML385 treatment groups.</a:t>
            </a:r>
          </a:p>
        </p:txBody>
      </p:sp>
      <p:sp>
        <p:nvSpPr>
          <p:cNvPr id="96" name="TextBox 95">
            <a:extLst>
              <a:ext uri="{FF2B5EF4-FFF2-40B4-BE49-F238E27FC236}">
                <a16:creationId xmlns:a16="http://schemas.microsoft.com/office/drawing/2014/main" id="{C1390B71-A785-7A72-9DE3-C7D08C9FC27F}"/>
              </a:ext>
            </a:extLst>
          </p:cNvPr>
          <p:cNvSpPr txBox="1"/>
          <p:nvPr/>
        </p:nvSpPr>
        <p:spPr>
          <a:xfrm>
            <a:off x="289706" y="558406"/>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B466D09C-8CA7-DD7D-9211-F19AC799F550}"/>
              </a:ext>
            </a:extLst>
          </p:cNvPr>
          <p:cNvSpPr txBox="1"/>
          <p:nvPr/>
        </p:nvSpPr>
        <p:spPr>
          <a:xfrm>
            <a:off x="289706" y="4306622"/>
            <a:ext cx="295274" cy="276999"/>
          </a:xfrm>
          <a:prstGeom prst="rect">
            <a:avLst/>
          </a:prstGeom>
          <a:noFill/>
        </p:spPr>
        <p:txBody>
          <a:bodyPr wrap="none" rtlCol="0" anchor="ctr">
            <a:spAutoFit/>
          </a:bodyPr>
          <a:lstStyle/>
          <a:p>
            <a:pPr algn="ctr"/>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3CD758E6-CC0A-C043-A8AE-63D1AF4DF243}"/>
              </a:ext>
            </a:extLst>
          </p:cNvPr>
          <p:cNvSpPr txBox="1"/>
          <p:nvPr/>
        </p:nvSpPr>
        <p:spPr>
          <a:xfrm>
            <a:off x="149297" y="193839"/>
            <a:ext cx="5841932" cy="307777"/>
          </a:xfrm>
          <a:prstGeom prst="rect">
            <a:avLst/>
          </a:prstGeom>
          <a:noFill/>
        </p:spPr>
        <p:txBody>
          <a:bodyPr wrap="square" rtlCol="0" anchor="ctr">
            <a:spAutoFit/>
          </a:bodyPr>
          <a:lstStyle/>
          <a:p>
            <a:pPr>
              <a:spcAft>
                <a:spcPts val="1200"/>
              </a:spcAft>
            </a:pPr>
            <a:r>
              <a:rPr lang="en-US" altLang="ko-KR" sz="1400" b="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Figure S7.</a:t>
            </a:r>
            <a:endParaRPr lang="ko-KR" altLang="ko-KR" sz="1400" b="1"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nvGrpSpPr>
          <p:cNvPr id="17" name="그룹 16">
            <a:extLst>
              <a:ext uri="{FF2B5EF4-FFF2-40B4-BE49-F238E27FC236}">
                <a16:creationId xmlns:a16="http://schemas.microsoft.com/office/drawing/2014/main" id="{510FBAD1-DD92-8C66-D9FC-287227762D40}"/>
              </a:ext>
            </a:extLst>
          </p:cNvPr>
          <p:cNvGrpSpPr/>
          <p:nvPr/>
        </p:nvGrpSpPr>
        <p:grpSpPr>
          <a:xfrm>
            <a:off x="473018" y="731256"/>
            <a:ext cx="4310063" cy="3432721"/>
            <a:chOff x="473018" y="731256"/>
            <a:chExt cx="4310063" cy="3432721"/>
          </a:xfrm>
        </p:grpSpPr>
        <p:sp>
          <p:nvSpPr>
            <p:cNvPr id="5" name="TextBox 4">
              <a:extLst>
                <a:ext uri="{FF2B5EF4-FFF2-40B4-BE49-F238E27FC236}">
                  <a16:creationId xmlns:a16="http://schemas.microsoft.com/office/drawing/2014/main" id="{C47F4F0E-6FD4-ADAB-2DD3-7823CDAE3B36}"/>
                </a:ext>
              </a:extLst>
            </p:cNvPr>
            <p:cNvSpPr txBox="1"/>
            <p:nvPr/>
          </p:nvSpPr>
          <p:spPr>
            <a:xfrm>
              <a:off x="1331788" y="3779256"/>
              <a:ext cx="627945"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NLRP1</a:t>
              </a:r>
              <a:endParaRPr lang="ko-KR" altLang="en-US" sz="10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4F2C1910-A51B-C5D2-E8A6-94182E402D5D}"/>
                </a:ext>
              </a:extLst>
            </p:cNvPr>
            <p:cNvSpPr txBox="1"/>
            <p:nvPr/>
          </p:nvSpPr>
          <p:spPr>
            <a:xfrm>
              <a:off x="1767567" y="3779256"/>
              <a:ext cx="783159"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N-terminal</a:t>
              </a:r>
            </a:p>
            <a:p>
              <a:pPr algn="ctr"/>
              <a:r>
                <a:rPr lang="en-US" altLang="ko-KR" sz="950" dirty="0">
                  <a:latin typeface="Arial" panose="020B0604020202020204" pitchFamily="34" charset="0"/>
                  <a:cs typeface="Arial" panose="020B0604020202020204" pitchFamily="34" charset="0"/>
                </a:rPr>
                <a:t>GSDMD</a:t>
              </a:r>
              <a:endParaRPr lang="ko-KR" altLang="en-US" sz="95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C9312439-9121-D63B-1407-1461AC57C82A}"/>
                </a:ext>
              </a:extLst>
            </p:cNvPr>
            <p:cNvSpPr txBox="1"/>
            <p:nvPr/>
          </p:nvSpPr>
          <p:spPr>
            <a:xfrm>
              <a:off x="2428463" y="3779256"/>
              <a:ext cx="471042"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ASC</a:t>
              </a:r>
              <a:endParaRPr lang="ko-KR" altLang="en-US" sz="10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CC1E794B-A2BA-7FEA-4602-A9CAC233CAC1}"/>
                </a:ext>
              </a:extLst>
            </p:cNvPr>
            <p:cNvSpPr txBox="1"/>
            <p:nvPr/>
          </p:nvSpPr>
          <p:spPr>
            <a:xfrm>
              <a:off x="2899045" y="3779256"/>
              <a:ext cx="545276"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NEK7</a:t>
              </a:r>
              <a:endParaRPr lang="ko-KR" altLang="en-US" sz="10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C499039F-C4D9-A7E1-C3B7-B372135C69D3}"/>
                </a:ext>
              </a:extLst>
            </p:cNvPr>
            <p:cNvSpPr txBox="1"/>
            <p:nvPr/>
          </p:nvSpPr>
          <p:spPr>
            <a:xfrm>
              <a:off x="3274300" y="3779256"/>
              <a:ext cx="811840"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Cleaved</a:t>
              </a:r>
            </a:p>
            <a:p>
              <a:pPr algn="ctr"/>
              <a:r>
                <a:rPr lang="en-US" altLang="ko-KR" sz="950" dirty="0">
                  <a:latin typeface="Arial" panose="020B0604020202020204" pitchFamily="34" charset="0"/>
                  <a:cs typeface="Arial" panose="020B0604020202020204" pitchFamily="34" charset="0"/>
                </a:rPr>
                <a:t>Caspase-1</a:t>
              </a:r>
              <a:endParaRPr lang="ko-KR" altLang="en-US" sz="95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14D0A1CD-B61A-B4CF-3EF8-4756F80EE5F9}"/>
                </a:ext>
              </a:extLst>
            </p:cNvPr>
            <p:cNvSpPr txBox="1"/>
            <p:nvPr/>
          </p:nvSpPr>
          <p:spPr>
            <a:xfrm>
              <a:off x="3873258" y="3779256"/>
              <a:ext cx="663374" cy="384721"/>
            </a:xfrm>
            <a:prstGeom prst="rect">
              <a:avLst/>
            </a:prstGeom>
            <a:noFill/>
          </p:spPr>
          <p:txBody>
            <a:bodyPr wrap="none" rtlCol="0">
              <a:spAutoFit/>
            </a:bodyPr>
            <a:lstStyle/>
            <a:p>
              <a:pPr algn="ctr"/>
              <a:r>
                <a:rPr lang="en-US" altLang="ko-KR" sz="950" dirty="0">
                  <a:latin typeface="Arial" panose="020B0604020202020204" pitchFamily="34" charset="0"/>
                  <a:cs typeface="Arial" panose="020B0604020202020204" pitchFamily="34" charset="0"/>
                </a:rPr>
                <a:t>Cleaved</a:t>
              </a:r>
            </a:p>
            <a:p>
              <a:pPr algn="ctr"/>
              <a:r>
                <a:rPr lang="en-US" altLang="ko-KR" sz="950" dirty="0">
                  <a:latin typeface="Arial" panose="020B0604020202020204" pitchFamily="34" charset="0"/>
                  <a:cs typeface="Arial" panose="020B0604020202020204" pitchFamily="34" charset="0"/>
                </a:rPr>
                <a:t>IL-1</a:t>
              </a:r>
              <a:r>
                <a:rPr lang="en-US" altLang="ko-KR" sz="950" dirty="0">
                  <a:latin typeface="Arial" panose="020B0604020202020204" pitchFamily="34" charset="0"/>
                  <a:cs typeface="Arial" panose="020B0604020202020204" pitchFamily="34" charset="0"/>
                  <a:sym typeface="Symbol" panose="05050102010706020507" pitchFamily="18" charset="2"/>
                </a:rPr>
                <a:t></a:t>
              </a:r>
              <a:endParaRPr lang="ko-KR" altLang="en-US" sz="950" dirty="0">
                <a:latin typeface="Arial" panose="020B0604020202020204" pitchFamily="34" charset="0"/>
                <a:cs typeface="Arial" panose="020B0604020202020204" pitchFamily="34" charset="0"/>
              </a:endParaRPr>
            </a:p>
          </p:txBody>
        </p:sp>
        <p:graphicFrame>
          <p:nvGraphicFramePr>
            <p:cNvPr id="16" name="개체 15">
              <a:extLst>
                <a:ext uri="{FF2B5EF4-FFF2-40B4-BE49-F238E27FC236}">
                  <a16:creationId xmlns:a16="http://schemas.microsoft.com/office/drawing/2014/main" id="{2FE7AE23-8559-2EA0-2DD3-3D57A4D9E88B}"/>
                </a:ext>
              </a:extLst>
            </p:cNvPr>
            <p:cNvGraphicFramePr>
              <a:graphicFrameLocks noChangeAspect="1"/>
            </p:cNvGraphicFramePr>
            <p:nvPr>
              <p:extLst>
                <p:ext uri="{D42A27DB-BD31-4B8C-83A1-F6EECF244321}">
                  <p14:modId xmlns:p14="http://schemas.microsoft.com/office/powerpoint/2010/main" val="2784413074"/>
                </p:ext>
              </p:extLst>
            </p:nvPr>
          </p:nvGraphicFramePr>
          <p:xfrm>
            <a:off x="473018" y="731256"/>
            <a:ext cx="4310063" cy="3048000"/>
          </p:xfrm>
          <a:graphic>
            <a:graphicData uri="http://schemas.openxmlformats.org/presentationml/2006/ole">
              <mc:AlternateContent xmlns:mc="http://schemas.openxmlformats.org/markup-compatibility/2006">
                <mc:Choice xmlns:v="urn:schemas-microsoft-com:vml" Requires="v">
                  <p:oleObj name="Graph" r:id="rId2" imgW="33403857" imgH="23621831" progId="Origin50.Graph">
                    <p:embed/>
                  </p:oleObj>
                </mc:Choice>
                <mc:Fallback>
                  <p:oleObj name="Graph" r:id="rId2" imgW="33403857" imgH="23621831" progId="Origin50.Graph">
                    <p:embed/>
                    <p:pic>
                      <p:nvPicPr>
                        <p:cNvPr id="16" name="개체 15">
                          <a:extLst>
                            <a:ext uri="{FF2B5EF4-FFF2-40B4-BE49-F238E27FC236}">
                              <a16:creationId xmlns:a16="http://schemas.microsoft.com/office/drawing/2014/main" id="{2FE7AE23-8559-2EA0-2DD3-3D57A4D9E88B}"/>
                            </a:ext>
                          </a:extLst>
                        </p:cNvPr>
                        <p:cNvPicPr/>
                        <p:nvPr/>
                      </p:nvPicPr>
                      <p:blipFill>
                        <a:blip r:embed="rId3"/>
                        <a:stretch>
                          <a:fillRect/>
                        </a:stretch>
                      </p:blipFill>
                      <p:spPr>
                        <a:xfrm>
                          <a:off x="473018" y="731256"/>
                          <a:ext cx="4310063" cy="3048000"/>
                        </a:xfrm>
                        <a:prstGeom prst="rect">
                          <a:avLst/>
                        </a:prstGeom>
                      </p:spPr>
                    </p:pic>
                  </p:oleObj>
                </mc:Fallback>
              </mc:AlternateContent>
            </a:graphicData>
          </a:graphic>
        </p:graphicFrame>
      </p:grpSp>
      <p:grpSp>
        <p:nvGrpSpPr>
          <p:cNvPr id="19" name="그룹 18">
            <a:extLst>
              <a:ext uri="{FF2B5EF4-FFF2-40B4-BE49-F238E27FC236}">
                <a16:creationId xmlns:a16="http://schemas.microsoft.com/office/drawing/2014/main" id="{1404D1DC-07BF-76CA-765C-05D53F505B65}"/>
              </a:ext>
            </a:extLst>
          </p:cNvPr>
          <p:cNvGrpSpPr/>
          <p:nvPr/>
        </p:nvGrpSpPr>
        <p:grpSpPr>
          <a:xfrm>
            <a:off x="584980" y="4364838"/>
            <a:ext cx="4063614" cy="3145920"/>
            <a:chOff x="584980" y="4364838"/>
            <a:chExt cx="4063614" cy="3145920"/>
          </a:xfrm>
        </p:grpSpPr>
        <p:sp>
          <p:nvSpPr>
            <p:cNvPr id="12" name="TextBox 11">
              <a:extLst>
                <a:ext uri="{FF2B5EF4-FFF2-40B4-BE49-F238E27FC236}">
                  <a16:creationId xmlns:a16="http://schemas.microsoft.com/office/drawing/2014/main" id="{EEB7DFA8-2E33-D6F3-56A9-DE54A0BD6100}"/>
                </a:ext>
              </a:extLst>
            </p:cNvPr>
            <p:cNvSpPr txBox="1"/>
            <p:nvPr/>
          </p:nvSpPr>
          <p:spPr>
            <a:xfrm>
              <a:off x="1446810" y="7219568"/>
              <a:ext cx="1305257" cy="291190"/>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NF-</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NF-</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8FF2FC70-5236-23C1-C2CC-95076F579D47}"/>
                </a:ext>
              </a:extLst>
            </p:cNvPr>
            <p:cNvSpPr txBox="1"/>
            <p:nvPr/>
          </p:nvSpPr>
          <p:spPr>
            <a:xfrm>
              <a:off x="3023161" y="7219568"/>
              <a:ext cx="909211" cy="291190"/>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p-I</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I-</a:t>
              </a:r>
              <a:r>
                <a:rPr lang="el-GR" altLang="ko-KR" sz="1200" dirty="0">
                  <a:latin typeface="Arial" panose="020B0604020202020204" pitchFamily="34" charset="0"/>
                  <a:cs typeface="Arial" panose="020B0604020202020204" pitchFamily="34" charset="0"/>
                </a:rPr>
                <a:t>κ</a:t>
              </a:r>
              <a:r>
                <a:rPr lang="en-US" altLang="ko-KR" sz="1200" dirty="0">
                  <a:latin typeface="Arial" panose="020B0604020202020204" pitchFamily="34" charset="0"/>
                  <a:cs typeface="Arial" panose="020B0604020202020204" pitchFamily="34" charset="0"/>
                </a:rPr>
                <a:t>B</a:t>
              </a:r>
            </a:p>
          </p:txBody>
        </p:sp>
        <p:graphicFrame>
          <p:nvGraphicFramePr>
            <p:cNvPr id="18" name="개체 17">
              <a:extLst>
                <a:ext uri="{FF2B5EF4-FFF2-40B4-BE49-F238E27FC236}">
                  <a16:creationId xmlns:a16="http://schemas.microsoft.com/office/drawing/2014/main" id="{BC02A363-2A0B-9DB5-DBE0-3A2D37AA403E}"/>
                </a:ext>
              </a:extLst>
            </p:cNvPr>
            <p:cNvGraphicFramePr>
              <a:graphicFrameLocks noChangeAspect="1"/>
            </p:cNvGraphicFramePr>
            <p:nvPr>
              <p:extLst>
                <p:ext uri="{D42A27DB-BD31-4B8C-83A1-F6EECF244321}">
                  <p14:modId xmlns:p14="http://schemas.microsoft.com/office/powerpoint/2010/main" val="3256596760"/>
                </p:ext>
              </p:extLst>
            </p:nvPr>
          </p:nvGraphicFramePr>
          <p:xfrm>
            <a:off x="584980" y="4364838"/>
            <a:ext cx="4063614" cy="2873715"/>
          </p:xfrm>
          <a:graphic>
            <a:graphicData uri="http://schemas.openxmlformats.org/presentationml/2006/ole">
              <mc:AlternateContent xmlns:mc="http://schemas.openxmlformats.org/markup-compatibility/2006">
                <mc:Choice xmlns:v="urn:schemas-microsoft-com:vml" Requires="v">
                  <p:oleObj name="Graph" r:id="rId4" imgW="33403857" imgH="23621831" progId="Origin50.Graph">
                    <p:embed/>
                  </p:oleObj>
                </mc:Choice>
                <mc:Fallback>
                  <p:oleObj name="Graph" r:id="rId4" imgW="33403857" imgH="23621831" progId="Origin50.Graph">
                    <p:embed/>
                    <p:pic>
                      <p:nvPicPr>
                        <p:cNvPr id="18" name="개체 17">
                          <a:extLst>
                            <a:ext uri="{FF2B5EF4-FFF2-40B4-BE49-F238E27FC236}">
                              <a16:creationId xmlns:a16="http://schemas.microsoft.com/office/drawing/2014/main" id="{BC02A363-2A0B-9DB5-DBE0-3A2D37AA403E}"/>
                            </a:ext>
                          </a:extLst>
                        </p:cNvPr>
                        <p:cNvPicPr/>
                        <p:nvPr/>
                      </p:nvPicPr>
                      <p:blipFill>
                        <a:blip r:embed="rId5"/>
                        <a:stretch>
                          <a:fillRect/>
                        </a:stretch>
                      </p:blipFill>
                      <p:spPr>
                        <a:xfrm>
                          <a:off x="584980" y="4364838"/>
                          <a:ext cx="4063614" cy="2873715"/>
                        </a:xfrm>
                        <a:prstGeom prst="rect">
                          <a:avLst/>
                        </a:prstGeom>
                      </p:spPr>
                    </p:pic>
                  </p:oleObj>
                </mc:Fallback>
              </mc:AlternateContent>
            </a:graphicData>
          </a:graphic>
        </p:graphicFrame>
      </p:grpSp>
    </p:spTree>
    <p:extLst>
      <p:ext uri="{BB962C8B-B14F-4D97-AF65-F5344CB8AC3E}">
        <p14:creationId xmlns:p14="http://schemas.microsoft.com/office/powerpoint/2010/main" val="262983959"/>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테마">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6406</TotalTime>
  <Words>1392</Words>
  <Application>Microsoft Office PowerPoint</Application>
  <PresentationFormat>A4 용지(210x297mm)</PresentationFormat>
  <Paragraphs>179</Paragraphs>
  <Slides>9</Slides>
  <Notes>0</Notes>
  <HiddenSlides>0</HiddenSlides>
  <MMClips>0</MMClips>
  <ScaleCrop>false</ScaleCrop>
  <HeadingPairs>
    <vt:vector size="8" baseType="variant">
      <vt:variant>
        <vt:lpstr>사용한 글꼴</vt:lpstr>
      </vt:variant>
      <vt:variant>
        <vt:i4>6</vt:i4>
      </vt:variant>
      <vt:variant>
        <vt:lpstr>테마</vt:lpstr>
      </vt:variant>
      <vt:variant>
        <vt:i4>1</vt:i4>
      </vt:variant>
      <vt:variant>
        <vt:lpstr>포함된 OLE 서버</vt:lpstr>
      </vt:variant>
      <vt:variant>
        <vt:i4>2</vt:i4>
      </vt:variant>
      <vt:variant>
        <vt:lpstr>슬라이드 제목</vt:lpstr>
      </vt:variant>
      <vt:variant>
        <vt:i4>9</vt:i4>
      </vt:variant>
    </vt:vector>
  </HeadingPairs>
  <TitlesOfParts>
    <vt:vector size="18" baseType="lpstr">
      <vt:lpstr>Arial Unicode MS</vt:lpstr>
      <vt:lpstr>Aptos</vt:lpstr>
      <vt:lpstr>Aptos Display</vt:lpstr>
      <vt:lpstr>Arial</vt:lpstr>
      <vt:lpstr>Palatino Linotype</vt:lpstr>
      <vt:lpstr>Times New Roman</vt:lpstr>
      <vt:lpstr>Office 테마</vt:lpstr>
      <vt:lpstr>Graph</vt:lpstr>
      <vt:lpstr>Origin Graph</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ffect of IPA on DEP-induced NRLP1 inflammasome via Keap-1/p62/Nrf2  in Hacat</dc:title>
  <dc:creator>gi ho Lee</dc:creator>
  <cp:lastModifiedBy>. .</cp:lastModifiedBy>
  <cp:revision>8</cp:revision>
  <dcterms:created xsi:type="dcterms:W3CDTF">2024-03-04T03:22:48Z</dcterms:created>
  <dcterms:modified xsi:type="dcterms:W3CDTF">2025-05-15T03:59:49Z</dcterms:modified>
</cp:coreProperties>
</file>